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0"/>
  </p:notesMasterIdLst>
  <p:sldIdLst>
    <p:sldId id="276" r:id="rId2"/>
    <p:sldId id="267" r:id="rId3"/>
    <p:sldId id="278" r:id="rId4"/>
    <p:sldId id="259" r:id="rId5"/>
    <p:sldId id="262" r:id="rId6"/>
    <p:sldId id="269" r:id="rId7"/>
    <p:sldId id="273" r:id="rId8"/>
    <p:sldId id="263" r:id="rId9"/>
  </p:sldIdLst>
  <p:sldSz cx="21599525" cy="25199975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C538378-7B72-58E2-616B-349E9EAAF01C}" v="119" dt="2024-11-13T11:47:03.623"/>
    <p1510:client id="{10AE761A-7465-1BDD-7F7D-0901F2E479C0}" v="18" dt="2024-11-11T16:48:12.378"/>
    <p1510:client id="{56B6EAE2-8D2B-9878-434D-991B9EECED73}" v="17" dt="2024-11-13T12:08:41.97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laria Laurenzana" userId="S::ilaria.laurenzana@crob.it::d20e3a4c-5152-4781-9a82-e8e358f0fc6e" providerId="AD" clId="Web-{E9A5C8F4-8985-7D32-C257-EDC77104564A}"/>
    <pc:docChg chg="modSld">
      <pc:chgData name="Ilaria Laurenzana" userId="S::ilaria.laurenzana@crob.it::d20e3a4c-5152-4781-9a82-e8e358f0fc6e" providerId="AD" clId="Web-{E9A5C8F4-8985-7D32-C257-EDC77104564A}" dt="2024-09-26T11:37:06.630" v="11" actId="1076"/>
      <pc:docMkLst>
        <pc:docMk/>
      </pc:docMkLst>
      <pc:sldChg chg="addSp modSp">
        <pc:chgData name="Ilaria Laurenzana" userId="S::ilaria.laurenzana@crob.it::d20e3a4c-5152-4781-9a82-e8e358f0fc6e" providerId="AD" clId="Web-{E9A5C8F4-8985-7D32-C257-EDC77104564A}" dt="2024-09-26T11:37:06.630" v="11" actId="1076"/>
        <pc:sldMkLst>
          <pc:docMk/>
          <pc:sldMk cId="425908882" sldId="258"/>
        </pc:sldMkLst>
        <pc:picChg chg="add mod">
          <ac:chgData name="Ilaria Laurenzana" userId="S::ilaria.laurenzana@crob.it::d20e3a4c-5152-4781-9a82-e8e358f0fc6e" providerId="AD" clId="Web-{E9A5C8F4-8985-7D32-C257-EDC77104564A}" dt="2024-09-26T11:37:06.630" v="11" actId="1076"/>
          <ac:picMkLst>
            <pc:docMk/>
            <pc:sldMk cId="425908882" sldId="258"/>
            <ac:picMk id="15" creationId="{41B43AF4-826A-A3C5-F74C-3B7B735BB113}"/>
          </ac:picMkLst>
        </pc:picChg>
      </pc:sldChg>
    </pc:docChg>
  </pc:docChgLst>
  <pc:docChgLst>
    <pc:chgData name="Daniela Lamorte" userId="S::daniela.lamorte@crob.it::4daa296d-a8f4-4e51-80aa-76962eb20860" providerId="AD" clId="Web-{E1623494-8EED-761D-D376-2788F9B3334C}"/>
    <pc:docChg chg="modSld">
      <pc:chgData name="Daniela Lamorte" userId="S::daniela.lamorte@crob.it::4daa296d-a8f4-4e51-80aa-76962eb20860" providerId="AD" clId="Web-{E1623494-8EED-761D-D376-2788F9B3334C}" dt="2024-11-11T10:24:52.258" v="3" actId="20577"/>
      <pc:docMkLst>
        <pc:docMk/>
      </pc:docMkLst>
      <pc:sldChg chg="addSp modSp">
        <pc:chgData name="Daniela Lamorte" userId="S::daniela.lamorte@crob.it::4daa296d-a8f4-4e51-80aa-76962eb20860" providerId="AD" clId="Web-{E1623494-8EED-761D-D376-2788F9B3334C}" dt="2024-11-11T10:24:52.258" v="3" actId="20577"/>
        <pc:sldMkLst>
          <pc:docMk/>
          <pc:sldMk cId="302162955" sldId="273"/>
        </pc:sldMkLst>
        <pc:spChg chg="add">
          <ac:chgData name="Daniela Lamorte" userId="S::daniela.lamorte@crob.it::4daa296d-a8f4-4e51-80aa-76962eb20860" providerId="AD" clId="Web-{E1623494-8EED-761D-D376-2788F9B3334C}" dt="2024-11-11T10:24:41.133" v="0"/>
          <ac:spMkLst>
            <pc:docMk/>
            <pc:sldMk cId="302162955" sldId="273"/>
            <ac:spMk id="9" creationId="{E4BFA399-B7B9-9173-4346-5BEE3F8A7E00}"/>
          </ac:spMkLst>
        </pc:spChg>
        <pc:spChg chg="add mod">
          <ac:chgData name="Daniela Lamorte" userId="S::daniela.lamorte@crob.it::4daa296d-a8f4-4e51-80aa-76962eb20860" providerId="AD" clId="Web-{E1623494-8EED-761D-D376-2788F9B3334C}" dt="2024-11-11T10:24:52.258" v="3" actId="20577"/>
          <ac:spMkLst>
            <pc:docMk/>
            <pc:sldMk cId="302162955" sldId="273"/>
            <ac:spMk id="11" creationId="{893B85F0-C729-AB89-1007-D028FD6BE6A3}"/>
          </ac:spMkLst>
        </pc:spChg>
      </pc:sldChg>
    </pc:docChg>
  </pc:docChgLst>
  <pc:docChgLst>
    <pc:chgData clId="Web-{10AE761A-7465-1BDD-7F7D-0901F2E479C0}"/>
    <pc:docChg chg="delSld">
      <pc:chgData name="" userId="" providerId="" clId="Web-{10AE761A-7465-1BDD-7F7D-0901F2E479C0}" dt="2024-11-11T16:46:28.312" v="1"/>
      <pc:docMkLst>
        <pc:docMk/>
      </pc:docMkLst>
      <pc:sldChg chg="del">
        <pc:chgData name="" userId="" providerId="" clId="Web-{10AE761A-7465-1BDD-7F7D-0901F2E479C0}" dt="2024-11-11T16:46:28.312" v="1"/>
        <pc:sldMkLst>
          <pc:docMk/>
          <pc:sldMk cId="425908882" sldId="258"/>
        </pc:sldMkLst>
      </pc:sldChg>
      <pc:sldChg chg="del">
        <pc:chgData name="" userId="" providerId="" clId="Web-{10AE761A-7465-1BDD-7F7D-0901F2E479C0}" dt="2024-11-11T16:46:23.265" v="0"/>
        <pc:sldMkLst>
          <pc:docMk/>
          <pc:sldMk cId="3557762631" sldId="275"/>
        </pc:sldMkLst>
      </pc:sldChg>
    </pc:docChg>
  </pc:docChgLst>
  <pc:docChgLst>
    <pc:chgData name="Luciana De Luca" userId="S::luciana.deluca@crob.it::bae8d283-e187-4b8e-966b-081af72c9cd4" providerId="AD" clId="Web-{0C538378-7B72-58E2-616B-349E9EAAF01C}"/>
    <pc:docChg chg="modSld">
      <pc:chgData name="Luciana De Luca" userId="S::luciana.deluca@crob.it::bae8d283-e187-4b8e-966b-081af72c9cd4" providerId="AD" clId="Web-{0C538378-7B72-58E2-616B-349E9EAAF01C}" dt="2024-11-13T11:47:03.608" v="91" actId="20577"/>
      <pc:docMkLst>
        <pc:docMk/>
      </pc:docMkLst>
      <pc:sldChg chg="delSp modSp">
        <pc:chgData name="Luciana De Luca" userId="S::luciana.deluca@crob.it::bae8d283-e187-4b8e-966b-081af72c9cd4" providerId="AD" clId="Web-{0C538378-7B72-58E2-616B-349E9EAAF01C}" dt="2024-11-13T11:40:16.629" v="68" actId="20577"/>
        <pc:sldMkLst>
          <pc:docMk/>
          <pc:sldMk cId="3226044835" sldId="259"/>
        </pc:sldMkLst>
        <pc:spChg chg="mod">
          <ac:chgData name="Luciana De Luca" userId="S::luciana.deluca@crob.it::bae8d283-e187-4b8e-966b-081af72c9cd4" providerId="AD" clId="Web-{0C538378-7B72-58E2-616B-349E9EAAF01C}" dt="2024-11-13T11:40:16.629" v="68" actId="20577"/>
          <ac:spMkLst>
            <pc:docMk/>
            <pc:sldMk cId="3226044835" sldId="259"/>
            <ac:spMk id="2" creationId="{45ED1FF6-81DF-599C-E177-42FA8A0097E3}"/>
          </ac:spMkLst>
        </pc:spChg>
        <pc:spChg chg="del">
          <ac:chgData name="Luciana De Luca" userId="S::luciana.deluca@crob.it::bae8d283-e187-4b8e-966b-081af72c9cd4" providerId="AD" clId="Web-{0C538378-7B72-58E2-616B-349E9EAAF01C}" dt="2024-11-13T11:39:12.392" v="65"/>
          <ac:spMkLst>
            <pc:docMk/>
            <pc:sldMk cId="3226044835" sldId="259"/>
            <ac:spMk id="4" creationId="{DE32E2C9-A818-F7F3-5870-26E8FA6602EF}"/>
          </ac:spMkLst>
        </pc:spChg>
      </pc:sldChg>
      <pc:sldChg chg="delSp modSp">
        <pc:chgData name="Luciana De Luca" userId="S::luciana.deluca@crob.it::bae8d283-e187-4b8e-966b-081af72c9cd4" providerId="AD" clId="Web-{0C538378-7B72-58E2-616B-349E9EAAF01C}" dt="2024-11-13T11:44:34.104" v="75" actId="20577"/>
        <pc:sldMkLst>
          <pc:docMk/>
          <pc:sldMk cId="3807340237" sldId="262"/>
        </pc:sldMkLst>
        <pc:spChg chg="del">
          <ac:chgData name="Luciana De Luca" userId="S::luciana.deluca@crob.it::bae8d283-e187-4b8e-966b-081af72c9cd4" providerId="AD" clId="Web-{0C538378-7B72-58E2-616B-349E9EAAF01C}" dt="2024-11-13T11:40:20.207" v="69"/>
          <ac:spMkLst>
            <pc:docMk/>
            <pc:sldMk cId="3807340237" sldId="262"/>
            <ac:spMk id="4" creationId="{DE32E2C9-A818-F7F3-5870-26E8FA6602EF}"/>
          </ac:spMkLst>
        </pc:spChg>
        <pc:spChg chg="mod">
          <ac:chgData name="Luciana De Luca" userId="S::luciana.deluca@crob.it::bae8d283-e187-4b8e-966b-081af72c9cd4" providerId="AD" clId="Web-{0C538378-7B72-58E2-616B-349E9EAAF01C}" dt="2024-11-13T11:44:34.104" v="75" actId="20577"/>
          <ac:spMkLst>
            <pc:docMk/>
            <pc:sldMk cId="3807340237" sldId="262"/>
            <ac:spMk id="5" creationId="{A03200F7-95D6-2B5B-32DE-BBC23B80256E}"/>
          </ac:spMkLst>
        </pc:spChg>
      </pc:sldChg>
      <pc:sldChg chg="delSp modSp">
        <pc:chgData name="Luciana De Luca" userId="S::luciana.deluca@crob.it::bae8d283-e187-4b8e-966b-081af72c9cd4" providerId="AD" clId="Web-{0C538378-7B72-58E2-616B-349E9EAAF01C}" dt="2024-11-13T11:47:03.608" v="91" actId="20577"/>
        <pc:sldMkLst>
          <pc:docMk/>
          <pc:sldMk cId="4156066348" sldId="263"/>
        </pc:sldMkLst>
        <pc:spChg chg="del">
          <ac:chgData name="Luciana De Luca" userId="S::luciana.deluca@crob.it::bae8d283-e187-4b8e-966b-081af72c9cd4" providerId="AD" clId="Web-{0C538378-7B72-58E2-616B-349E9EAAF01C}" dt="2024-11-13T11:46:52.607" v="88"/>
          <ac:spMkLst>
            <pc:docMk/>
            <pc:sldMk cId="4156066348" sldId="263"/>
            <ac:spMk id="4" creationId="{DE32E2C9-A818-F7F3-5870-26E8FA6602EF}"/>
          </ac:spMkLst>
        </pc:spChg>
        <pc:spChg chg="mod">
          <ac:chgData name="Luciana De Luca" userId="S::luciana.deluca@crob.it::bae8d283-e187-4b8e-966b-081af72c9cd4" providerId="AD" clId="Web-{0C538378-7B72-58E2-616B-349E9EAAF01C}" dt="2024-11-13T11:47:03.608" v="91" actId="20577"/>
          <ac:spMkLst>
            <pc:docMk/>
            <pc:sldMk cId="4156066348" sldId="263"/>
            <ac:spMk id="5" creationId="{579A38AE-37D6-05EF-9F03-DF4A31ACC761}"/>
          </ac:spMkLst>
        </pc:spChg>
      </pc:sldChg>
      <pc:sldChg chg="delSp modSp">
        <pc:chgData name="Luciana De Luca" userId="S::luciana.deluca@crob.it::bae8d283-e187-4b8e-966b-081af72c9cd4" providerId="AD" clId="Web-{0C538378-7B72-58E2-616B-349E9EAAF01C}" dt="2024-11-13T11:34:14.166" v="7" actId="20577"/>
        <pc:sldMkLst>
          <pc:docMk/>
          <pc:sldMk cId="2186378430" sldId="267"/>
        </pc:sldMkLst>
        <pc:spChg chg="mod">
          <ac:chgData name="Luciana De Luca" userId="S::luciana.deluca@crob.it::bae8d283-e187-4b8e-966b-081af72c9cd4" providerId="AD" clId="Web-{0C538378-7B72-58E2-616B-349E9EAAF01C}" dt="2024-11-13T11:34:14.166" v="7" actId="20577"/>
          <ac:spMkLst>
            <pc:docMk/>
            <pc:sldMk cId="2186378430" sldId="267"/>
            <ac:spMk id="3" creationId="{74FF4113-2BEA-C9E4-D8F8-05FD8346D6A6}"/>
          </ac:spMkLst>
        </pc:spChg>
        <pc:spChg chg="del">
          <ac:chgData name="Luciana De Luca" userId="S::luciana.deluca@crob.it::bae8d283-e187-4b8e-966b-081af72c9cd4" providerId="AD" clId="Web-{0C538378-7B72-58E2-616B-349E9EAAF01C}" dt="2024-11-13T11:33:08.664" v="4"/>
          <ac:spMkLst>
            <pc:docMk/>
            <pc:sldMk cId="2186378430" sldId="267"/>
            <ac:spMk id="4" creationId="{3A0595E7-1F95-EDFD-A53A-C2F1EE018F1B}"/>
          </ac:spMkLst>
        </pc:spChg>
      </pc:sldChg>
      <pc:sldChg chg="delSp modSp">
        <pc:chgData name="Luciana De Luca" userId="S::luciana.deluca@crob.it::bae8d283-e187-4b8e-966b-081af72c9cd4" providerId="AD" clId="Web-{0C538378-7B72-58E2-616B-349E9EAAF01C}" dt="2024-11-13T11:45:52.528" v="82" actId="20577"/>
        <pc:sldMkLst>
          <pc:docMk/>
          <pc:sldMk cId="220276941" sldId="269"/>
        </pc:sldMkLst>
        <pc:spChg chg="mod">
          <ac:chgData name="Luciana De Luca" userId="S::luciana.deluca@crob.it::bae8d283-e187-4b8e-966b-081af72c9cd4" providerId="AD" clId="Web-{0C538378-7B72-58E2-616B-349E9EAAF01C}" dt="2024-11-13T11:45:52.528" v="82" actId="20577"/>
          <ac:spMkLst>
            <pc:docMk/>
            <pc:sldMk cId="220276941" sldId="269"/>
            <ac:spMk id="2" creationId="{9D624420-34C3-E417-184E-F512597865AB}"/>
          </ac:spMkLst>
        </pc:spChg>
        <pc:spChg chg="del">
          <ac:chgData name="Luciana De Luca" userId="S::luciana.deluca@crob.it::bae8d283-e187-4b8e-966b-081af72c9cd4" providerId="AD" clId="Web-{0C538378-7B72-58E2-616B-349E9EAAF01C}" dt="2024-11-13T11:44:59.011" v="76"/>
          <ac:spMkLst>
            <pc:docMk/>
            <pc:sldMk cId="220276941" sldId="269"/>
            <ac:spMk id="6" creationId="{248E34C9-FF70-85AE-BBD4-7940C183F8C4}"/>
          </ac:spMkLst>
        </pc:spChg>
      </pc:sldChg>
      <pc:sldChg chg="delSp modSp">
        <pc:chgData name="Luciana De Luca" userId="S::luciana.deluca@crob.it::bae8d283-e187-4b8e-966b-081af72c9cd4" providerId="AD" clId="Web-{0C538378-7B72-58E2-616B-349E9EAAF01C}" dt="2024-11-13T11:46:47.592" v="87" actId="20577"/>
        <pc:sldMkLst>
          <pc:docMk/>
          <pc:sldMk cId="302162955" sldId="273"/>
        </pc:sldMkLst>
        <pc:spChg chg="mod">
          <ac:chgData name="Luciana De Luca" userId="S::luciana.deluca@crob.it::bae8d283-e187-4b8e-966b-081af72c9cd4" providerId="AD" clId="Web-{0C538378-7B72-58E2-616B-349E9EAAF01C}" dt="2024-11-13T11:46:47.592" v="87" actId="20577"/>
          <ac:spMkLst>
            <pc:docMk/>
            <pc:sldMk cId="302162955" sldId="273"/>
            <ac:spMk id="2" creationId="{14DA2553-C8D1-DD73-0966-0144DFF9F5F9}"/>
          </ac:spMkLst>
        </pc:spChg>
        <pc:spChg chg="del">
          <ac:chgData name="Luciana De Luca" userId="S::luciana.deluca@crob.it::bae8d283-e187-4b8e-966b-081af72c9cd4" providerId="AD" clId="Web-{0C538378-7B72-58E2-616B-349E9EAAF01C}" dt="2024-11-13T11:45:56.309" v="83"/>
          <ac:spMkLst>
            <pc:docMk/>
            <pc:sldMk cId="302162955" sldId="273"/>
            <ac:spMk id="5" creationId="{07CCE871-86F8-59B4-78CF-BAD355831141}"/>
          </ac:spMkLst>
        </pc:spChg>
      </pc:sldChg>
      <pc:sldChg chg="delSp modSp">
        <pc:chgData name="Luciana De Luca" userId="S::luciana.deluca@crob.it::bae8d283-e187-4b8e-966b-081af72c9cd4" providerId="AD" clId="Web-{0C538378-7B72-58E2-616B-349E9EAAF01C}" dt="2024-11-13T11:33:05.367" v="3" actId="20577"/>
        <pc:sldMkLst>
          <pc:docMk/>
          <pc:sldMk cId="2412630881" sldId="276"/>
        </pc:sldMkLst>
        <pc:spChg chg="del">
          <ac:chgData name="Luciana De Luca" userId="S::luciana.deluca@crob.it::bae8d283-e187-4b8e-966b-081af72c9cd4" providerId="AD" clId="Web-{0C538378-7B72-58E2-616B-349E9EAAF01C}" dt="2024-11-13T11:31:22.927" v="0"/>
          <ac:spMkLst>
            <pc:docMk/>
            <pc:sldMk cId="2412630881" sldId="276"/>
            <ac:spMk id="4" creationId="{C7B457B4-ABFB-7A5B-3CB7-7F2D3622C671}"/>
          </ac:spMkLst>
        </pc:spChg>
        <pc:spChg chg="mod">
          <ac:chgData name="Luciana De Luca" userId="S::luciana.deluca@crob.it::bae8d283-e187-4b8e-966b-081af72c9cd4" providerId="AD" clId="Web-{0C538378-7B72-58E2-616B-349E9EAAF01C}" dt="2024-11-13T11:33:05.367" v="3" actId="20577"/>
          <ac:spMkLst>
            <pc:docMk/>
            <pc:sldMk cId="2412630881" sldId="276"/>
            <ac:spMk id="5" creationId="{D8322C17-F6B7-AEC2-548B-5C567D71D36B}"/>
          </ac:spMkLst>
        </pc:spChg>
      </pc:sldChg>
      <pc:sldChg chg="delSp modSp">
        <pc:chgData name="Luciana De Luca" userId="S::luciana.deluca@crob.it::bae8d283-e187-4b8e-966b-081af72c9cd4" providerId="AD" clId="Web-{0C538378-7B72-58E2-616B-349E9EAAF01C}" dt="2024-11-13T11:39:06.424" v="64" actId="20577"/>
        <pc:sldMkLst>
          <pc:docMk/>
          <pc:sldMk cId="3623638635" sldId="278"/>
        </pc:sldMkLst>
        <pc:spChg chg="mod">
          <ac:chgData name="Luciana De Luca" userId="S::luciana.deluca@crob.it::bae8d283-e187-4b8e-966b-081af72c9cd4" providerId="AD" clId="Web-{0C538378-7B72-58E2-616B-349E9EAAF01C}" dt="2024-11-13T11:34:38.854" v="52" actId="1076"/>
          <ac:spMkLst>
            <pc:docMk/>
            <pc:sldMk cId="3623638635" sldId="278"/>
            <ac:spMk id="3" creationId="{032C79FA-F572-72CA-2346-F447ACA00F09}"/>
          </ac:spMkLst>
        </pc:spChg>
        <pc:spChg chg="mod">
          <ac:chgData name="Luciana De Luca" userId="S::luciana.deluca@crob.it::bae8d283-e187-4b8e-966b-081af72c9cd4" providerId="AD" clId="Web-{0C538378-7B72-58E2-616B-349E9EAAF01C}" dt="2024-11-13T11:34:38.870" v="53" actId="1076"/>
          <ac:spMkLst>
            <pc:docMk/>
            <pc:sldMk cId="3623638635" sldId="278"/>
            <ac:spMk id="4" creationId="{53595E63-5C54-5E29-B709-FCEF276E4532}"/>
          </ac:spMkLst>
        </pc:spChg>
        <pc:spChg chg="del">
          <ac:chgData name="Luciana De Luca" userId="S::luciana.deluca@crob.it::bae8d283-e187-4b8e-966b-081af72c9cd4" providerId="AD" clId="Web-{0C538378-7B72-58E2-616B-349E9EAAF01C}" dt="2024-11-13T11:34:17.338" v="8"/>
          <ac:spMkLst>
            <pc:docMk/>
            <pc:sldMk cId="3623638635" sldId="278"/>
            <ac:spMk id="5" creationId="{07CCE871-86F8-59B4-78CF-BAD355831141}"/>
          </ac:spMkLst>
        </pc:spChg>
        <pc:spChg chg="mod">
          <ac:chgData name="Luciana De Luca" userId="S::luciana.deluca@crob.it::bae8d283-e187-4b8e-966b-081af72c9cd4" providerId="AD" clId="Web-{0C538378-7B72-58E2-616B-349E9EAAF01C}" dt="2024-11-13T11:39:06.424" v="64" actId="20577"/>
          <ac:spMkLst>
            <pc:docMk/>
            <pc:sldMk cId="3623638635" sldId="278"/>
            <ac:spMk id="6" creationId="{4C2C216D-613B-A38D-B02B-1EF396AF8E74}"/>
          </ac:spMkLst>
        </pc:spChg>
        <pc:picChg chg="mod">
          <ac:chgData name="Luciana De Luca" userId="S::luciana.deluca@crob.it::bae8d283-e187-4b8e-966b-081af72c9cd4" providerId="AD" clId="Web-{0C538378-7B72-58E2-616B-349E9EAAF01C}" dt="2024-11-13T11:34:38.917" v="55" actId="1076"/>
          <ac:picMkLst>
            <pc:docMk/>
            <pc:sldMk cId="3623638635" sldId="278"/>
            <ac:picMk id="7" creationId="{E21987B3-477B-B9D7-EE7E-8B4A5B857F4B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557" v="35" actId="1076"/>
          <ac:picMkLst>
            <pc:docMk/>
            <pc:sldMk cId="3623638635" sldId="278"/>
            <ac:picMk id="8" creationId="{89CB2316-8ED9-3DA3-F379-9957AF970C43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573" v="36" actId="1076"/>
          <ac:picMkLst>
            <pc:docMk/>
            <pc:sldMk cId="3623638635" sldId="278"/>
            <ac:picMk id="9" creationId="{74F88B03-1EC0-5AB1-92E7-B1A236A13C0E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589" v="37" actId="1076"/>
          <ac:picMkLst>
            <pc:docMk/>
            <pc:sldMk cId="3623638635" sldId="278"/>
            <ac:picMk id="10" creationId="{30C7E740-7576-7A80-0090-289333DCD923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604" v="38" actId="1076"/>
          <ac:picMkLst>
            <pc:docMk/>
            <pc:sldMk cId="3623638635" sldId="278"/>
            <ac:picMk id="11" creationId="{76E50415-919B-550E-212B-1C2A04192796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620" v="39" actId="1076"/>
          <ac:picMkLst>
            <pc:docMk/>
            <pc:sldMk cId="3623638635" sldId="278"/>
            <ac:picMk id="12" creationId="{5F5B637A-2E6C-8ECB-9E5F-AD86E9F13A99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948" v="56" actId="1076"/>
          <ac:picMkLst>
            <pc:docMk/>
            <pc:sldMk cId="3623638635" sldId="278"/>
            <ac:picMk id="13" creationId="{ECA5C339-D8D1-6351-4DF7-92981A6E14EE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979" v="57" actId="1076"/>
          <ac:picMkLst>
            <pc:docMk/>
            <pc:sldMk cId="3623638635" sldId="278"/>
            <ac:picMk id="14" creationId="{3B7BEB9A-8E4D-C1F4-B3C1-05AC23579EF0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635" v="40" actId="1076"/>
          <ac:picMkLst>
            <pc:docMk/>
            <pc:sldMk cId="3623638635" sldId="278"/>
            <ac:picMk id="15" creationId="{06519645-8BD3-F02B-5D1F-A5C160FB13A5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651" v="41" actId="1076"/>
          <ac:picMkLst>
            <pc:docMk/>
            <pc:sldMk cId="3623638635" sldId="278"/>
            <ac:picMk id="16" creationId="{34D3EE78-F6E2-0FCB-7CA1-4B4DCD060709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667" v="42" actId="1076"/>
          <ac:picMkLst>
            <pc:docMk/>
            <pc:sldMk cId="3623638635" sldId="278"/>
            <ac:picMk id="17" creationId="{1B004F38-8660-D55C-B83B-3084199EF8F9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682" v="43" actId="1076"/>
          <ac:picMkLst>
            <pc:docMk/>
            <pc:sldMk cId="3623638635" sldId="278"/>
            <ac:picMk id="18" creationId="{CFE50A75-CFF7-0A1D-6D48-687D1AE30414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714" v="44" actId="1076"/>
          <ac:picMkLst>
            <pc:docMk/>
            <pc:sldMk cId="3623638635" sldId="278"/>
            <ac:picMk id="19" creationId="{B8A7CF89-55DC-2374-017A-981426D0069D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729" v="45" actId="1076"/>
          <ac:picMkLst>
            <pc:docMk/>
            <pc:sldMk cId="3623638635" sldId="278"/>
            <ac:picMk id="20" creationId="{68B907D0-E2EC-1CE0-551B-232FD89833D7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745" v="46" actId="1076"/>
          <ac:picMkLst>
            <pc:docMk/>
            <pc:sldMk cId="3623638635" sldId="278"/>
            <ac:picMk id="22" creationId="{D8752FED-5035-FEEA-C8A8-FBAA380F6AFE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760" v="47" actId="1076"/>
          <ac:picMkLst>
            <pc:docMk/>
            <pc:sldMk cId="3623638635" sldId="278"/>
            <ac:picMk id="23" creationId="{8162C6DA-2978-4084-0C71-5062B39F2211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776" v="48" actId="1076"/>
          <ac:picMkLst>
            <pc:docMk/>
            <pc:sldMk cId="3623638635" sldId="278"/>
            <ac:picMk id="24" creationId="{C6BCA9BC-80E1-3708-D838-95F821208025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807" v="49" actId="1076"/>
          <ac:picMkLst>
            <pc:docMk/>
            <pc:sldMk cId="3623638635" sldId="278"/>
            <ac:picMk id="25" creationId="{61089F04-884F-5C95-F742-FE3FD5686027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823" v="50" actId="1076"/>
          <ac:picMkLst>
            <pc:docMk/>
            <pc:sldMk cId="3623638635" sldId="278"/>
            <ac:picMk id="26" creationId="{A4AC95E8-A24D-7FB0-79FC-063B23C056B4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839" v="51" actId="1076"/>
          <ac:picMkLst>
            <pc:docMk/>
            <pc:sldMk cId="3623638635" sldId="278"/>
            <ac:picMk id="27" creationId="{0D3C626E-EB83-FB1B-54B4-8BBF621CD4EC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995" v="58" actId="1076"/>
          <ac:picMkLst>
            <pc:docMk/>
            <pc:sldMk cId="3623638635" sldId="278"/>
            <ac:picMk id="28" creationId="{820BD914-50A3-A76C-C67D-B2A51E20BE37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8.995" v="59" actId="1076"/>
          <ac:picMkLst>
            <pc:docMk/>
            <pc:sldMk cId="3623638635" sldId="278"/>
            <ac:picMk id="29" creationId="{0EC3F3D7-28DD-CED5-C97C-376B51034844}"/>
          </ac:picMkLst>
        </pc:picChg>
        <pc:picChg chg="mod">
          <ac:chgData name="Luciana De Luca" userId="S::luciana.deluca@crob.it::bae8d283-e187-4b8e-966b-081af72c9cd4" providerId="AD" clId="Web-{0C538378-7B72-58E2-616B-349E9EAAF01C}" dt="2024-11-13T11:34:39.010" v="60" actId="1076"/>
          <ac:picMkLst>
            <pc:docMk/>
            <pc:sldMk cId="3623638635" sldId="278"/>
            <ac:picMk id="30" creationId="{F92A34DD-7559-ED0C-4204-2EDA6016E029}"/>
          </ac:picMkLst>
        </pc:picChg>
      </pc:sldChg>
    </pc:docChg>
  </pc:docChgLst>
  <pc:docChgLst>
    <pc:chgData name="Ilaria Laurenzana" userId="S::ilaria.laurenzana@crob.it::d20e3a4c-5152-4781-9a82-e8e358f0fc6e" providerId="AD" clId="Web-{10AE761A-7465-1BDD-7F7D-0901F2E479C0}"/>
    <pc:docChg chg="delSld modSld">
      <pc:chgData name="Ilaria Laurenzana" userId="S::ilaria.laurenzana@crob.it::d20e3a4c-5152-4781-9a82-e8e358f0fc6e" providerId="AD" clId="Web-{10AE761A-7465-1BDD-7F7D-0901F2E479C0}" dt="2024-11-11T16:48:12.378" v="10"/>
      <pc:docMkLst>
        <pc:docMk/>
      </pc:docMkLst>
      <pc:sldChg chg="del">
        <pc:chgData name="Ilaria Laurenzana" userId="S::ilaria.laurenzana@crob.it::d20e3a4c-5152-4781-9a82-e8e358f0fc6e" providerId="AD" clId="Web-{10AE761A-7465-1BDD-7F7D-0901F2E479C0}" dt="2024-11-11T16:46:43.797" v="2"/>
        <pc:sldMkLst>
          <pc:docMk/>
          <pc:sldMk cId="3284960555" sldId="261"/>
        </pc:sldMkLst>
      </pc:sldChg>
      <pc:sldChg chg="delSp modSp">
        <pc:chgData name="Ilaria Laurenzana" userId="S::ilaria.laurenzana@crob.it::d20e3a4c-5152-4781-9a82-e8e358f0fc6e" providerId="AD" clId="Web-{10AE761A-7465-1BDD-7F7D-0901F2E479C0}" dt="2024-11-11T16:47:35.205" v="7"/>
        <pc:sldMkLst>
          <pc:docMk/>
          <pc:sldMk cId="3807340237" sldId="262"/>
        </pc:sldMkLst>
        <pc:spChg chg="del mod">
          <ac:chgData name="Ilaria Laurenzana" userId="S::ilaria.laurenzana@crob.it::d20e3a4c-5152-4781-9a82-e8e358f0fc6e" providerId="AD" clId="Web-{10AE761A-7465-1BDD-7F7D-0901F2E479C0}" dt="2024-11-11T16:47:35.205" v="7"/>
          <ac:spMkLst>
            <pc:docMk/>
            <pc:sldMk cId="3807340237" sldId="262"/>
            <ac:spMk id="19" creationId="{DBA5B6B7-AB2F-C940-C5A9-1BB010B7364E}"/>
          </ac:spMkLst>
        </pc:spChg>
      </pc:sldChg>
      <pc:sldChg chg="delSp">
        <pc:chgData name="Ilaria Laurenzana" userId="S::ilaria.laurenzana@crob.it::d20e3a4c-5152-4781-9a82-e8e358f0fc6e" providerId="AD" clId="Web-{10AE761A-7465-1BDD-7F7D-0901F2E479C0}" dt="2024-11-11T16:48:12.378" v="10"/>
        <pc:sldMkLst>
          <pc:docMk/>
          <pc:sldMk cId="4156066348" sldId="263"/>
        </pc:sldMkLst>
        <pc:spChg chg="del">
          <ac:chgData name="Ilaria Laurenzana" userId="S::ilaria.laurenzana@crob.it::d20e3a4c-5152-4781-9a82-e8e358f0fc6e" providerId="AD" clId="Web-{10AE761A-7465-1BDD-7F7D-0901F2E479C0}" dt="2024-11-11T16:48:12.378" v="10"/>
          <ac:spMkLst>
            <pc:docMk/>
            <pc:sldMk cId="4156066348" sldId="263"/>
            <ac:spMk id="31" creationId="{26C04195-E141-18E7-4588-845B4091EB4C}"/>
          </ac:spMkLst>
        </pc:spChg>
      </pc:sldChg>
      <pc:sldChg chg="del">
        <pc:chgData name="Ilaria Laurenzana" userId="S::ilaria.laurenzana@crob.it::d20e3a4c-5152-4781-9a82-e8e358f0fc6e" providerId="AD" clId="Web-{10AE761A-7465-1BDD-7F7D-0901F2E479C0}" dt="2024-11-11T16:46:31.796" v="0"/>
        <pc:sldMkLst>
          <pc:docMk/>
          <pc:sldMk cId="1785329976" sldId="266"/>
        </pc:sldMkLst>
      </pc:sldChg>
      <pc:sldChg chg="delSp">
        <pc:chgData name="Ilaria Laurenzana" userId="S::ilaria.laurenzana@crob.it::d20e3a4c-5152-4781-9a82-e8e358f0fc6e" providerId="AD" clId="Web-{10AE761A-7465-1BDD-7F7D-0901F2E479C0}" dt="2024-11-11T16:46:55.453" v="5"/>
        <pc:sldMkLst>
          <pc:docMk/>
          <pc:sldMk cId="2186378430" sldId="267"/>
        </pc:sldMkLst>
        <pc:spChg chg="del">
          <ac:chgData name="Ilaria Laurenzana" userId="S::ilaria.laurenzana@crob.it::d20e3a4c-5152-4781-9a82-e8e358f0fc6e" providerId="AD" clId="Web-{10AE761A-7465-1BDD-7F7D-0901F2E479C0}" dt="2024-11-11T16:46:55.453" v="5"/>
          <ac:spMkLst>
            <pc:docMk/>
            <pc:sldMk cId="2186378430" sldId="267"/>
            <ac:spMk id="5" creationId="{215DE3A2-58A0-0385-3298-EE5269C4B52F}"/>
          </ac:spMkLst>
        </pc:spChg>
      </pc:sldChg>
      <pc:sldChg chg="del">
        <pc:chgData name="Ilaria Laurenzana" userId="S::ilaria.laurenzana@crob.it::d20e3a4c-5152-4781-9a82-e8e358f0fc6e" providerId="AD" clId="Web-{10AE761A-7465-1BDD-7F7D-0901F2E479C0}" dt="2024-11-11T16:46:34.359" v="1"/>
        <pc:sldMkLst>
          <pc:docMk/>
          <pc:sldMk cId="3690092758" sldId="268"/>
        </pc:sldMkLst>
      </pc:sldChg>
      <pc:sldChg chg="delSp modSp">
        <pc:chgData name="Ilaria Laurenzana" userId="S::ilaria.laurenzana@crob.it::d20e3a4c-5152-4781-9a82-e8e358f0fc6e" providerId="AD" clId="Web-{10AE761A-7465-1BDD-7F7D-0901F2E479C0}" dt="2024-11-11T16:48:04.440" v="9"/>
        <pc:sldMkLst>
          <pc:docMk/>
          <pc:sldMk cId="220276941" sldId="269"/>
        </pc:sldMkLst>
        <pc:spChg chg="del mod">
          <ac:chgData name="Ilaria Laurenzana" userId="S::ilaria.laurenzana@crob.it::d20e3a4c-5152-4781-9a82-e8e358f0fc6e" providerId="AD" clId="Web-{10AE761A-7465-1BDD-7F7D-0901F2E479C0}" dt="2024-11-11T16:48:04.440" v="9"/>
          <ac:spMkLst>
            <pc:docMk/>
            <pc:sldMk cId="220276941" sldId="269"/>
            <ac:spMk id="27" creationId="{FDBCF8BA-1E3D-CCEC-390A-BA8910E7EDB4}"/>
          </ac:spMkLst>
        </pc:spChg>
      </pc:sldChg>
      <pc:sldChg chg="del">
        <pc:chgData name="Ilaria Laurenzana" userId="S::ilaria.laurenzana@crob.it::d20e3a4c-5152-4781-9a82-e8e358f0fc6e" providerId="AD" clId="Web-{10AE761A-7465-1BDD-7F7D-0901F2E479C0}" dt="2024-11-11T16:46:45.250" v="3"/>
        <pc:sldMkLst>
          <pc:docMk/>
          <pc:sldMk cId="3128085413" sldId="272"/>
        </pc:sldMkLst>
      </pc:sldChg>
      <pc:sldChg chg="del">
        <pc:chgData name="Ilaria Laurenzana" userId="S::ilaria.laurenzana@crob.it::d20e3a4c-5152-4781-9a82-e8e358f0fc6e" providerId="AD" clId="Web-{10AE761A-7465-1BDD-7F7D-0901F2E479C0}" dt="2024-11-11T16:46:46.359" v="4"/>
        <pc:sldMkLst>
          <pc:docMk/>
          <pc:sldMk cId="4252137472" sldId="279"/>
        </pc:sldMkLst>
      </pc:sldChg>
    </pc:docChg>
  </pc:docChgLst>
  <pc:docChgLst>
    <pc:chgData name="Ilaria Laurenzana" userId="d20e3a4c-5152-4781-9a82-e8e358f0fc6e" providerId="ADAL" clId="{F25154BB-24FE-45A5-ACC5-F4DE14291D12}"/>
    <pc:docChg chg="undo redo custSel addSld delSld modSld sldOrd">
      <pc:chgData name="Ilaria Laurenzana" userId="d20e3a4c-5152-4781-9a82-e8e358f0fc6e" providerId="ADAL" clId="{F25154BB-24FE-45A5-ACC5-F4DE14291D12}" dt="2024-09-25T07:35:33.723" v="7578" actId="478"/>
      <pc:docMkLst>
        <pc:docMk/>
      </pc:docMkLst>
      <pc:sldChg chg="addSp delSp modSp mod ord">
        <pc:chgData name="Ilaria Laurenzana" userId="d20e3a4c-5152-4781-9a82-e8e358f0fc6e" providerId="ADAL" clId="{F25154BB-24FE-45A5-ACC5-F4DE14291D12}" dt="2024-09-25T07:35:33.723" v="7578" actId="478"/>
        <pc:sldMkLst>
          <pc:docMk/>
          <pc:sldMk cId="425908882" sldId="258"/>
        </pc:sldMkLst>
        <pc:spChg chg="mod">
          <ac:chgData name="Ilaria Laurenzana" userId="d20e3a4c-5152-4781-9a82-e8e358f0fc6e" providerId="ADAL" clId="{F25154BB-24FE-45A5-ACC5-F4DE14291D12}" dt="2024-09-12T08:32:35.001" v="1768" actId="164"/>
          <ac:spMkLst>
            <pc:docMk/>
            <pc:sldMk cId="425908882" sldId="258"/>
            <ac:spMk id="2" creationId="{CD268E51-9996-4DE3-F593-19B487846C7F}"/>
          </ac:spMkLst>
        </pc:spChg>
        <pc:spChg chg="add mod">
          <ac:chgData name="Ilaria Laurenzana" userId="d20e3a4c-5152-4781-9a82-e8e358f0fc6e" providerId="ADAL" clId="{F25154BB-24FE-45A5-ACC5-F4DE14291D12}" dt="2024-09-23T07:41:13.079" v="7281" actId="554"/>
          <ac:spMkLst>
            <pc:docMk/>
            <pc:sldMk cId="425908882" sldId="258"/>
            <ac:spMk id="6" creationId="{A014E532-993D-4D50-66EF-21E53F4CC508}"/>
          </ac:spMkLst>
        </pc:spChg>
        <pc:spChg chg="add mod">
          <ac:chgData name="Ilaria Laurenzana" userId="d20e3a4c-5152-4781-9a82-e8e358f0fc6e" providerId="ADAL" clId="{F25154BB-24FE-45A5-ACC5-F4DE14291D12}" dt="2024-09-23T07:41:13.079" v="7281" actId="554"/>
          <ac:spMkLst>
            <pc:docMk/>
            <pc:sldMk cId="425908882" sldId="258"/>
            <ac:spMk id="7" creationId="{2ABFFD79-E47A-9B11-86A0-BC880C53D354}"/>
          </ac:spMkLst>
        </pc:spChg>
        <pc:spChg chg="add mod">
          <ac:chgData name="Ilaria Laurenzana" userId="d20e3a4c-5152-4781-9a82-e8e358f0fc6e" providerId="ADAL" clId="{F25154BB-24FE-45A5-ACC5-F4DE14291D12}" dt="2024-09-25T07:35:00.959" v="7559" actId="14100"/>
          <ac:spMkLst>
            <pc:docMk/>
            <pc:sldMk cId="425908882" sldId="258"/>
            <ac:spMk id="8" creationId="{DFBE8123-34EE-FBE2-E06E-39306643FBF4}"/>
          </ac:spMkLst>
        </pc:spChg>
        <pc:spChg chg="add mod">
          <ac:chgData name="Ilaria Laurenzana" userId="d20e3a4c-5152-4781-9a82-e8e358f0fc6e" providerId="ADAL" clId="{F25154BB-24FE-45A5-ACC5-F4DE14291D12}" dt="2024-09-25T07:18:20.163" v="7402" actId="20577"/>
          <ac:spMkLst>
            <pc:docMk/>
            <pc:sldMk cId="425908882" sldId="258"/>
            <ac:spMk id="11" creationId="{44541251-7F4C-C843-7145-0957D6C8003F}"/>
          </ac:spMkLst>
        </pc:spChg>
        <pc:spChg chg="add mod">
          <ac:chgData name="Ilaria Laurenzana" userId="d20e3a4c-5152-4781-9a82-e8e358f0fc6e" providerId="ADAL" clId="{F25154BB-24FE-45A5-ACC5-F4DE14291D12}" dt="2024-09-25T07:34:53.170" v="7556" actId="14100"/>
          <ac:spMkLst>
            <pc:docMk/>
            <pc:sldMk cId="425908882" sldId="258"/>
            <ac:spMk id="14" creationId="{03F1EF6C-57BC-7190-2D81-6DF6605A42A3}"/>
          </ac:spMkLst>
        </pc:spChg>
        <pc:spChg chg="add del mod">
          <ac:chgData name="Ilaria Laurenzana" userId="d20e3a4c-5152-4781-9a82-e8e358f0fc6e" providerId="ADAL" clId="{F25154BB-24FE-45A5-ACC5-F4DE14291D12}" dt="2024-09-25T07:33:40.580" v="7535" actId="478"/>
          <ac:spMkLst>
            <pc:docMk/>
            <pc:sldMk cId="425908882" sldId="258"/>
            <ac:spMk id="15" creationId="{0C5AF22F-7AD7-4E59-BDC1-08F6081E5FA5}"/>
          </ac:spMkLst>
        </pc:spChg>
        <pc:spChg chg="add del mod">
          <ac:chgData name="Ilaria Laurenzana" userId="d20e3a4c-5152-4781-9a82-e8e358f0fc6e" providerId="ADAL" clId="{F25154BB-24FE-45A5-ACC5-F4DE14291D12}" dt="2024-09-25T07:35:11.158" v="7561" actId="478"/>
          <ac:spMkLst>
            <pc:docMk/>
            <pc:sldMk cId="425908882" sldId="258"/>
            <ac:spMk id="18" creationId="{E8C248D2-E649-CB7B-FB1C-F55BF9A070EF}"/>
          </ac:spMkLst>
        </pc:spChg>
        <pc:spChg chg="add mod">
          <ac:chgData name="Ilaria Laurenzana" userId="d20e3a4c-5152-4781-9a82-e8e358f0fc6e" providerId="ADAL" clId="{F25154BB-24FE-45A5-ACC5-F4DE14291D12}" dt="2024-09-25T07:35:08.598" v="7560" actId="164"/>
          <ac:spMkLst>
            <pc:docMk/>
            <pc:sldMk cId="425908882" sldId="258"/>
            <ac:spMk id="19" creationId="{4006EEEB-AFC5-7279-086F-FF1914C1A2DC}"/>
          </ac:spMkLst>
        </pc:spChg>
        <pc:spChg chg="add del mod">
          <ac:chgData name="Ilaria Laurenzana" userId="d20e3a4c-5152-4781-9a82-e8e358f0fc6e" providerId="ADAL" clId="{F25154BB-24FE-45A5-ACC5-F4DE14291D12}" dt="2024-09-25T07:35:33.723" v="7578" actId="478"/>
          <ac:spMkLst>
            <pc:docMk/>
            <pc:sldMk cId="425908882" sldId="258"/>
            <ac:spMk id="21" creationId="{8120B4C7-8303-15F0-675C-AE6C2EB93582}"/>
          </ac:spMkLst>
        </pc:spChg>
        <pc:spChg chg="add mod">
          <ac:chgData name="Ilaria Laurenzana" userId="d20e3a4c-5152-4781-9a82-e8e358f0fc6e" providerId="ADAL" clId="{F25154BB-24FE-45A5-ACC5-F4DE14291D12}" dt="2024-09-25T07:35:30.585" v="7577" actId="164"/>
          <ac:spMkLst>
            <pc:docMk/>
            <pc:sldMk cId="425908882" sldId="258"/>
            <ac:spMk id="23" creationId="{3C000FD2-A5CF-861A-C1DD-67C3B89E8BDB}"/>
          </ac:spMkLst>
        </pc:spChg>
        <pc:grpChg chg="add mod">
          <ac:chgData name="Ilaria Laurenzana" userId="d20e3a4c-5152-4781-9a82-e8e358f0fc6e" providerId="ADAL" clId="{F25154BB-24FE-45A5-ACC5-F4DE14291D12}" dt="2024-09-24T06:52:46.757" v="7338" actId="14100"/>
          <ac:grpSpMkLst>
            <pc:docMk/>
            <pc:sldMk cId="425908882" sldId="258"/>
            <ac:grpSpMk id="3" creationId="{777E4697-9EB3-7E47-A92C-F617A1E978B8}"/>
          </ac:grpSpMkLst>
        </pc:grpChg>
        <pc:grpChg chg="add mod">
          <ac:chgData name="Ilaria Laurenzana" userId="d20e3a4c-5152-4781-9a82-e8e358f0fc6e" providerId="ADAL" clId="{F25154BB-24FE-45A5-ACC5-F4DE14291D12}" dt="2024-09-25T07:33:25.112" v="7521" actId="164"/>
          <ac:grpSpMkLst>
            <pc:docMk/>
            <pc:sldMk cId="425908882" sldId="258"/>
            <ac:grpSpMk id="12" creationId="{CADE8B2D-54A9-05F4-4915-51013D4062C2}"/>
          </ac:grpSpMkLst>
        </pc:grpChg>
        <pc:grpChg chg="add mod">
          <ac:chgData name="Ilaria Laurenzana" userId="d20e3a4c-5152-4781-9a82-e8e358f0fc6e" providerId="ADAL" clId="{F25154BB-24FE-45A5-ACC5-F4DE14291D12}" dt="2024-09-25T07:34:26.613" v="7539" actId="164"/>
          <ac:grpSpMkLst>
            <pc:docMk/>
            <pc:sldMk cId="425908882" sldId="258"/>
            <ac:grpSpMk id="16" creationId="{2594A7AC-793B-0E15-98C5-3008DCF2DC54}"/>
          </ac:grpSpMkLst>
        </pc:grpChg>
        <pc:grpChg chg="add mod">
          <ac:chgData name="Ilaria Laurenzana" userId="d20e3a4c-5152-4781-9a82-e8e358f0fc6e" providerId="ADAL" clId="{F25154BB-24FE-45A5-ACC5-F4DE14291D12}" dt="2024-09-25T07:35:08.598" v="7560" actId="164"/>
          <ac:grpSpMkLst>
            <pc:docMk/>
            <pc:sldMk cId="425908882" sldId="258"/>
            <ac:grpSpMk id="22" creationId="{34A315C1-3959-1590-5392-5753BB41A3E2}"/>
          </ac:grpSpMkLst>
        </pc:grpChg>
        <pc:grpChg chg="add mod">
          <ac:chgData name="Ilaria Laurenzana" userId="d20e3a4c-5152-4781-9a82-e8e358f0fc6e" providerId="ADAL" clId="{F25154BB-24FE-45A5-ACC5-F4DE14291D12}" dt="2024-09-25T07:35:30.585" v="7577" actId="164"/>
          <ac:grpSpMkLst>
            <pc:docMk/>
            <pc:sldMk cId="425908882" sldId="258"/>
            <ac:grpSpMk id="24" creationId="{068871EC-B7C0-AA29-95BD-7AFCB5EA0F09}"/>
          </ac:grpSpMkLst>
        </pc:grpChg>
        <pc:graphicFrameChg chg="mod">
          <ac:chgData name="Ilaria Laurenzana" userId="d20e3a4c-5152-4781-9a82-e8e358f0fc6e" providerId="ADAL" clId="{F25154BB-24FE-45A5-ACC5-F4DE14291D12}" dt="2024-09-23T07:40:56.097" v="7278" actId="1076"/>
          <ac:graphicFrameMkLst>
            <pc:docMk/>
            <pc:sldMk cId="425908882" sldId="258"/>
            <ac:graphicFrameMk id="5" creationId="{AABE7AA0-1E48-A4D6-0F0C-59711385FA10}"/>
          </ac:graphicFrameMkLst>
        </pc:graphicFrameChg>
        <pc:picChg chg="add mod">
          <ac:chgData name="Ilaria Laurenzana" userId="d20e3a4c-5152-4781-9a82-e8e358f0fc6e" providerId="ADAL" clId="{F25154BB-24FE-45A5-ACC5-F4DE14291D12}" dt="2024-09-24T06:53:35.118" v="7377" actId="14100"/>
          <ac:picMkLst>
            <pc:docMk/>
            <pc:sldMk cId="425908882" sldId="258"/>
            <ac:picMk id="9" creationId="{9D15BB14-5E57-16C7-FB40-1A47BFFCF7B1}"/>
          </ac:picMkLst>
        </pc:picChg>
        <pc:picChg chg="add mod">
          <ac:chgData name="Ilaria Laurenzana" userId="d20e3a4c-5152-4781-9a82-e8e358f0fc6e" providerId="ADAL" clId="{F25154BB-24FE-45A5-ACC5-F4DE14291D12}" dt="2024-09-25T07:33:25.112" v="7521" actId="164"/>
          <ac:picMkLst>
            <pc:docMk/>
            <pc:sldMk cId="425908882" sldId="258"/>
            <ac:picMk id="10" creationId="{CF6569BC-5CD9-AF69-869B-4740533C4BD8}"/>
          </ac:picMkLst>
        </pc:picChg>
        <pc:picChg chg="add mod">
          <ac:chgData name="Ilaria Laurenzana" userId="d20e3a4c-5152-4781-9a82-e8e358f0fc6e" providerId="ADAL" clId="{F25154BB-24FE-45A5-ACC5-F4DE14291D12}" dt="2024-09-25T07:34:26.613" v="7539" actId="164"/>
          <ac:picMkLst>
            <pc:docMk/>
            <pc:sldMk cId="425908882" sldId="258"/>
            <ac:picMk id="13" creationId="{E378ADC3-CF90-85B3-84CC-C6BAE410E9B8}"/>
          </ac:picMkLst>
        </pc:picChg>
        <pc:picChg chg="add mod">
          <ac:chgData name="Ilaria Laurenzana" userId="d20e3a4c-5152-4781-9a82-e8e358f0fc6e" providerId="ADAL" clId="{F25154BB-24FE-45A5-ACC5-F4DE14291D12}" dt="2024-09-25T07:35:08.598" v="7560" actId="164"/>
          <ac:picMkLst>
            <pc:docMk/>
            <pc:sldMk cId="425908882" sldId="258"/>
            <ac:picMk id="17" creationId="{9B72AB15-A3D0-2B00-0284-2163AF2524AC}"/>
          </ac:picMkLst>
        </pc:picChg>
        <pc:picChg chg="add mod">
          <ac:chgData name="Ilaria Laurenzana" userId="d20e3a4c-5152-4781-9a82-e8e358f0fc6e" providerId="ADAL" clId="{F25154BB-24FE-45A5-ACC5-F4DE14291D12}" dt="2024-09-25T07:35:30.585" v="7577" actId="164"/>
          <ac:picMkLst>
            <pc:docMk/>
            <pc:sldMk cId="425908882" sldId="258"/>
            <ac:picMk id="20" creationId="{370D60BB-8593-6657-D098-41D3BB8EDC5C}"/>
          </ac:picMkLst>
        </pc:picChg>
      </pc:sldChg>
      <pc:sldChg chg="addSp modSp mod ord">
        <pc:chgData name="Ilaria Laurenzana" userId="d20e3a4c-5152-4781-9a82-e8e358f0fc6e" providerId="ADAL" clId="{F25154BB-24FE-45A5-ACC5-F4DE14291D12}" dt="2024-09-23T08:31:44.903" v="7307" actId="20577"/>
        <pc:sldMkLst>
          <pc:docMk/>
          <pc:sldMk cId="3226044835" sldId="259"/>
        </pc:sldMkLst>
        <pc:spChg chg="add mod">
          <ac:chgData name="Ilaria Laurenzana" userId="d20e3a4c-5152-4781-9a82-e8e358f0fc6e" providerId="ADAL" clId="{F25154BB-24FE-45A5-ACC5-F4DE14291D12}" dt="2024-09-23T08:31:32.582" v="7304" actId="20577"/>
          <ac:spMkLst>
            <pc:docMk/>
            <pc:sldMk cId="3226044835" sldId="259"/>
            <ac:spMk id="2" creationId="{45ED1FF6-81DF-599C-E177-42FA8A0097E3}"/>
          </ac:spMkLst>
        </pc:spChg>
        <pc:spChg chg="add mod">
          <ac:chgData name="Ilaria Laurenzana" userId="d20e3a4c-5152-4781-9a82-e8e358f0fc6e" providerId="ADAL" clId="{F25154BB-24FE-45A5-ACC5-F4DE14291D12}" dt="2024-09-19T12:21:24.687" v="6453" actId="1037"/>
          <ac:spMkLst>
            <pc:docMk/>
            <pc:sldMk cId="3226044835" sldId="259"/>
            <ac:spMk id="3" creationId="{06A4C7AF-92F4-E21B-C317-DCAE75B23D4D}"/>
          </ac:spMkLst>
        </pc:spChg>
        <pc:spChg chg="mod">
          <ac:chgData name="Ilaria Laurenzana" userId="d20e3a4c-5152-4781-9a82-e8e358f0fc6e" providerId="ADAL" clId="{F25154BB-24FE-45A5-ACC5-F4DE14291D12}" dt="2024-09-23T08:31:44.903" v="7307" actId="20577"/>
          <ac:spMkLst>
            <pc:docMk/>
            <pc:sldMk cId="3226044835" sldId="259"/>
            <ac:spMk id="4" creationId="{DE32E2C9-A818-F7F3-5870-26E8FA6602EF}"/>
          </ac:spMkLst>
        </pc:spChg>
        <pc:spChg chg="add mod">
          <ac:chgData name="Ilaria Laurenzana" userId="d20e3a4c-5152-4781-9a82-e8e358f0fc6e" providerId="ADAL" clId="{F25154BB-24FE-45A5-ACC5-F4DE14291D12}" dt="2024-09-19T12:14:34.638" v="6333"/>
          <ac:spMkLst>
            <pc:docMk/>
            <pc:sldMk cId="3226044835" sldId="259"/>
            <ac:spMk id="6" creationId="{B71E9C9D-0486-4492-1C8E-B5181E56C5A2}"/>
          </ac:spMkLst>
        </pc:sp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5" creationId="{49C65AEB-CA5A-65B8-7F99-C1B8997A5FA3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19T12:21:15.397" v="6436" actId="14100"/>
          <ac:graphicFrameMkLst>
            <pc:docMk/>
            <pc:sldMk cId="3226044835" sldId="259"/>
            <ac:graphicFrameMk id="7" creationId="{2F6AD1B3-F2E6-87DE-FF6D-9C142CA524A4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16" creationId="{D9374029-72DB-5050-C761-4236F90B11A1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17" creationId="{32A32D1E-1710-83BF-FF49-D992E535ECC2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18" creationId="{AFAD40CC-1D80-3170-9E69-A5E7F7C4D89E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19" creationId="{3977DA2B-85DC-99E1-CB19-A7C1AB953550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20" creationId="{5C5D0E6C-6374-4F57-775E-86C3798EC4F8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21" creationId="{14A6DE69-92DD-0CA7-CE5F-A92346524C5F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22" creationId="{DF83BB9F-8CA0-B689-B0E8-1F931E98C869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23" creationId="{664DF3E2-EC51-555A-2F21-B2A4866DEE84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24" creationId="{1DD05725-BB1A-28C8-2A58-17B333EA225F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25" creationId="{CA1E2B7D-710A-8C8C-0F66-E8D2AC4C253E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21:45.397" v="6455" actId="1076"/>
          <ac:graphicFrameMkLst>
            <pc:docMk/>
            <pc:sldMk cId="3226044835" sldId="259"/>
            <ac:graphicFrameMk id="26" creationId="{D68CB885-5AA3-E5FA-334E-BBE155ADA01A}"/>
          </ac:graphicFrameMkLst>
        </pc:graphicFrameChg>
      </pc:sldChg>
      <pc:sldChg chg="addSp delSp modSp del mod ord">
        <pc:chgData name="Ilaria Laurenzana" userId="d20e3a4c-5152-4781-9a82-e8e358f0fc6e" providerId="ADAL" clId="{F25154BB-24FE-45A5-ACC5-F4DE14291D12}" dt="2024-09-09T12:04:52.799" v="360" actId="2696"/>
        <pc:sldMkLst>
          <pc:docMk/>
          <pc:sldMk cId="1922271378" sldId="260"/>
        </pc:sldMkLst>
        <pc:spChg chg="mod">
          <ac:chgData name="Ilaria Laurenzana" userId="d20e3a4c-5152-4781-9a82-e8e358f0fc6e" providerId="ADAL" clId="{F25154BB-24FE-45A5-ACC5-F4DE14291D12}" dt="2024-09-09T11:55:59.192" v="82"/>
          <ac:spMkLst>
            <pc:docMk/>
            <pc:sldMk cId="1922271378" sldId="260"/>
            <ac:spMk id="11" creationId="{9025F3CD-D898-A720-F165-5DCC0C1FB06F}"/>
          </ac:spMkLst>
        </pc:spChg>
        <pc:spChg chg="mod">
          <ac:chgData name="Ilaria Laurenzana" userId="d20e3a4c-5152-4781-9a82-e8e358f0fc6e" providerId="ADAL" clId="{F25154BB-24FE-45A5-ACC5-F4DE14291D12}" dt="2024-09-09T11:55:59.192" v="82"/>
          <ac:spMkLst>
            <pc:docMk/>
            <pc:sldMk cId="1922271378" sldId="260"/>
            <ac:spMk id="27" creationId="{5716313A-EFC2-7FE7-F539-CD5EFA6B8F5B}"/>
          </ac:spMkLst>
        </pc:spChg>
        <pc:grpChg chg="add mod">
          <ac:chgData name="Ilaria Laurenzana" userId="d20e3a4c-5152-4781-9a82-e8e358f0fc6e" providerId="ADAL" clId="{F25154BB-24FE-45A5-ACC5-F4DE14291D12}" dt="2024-09-09T11:55:59.192" v="82"/>
          <ac:grpSpMkLst>
            <pc:docMk/>
            <pc:sldMk cId="1922271378" sldId="260"/>
            <ac:grpSpMk id="5" creationId="{AA966C31-A0BA-5F7B-CA1B-F4BE00E4AFB0}"/>
          </ac:grpSpMkLst>
        </pc:grpChg>
        <pc:grpChg chg="mod">
          <ac:chgData name="Ilaria Laurenzana" userId="d20e3a4c-5152-4781-9a82-e8e358f0fc6e" providerId="ADAL" clId="{F25154BB-24FE-45A5-ACC5-F4DE14291D12}" dt="2024-09-09T11:55:59.192" v="82"/>
          <ac:grpSpMkLst>
            <pc:docMk/>
            <pc:sldMk cId="1922271378" sldId="260"/>
            <ac:grpSpMk id="9" creationId="{625ED6C7-A440-120F-4CBA-7BCC3A4C95A6}"/>
          </ac:grpSpMkLst>
        </pc:grpChg>
        <pc:grpChg chg="del">
          <ac:chgData name="Ilaria Laurenzana" userId="d20e3a4c-5152-4781-9a82-e8e358f0fc6e" providerId="ADAL" clId="{F25154BB-24FE-45A5-ACC5-F4DE14291D12}" dt="2024-09-09T11:54:54.309" v="69" actId="478"/>
          <ac:grpSpMkLst>
            <pc:docMk/>
            <pc:sldMk cId="1922271378" sldId="260"/>
            <ac:grpSpMk id="19" creationId="{C80E1454-4DC1-81A7-FC7D-A795E36A27AB}"/>
          </ac:grpSpMkLst>
        </pc:grpChg>
        <pc:grpChg chg="mod">
          <ac:chgData name="Ilaria Laurenzana" userId="d20e3a4c-5152-4781-9a82-e8e358f0fc6e" providerId="ADAL" clId="{F25154BB-24FE-45A5-ACC5-F4DE14291D12}" dt="2024-09-09T11:55:59.192" v="82"/>
          <ac:grpSpMkLst>
            <pc:docMk/>
            <pc:sldMk cId="1922271378" sldId="260"/>
            <ac:grpSpMk id="25" creationId="{EDE82270-41C7-B0C6-C210-61D6C7D079A3}"/>
          </ac:grpSpMkLst>
        </pc:grpChg>
        <pc:grpChg chg="del">
          <ac:chgData name="Ilaria Laurenzana" userId="d20e3a4c-5152-4781-9a82-e8e358f0fc6e" providerId="ADAL" clId="{F25154BB-24FE-45A5-ACC5-F4DE14291D12}" dt="2024-09-09T11:54:55.818" v="70" actId="478"/>
          <ac:grpSpMkLst>
            <pc:docMk/>
            <pc:sldMk cId="1922271378" sldId="260"/>
            <ac:grpSpMk id="29" creationId="{45FD1639-A18B-32C7-2ED6-F24DE2CCD896}"/>
          </ac:grpSpMkLst>
        </pc:grpChg>
        <pc:grpChg chg="del">
          <ac:chgData name="Ilaria Laurenzana" userId="d20e3a4c-5152-4781-9a82-e8e358f0fc6e" providerId="ADAL" clId="{F25154BB-24FE-45A5-ACC5-F4DE14291D12}" dt="2024-09-09T11:54:56.241" v="71" actId="478"/>
          <ac:grpSpMkLst>
            <pc:docMk/>
            <pc:sldMk cId="1922271378" sldId="260"/>
            <ac:grpSpMk id="31" creationId="{4444C674-3990-F682-172C-40263F63A4A6}"/>
          </ac:grpSpMkLst>
        </pc:grpChg>
        <pc:grpChg chg="del">
          <ac:chgData name="Ilaria Laurenzana" userId="d20e3a4c-5152-4781-9a82-e8e358f0fc6e" providerId="ADAL" clId="{F25154BB-24FE-45A5-ACC5-F4DE14291D12}" dt="2024-09-09T11:54:57.057" v="73" actId="478"/>
          <ac:grpSpMkLst>
            <pc:docMk/>
            <pc:sldMk cId="1922271378" sldId="260"/>
            <ac:grpSpMk id="33" creationId="{AEA545C4-CCCA-1C3A-F19B-11E302515794}"/>
          </ac:grpSpMkLst>
        </pc:grpChg>
        <pc:grpChg chg="del">
          <ac:chgData name="Ilaria Laurenzana" userId="d20e3a4c-5152-4781-9a82-e8e358f0fc6e" providerId="ADAL" clId="{F25154BB-24FE-45A5-ACC5-F4DE14291D12}" dt="2024-09-09T11:54:56.633" v="72" actId="478"/>
          <ac:grpSpMkLst>
            <pc:docMk/>
            <pc:sldMk cId="1922271378" sldId="260"/>
            <ac:grpSpMk id="35" creationId="{45B93939-55F7-0576-8156-E8852EF36183}"/>
          </ac:grpSpMkLst>
        </pc:grpChg>
        <pc:graphicFrameChg chg="mod">
          <ac:chgData name="Ilaria Laurenzana" userId="d20e3a4c-5152-4781-9a82-e8e358f0fc6e" providerId="ADAL" clId="{F25154BB-24FE-45A5-ACC5-F4DE14291D12}" dt="2024-09-09T11:55:59.192" v="82"/>
          <ac:graphicFrameMkLst>
            <pc:docMk/>
            <pc:sldMk cId="1922271378" sldId="260"/>
            <ac:graphicFrameMk id="24" creationId="{96138383-861A-7836-71D9-694AB97C78CC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1:55:59.192" v="82"/>
          <ac:graphicFrameMkLst>
            <pc:docMk/>
            <pc:sldMk cId="1922271378" sldId="260"/>
            <ac:graphicFrameMk id="26" creationId="{4A34C4B5-93A5-953A-BB3B-5AC0B6529446}"/>
          </ac:graphicFrameMkLst>
        </pc:graphicFrameChg>
      </pc:sldChg>
      <pc:sldChg chg="delSp modSp mod ord">
        <pc:chgData name="Ilaria Laurenzana" userId="d20e3a4c-5152-4781-9a82-e8e358f0fc6e" providerId="ADAL" clId="{F25154BB-24FE-45A5-ACC5-F4DE14291D12}" dt="2024-09-19T10:23:50.268" v="4820"/>
        <pc:sldMkLst>
          <pc:docMk/>
          <pc:sldMk cId="3284960555" sldId="261"/>
        </pc:sldMkLst>
        <pc:spChg chg="del">
          <ac:chgData name="Ilaria Laurenzana" userId="d20e3a4c-5152-4781-9a82-e8e358f0fc6e" providerId="ADAL" clId="{F25154BB-24FE-45A5-ACC5-F4DE14291D12}" dt="2024-09-09T12:03:38.013" v="359" actId="478"/>
          <ac:spMkLst>
            <pc:docMk/>
            <pc:sldMk cId="3284960555" sldId="261"/>
            <ac:spMk id="3" creationId="{BD3B80DC-D92C-463F-7776-6525BE028DE3}"/>
          </ac:spMkLst>
        </pc:spChg>
        <pc:spChg chg="mod">
          <ac:chgData name="Ilaria Laurenzana" userId="d20e3a4c-5152-4781-9a82-e8e358f0fc6e" providerId="ADAL" clId="{F25154BB-24FE-45A5-ACC5-F4DE14291D12}" dt="2024-09-12T10:53:18.079" v="2660" actId="20577"/>
          <ac:spMkLst>
            <pc:docMk/>
            <pc:sldMk cId="3284960555" sldId="261"/>
            <ac:spMk id="4" creationId="{DE32E2C9-A818-F7F3-5870-26E8FA6602EF}"/>
          </ac:spMkLst>
        </pc:spChg>
        <pc:spChg chg="mod">
          <ac:chgData name="Ilaria Laurenzana" userId="d20e3a4c-5152-4781-9a82-e8e358f0fc6e" providerId="ADAL" clId="{F25154BB-24FE-45A5-ACC5-F4DE14291D12}" dt="2024-09-12T12:41:23.239" v="2679" actId="6549"/>
          <ac:spMkLst>
            <pc:docMk/>
            <pc:sldMk cId="3284960555" sldId="261"/>
            <ac:spMk id="16" creationId="{1F799A3C-9431-7F62-E09B-021457EFE554}"/>
          </ac:spMkLst>
        </pc:spChg>
        <pc:spChg chg="mod">
          <ac:chgData name="Ilaria Laurenzana" userId="d20e3a4c-5152-4781-9a82-e8e358f0fc6e" providerId="ADAL" clId="{F25154BB-24FE-45A5-ACC5-F4DE14291D12}" dt="2024-09-12T12:41:21.780" v="2678" actId="6549"/>
          <ac:spMkLst>
            <pc:docMk/>
            <pc:sldMk cId="3284960555" sldId="261"/>
            <ac:spMk id="17" creationId="{389499A4-85D9-960C-2419-2FC61BCCA929}"/>
          </ac:spMkLst>
        </pc:spChg>
        <pc:spChg chg="mod">
          <ac:chgData name="Ilaria Laurenzana" userId="d20e3a4c-5152-4781-9a82-e8e358f0fc6e" providerId="ADAL" clId="{F25154BB-24FE-45A5-ACC5-F4DE14291D12}" dt="2024-09-09T12:02:06.580" v="340" actId="1076"/>
          <ac:spMkLst>
            <pc:docMk/>
            <pc:sldMk cId="3284960555" sldId="261"/>
            <ac:spMk id="37" creationId="{21C35AE3-DE69-7185-016D-CD74DE190266}"/>
          </ac:spMkLst>
        </pc:spChg>
        <pc:spChg chg="mod">
          <ac:chgData name="Ilaria Laurenzana" userId="d20e3a4c-5152-4781-9a82-e8e358f0fc6e" providerId="ADAL" clId="{F25154BB-24FE-45A5-ACC5-F4DE14291D12}" dt="2024-09-10T07:13:19.073" v="879" actId="1035"/>
          <ac:spMkLst>
            <pc:docMk/>
            <pc:sldMk cId="3284960555" sldId="261"/>
            <ac:spMk id="49" creationId="{C3FC796C-397F-EF39-E1CA-8F533D9140F1}"/>
          </ac:spMkLst>
        </pc:spChg>
        <pc:spChg chg="mod">
          <ac:chgData name="Ilaria Laurenzana" userId="d20e3a4c-5152-4781-9a82-e8e358f0fc6e" providerId="ADAL" clId="{F25154BB-24FE-45A5-ACC5-F4DE14291D12}" dt="2024-09-17T11:01:28.751" v="3698" actId="1036"/>
          <ac:spMkLst>
            <pc:docMk/>
            <pc:sldMk cId="3284960555" sldId="261"/>
            <ac:spMk id="52" creationId="{31A38C9E-CF95-81B2-C54A-40965811C94B}"/>
          </ac:spMkLst>
        </pc:spChg>
        <pc:grpChg chg="mod">
          <ac:chgData name="Ilaria Laurenzana" userId="d20e3a4c-5152-4781-9a82-e8e358f0fc6e" providerId="ADAL" clId="{F25154BB-24FE-45A5-ACC5-F4DE14291D12}" dt="2024-09-09T12:07:44.056" v="402" actId="1076"/>
          <ac:grpSpMkLst>
            <pc:docMk/>
            <pc:sldMk cId="3284960555" sldId="261"/>
            <ac:grpSpMk id="57" creationId="{91192EC7-7C29-70E5-9DAF-9647F27DEA93}"/>
          </ac:grpSpMkLst>
        </pc:grpChg>
        <pc:grpChg chg="del">
          <ac:chgData name="Ilaria Laurenzana" userId="d20e3a4c-5152-4781-9a82-e8e358f0fc6e" providerId="ADAL" clId="{F25154BB-24FE-45A5-ACC5-F4DE14291D12}" dt="2024-09-09T12:02:26.903" v="341" actId="21"/>
          <ac:grpSpMkLst>
            <pc:docMk/>
            <pc:sldMk cId="3284960555" sldId="261"/>
            <ac:grpSpMk id="59" creationId="{0386616D-50C4-DD43-5CC0-47E3B2457D48}"/>
          </ac:grpSpMkLst>
        </pc:grpChg>
        <pc:grpChg chg="del">
          <ac:chgData name="Ilaria Laurenzana" userId="d20e3a4c-5152-4781-9a82-e8e358f0fc6e" providerId="ADAL" clId="{F25154BB-24FE-45A5-ACC5-F4DE14291D12}" dt="2024-09-09T12:03:36.476" v="357" actId="478"/>
          <ac:grpSpMkLst>
            <pc:docMk/>
            <pc:sldMk cId="3284960555" sldId="261"/>
            <ac:grpSpMk id="60" creationId="{8B84D659-CA7C-2CB4-031C-1DD288C3BEEE}"/>
          </ac:grpSpMkLst>
        </pc:grpChg>
        <pc:grpChg chg="mod">
          <ac:chgData name="Ilaria Laurenzana" userId="d20e3a4c-5152-4781-9a82-e8e358f0fc6e" providerId="ADAL" clId="{F25154BB-24FE-45A5-ACC5-F4DE14291D12}" dt="2024-09-09T12:03:31.356" v="355" actId="1076"/>
          <ac:grpSpMkLst>
            <pc:docMk/>
            <pc:sldMk cId="3284960555" sldId="261"/>
            <ac:grpSpMk id="61" creationId="{F92BC0C0-6F6A-3C42-458E-58DB59DEB05C}"/>
          </ac:grpSpMkLst>
        </pc:grpChg>
        <pc:grpChg chg="mod">
          <ac:chgData name="Ilaria Laurenzana" userId="d20e3a4c-5152-4781-9a82-e8e358f0fc6e" providerId="ADAL" clId="{F25154BB-24FE-45A5-ACC5-F4DE14291D12}" dt="2024-09-09T12:03:35.221" v="356" actId="1076"/>
          <ac:grpSpMkLst>
            <pc:docMk/>
            <pc:sldMk cId="3284960555" sldId="261"/>
            <ac:grpSpMk id="62" creationId="{C3B0D3B5-C810-BF05-C7AB-1943B7744115}"/>
          </ac:grpSpMkLst>
        </pc:grpChg>
        <pc:grpChg chg="del">
          <ac:chgData name="Ilaria Laurenzana" userId="d20e3a4c-5152-4781-9a82-e8e358f0fc6e" providerId="ADAL" clId="{F25154BB-24FE-45A5-ACC5-F4DE14291D12}" dt="2024-09-09T12:03:36.947" v="358" actId="478"/>
          <ac:grpSpMkLst>
            <pc:docMk/>
            <pc:sldMk cId="3284960555" sldId="261"/>
            <ac:grpSpMk id="63" creationId="{8D0B3587-3B78-909C-18C0-26A06C332C5D}"/>
          </ac:grpSpMkLst>
        </pc:grpChg>
      </pc:sldChg>
      <pc:sldChg chg="addSp delSp modSp mod ord modClrScheme chgLayout">
        <pc:chgData name="Ilaria Laurenzana" userId="d20e3a4c-5152-4781-9a82-e8e358f0fc6e" providerId="ADAL" clId="{F25154BB-24FE-45A5-ACC5-F4DE14291D12}" dt="2024-09-23T08:55:43.679" v="7313" actId="20577"/>
        <pc:sldMkLst>
          <pc:docMk/>
          <pc:sldMk cId="3807340237" sldId="262"/>
        </pc:sldMkLst>
        <pc:spChg chg="mod">
          <ac:chgData name="Ilaria Laurenzana" userId="d20e3a4c-5152-4781-9a82-e8e358f0fc6e" providerId="ADAL" clId="{F25154BB-24FE-45A5-ACC5-F4DE14291D12}" dt="2024-09-23T08:55:30.682" v="7310" actId="20577"/>
          <ac:spMkLst>
            <pc:docMk/>
            <pc:sldMk cId="3807340237" sldId="262"/>
            <ac:spMk id="4" creationId="{DE32E2C9-A818-F7F3-5870-26E8FA6602EF}"/>
          </ac:spMkLst>
        </pc:spChg>
        <pc:spChg chg="add mod">
          <ac:chgData name="Ilaria Laurenzana" userId="d20e3a4c-5152-4781-9a82-e8e358f0fc6e" providerId="ADAL" clId="{F25154BB-24FE-45A5-ACC5-F4DE14291D12}" dt="2024-09-23T08:55:43.679" v="7313" actId="20577"/>
          <ac:spMkLst>
            <pc:docMk/>
            <pc:sldMk cId="3807340237" sldId="262"/>
            <ac:spMk id="5" creationId="{A03200F7-95D6-2B5B-32DE-BBC23B80256E}"/>
          </ac:spMkLst>
        </pc:spChg>
        <pc:spChg chg="del mod topLvl">
          <ac:chgData name="Ilaria Laurenzana" userId="d20e3a4c-5152-4781-9a82-e8e358f0fc6e" providerId="ADAL" clId="{F25154BB-24FE-45A5-ACC5-F4DE14291D12}" dt="2024-09-09T11:53:29.846" v="29" actId="478"/>
          <ac:spMkLst>
            <pc:docMk/>
            <pc:sldMk cId="3807340237" sldId="262"/>
            <ac:spMk id="13" creationId="{107DB49A-D7B9-6336-B44D-53015ADBC3D1}"/>
          </ac:spMkLst>
        </pc:spChg>
        <pc:spChg chg="add mod">
          <ac:chgData name="Ilaria Laurenzana" userId="d20e3a4c-5152-4781-9a82-e8e358f0fc6e" providerId="ADAL" clId="{F25154BB-24FE-45A5-ACC5-F4DE14291D12}" dt="2024-09-19T12:30:20.007" v="6610"/>
          <ac:spMkLst>
            <pc:docMk/>
            <pc:sldMk cId="3807340237" sldId="262"/>
            <ac:spMk id="13" creationId="{99DF8BE5-A182-6215-FED9-20BA700592B5}"/>
          </ac:spMkLst>
        </pc:spChg>
        <pc:spChg chg="add mod">
          <ac:chgData name="Ilaria Laurenzana" userId="d20e3a4c-5152-4781-9a82-e8e358f0fc6e" providerId="ADAL" clId="{F25154BB-24FE-45A5-ACC5-F4DE14291D12}" dt="2024-09-19T12:30:20.007" v="6610"/>
          <ac:spMkLst>
            <pc:docMk/>
            <pc:sldMk cId="3807340237" sldId="262"/>
            <ac:spMk id="18" creationId="{3EFD1BF0-4DCE-A352-81FC-5472A797366D}"/>
          </ac:spMkLst>
        </pc:spChg>
        <pc:spChg chg="del mod topLvl">
          <ac:chgData name="Ilaria Laurenzana" userId="d20e3a4c-5152-4781-9a82-e8e358f0fc6e" providerId="ADAL" clId="{F25154BB-24FE-45A5-ACC5-F4DE14291D12}" dt="2024-09-09T11:52:50.426" v="12" actId="478"/>
          <ac:spMkLst>
            <pc:docMk/>
            <pc:sldMk cId="3807340237" sldId="262"/>
            <ac:spMk id="18" creationId="{DB65719F-21A7-2CBA-D4A4-892F43A2441F}"/>
          </ac:spMkLst>
        </pc:spChg>
        <pc:spChg chg="mod">
          <ac:chgData name="Ilaria Laurenzana" userId="d20e3a4c-5152-4781-9a82-e8e358f0fc6e" providerId="ADAL" clId="{F25154BB-24FE-45A5-ACC5-F4DE14291D12}" dt="2024-09-19T12:24:46.493" v="6554" actId="1076"/>
          <ac:spMkLst>
            <pc:docMk/>
            <pc:sldMk cId="3807340237" sldId="262"/>
            <ac:spMk id="19" creationId="{DBA5B6B7-AB2F-C940-C5A9-1BB010B7364E}"/>
          </ac:spMkLst>
        </pc:spChg>
        <pc:spChg chg="del mod topLvl">
          <ac:chgData name="Ilaria Laurenzana" userId="d20e3a4c-5152-4781-9a82-e8e358f0fc6e" providerId="ADAL" clId="{F25154BB-24FE-45A5-ACC5-F4DE14291D12}" dt="2024-09-09T11:53:15.093" v="21" actId="478"/>
          <ac:spMkLst>
            <pc:docMk/>
            <pc:sldMk cId="3807340237" sldId="262"/>
            <ac:spMk id="20" creationId="{85644D68-5C59-6093-C855-D6DC42BD63CB}"/>
          </ac:spMkLst>
        </pc:spChg>
        <pc:spChg chg="del mod topLvl">
          <ac:chgData name="Ilaria Laurenzana" userId="d20e3a4c-5152-4781-9a82-e8e358f0fc6e" providerId="ADAL" clId="{F25154BB-24FE-45A5-ACC5-F4DE14291D12}" dt="2024-09-09T11:53:15.799" v="22" actId="478"/>
          <ac:spMkLst>
            <pc:docMk/>
            <pc:sldMk cId="3807340237" sldId="262"/>
            <ac:spMk id="21" creationId="{5339F16C-EF28-F42B-4C63-0B378323379D}"/>
          </ac:spMkLst>
        </pc:spChg>
        <pc:spChg chg="del mod topLvl">
          <ac:chgData name="Ilaria Laurenzana" userId="d20e3a4c-5152-4781-9a82-e8e358f0fc6e" providerId="ADAL" clId="{F25154BB-24FE-45A5-ACC5-F4DE14291D12}" dt="2024-09-09T11:53:25.923" v="27" actId="478"/>
          <ac:spMkLst>
            <pc:docMk/>
            <pc:sldMk cId="3807340237" sldId="262"/>
            <ac:spMk id="22" creationId="{B054FD14-4519-B11F-C7E2-9C8695A7F893}"/>
          </ac:spMkLst>
        </pc:spChg>
        <pc:spChg chg="add del mod ord">
          <ac:chgData name="Ilaria Laurenzana" userId="d20e3a4c-5152-4781-9a82-e8e358f0fc6e" providerId="ADAL" clId="{F25154BB-24FE-45A5-ACC5-F4DE14291D12}" dt="2024-09-09T11:52:07.434" v="7" actId="700"/>
          <ac:spMkLst>
            <pc:docMk/>
            <pc:sldMk cId="3807340237" sldId="262"/>
            <ac:spMk id="23" creationId="{9C18BB7D-3AE7-CB19-035A-8D700F4E9AB8}"/>
          </ac:spMkLst>
        </pc:spChg>
        <pc:spChg chg="add del mod ord">
          <ac:chgData name="Ilaria Laurenzana" userId="d20e3a4c-5152-4781-9a82-e8e358f0fc6e" providerId="ADAL" clId="{F25154BB-24FE-45A5-ACC5-F4DE14291D12}" dt="2024-09-09T11:52:07.434" v="7" actId="700"/>
          <ac:spMkLst>
            <pc:docMk/>
            <pc:sldMk cId="3807340237" sldId="262"/>
            <ac:spMk id="24" creationId="{579F0CD5-6DAE-09D9-9D9F-97A019492DB8}"/>
          </ac:spMkLst>
        </pc:spChg>
        <pc:grpChg chg="add del mod">
          <ac:chgData name="Ilaria Laurenzana" userId="d20e3a4c-5152-4781-9a82-e8e358f0fc6e" providerId="ADAL" clId="{F25154BB-24FE-45A5-ACC5-F4DE14291D12}" dt="2024-09-09T11:52:12.566" v="8" actId="165"/>
          <ac:grpSpMkLst>
            <pc:docMk/>
            <pc:sldMk cId="3807340237" sldId="262"/>
            <ac:grpSpMk id="5" creationId="{69774448-5C1F-50E3-1497-6E4538CA3403}"/>
          </ac:grpSpMkLst>
        </pc:grpChg>
        <pc:grpChg chg="del mod topLvl">
          <ac:chgData name="Ilaria Laurenzana" userId="d20e3a4c-5152-4781-9a82-e8e358f0fc6e" providerId="ADAL" clId="{F25154BB-24FE-45A5-ACC5-F4DE14291D12}" dt="2024-09-09T11:52:20.482" v="9" actId="165"/>
          <ac:grpSpMkLst>
            <pc:docMk/>
            <pc:sldMk cId="3807340237" sldId="262"/>
            <ac:grpSpMk id="12" creationId="{1EC6F7BC-ED7A-1BE8-562A-7F65FF3FEDB8}"/>
          </ac:grpSpMkLst>
        </pc:grpChg>
        <pc:graphicFrameChg chg="mod">
          <ac:chgData name="Ilaria Laurenzana" userId="d20e3a4c-5152-4781-9a82-e8e358f0fc6e" providerId="ADAL" clId="{F25154BB-24FE-45A5-ACC5-F4DE14291D12}" dt="2024-09-19T12:30:29.953" v="6624" actId="1036"/>
          <ac:graphicFrameMkLst>
            <pc:docMk/>
            <pc:sldMk cId="3807340237" sldId="262"/>
            <ac:graphicFrameMk id="2" creationId="{40E1CE83-F5A8-C10D-EE2F-3ADABEE7E8D6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30:29.953" v="6624" actId="1036"/>
          <ac:graphicFrameMkLst>
            <pc:docMk/>
            <pc:sldMk cId="3807340237" sldId="262"/>
            <ac:graphicFrameMk id="3" creationId="{A5EA9854-5B0E-730A-7803-C27B03C11F9D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30:29.953" v="6624" actId="1036"/>
          <ac:graphicFrameMkLst>
            <pc:docMk/>
            <pc:sldMk cId="3807340237" sldId="262"/>
            <ac:graphicFrameMk id="6" creationId="{B2455BC1-E312-D5EA-2CF8-ABDF3A3E32F3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36:23.623" v="6797" actId="1036"/>
          <ac:graphicFrameMkLst>
            <pc:docMk/>
            <pc:sldMk cId="3807340237" sldId="262"/>
            <ac:graphicFrameMk id="7" creationId="{19CA2CFC-51DE-59F1-14A8-1763A48DE782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36:23.623" v="6797" actId="1036"/>
          <ac:graphicFrameMkLst>
            <pc:docMk/>
            <pc:sldMk cId="3807340237" sldId="262"/>
            <ac:graphicFrameMk id="8" creationId="{D75E5927-271B-EBE3-1061-31A28E4B7C82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36:23.623" v="6797" actId="1036"/>
          <ac:graphicFrameMkLst>
            <pc:docMk/>
            <pc:sldMk cId="3807340237" sldId="262"/>
            <ac:graphicFrameMk id="9" creationId="{4E555D9E-3ED1-A954-02D0-85B47C5C601F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36:23.623" v="6797" actId="1036"/>
          <ac:graphicFrameMkLst>
            <pc:docMk/>
            <pc:sldMk cId="3807340237" sldId="262"/>
            <ac:graphicFrameMk id="10" creationId="{35018769-3148-ADE5-37E5-15D6D0E31263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2:30:29.953" v="6624" actId="1036"/>
          <ac:graphicFrameMkLst>
            <pc:docMk/>
            <pc:sldMk cId="3807340237" sldId="262"/>
            <ac:graphicFrameMk id="11" creationId="{498E299F-17BA-FDA0-4A39-3CFC8B3EFAB7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19T12:30:24.016" v="6618" actId="1035"/>
          <ac:graphicFrameMkLst>
            <pc:docMk/>
            <pc:sldMk cId="3807340237" sldId="262"/>
            <ac:graphicFrameMk id="12" creationId="{DDD5355E-D20A-0BEF-0C72-540CF32CA6D8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9T12:36:23.623" v="6797" actId="1036"/>
          <ac:graphicFrameMkLst>
            <pc:docMk/>
            <pc:sldMk cId="3807340237" sldId="262"/>
            <ac:graphicFrameMk id="14" creationId="{DD305292-C524-5545-9C24-71EF21D3C8C3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9T12:36:23.623" v="6797" actId="1036"/>
          <ac:graphicFrameMkLst>
            <pc:docMk/>
            <pc:sldMk cId="3807340237" sldId="262"/>
            <ac:graphicFrameMk id="15" creationId="{830E2FB2-CEB2-14AB-F0CC-BB255E989E01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9T12:36:23.623" v="6797" actId="1036"/>
          <ac:graphicFrameMkLst>
            <pc:docMk/>
            <pc:sldMk cId="3807340237" sldId="262"/>
            <ac:graphicFrameMk id="16" creationId="{7D133F4A-9CD6-8CC8-7016-AE9864884DB5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9T12:36:23.623" v="6797" actId="1036"/>
          <ac:graphicFrameMkLst>
            <pc:docMk/>
            <pc:sldMk cId="3807340237" sldId="262"/>
            <ac:graphicFrameMk id="17" creationId="{A74E0F31-8289-4A9F-6760-CD0F163ACC1F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1:53:54.652" v="34" actId="571"/>
          <ac:graphicFrameMkLst>
            <pc:docMk/>
            <pc:sldMk cId="3807340237" sldId="262"/>
            <ac:graphicFrameMk id="25" creationId="{E1B426FF-60F9-8666-CE26-DB5FDB49929B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1:53:54.652" v="34" actId="571"/>
          <ac:graphicFrameMkLst>
            <pc:docMk/>
            <pc:sldMk cId="3807340237" sldId="262"/>
            <ac:graphicFrameMk id="26" creationId="{EB42108D-63E5-DDFA-1CFB-C74D7BD57080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1:53:54.652" v="34" actId="571"/>
          <ac:graphicFrameMkLst>
            <pc:docMk/>
            <pc:sldMk cId="3807340237" sldId="262"/>
            <ac:graphicFrameMk id="27" creationId="{DF26F04C-9CC2-5D79-70BE-B492BB582136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1:53:57.398" v="36" actId="571"/>
          <ac:graphicFrameMkLst>
            <pc:docMk/>
            <pc:sldMk cId="3807340237" sldId="262"/>
            <ac:graphicFrameMk id="28" creationId="{81B3C9C5-0704-5D20-ADBC-27EFB9B17EEB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1:53:57.398" v="36" actId="571"/>
          <ac:graphicFrameMkLst>
            <pc:docMk/>
            <pc:sldMk cId="3807340237" sldId="262"/>
            <ac:graphicFrameMk id="29" creationId="{F63051B9-9C59-4979-ADB0-ED2B2F2670E0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1:53:57.398" v="36" actId="571"/>
          <ac:graphicFrameMkLst>
            <pc:docMk/>
            <pc:sldMk cId="3807340237" sldId="262"/>
            <ac:graphicFrameMk id="30" creationId="{052A60CA-F695-0FB4-B456-E5A049489C6E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1:53:57.398" v="36" actId="571"/>
          <ac:graphicFrameMkLst>
            <pc:docMk/>
            <pc:sldMk cId="3807340237" sldId="262"/>
            <ac:graphicFrameMk id="31" creationId="{916B95C5-A1B1-3DB5-BC8F-7531ED3C55FD}"/>
          </ac:graphicFrameMkLst>
        </pc:graphicFrameChg>
      </pc:sldChg>
      <pc:sldChg chg="addSp delSp modSp mod">
        <pc:chgData name="Ilaria Laurenzana" userId="d20e3a4c-5152-4781-9a82-e8e358f0fc6e" providerId="ADAL" clId="{F25154BB-24FE-45A5-ACC5-F4DE14291D12}" dt="2024-09-23T08:56:18.014" v="7331" actId="20577"/>
        <pc:sldMkLst>
          <pc:docMk/>
          <pc:sldMk cId="4156066348" sldId="263"/>
        </pc:sldMkLst>
        <pc:spChg chg="mod">
          <ac:chgData name="Ilaria Laurenzana" userId="d20e3a4c-5152-4781-9a82-e8e358f0fc6e" providerId="ADAL" clId="{F25154BB-24FE-45A5-ACC5-F4DE14291D12}" dt="2024-09-23T08:56:12.831" v="7328" actId="20577"/>
          <ac:spMkLst>
            <pc:docMk/>
            <pc:sldMk cId="4156066348" sldId="263"/>
            <ac:spMk id="4" creationId="{DE32E2C9-A818-F7F3-5870-26E8FA6602EF}"/>
          </ac:spMkLst>
        </pc:spChg>
        <pc:spChg chg="add mod">
          <ac:chgData name="Ilaria Laurenzana" userId="d20e3a4c-5152-4781-9a82-e8e358f0fc6e" providerId="ADAL" clId="{F25154BB-24FE-45A5-ACC5-F4DE14291D12}" dt="2024-09-23T08:56:18.014" v="7331" actId="20577"/>
          <ac:spMkLst>
            <pc:docMk/>
            <pc:sldMk cId="4156066348" sldId="263"/>
            <ac:spMk id="5" creationId="{579A38AE-37D6-05EF-9F03-DF4A31ACC761}"/>
          </ac:spMkLst>
        </pc:spChg>
        <pc:spChg chg="del mod topLvl">
          <ac:chgData name="Ilaria Laurenzana" userId="d20e3a4c-5152-4781-9a82-e8e358f0fc6e" providerId="ADAL" clId="{F25154BB-24FE-45A5-ACC5-F4DE14291D12}" dt="2024-09-09T12:02:43.181" v="346" actId="478"/>
          <ac:spMkLst>
            <pc:docMk/>
            <pc:sldMk cId="4156066348" sldId="263"/>
            <ac:spMk id="5" creationId="{E69FF8E6-45FE-EF36-329E-B02F12A6EF08}"/>
          </ac:spMkLst>
        </pc:spChg>
        <pc:spChg chg="del mod topLvl">
          <ac:chgData name="Ilaria Laurenzana" userId="d20e3a4c-5152-4781-9a82-e8e358f0fc6e" providerId="ADAL" clId="{F25154BB-24FE-45A5-ACC5-F4DE14291D12}" dt="2024-09-09T12:02:44.954" v="347" actId="478"/>
          <ac:spMkLst>
            <pc:docMk/>
            <pc:sldMk cId="4156066348" sldId="263"/>
            <ac:spMk id="24" creationId="{ACCF3B2D-42AF-54C7-9DED-CFD6B76F2501}"/>
          </ac:spMkLst>
        </pc:spChg>
        <pc:spChg chg="del mod topLvl">
          <ac:chgData name="Ilaria Laurenzana" userId="d20e3a4c-5152-4781-9a82-e8e358f0fc6e" providerId="ADAL" clId="{F25154BB-24FE-45A5-ACC5-F4DE14291D12}" dt="2024-09-09T12:02:40.764" v="345" actId="478"/>
          <ac:spMkLst>
            <pc:docMk/>
            <pc:sldMk cId="4156066348" sldId="263"/>
            <ac:spMk id="58" creationId="{AD1F0334-B872-304E-A201-D8F83D1F9645}"/>
          </ac:spMkLst>
        </pc:spChg>
        <pc:grpChg chg="del mod topLvl">
          <ac:chgData name="Ilaria Laurenzana" userId="d20e3a4c-5152-4781-9a82-e8e358f0fc6e" providerId="ADAL" clId="{F25154BB-24FE-45A5-ACC5-F4DE14291D12}" dt="2024-09-09T12:02:44.954" v="347" actId="478"/>
          <ac:grpSpMkLst>
            <pc:docMk/>
            <pc:sldMk cId="4156066348" sldId="263"/>
            <ac:grpSpMk id="15" creationId="{9EDFA0A1-606C-57C5-A6A2-B2CBD6134E18}"/>
          </ac:grpSpMkLst>
        </pc:grpChg>
        <pc:grpChg chg="del mod topLvl">
          <ac:chgData name="Ilaria Laurenzana" userId="d20e3a4c-5152-4781-9a82-e8e358f0fc6e" providerId="ADAL" clId="{F25154BB-24FE-45A5-ACC5-F4DE14291D12}" dt="2024-09-09T12:02:43.181" v="346" actId="478"/>
          <ac:grpSpMkLst>
            <pc:docMk/>
            <pc:sldMk cId="4156066348" sldId="263"/>
            <ac:grpSpMk id="38" creationId="{FD8374AE-8BF3-6384-EDFF-270345B3C7A0}"/>
          </ac:grpSpMkLst>
        </pc:grpChg>
        <pc:grpChg chg="add del mod">
          <ac:chgData name="Ilaria Laurenzana" userId="d20e3a4c-5152-4781-9a82-e8e358f0fc6e" providerId="ADAL" clId="{F25154BB-24FE-45A5-ACC5-F4DE14291D12}" dt="2024-09-09T12:02:38.897" v="344" actId="165"/>
          <ac:grpSpMkLst>
            <pc:docMk/>
            <pc:sldMk cId="4156066348" sldId="263"/>
            <ac:grpSpMk id="59" creationId="{0386616D-50C4-DD43-5CC0-47E3B2457D48}"/>
          </ac:grpSpMkLst>
        </pc:grpChg>
        <pc:graphicFrameChg chg="mod topLvl">
          <ac:chgData name="Ilaria Laurenzana" userId="d20e3a4c-5152-4781-9a82-e8e358f0fc6e" providerId="ADAL" clId="{F25154BB-24FE-45A5-ACC5-F4DE14291D12}" dt="2024-09-09T12:03:06.356" v="350" actId="1076"/>
          <ac:graphicFrameMkLst>
            <pc:docMk/>
            <pc:sldMk cId="4156066348" sldId="263"/>
            <ac:graphicFrameMk id="2" creationId="{0DCCA837-C239-A0B7-92A8-D3EC76BC6BCC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09T12:02:58.686" v="349" actId="1076"/>
          <ac:graphicFrameMkLst>
            <pc:docMk/>
            <pc:sldMk cId="4156066348" sldId="263"/>
            <ac:graphicFrameMk id="3" creationId="{CD172DF4-F594-4209-3CF2-CD6FB28B70E9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03:10.712" v="351" actId="1076"/>
          <ac:graphicFrameMkLst>
            <pc:docMk/>
            <pc:sldMk cId="4156066348" sldId="263"/>
            <ac:graphicFrameMk id="26" creationId="{18D01538-9BF9-157B-5EE9-AF0DAEBC5B3F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03:13.196" v="352" actId="1076"/>
          <ac:graphicFrameMkLst>
            <pc:docMk/>
            <pc:sldMk cId="4156066348" sldId="263"/>
            <ac:graphicFrameMk id="27" creationId="{ED167F1D-BBB9-53C5-0D61-3E8E00E38625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03:17.455" v="353" actId="1076"/>
          <ac:graphicFrameMkLst>
            <pc:docMk/>
            <pc:sldMk cId="4156066348" sldId="263"/>
            <ac:graphicFrameMk id="28" creationId="{FDECDE19-0E04-DDF7-0B99-F80099BF1A0B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03:20.564" v="354" actId="1076"/>
          <ac:graphicFrameMkLst>
            <pc:docMk/>
            <pc:sldMk cId="4156066348" sldId="263"/>
            <ac:graphicFrameMk id="29" creationId="{3FFD888C-5868-6AF0-4B3A-CBBC67C08515}"/>
          </ac:graphicFrameMkLst>
        </pc:graphicFrameChg>
      </pc:sldChg>
      <pc:sldChg chg="addSp delSp modSp mod ord">
        <pc:chgData name="Ilaria Laurenzana" userId="d20e3a4c-5152-4781-9a82-e8e358f0fc6e" providerId="ADAL" clId="{F25154BB-24FE-45A5-ACC5-F4DE14291D12}" dt="2024-09-19T10:23:13.132" v="4800"/>
        <pc:sldMkLst>
          <pc:docMk/>
          <pc:sldMk cId="1785329976" sldId="266"/>
        </pc:sldMkLst>
        <pc:spChg chg="del">
          <ac:chgData name="Ilaria Laurenzana" userId="d20e3a4c-5152-4781-9a82-e8e358f0fc6e" providerId="ADAL" clId="{F25154BB-24FE-45A5-ACC5-F4DE14291D12}" dt="2024-09-09T12:01:41.766" v="312" actId="478"/>
          <ac:spMkLst>
            <pc:docMk/>
            <pc:sldMk cId="1785329976" sldId="266"/>
            <ac:spMk id="3" creationId="{C15225FD-906A-3402-7200-77EFFDD4EF52}"/>
          </ac:spMkLst>
        </pc:spChg>
        <pc:spChg chg="mod">
          <ac:chgData name="Ilaria Laurenzana" userId="d20e3a4c-5152-4781-9a82-e8e358f0fc6e" providerId="ADAL" clId="{F25154BB-24FE-45A5-ACC5-F4DE14291D12}" dt="2024-09-09T12:22:20.992" v="842" actId="20577"/>
          <ac:spMkLst>
            <pc:docMk/>
            <pc:sldMk cId="1785329976" sldId="266"/>
            <ac:spMk id="4" creationId="{50497295-7F13-D7C4-E438-2DD323BA955C}"/>
          </ac:spMkLst>
        </pc:spChg>
        <pc:spChg chg="add mod">
          <ac:chgData name="Ilaria Laurenzana" userId="d20e3a4c-5152-4781-9a82-e8e358f0fc6e" providerId="ADAL" clId="{F25154BB-24FE-45A5-ACC5-F4DE14291D12}" dt="2024-09-12T12:40:47.593" v="2670" actId="6549"/>
          <ac:spMkLst>
            <pc:docMk/>
            <pc:sldMk cId="1785329976" sldId="266"/>
            <ac:spMk id="5" creationId="{CED552E5-F927-2A46-8D71-B0EAF14E957C}"/>
          </ac:spMkLst>
        </pc:spChg>
        <pc:spChg chg="add mod">
          <ac:chgData name="Ilaria Laurenzana" userId="d20e3a4c-5152-4781-9a82-e8e358f0fc6e" providerId="ADAL" clId="{F25154BB-24FE-45A5-ACC5-F4DE14291D12}" dt="2024-09-12T12:40:45.540" v="2669" actId="6549"/>
          <ac:spMkLst>
            <pc:docMk/>
            <pc:sldMk cId="1785329976" sldId="266"/>
            <ac:spMk id="6" creationId="{B3C5050B-D617-D0D5-636A-CC61A844437F}"/>
          </ac:spMkLst>
        </pc:spChg>
        <pc:spChg chg="add del mod">
          <ac:chgData name="Ilaria Laurenzana" userId="d20e3a4c-5152-4781-9a82-e8e358f0fc6e" providerId="ADAL" clId="{F25154BB-24FE-45A5-ACC5-F4DE14291D12}" dt="2024-09-12T08:36:08.595" v="1941" actId="478"/>
          <ac:spMkLst>
            <pc:docMk/>
            <pc:sldMk cId="1785329976" sldId="266"/>
            <ac:spMk id="8" creationId="{52FFE5D0-EBAC-B054-4E48-76A42FD72563}"/>
          </ac:spMkLst>
        </pc:spChg>
        <pc:spChg chg="del">
          <ac:chgData name="Ilaria Laurenzana" userId="d20e3a4c-5152-4781-9a82-e8e358f0fc6e" providerId="ADAL" clId="{F25154BB-24FE-45A5-ACC5-F4DE14291D12}" dt="2024-09-09T12:01:42.926" v="313" actId="478"/>
          <ac:spMkLst>
            <pc:docMk/>
            <pc:sldMk cId="1785329976" sldId="266"/>
            <ac:spMk id="9" creationId="{5CA9F2A0-6773-BE13-1824-CA01978DB3BC}"/>
          </ac:spMkLst>
        </pc:spChg>
        <pc:spChg chg="add del mod">
          <ac:chgData name="Ilaria Laurenzana" userId="d20e3a4c-5152-4781-9a82-e8e358f0fc6e" providerId="ADAL" clId="{F25154BB-24FE-45A5-ACC5-F4DE14291D12}" dt="2024-09-12T08:36:16.752" v="1949" actId="478"/>
          <ac:spMkLst>
            <pc:docMk/>
            <pc:sldMk cId="1785329976" sldId="266"/>
            <ac:spMk id="12" creationId="{7998904F-BBCA-860B-F38C-DD3672A0FE0F}"/>
          </ac:spMkLst>
        </pc:spChg>
        <pc:spChg chg="add del mod">
          <ac:chgData name="Ilaria Laurenzana" userId="d20e3a4c-5152-4781-9a82-e8e358f0fc6e" providerId="ADAL" clId="{F25154BB-24FE-45A5-ACC5-F4DE14291D12}" dt="2024-09-12T08:36:15.467" v="1948" actId="478"/>
          <ac:spMkLst>
            <pc:docMk/>
            <pc:sldMk cId="1785329976" sldId="266"/>
            <ac:spMk id="13" creationId="{E94AD5CB-D3F4-E7D6-FE2E-18193F77423F}"/>
          </ac:spMkLst>
        </pc:spChg>
        <pc:spChg chg="add del mod">
          <ac:chgData name="Ilaria Laurenzana" userId="d20e3a4c-5152-4781-9a82-e8e358f0fc6e" providerId="ADAL" clId="{F25154BB-24FE-45A5-ACC5-F4DE14291D12}" dt="2024-09-12T08:36:14.432" v="1947" actId="478"/>
          <ac:spMkLst>
            <pc:docMk/>
            <pc:sldMk cId="1785329976" sldId="266"/>
            <ac:spMk id="14" creationId="{DB2A9715-0D64-89A4-D1C0-A01B722A6620}"/>
          </ac:spMkLst>
        </pc:spChg>
        <pc:spChg chg="add mod">
          <ac:chgData name="Ilaria Laurenzana" userId="d20e3a4c-5152-4781-9a82-e8e358f0fc6e" providerId="ADAL" clId="{F25154BB-24FE-45A5-ACC5-F4DE14291D12}" dt="2024-09-12T08:35:08.869" v="1921" actId="164"/>
          <ac:spMkLst>
            <pc:docMk/>
            <pc:sldMk cId="1785329976" sldId="266"/>
            <ac:spMk id="17" creationId="{6D896524-4887-7390-1C83-0572767C420C}"/>
          </ac:spMkLst>
        </pc:spChg>
        <pc:spChg chg="mod topLvl">
          <ac:chgData name="Ilaria Laurenzana" userId="d20e3a4c-5152-4781-9a82-e8e358f0fc6e" providerId="ADAL" clId="{F25154BB-24FE-45A5-ACC5-F4DE14291D12}" dt="2024-09-12T08:42:54.250" v="2049" actId="165"/>
          <ac:spMkLst>
            <pc:docMk/>
            <pc:sldMk cId="1785329976" sldId="266"/>
            <ac:spMk id="19" creationId="{794F691A-3BB9-111C-C409-0F85FAC09774}"/>
          </ac:spMkLst>
        </pc:spChg>
        <pc:spChg chg="add mod">
          <ac:chgData name="Ilaria Laurenzana" userId="d20e3a4c-5152-4781-9a82-e8e358f0fc6e" providerId="ADAL" clId="{F25154BB-24FE-45A5-ACC5-F4DE14291D12}" dt="2024-09-17T06:54:14.552" v="3339" actId="1035"/>
          <ac:spMkLst>
            <pc:docMk/>
            <pc:sldMk cId="1785329976" sldId="266"/>
            <ac:spMk id="20" creationId="{4DF8CEFC-379A-4398-4452-0E4B3B7A83D6}"/>
          </ac:spMkLst>
        </pc:spChg>
        <pc:spChg chg="add mod">
          <ac:chgData name="Ilaria Laurenzana" userId="d20e3a4c-5152-4781-9a82-e8e358f0fc6e" providerId="ADAL" clId="{F25154BB-24FE-45A5-ACC5-F4DE14291D12}" dt="2024-09-12T08:35:18.327" v="1929" actId="1037"/>
          <ac:spMkLst>
            <pc:docMk/>
            <pc:sldMk cId="1785329976" sldId="266"/>
            <ac:spMk id="21" creationId="{596814F3-8D9F-4A34-9688-61537F2DD25B}"/>
          </ac:spMkLst>
        </pc:spChg>
        <pc:spChg chg="add mod">
          <ac:chgData name="Ilaria Laurenzana" userId="d20e3a4c-5152-4781-9a82-e8e358f0fc6e" providerId="ADAL" clId="{F25154BB-24FE-45A5-ACC5-F4DE14291D12}" dt="2024-09-12T08:35:22.992" v="1930" actId="14100"/>
          <ac:spMkLst>
            <pc:docMk/>
            <pc:sldMk cId="1785329976" sldId="266"/>
            <ac:spMk id="22" creationId="{A0C4202A-AD8D-7213-B90E-F5550E7E829E}"/>
          </ac:spMkLst>
        </pc:spChg>
        <pc:spChg chg="add mod">
          <ac:chgData name="Ilaria Laurenzana" userId="d20e3a4c-5152-4781-9a82-e8e358f0fc6e" providerId="ADAL" clId="{F25154BB-24FE-45A5-ACC5-F4DE14291D12}" dt="2024-09-17T06:51:45.428" v="3239" actId="552"/>
          <ac:spMkLst>
            <pc:docMk/>
            <pc:sldMk cId="1785329976" sldId="266"/>
            <ac:spMk id="24" creationId="{954F1F44-0444-6C9C-DA84-9D028A23F80B}"/>
          </ac:spMkLst>
        </pc:spChg>
        <pc:spChg chg="add mod">
          <ac:chgData name="Ilaria Laurenzana" userId="d20e3a4c-5152-4781-9a82-e8e358f0fc6e" providerId="ADAL" clId="{F25154BB-24FE-45A5-ACC5-F4DE14291D12}" dt="2024-09-12T08:46:04.441" v="2219" actId="20577"/>
          <ac:spMkLst>
            <pc:docMk/>
            <pc:sldMk cId="1785329976" sldId="266"/>
            <ac:spMk id="26" creationId="{F455EB89-A21A-4828-C9E6-7B65F36CDF4F}"/>
          </ac:spMkLst>
        </pc:spChg>
        <pc:spChg chg="mod ord topLvl">
          <ac:chgData name="Ilaria Laurenzana" userId="d20e3a4c-5152-4781-9a82-e8e358f0fc6e" providerId="ADAL" clId="{F25154BB-24FE-45A5-ACC5-F4DE14291D12}" dt="2024-09-12T08:43:31.452" v="2054" actId="164"/>
          <ac:spMkLst>
            <pc:docMk/>
            <pc:sldMk cId="1785329976" sldId="266"/>
            <ac:spMk id="28" creationId="{984DC770-C0CD-009F-200D-66960D91AA71}"/>
          </ac:spMkLst>
        </pc:spChg>
        <pc:spChg chg="add mod">
          <ac:chgData name="Ilaria Laurenzana" userId="d20e3a4c-5152-4781-9a82-e8e358f0fc6e" providerId="ADAL" clId="{F25154BB-24FE-45A5-ACC5-F4DE14291D12}" dt="2024-09-17T06:54:34.147" v="3348" actId="164"/>
          <ac:spMkLst>
            <pc:docMk/>
            <pc:sldMk cId="1785329976" sldId="266"/>
            <ac:spMk id="30" creationId="{72C6981E-22C4-5196-EECE-FF9DFCB64E51}"/>
          </ac:spMkLst>
        </pc:spChg>
        <pc:spChg chg="mod">
          <ac:chgData name="Ilaria Laurenzana" userId="d20e3a4c-5152-4781-9a82-e8e358f0fc6e" providerId="ADAL" clId="{F25154BB-24FE-45A5-ACC5-F4DE14291D12}" dt="2024-09-12T08:46:22.640" v="2226" actId="14100"/>
          <ac:spMkLst>
            <pc:docMk/>
            <pc:sldMk cId="1785329976" sldId="266"/>
            <ac:spMk id="31" creationId="{9E0EF7FE-2981-542A-5C18-E0E8E82EE674}"/>
          </ac:spMkLst>
        </pc:spChg>
        <pc:spChg chg="add mod">
          <ac:chgData name="Ilaria Laurenzana" userId="d20e3a4c-5152-4781-9a82-e8e358f0fc6e" providerId="ADAL" clId="{F25154BB-24FE-45A5-ACC5-F4DE14291D12}" dt="2024-09-17T06:54:28.523" v="3347" actId="164"/>
          <ac:spMkLst>
            <pc:docMk/>
            <pc:sldMk cId="1785329976" sldId="266"/>
            <ac:spMk id="32" creationId="{A94B07F5-1B5B-2C8D-938F-F7AE2C541A09}"/>
          </ac:spMkLst>
        </pc:spChg>
        <pc:spChg chg="add mod">
          <ac:chgData name="Ilaria Laurenzana" userId="d20e3a4c-5152-4781-9a82-e8e358f0fc6e" providerId="ADAL" clId="{F25154BB-24FE-45A5-ACC5-F4DE14291D12}" dt="2024-09-17T06:54:37.874" v="3349" actId="164"/>
          <ac:spMkLst>
            <pc:docMk/>
            <pc:sldMk cId="1785329976" sldId="266"/>
            <ac:spMk id="33" creationId="{617667FC-1058-FFE0-2BC1-6D9B5C134825}"/>
          </ac:spMkLst>
        </pc:spChg>
        <pc:spChg chg="add mod ord topLvl">
          <ac:chgData name="Ilaria Laurenzana" userId="d20e3a4c-5152-4781-9a82-e8e358f0fc6e" providerId="ADAL" clId="{F25154BB-24FE-45A5-ACC5-F4DE14291D12}" dt="2024-09-12T08:43:18.614" v="2052" actId="164"/>
          <ac:spMkLst>
            <pc:docMk/>
            <pc:sldMk cId="1785329976" sldId="266"/>
            <ac:spMk id="34" creationId="{4ECFB074-63DF-F9B6-81A7-37A302AC1A3F}"/>
          </ac:spMkLst>
        </pc:spChg>
        <pc:spChg chg="add del mod">
          <ac:chgData name="Ilaria Laurenzana" userId="d20e3a4c-5152-4781-9a82-e8e358f0fc6e" providerId="ADAL" clId="{F25154BB-24FE-45A5-ACC5-F4DE14291D12}" dt="2024-09-17T12:44:51.121" v="3712" actId="478"/>
          <ac:spMkLst>
            <pc:docMk/>
            <pc:sldMk cId="1785329976" sldId="266"/>
            <ac:spMk id="35" creationId="{125172B3-D0DC-8BAC-A1AE-7052D5779F31}"/>
          </ac:spMkLst>
        </pc:spChg>
        <pc:spChg chg="add mod">
          <ac:chgData name="Ilaria Laurenzana" userId="d20e3a4c-5152-4781-9a82-e8e358f0fc6e" providerId="ADAL" clId="{F25154BB-24FE-45A5-ACC5-F4DE14291D12}" dt="2024-09-17T06:55:08.514" v="3352" actId="164"/>
          <ac:spMkLst>
            <pc:docMk/>
            <pc:sldMk cId="1785329976" sldId="266"/>
            <ac:spMk id="38" creationId="{C0D9C35D-D905-DCCD-3AD7-B7C6EAB5CF64}"/>
          </ac:spMkLst>
        </pc:spChg>
        <pc:spChg chg="add mod">
          <ac:chgData name="Ilaria Laurenzana" userId="d20e3a4c-5152-4781-9a82-e8e358f0fc6e" providerId="ADAL" clId="{F25154BB-24FE-45A5-ACC5-F4DE14291D12}" dt="2024-09-17T06:55:13.118" v="3353" actId="164"/>
          <ac:spMkLst>
            <pc:docMk/>
            <pc:sldMk cId="1785329976" sldId="266"/>
            <ac:spMk id="39" creationId="{FE338135-C5AE-6FE2-3252-DBAA6F70C63A}"/>
          </ac:spMkLst>
        </pc:spChg>
        <pc:spChg chg="add mod ord">
          <ac:chgData name="Ilaria Laurenzana" userId="d20e3a4c-5152-4781-9a82-e8e358f0fc6e" providerId="ADAL" clId="{F25154BB-24FE-45A5-ACC5-F4DE14291D12}" dt="2024-09-17T06:55:17.104" v="3354" actId="164"/>
          <ac:spMkLst>
            <pc:docMk/>
            <pc:sldMk cId="1785329976" sldId="266"/>
            <ac:spMk id="40" creationId="{B444B3A2-DFDF-33D0-D82D-AB53A1E79D76}"/>
          </ac:spMkLst>
        </pc:spChg>
        <pc:spChg chg="add mod">
          <ac:chgData name="Ilaria Laurenzana" userId="d20e3a4c-5152-4781-9a82-e8e358f0fc6e" providerId="ADAL" clId="{F25154BB-24FE-45A5-ACC5-F4DE14291D12}" dt="2024-09-17T06:55:21.356" v="3355" actId="164"/>
          <ac:spMkLst>
            <pc:docMk/>
            <pc:sldMk cId="1785329976" sldId="266"/>
            <ac:spMk id="41" creationId="{834BA1EF-F595-A2E0-006E-460F140F87AC}"/>
          </ac:spMkLst>
        </pc:spChg>
        <pc:spChg chg="add mod">
          <ac:chgData name="Ilaria Laurenzana" userId="d20e3a4c-5152-4781-9a82-e8e358f0fc6e" providerId="ADAL" clId="{F25154BB-24FE-45A5-ACC5-F4DE14291D12}" dt="2024-09-17T07:04:18.812" v="3439" actId="1035"/>
          <ac:spMkLst>
            <pc:docMk/>
            <pc:sldMk cId="1785329976" sldId="266"/>
            <ac:spMk id="42" creationId="{0C7AE62C-70A2-97D2-0FC1-B10E596543C9}"/>
          </ac:spMkLst>
        </pc:spChg>
        <pc:spChg chg="add mod">
          <ac:chgData name="Ilaria Laurenzana" userId="d20e3a4c-5152-4781-9a82-e8e358f0fc6e" providerId="ADAL" clId="{F25154BB-24FE-45A5-ACC5-F4DE14291D12}" dt="2024-09-17T07:04:15.389" v="3437" actId="1035"/>
          <ac:spMkLst>
            <pc:docMk/>
            <pc:sldMk cId="1785329976" sldId="266"/>
            <ac:spMk id="43" creationId="{2EA81E23-979B-E13D-BC1F-DF5280F6E4B5}"/>
          </ac:spMkLst>
        </pc:spChg>
        <pc:spChg chg="add mod">
          <ac:chgData name="Ilaria Laurenzana" userId="d20e3a4c-5152-4781-9a82-e8e358f0fc6e" providerId="ADAL" clId="{F25154BB-24FE-45A5-ACC5-F4DE14291D12}" dt="2024-09-17T07:04:08.675" v="3435" actId="1035"/>
          <ac:spMkLst>
            <pc:docMk/>
            <pc:sldMk cId="1785329976" sldId="266"/>
            <ac:spMk id="44" creationId="{068003FE-6CF4-5BBC-A144-BB2F1420062E}"/>
          </ac:spMkLst>
        </pc:spChg>
        <pc:spChg chg="add mod">
          <ac:chgData name="Ilaria Laurenzana" userId="d20e3a4c-5152-4781-9a82-e8e358f0fc6e" providerId="ADAL" clId="{F25154BB-24FE-45A5-ACC5-F4DE14291D12}" dt="2024-09-17T06:58:34.222" v="3396" actId="1036"/>
          <ac:spMkLst>
            <pc:docMk/>
            <pc:sldMk cId="1785329976" sldId="266"/>
            <ac:spMk id="55" creationId="{15CC0D08-4905-564A-1C80-4230BA6274AB}"/>
          </ac:spMkLst>
        </pc:spChg>
        <pc:spChg chg="add mod">
          <ac:chgData name="Ilaria Laurenzana" userId="d20e3a4c-5152-4781-9a82-e8e358f0fc6e" providerId="ADAL" clId="{F25154BB-24FE-45A5-ACC5-F4DE14291D12}" dt="2024-09-17T06:57:26.824" v="3379" actId="164"/>
          <ac:spMkLst>
            <pc:docMk/>
            <pc:sldMk cId="1785329976" sldId="266"/>
            <ac:spMk id="56" creationId="{B3F3A689-164C-7F10-1FEC-37278FD801C6}"/>
          </ac:spMkLst>
        </pc:spChg>
        <pc:spChg chg="add mod">
          <ac:chgData name="Ilaria Laurenzana" userId="d20e3a4c-5152-4781-9a82-e8e358f0fc6e" providerId="ADAL" clId="{F25154BB-24FE-45A5-ACC5-F4DE14291D12}" dt="2024-09-17T06:57:40.195" v="3382" actId="164"/>
          <ac:spMkLst>
            <pc:docMk/>
            <pc:sldMk cId="1785329976" sldId="266"/>
            <ac:spMk id="58" creationId="{BA789CF5-3923-C1CC-615D-77B2411581DB}"/>
          </ac:spMkLst>
        </pc:spChg>
        <pc:spChg chg="add mod">
          <ac:chgData name="Ilaria Laurenzana" userId="d20e3a4c-5152-4781-9a82-e8e358f0fc6e" providerId="ADAL" clId="{F25154BB-24FE-45A5-ACC5-F4DE14291D12}" dt="2024-09-17T06:58:14.573" v="3391" actId="255"/>
          <ac:spMkLst>
            <pc:docMk/>
            <pc:sldMk cId="1785329976" sldId="266"/>
            <ac:spMk id="60" creationId="{B63EF1A6-5858-E262-93AC-2BD4D660D882}"/>
          </ac:spMkLst>
        </pc:spChg>
        <pc:spChg chg="add mod">
          <ac:chgData name="Ilaria Laurenzana" userId="d20e3a4c-5152-4781-9a82-e8e358f0fc6e" providerId="ADAL" clId="{F25154BB-24FE-45A5-ACC5-F4DE14291D12}" dt="2024-09-17T06:59:06.394" v="3400" actId="164"/>
          <ac:spMkLst>
            <pc:docMk/>
            <pc:sldMk cId="1785329976" sldId="266"/>
            <ac:spMk id="63" creationId="{7679B64A-83BE-9D4D-EF4A-8CB51DF25D0C}"/>
          </ac:spMkLst>
        </pc:spChg>
        <pc:spChg chg="add mod">
          <ac:chgData name="Ilaria Laurenzana" userId="d20e3a4c-5152-4781-9a82-e8e358f0fc6e" providerId="ADAL" clId="{F25154BB-24FE-45A5-ACC5-F4DE14291D12}" dt="2024-09-17T06:59:19.653" v="3412" actId="164"/>
          <ac:spMkLst>
            <pc:docMk/>
            <pc:sldMk cId="1785329976" sldId="266"/>
            <ac:spMk id="65" creationId="{5E9D1455-E420-5A35-A2AE-E8704FCAD30B}"/>
          </ac:spMkLst>
        </pc:spChg>
        <pc:spChg chg="add del mod">
          <ac:chgData name="Ilaria Laurenzana" userId="d20e3a4c-5152-4781-9a82-e8e358f0fc6e" providerId="ADAL" clId="{F25154BB-24FE-45A5-ACC5-F4DE14291D12}" dt="2024-09-17T06:59:32.030" v="3421" actId="478"/>
          <ac:spMkLst>
            <pc:docMk/>
            <pc:sldMk cId="1785329976" sldId="266"/>
            <ac:spMk id="67" creationId="{ADF534E0-3200-ED5A-2CAC-5C345523168B}"/>
          </ac:spMkLst>
        </pc:spChg>
        <pc:spChg chg="add del mod">
          <ac:chgData name="Ilaria Laurenzana" userId="d20e3a4c-5152-4781-9a82-e8e358f0fc6e" providerId="ADAL" clId="{F25154BB-24FE-45A5-ACC5-F4DE14291D12}" dt="2024-09-17T12:44:42.412" v="3706" actId="478"/>
          <ac:spMkLst>
            <pc:docMk/>
            <pc:sldMk cId="1785329976" sldId="266"/>
            <ac:spMk id="68" creationId="{0808B01C-E4BD-5154-D301-4A851EE52E1F}"/>
          </ac:spMkLst>
        </pc:spChg>
        <pc:spChg chg="add del mod">
          <ac:chgData name="Ilaria Laurenzana" userId="d20e3a4c-5152-4781-9a82-e8e358f0fc6e" providerId="ADAL" clId="{F25154BB-24FE-45A5-ACC5-F4DE14291D12}" dt="2024-09-17T12:44:44.939" v="3709" actId="478"/>
          <ac:spMkLst>
            <pc:docMk/>
            <pc:sldMk cId="1785329976" sldId="266"/>
            <ac:spMk id="70" creationId="{ABC644EE-BDE9-A1C9-F5D8-30DB6E6E26A7}"/>
          </ac:spMkLst>
        </pc:spChg>
        <pc:spChg chg="add mod">
          <ac:chgData name="Ilaria Laurenzana" userId="d20e3a4c-5152-4781-9a82-e8e358f0fc6e" providerId="ADAL" clId="{F25154BB-24FE-45A5-ACC5-F4DE14291D12}" dt="2024-09-17T07:53:13.742" v="3697" actId="164"/>
          <ac:spMkLst>
            <pc:docMk/>
            <pc:sldMk cId="1785329976" sldId="266"/>
            <ac:spMk id="71" creationId="{7EEDCDEC-198D-05D5-16D6-A06E311DD090}"/>
          </ac:spMkLst>
        </pc:spChg>
        <pc:grpChg chg="del mod topLvl">
          <ac:chgData name="Ilaria Laurenzana" userId="d20e3a4c-5152-4781-9a82-e8e358f0fc6e" providerId="ADAL" clId="{F25154BB-24FE-45A5-ACC5-F4DE14291D12}" dt="2024-09-12T08:43:11.320" v="2051" actId="165"/>
          <ac:grpSpMkLst>
            <pc:docMk/>
            <pc:sldMk cId="1785329976" sldId="266"/>
            <ac:grpSpMk id="16" creationId="{529746B8-2335-9AD7-4D6D-633EEA979C71}"/>
          </ac:grpSpMkLst>
        </pc:grpChg>
        <pc:grpChg chg="del mod topLvl">
          <ac:chgData name="Ilaria Laurenzana" userId="d20e3a4c-5152-4781-9a82-e8e358f0fc6e" providerId="ADAL" clId="{F25154BB-24FE-45A5-ACC5-F4DE14291D12}" dt="2024-09-12T08:42:58.345" v="2050" actId="165"/>
          <ac:grpSpMkLst>
            <pc:docMk/>
            <pc:sldMk cId="1785329976" sldId="266"/>
            <ac:grpSpMk id="18" creationId="{4976A06E-F2D9-1247-CFF8-9D3D751F97C9}"/>
          </ac:grpSpMkLst>
        </pc:grpChg>
        <pc:grpChg chg="del mod topLvl">
          <ac:chgData name="Ilaria Laurenzana" userId="d20e3a4c-5152-4781-9a82-e8e358f0fc6e" providerId="ADAL" clId="{F25154BB-24FE-45A5-ACC5-F4DE14291D12}" dt="2024-09-12T08:42:54.250" v="2049" actId="165"/>
          <ac:grpSpMkLst>
            <pc:docMk/>
            <pc:sldMk cId="1785329976" sldId="266"/>
            <ac:grpSpMk id="20" creationId="{C51FA89F-FBF8-5E20-8199-1F6B34F6FCF1}"/>
          </ac:grpSpMkLst>
        </pc:grpChg>
        <pc:grpChg chg="add mod">
          <ac:chgData name="Ilaria Laurenzana" userId="d20e3a4c-5152-4781-9a82-e8e358f0fc6e" providerId="ADAL" clId="{F25154BB-24FE-45A5-ACC5-F4DE14291D12}" dt="2024-09-12T08:35:08.869" v="1921" actId="164"/>
          <ac:grpSpMkLst>
            <pc:docMk/>
            <pc:sldMk cId="1785329976" sldId="266"/>
            <ac:grpSpMk id="23" creationId="{6EEA5473-5164-4EE5-D9C8-72ED9AC9218E}"/>
          </ac:grpSpMkLst>
        </pc:grpChg>
        <pc:grpChg chg="del">
          <ac:chgData name="Ilaria Laurenzana" userId="d20e3a4c-5152-4781-9a82-e8e358f0fc6e" providerId="ADAL" clId="{F25154BB-24FE-45A5-ACC5-F4DE14291D12}" dt="2024-09-09T11:56:11.208" v="83" actId="21"/>
          <ac:grpSpMkLst>
            <pc:docMk/>
            <pc:sldMk cId="1785329976" sldId="266"/>
            <ac:grpSpMk id="25" creationId="{E62EBF76-CE14-16F5-8891-71171E64C873}"/>
          </ac:grpSpMkLst>
        </pc:grpChg>
        <pc:grpChg chg="del">
          <ac:chgData name="Ilaria Laurenzana" userId="d20e3a4c-5152-4781-9a82-e8e358f0fc6e" providerId="ADAL" clId="{F25154BB-24FE-45A5-ACC5-F4DE14291D12}" dt="2024-09-09T11:56:11.208" v="83" actId="21"/>
          <ac:grpSpMkLst>
            <pc:docMk/>
            <pc:sldMk cId="1785329976" sldId="266"/>
            <ac:grpSpMk id="32" creationId="{94AE6F88-768C-2BDC-71CA-50E93CCE8F3E}"/>
          </ac:grpSpMkLst>
        </pc:grpChg>
        <pc:grpChg chg="add del mod">
          <ac:chgData name="Ilaria Laurenzana" userId="d20e3a4c-5152-4781-9a82-e8e358f0fc6e" providerId="ADAL" clId="{F25154BB-24FE-45A5-ACC5-F4DE14291D12}" dt="2024-09-12T08:42:50.469" v="2048" actId="165"/>
          <ac:grpSpMkLst>
            <pc:docMk/>
            <pc:sldMk cId="1785329976" sldId="266"/>
            <ac:grpSpMk id="35" creationId="{9204063B-13D9-223D-1D41-280BDC835D86}"/>
          </ac:grpSpMkLst>
        </pc:grpChg>
        <pc:grpChg chg="add mod">
          <ac:chgData name="Ilaria Laurenzana" userId="d20e3a4c-5152-4781-9a82-e8e358f0fc6e" providerId="ADAL" clId="{F25154BB-24FE-45A5-ACC5-F4DE14291D12}" dt="2024-09-12T08:43:31.452" v="2054" actId="164"/>
          <ac:grpSpMkLst>
            <pc:docMk/>
            <pc:sldMk cId="1785329976" sldId="266"/>
            <ac:grpSpMk id="36" creationId="{F0EEAAFE-B046-E0FF-7665-426B89ECDF64}"/>
          </ac:grpSpMkLst>
        </pc:grpChg>
        <pc:grpChg chg="add mod">
          <ac:chgData name="Ilaria Laurenzana" userId="d20e3a4c-5152-4781-9a82-e8e358f0fc6e" providerId="ADAL" clId="{F25154BB-24FE-45A5-ACC5-F4DE14291D12}" dt="2024-09-12T08:43:31.452" v="2054" actId="164"/>
          <ac:grpSpMkLst>
            <pc:docMk/>
            <pc:sldMk cId="1785329976" sldId="266"/>
            <ac:grpSpMk id="37" creationId="{F3F0375D-1177-01C2-209C-F7979C6DA3CD}"/>
          </ac:grpSpMkLst>
        </pc:grpChg>
        <pc:grpChg chg="add mod">
          <ac:chgData name="Ilaria Laurenzana" userId="d20e3a4c-5152-4781-9a82-e8e358f0fc6e" providerId="ADAL" clId="{F25154BB-24FE-45A5-ACC5-F4DE14291D12}" dt="2024-09-17T06:54:28.523" v="3347" actId="164"/>
          <ac:grpSpMkLst>
            <pc:docMk/>
            <pc:sldMk cId="1785329976" sldId="266"/>
            <ac:grpSpMk id="45" creationId="{6F085619-49C8-45BD-81A0-2E71F4DE7891}"/>
          </ac:grpSpMkLst>
        </pc:grpChg>
        <pc:grpChg chg="add mod">
          <ac:chgData name="Ilaria Laurenzana" userId="d20e3a4c-5152-4781-9a82-e8e358f0fc6e" providerId="ADAL" clId="{F25154BB-24FE-45A5-ACC5-F4DE14291D12}" dt="2024-09-17T06:54:34.147" v="3348" actId="164"/>
          <ac:grpSpMkLst>
            <pc:docMk/>
            <pc:sldMk cId="1785329976" sldId="266"/>
            <ac:grpSpMk id="46" creationId="{72EDAF31-0A9C-5855-4F08-EB3C97A307B5}"/>
          </ac:grpSpMkLst>
        </pc:grpChg>
        <pc:grpChg chg="add mod">
          <ac:chgData name="Ilaria Laurenzana" userId="d20e3a4c-5152-4781-9a82-e8e358f0fc6e" providerId="ADAL" clId="{F25154BB-24FE-45A5-ACC5-F4DE14291D12}" dt="2024-09-17T06:54:37.874" v="3349" actId="164"/>
          <ac:grpSpMkLst>
            <pc:docMk/>
            <pc:sldMk cId="1785329976" sldId="266"/>
            <ac:grpSpMk id="47" creationId="{5405A14D-5791-B59A-317D-0FADFA41F300}"/>
          </ac:grpSpMkLst>
        </pc:grpChg>
        <pc:grpChg chg="add mod">
          <ac:chgData name="Ilaria Laurenzana" userId="d20e3a4c-5152-4781-9a82-e8e358f0fc6e" providerId="ADAL" clId="{F25154BB-24FE-45A5-ACC5-F4DE14291D12}" dt="2024-09-17T06:57:40.195" v="3382" actId="164"/>
          <ac:grpSpMkLst>
            <pc:docMk/>
            <pc:sldMk cId="1785329976" sldId="266"/>
            <ac:grpSpMk id="48" creationId="{DF5661BB-4A7B-5F9B-CDDD-29C25F6813D5}"/>
          </ac:grpSpMkLst>
        </pc:grpChg>
        <pc:grpChg chg="add mod">
          <ac:chgData name="Ilaria Laurenzana" userId="d20e3a4c-5152-4781-9a82-e8e358f0fc6e" providerId="ADAL" clId="{F25154BB-24FE-45A5-ACC5-F4DE14291D12}" dt="2024-09-17T06:57:26.824" v="3379" actId="164"/>
          <ac:grpSpMkLst>
            <pc:docMk/>
            <pc:sldMk cId="1785329976" sldId="266"/>
            <ac:grpSpMk id="49" creationId="{813B3BA7-4FB2-3EBC-7DFA-33371F7993C7}"/>
          </ac:grpSpMkLst>
        </pc:grpChg>
        <pc:grpChg chg="add del mod">
          <ac:chgData name="Ilaria Laurenzana" userId="d20e3a4c-5152-4781-9a82-e8e358f0fc6e" providerId="ADAL" clId="{F25154BB-24FE-45A5-ACC5-F4DE14291D12}" dt="2024-09-17T12:44:35.067" v="3700" actId="478"/>
          <ac:grpSpMkLst>
            <pc:docMk/>
            <pc:sldMk cId="1785329976" sldId="266"/>
            <ac:grpSpMk id="50" creationId="{F91FA98B-B333-0B97-49FE-5C1521CCF9CD}"/>
          </ac:grpSpMkLst>
        </pc:grpChg>
        <pc:grpChg chg="add del mod">
          <ac:chgData name="Ilaria Laurenzana" userId="d20e3a4c-5152-4781-9a82-e8e358f0fc6e" providerId="ADAL" clId="{F25154BB-24FE-45A5-ACC5-F4DE14291D12}" dt="2024-09-17T12:44:36.810" v="3701" actId="478"/>
          <ac:grpSpMkLst>
            <pc:docMk/>
            <pc:sldMk cId="1785329976" sldId="266"/>
            <ac:grpSpMk id="51" creationId="{500EF0F2-A73F-2CB5-B48A-3FAC0C22ECAD}"/>
          </ac:grpSpMkLst>
        </pc:grpChg>
        <pc:grpChg chg="add del mod">
          <ac:chgData name="Ilaria Laurenzana" userId="d20e3a4c-5152-4781-9a82-e8e358f0fc6e" providerId="ADAL" clId="{F25154BB-24FE-45A5-ACC5-F4DE14291D12}" dt="2024-09-17T12:44:40.154" v="3704" actId="478"/>
          <ac:grpSpMkLst>
            <pc:docMk/>
            <pc:sldMk cId="1785329976" sldId="266"/>
            <ac:grpSpMk id="52" creationId="{28FE36FD-BA9A-C4F3-FE31-F84131494D3D}"/>
          </ac:grpSpMkLst>
        </pc:grpChg>
        <pc:grpChg chg="add mod">
          <ac:chgData name="Ilaria Laurenzana" userId="d20e3a4c-5152-4781-9a82-e8e358f0fc6e" providerId="ADAL" clId="{F25154BB-24FE-45A5-ACC5-F4DE14291D12}" dt="2024-09-17T06:59:06.394" v="3400" actId="164"/>
          <ac:grpSpMkLst>
            <pc:docMk/>
            <pc:sldMk cId="1785329976" sldId="266"/>
            <ac:grpSpMk id="53" creationId="{3ED1F135-56DF-0812-1FED-1DFE81489E79}"/>
          </ac:grpSpMkLst>
        </pc:grpChg>
        <pc:grpChg chg="add del mod">
          <ac:chgData name="Ilaria Laurenzana" userId="d20e3a4c-5152-4781-9a82-e8e358f0fc6e" providerId="ADAL" clId="{F25154BB-24FE-45A5-ACC5-F4DE14291D12}" dt="2024-09-17T12:44:37.406" v="3702" actId="478"/>
          <ac:grpSpMkLst>
            <pc:docMk/>
            <pc:sldMk cId="1785329976" sldId="266"/>
            <ac:grpSpMk id="54" creationId="{3E75A6FE-5601-9CBD-0949-0888CBF2EB99}"/>
          </ac:grpSpMkLst>
        </pc:grpChg>
        <pc:grpChg chg="add mod ord">
          <ac:chgData name="Ilaria Laurenzana" userId="d20e3a4c-5152-4781-9a82-e8e358f0fc6e" providerId="ADAL" clId="{F25154BB-24FE-45A5-ACC5-F4DE14291D12}" dt="2024-09-17T06:58:28.008" v="3393" actId="164"/>
          <ac:grpSpMkLst>
            <pc:docMk/>
            <pc:sldMk cId="1785329976" sldId="266"/>
            <ac:grpSpMk id="57" creationId="{BC4CAD13-4ED7-DDE6-D058-24C1AEAC8483}"/>
          </ac:grpSpMkLst>
        </pc:grpChg>
        <pc:grpChg chg="add mod">
          <ac:chgData name="Ilaria Laurenzana" userId="d20e3a4c-5152-4781-9a82-e8e358f0fc6e" providerId="ADAL" clId="{F25154BB-24FE-45A5-ACC5-F4DE14291D12}" dt="2024-09-17T06:58:05.721" v="3390" actId="164"/>
          <ac:grpSpMkLst>
            <pc:docMk/>
            <pc:sldMk cId="1785329976" sldId="266"/>
            <ac:grpSpMk id="59" creationId="{1AE4EAFE-A48D-8B56-E194-D8093E943E3D}"/>
          </ac:grpSpMkLst>
        </pc:grpChg>
        <pc:grpChg chg="add del mod">
          <ac:chgData name="Ilaria Laurenzana" userId="d20e3a4c-5152-4781-9a82-e8e358f0fc6e" providerId="ADAL" clId="{F25154BB-24FE-45A5-ACC5-F4DE14291D12}" dt="2024-09-17T12:44:40.909" v="3705" actId="478"/>
          <ac:grpSpMkLst>
            <pc:docMk/>
            <pc:sldMk cId="1785329976" sldId="266"/>
            <ac:grpSpMk id="61" creationId="{B7A63FBF-4DA4-6465-5F20-0E1D1AC80A8F}"/>
          </ac:grpSpMkLst>
        </pc:grpChg>
        <pc:grpChg chg="add del mod">
          <ac:chgData name="Ilaria Laurenzana" userId="d20e3a4c-5152-4781-9a82-e8e358f0fc6e" providerId="ADAL" clId="{F25154BB-24FE-45A5-ACC5-F4DE14291D12}" dt="2024-09-17T07:52:17.512" v="3634" actId="478"/>
          <ac:grpSpMkLst>
            <pc:docMk/>
            <pc:sldMk cId="1785329976" sldId="266"/>
            <ac:grpSpMk id="62" creationId="{8DE9576E-6ACC-0E42-36AA-59F8EE0CB7BD}"/>
          </ac:grpSpMkLst>
        </pc:grpChg>
        <pc:grpChg chg="add mod">
          <ac:chgData name="Ilaria Laurenzana" userId="d20e3a4c-5152-4781-9a82-e8e358f0fc6e" providerId="ADAL" clId="{F25154BB-24FE-45A5-ACC5-F4DE14291D12}" dt="2024-09-17T06:59:19.653" v="3412" actId="164"/>
          <ac:grpSpMkLst>
            <pc:docMk/>
            <pc:sldMk cId="1785329976" sldId="266"/>
            <ac:grpSpMk id="64" creationId="{42112A84-B1D0-E5DB-CD94-8230032E28FB}"/>
          </ac:grpSpMkLst>
        </pc:grpChg>
        <pc:grpChg chg="add del mod">
          <ac:chgData name="Ilaria Laurenzana" userId="d20e3a4c-5152-4781-9a82-e8e358f0fc6e" providerId="ADAL" clId="{F25154BB-24FE-45A5-ACC5-F4DE14291D12}" dt="2024-09-17T12:44:37.924" v="3703" actId="478"/>
          <ac:grpSpMkLst>
            <pc:docMk/>
            <pc:sldMk cId="1785329976" sldId="266"/>
            <ac:grpSpMk id="66" creationId="{EABEBA0B-334D-8470-8030-4DE39426DD83}"/>
          </ac:grpSpMkLst>
        </pc:grpChg>
        <pc:grpChg chg="add del mod">
          <ac:chgData name="Ilaria Laurenzana" userId="d20e3a4c-5152-4781-9a82-e8e358f0fc6e" providerId="ADAL" clId="{F25154BB-24FE-45A5-ACC5-F4DE14291D12}" dt="2024-09-17T12:44:32.867" v="3699" actId="478"/>
          <ac:grpSpMkLst>
            <pc:docMk/>
            <pc:sldMk cId="1785329976" sldId="266"/>
            <ac:grpSpMk id="72" creationId="{D5C058B1-DE21-2B5F-940F-CA9F3301690E}"/>
          </ac:grpSpMkLst>
        </pc:grpChg>
        <pc:graphicFrameChg chg="mod topLvl">
          <ac:chgData name="Ilaria Laurenzana" userId="d20e3a4c-5152-4781-9a82-e8e358f0fc6e" providerId="ADAL" clId="{F25154BB-24FE-45A5-ACC5-F4DE14291D12}" dt="2024-09-12T08:43:18.614" v="2052" actId="164"/>
          <ac:graphicFrameMkLst>
            <pc:docMk/>
            <pc:sldMk cId="1785329976" sldId="266"/>
            <ac:graphicFrameMk id="2" creationId="{0611D3F6-1B8B-C388-0D38-A4323B9FA22C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12T08:35:08.869" v="1921" actId="164"/>
          <ac:graphicFrameMkLst>
            <pc:docMk/>
            <pc:sldMk cId="1785329976" sldId="266"/>
            <ac:graphicFrameMk id="3" creationId="{0777DA80-7998-29E9-077A-BEFE264A1499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2T08:43:31.452" v="2054" actId="164"/>
          <ac:graphicFrameMkLst>
            <pc:docMk/>
            <pc:sldMk cId="1785329976" sldId="266"/>
            <ac:graphicFrameMk id="10" creationId="{EE04E4FF-BCE3-3127-D2BF-02D70240989F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12T08:35:18.327" v="1929" actId="1037"/>
          <ac:graphicFrameMkLst>
            <pc:docMk/>
            <pc:sldMk cId="1785329976" sldId="266"/>
            <ac:graphicFrameMk id="15" creationId="{9D267487-74B3-D946-9DCD-9F4E8E25CEAB}"/>
          </ac:graphicFrameMkLst>
        </pc:graphicFrameChg>
        <pc:picChg chg="add del mod">
          <ac:chgData name="Ilaria Laurenzana" userId="d20e3a4c-5152-4781-9a82-e8e358f0fc6e" providerId="ADAL" clId="{F25154BB-24FE-45A5-ACC5-F4DE14291D12}" dt="2024-09-12T08:36:17.380" v="1950" actId="478"/>
          <ac:picMkLst>
            <pc:docMk/>
            <pc:sldMk cId="1785329976" sldId="266"/>
            <ac:picMk id="7" creationId="{79347DD4-E939-C1D4-E3A1-4DD881818273}"/>
          </ac:picMkLst>
        </pc:picChg>
        <pc:picChg chg="add mod">
          <ac:chgData name="Ilaria Laurenzana" userId="d20e3a4c-5152-4781-9a82-e8e358f0fc6e" providerId="ADAL" clId="{F25154BB-24FE-45A5-ACC5-F4DE14291D12}" dt="2024-09-18T06:57:20.076" v="3714" actId="14100"/>
          <ac:picMkLst>
            <pc:docMk/>
            <pc:sldMk cId="1785329976" sldId="266"/>
            <ac:picMk id="7" creationId="{DD7E06A9-8E7E-22A1-5C58-5F1B8CC12806}"/>
          </ac:picMkLst>
        </pc:picChg>
        <pc:picChg chg="add mod">
          <ac:chgData name="Ilaria Laurenzana" userId="d20e3a4c-5152-4781-9a82-e8e358f0fc6e" providerId="ADAL" clId="{F25154BB-24FE-45A5-ACC5-F4DE14291D12}" dt="2024-09-17T07:53:13.742" v="3697" actId="164"/>
          <ac:picMkLst>
            <pc:docMk/>
            <pc:sldMk cId="1785329976" sldId="266"/>
            <ac:picMk id="8" creationId="{A94EA7C8-B0FB-00CA-7025-3FCD0553F676}"/>
          </ac:picMkLst>
        </pc:picChg>
        <pc:picChg chg="add del mod">
          <ac:chgData name="Ilaria Laurenzana" userId="d20e3a4c-5152-4781-9a82-e8e358f0fc6e" providerId="ADAL" clId="{F25154BB-24FE-45A5-ACC5-F4DE14291D12}" dt="2024-09-17T06:32:04.578" v="2706" actId="478"/>
          <ac:picMkLst>
            <pc:docMk/>
            <pc:sldMk cId="1785329976" sldId="266"/>
            <ac:picMk id="8" creationId="{C56EB9B7-BE58-99EE-2B83-D62E64206664}"/>
          </ac:picMkLst>
        </pc:picChg>
        <pc:picChg chg="add del mod">
          <ac:chgData name="Ilaria Laurenzana" userId="d20e3a4c-5152-4781-9a82-e8e358f0fc6e" providerId="ADAL" clId="{F25154BB-24FE-45A5-ACC5-F4DE14291D12}" dt="2024-09-12T08:36:09.991" v="1943" actId="478"/>
          <ac:picMkLst>
            <pc:docMk/>
            <pc:sldMk cId="1785329976" sldId="266"/>
            <ac:picMk id="9" creationId="{09BA6F71-65F6-D9EB-A35E-6B4C8FDE19E6}"/>
          </ac:picMkLst>
        </pc:picChg>
        <pc:picChg chg="add mod">
          <ac:chgData name="Ilaria Laurenzana" userId="d20e3a4c-5152-4781-9a82-e8e358f0fc6e" providerId="ADAL" clId="{F25154BB-24FE-45A5-ACC5-F4DE14291D12}" dt="2024-09-17T06:55:08.514" v="3352" actId="164"/>
          <ac:picMkLst>
            <pc:docMk/>
            <pc:sldMk cId="1785329976" sldId="266"/>
            <ac:picMk id="9" creationId="{E0F32020-04E8-DF76-9AA7-F2673B72BB5C}"/>
          </ac:picMkLst>
        </pc:picChg>
        <pc:picChg chg="add del mod">
          <ac:chgData name="Ilaria Laurenzana" userId="d20e3a4c-5152-4781-9a82-e8e358f0fc6e" providerId="ADAL" clId="{F25154BB-24FE-45A5-ACC5-F4DE14291D12}" dt="2024-09-12T08:36:12.673" v="1946" actId="478"/>
          <ac:picMkLst>
            <pc:docMk/>
            <pc:sldMk cId="1785329976" sldId="266"/>
            <ac:picMk id="11" creationId="{733F0937-5DEE-2D46-D2BA-5D393DA1BFEA}"/>
          </ac:picMkLst>
        </pc:picChg>
        <pc:picChg chg="add mod">
          <ac:chgData name="Ilaria Laurenzana" userId="d20e3a4c-5152-4781-9a82-e8e358f0fc6e" providerId="ADAL" clId="{F25154BB-24FE-45A5-ACC5-F4DE14291D12}" dt="2024-09-17T06:55:13.118" v="3353" actId="164"/>
          <ac:picMkLst>
            <pc:docMk/>
            <pc:sldMk cId="1785329976" sldId="266"/>
            <ac:picMk id="11" creationId="{74543FCF-0531-AC09-D360-9F5F51EBF315}"/>
          </ac:picMkLst>
        </pc:picChg>
        <pc:picChg chg="add mod">
          <ac:chgData name="Ilaria Laurenzana" userId="d20e3a4c-5152-4781-9a82-e8e358f0fc6e" providerId="ADAL" clId="{F25154BB-24FE-45A5-ACC5-F4DE14291D12}" dt="2024-09-17T06:55:49.676" v="3363" actId="164"/>
          <ac:picMkLst>
            <pc:docMk/>
            <pc:sldMk cId="1785329976" sldId="266"/>
            <ac:picMk id="12" creationId="{2896A0C5-729F-5831-D532-D6405C264DE9}"/>
          </ac:picMkLst>
        </pc:picChg>
        <pc:picChg chg="add mod">
          <ac:chgData name="Ilaria Laurenzana" userId="d20e3a4c-5152-4781-9a82-e8e358f0fc6e" providerId="ADAL" clId="{F25154BB-24FE-45A5-ACC5-F4DE14291D12}" dt="2024-09-17T06:55:53.034" v="3364" actId="164"/>
          <ac:picMkLst>
            <pc:docMk/>
            <pc:sldMk cId="1785329976" sldId="266"/>
            <ac:picMk id="13" creationId="{3B838502-4879-FE2E-3550-A1BB7D37D5EC}"/>
          </ac:picMkLst>
        </pc:picChg>
        <pc:picChg chg="add mod">
          <ac:chgData name="Ilaria Laurenzana" userId="d20e3a4c-5152-4781-9a82-e8e358f0fc6e" providerId="ADAL" clId="{F25154BB-24FE-45A5-ACC5-F4DE14291D12}" dt="2024-09-17T06:55:45.645" v="3362" actId="164"/>
          <ac:picMkLst>
            <pc:docMk/>
            <pc:sldMk cId="1785329976" sldId="266"/>
            <ac:picMk id="14" creationId="{D9DB13CC-B363-4DA0-5CFB-54310B156FAF}"/>
          </ac:picMkLst>
        </pc:picChg>
        <pc:picChg chg="add mod">
          <ac:chgData name="Ilaria Laurenzana" userId="d20e3a4c-5152-4781-9a82-e8e358f0fc6e" providerId="ADAL" clId="{F25154BB-24FE-45A5-ACC5-F4DE14291D12}" dt="2024-09-17T06:55:17.104" v="3354" actId="164"/>
          <ac:picMkLst>
            <pc:docMk/>
            <pc:sldMk cId="1785329976" sldId="266"/>
            <ac:picMk id="16" creationId="{A568F7DE-4E02-9E63-298C-4D0B8B5D4771}"/>
          </ac:picMkLst>
        </pc:picChg>
        <pc:picChg chg="add mod">
          <ac:chgData name="Ilaria Laurenzana" userId="d20e3a4c-5152-4781-9a82-e8e358f0fc6e" providerId="ADAL" clId="{F25154BB-24FE-45A5-ACC5-F4DE14291D12}" dt="2024-09-17T06:55:21.356" v="3355" actId="164"/>
          <ac:picMkLst>
            <pc:docMk/>
            <pc:sldMk cId="1785329976" sldId="266"/>
            <ac:picMk id="18" creationId="{C8799374-A25D-5AFB-7A51-767903E0A1F1}"/>
          </ac:picMkLst>
        </pc:picChg>
        <pc:picChg chg="add mod">
          <ac:chgData name="Ilaria Laurenzana" userId="d20e3a4c-5152-4781-9a82-e8e358f0fc6e" providerId="ADAL" clId="{F25154BB-24FE-45A5-ACC5-F4DE14291D12}" dt="2024-09-17T06:54:34.147" v="3348" actId="164"/>
          <ac:picMkLst>
            <pc:docMk/>
            <pc:sldMk cId="1785329976" sldId="266"/>
            <ac:picMk id="25" creationId="{084EFF21-D1FA-C833-8FC1-FA2DCB5BB0D2}"/>
          </ac:picMkLst>
        </pc:picChg>
        <pc:picChg chg="add mod">
          <ac:chgData name="Ilaria Laurenzana" userId="d20e3a4c-5152-4781-9a82-e8e358f0fc6e" providerId="ADAL" clId="{F25154BB-24FE-45A5-ACC5-F4DE14291D12}" dt="2024-09-17T06:54:28.523" v="3347" actId="164"/>
          <ac:picMkLst>
            <pc:docMk/>
            <pc:sldMk cId="1785329976" sldId="266"/>
            <ac:picMk id="27" creationId="{C2D9225F-880C-E527-1C8B-B6B553894625}"/>
          </ac:picMkLst>
        </pc:picChg>
        <pc:picChg chg="add mod">
          <ac:chgData name="Ilaria Laurenzana" userId="d20e3a4c-5152-4781-9a82-e8e358f0fc6e" providerId="ADAL" clId="{F25154BB-24FE-45A5-ACC5-F4DE14291D12}" dt="2024-09-17T06:54:37.874" v="3349" actId="164"/>
          <ac:picMkLst>
            <pc:docMk/>
            <pc:sldMk cId="1785329976" sldId="266"/>
            <ac:picMk id="29" creationId="{3E6B9AA7-A744-EFC7-6906-9B1B266136A1}"/>
          </ac:picMkLst>
        </pc:picChg>
        <pc:cxnChg chg="add del mod">
          <ac:chgData name="Ilaria Laurenzana" userId="d20e3a4c-5152-4781-9a82-e8e358f0fc6e" providerId="ADAL" clId="{F25154BB-24FE-45A5-ACC5-F4DE14291D12}" dt="2024-09-17T12:44:43.230" v="3707" actId="478"/>
          <ac:cxnSpMkLst>
            <pc:docMk/>
            <pc:sldMk cId="1785329976" sldId="266"/>
            <ac:cxnSpMk id="67" creationId="{F58D9409-968F-D071-5216-BEBEBE0D5981}"/>
          </ac:cxnSpMkLst>
        </pc:cxnChg>
        <pc:cxnChg chg="add del mod">
          <ac:chgData name="Ilaria Laurenzana" userId="d20e3a4c-5152-4781-9a82-e8e358f0fc6e" providerId="ADAL" clId="{F25154BB-24FE-45A5-ACC5-F4DE14291D12}" dt="2024-09-17T12:44:45.441" v="3710" actId="478"/>
          <ac:cxnSpMkLst>
            <pc:docMk/>
            <pc:sldMk cId="1785329976" sldId="266"/>
            <ac:cxnSpMk id="69" creationId="{0C2F4CA2-7241-5553-20CF-B248E84FE292}"/>
          </ac:cxnSpMkLst>
        </pc:cxnChg>
      </pc:sldChg>
      <pc:sldChg chg="addSp delSp modSp mod ord">
        <pc:chgData name="Ilaria Laurenzana" userId="d20e3a4c-5152-4781-9a82-e8e358f0fc6e" providerId="ADAL" clId="{F25154BB-24FE-45A5-ACC5-F4DE14291D12}" dt="2024-09-23T08:30:58.882" v="7295" actId="20577"/>
        <pc:sldMkLst>
          <pc:docMk/>
          <pc:sldMk cId="2186378430" sldId="267"/>
        </pc:sldMkLst>
        <pc:spChg chg="add mod">
          <ac:chgData name="Ilaria Laurenzana" userId="d20e3a4c-5152-4781-9a82-e8e358f0fc6e" providerId="ADAL" clId="{F25154BB-24FE-45A5-ACC5-F4DE14291D12}" dt="2024-09-23T08:30:58.882" v="7295" actId="20577"/>
          <ac:spMkLst>
            <pc:docMk/>
            <pc:sldMk cId="2186378430" sldId="267"/>
            <ac:spMk id="3" creationId="{74FF4113-2BEA-C9E4-D8F8-05FD8346D6A6}"/>
          </ac:spMkLst>
        </pc:spChg>
        <pc:spChg chg="mod">
          <ac:chgData name="Ilaria Laurenzana" userId="d20e3a4c-5152-4781-9a82-e8e358f0fc6e" providerId="ADAL" clId="{F25154BB-24FE-45A5-ACC5-F4DE14291D12}" dt="2024-09-23T08:30:52.168" v="7292" actId="20577"/>
          <ac:spMkLst>
            <pc:docMk/>
            <pc:sldMk cId="2186378430" sldId="267"/>
            <ac:spMk id="4" creationId="{3A0595E7-1F95-EDFD-A53A-C2F1EE018F1B}"/>
          </ac:spMkLst>
        </pc:spChg>
        <pc:spChg chg="mod">
          <ac:chgData name="Ilaria Laurenzana" userId="d20e3a4c-5152-4781-9a82-e8e358f0fc6e" providerId="ADAL" clId="{F25154BB-24FE-45A5-ACC5-F4DE14291D12}" dt="2024-09-19T10:40:25.292" v="4835" actId="1076"/>
          <ac:spMkLst>
            <pc:docMk/>
            <pc:sldMk cId="2186378430" sldId="267"/>
            <ac:spMk id="5" creationId="{215DE3A2-58A0-0385-3298-EE5269C4B52F}"/>
          </ac:spMkLst>
        </pc:spChg>
        <pc:spChg chg="del mod topLvl">
          <ac:chgData name="Ilaria Laurenzana" userId="d20e3a4c-5152-4781-9a82-e8e358f0fc6e" providerId="ADAL" clId="{F25154BB-24FE-45A5-ACC5-F4DE14291D12}" dt="2024-09-09T12:00:38.464" v="233" actId="478"/>
          <ac:spMkLst>
            <pc:docMk/>
            <pc:sldMk cId="2186378430" sldId="267"/>
            <ac:spMk id="9" creationId="{23C425D1-50FF-8B4E-34DA-3A7610DB201E}"/>
          </ac:spMkLst>
        </pc:spChg>
        <pc:spChg chg="add mod">
          <ac:chgData name="Ilaria Laurenzana" userId="d20e3a4c-5152-4781-9a82-e8e358f0fc6e" providerId="ADAL" clId="{F25154BB-24FE-45A5-ACC5-F4DE14291D12}" dt="2024-09-19T10:44:10.215" v="5021" actId="1035"/>
          <ac:spMkLst>
            <pc:docMk/>
            <pc:sldMk cId="2186378430" sldId="267"/>
            <ac:spMk id="11" creationId="{1ECC4346-9AFA-39CA-6F04-47B1EE99CFF6}"/>
          </ac:spMkLst>
        </pc:spChg>
        <pc:spChg chg="del mod topLvl">
          <ac:chgData name="Ilaria Laurenzana" userId="d20e3a4c-5152-4781-9a82-e8e358f0fc6e" providerId="ADAL" clId="{F25154BB-24FE-45A5-ACC5-F4DE14291D12}" dt="2024-09-09T12:00:41.820" v="236" actId="478"/>
          <ac:spMkLst>
            <pc:docMk/>
            <pc:sldMk cId="2186378430" sldId="267"/>
            <ac:spMk id="11" creationId="{9D86445C-1B11-CFCF-AA6C-FFB792FF5FE7}"/>
          </ac:spMkLst>
        </pc:spChg>
        <pc:spChg chg="add mod">
          <ac:chgData name="Ilaria Laurenzana" userId="d20e3a4c-5152-4781-9a82-e8e358f0fc6e" providerId="ADAL" clId="{F25154BB-24FE-45A5-ACC5-F4DE14291D12}" dt="2024-09-19T10:44:04.784" v="5008" actId="1076"/>
          <ac:spMkLst>
            <pc:docMk/>
            <pc:sldMk cId="2186378430" sldId="267"/>
            <ac:spMk id="15" creationId="{996CAB75-0BC3-78EA-A6EF-3B4D6D75081B}"/>
          </ac:spMkLst>
        </pc:spChg>
        <pc:spChg chg="del mod topLvl">
          <ac:chgData name="Ilaria Laurenzana" userId="d20e3a4c-5152-4781-9a82-e8e358f0fc6e" providerId="ADAL" clId="{F25154BB-24FE-45A5-ACC5-F4DE14291D12}" dt="2024-09-09T12:00:42.479" v="237" actId="478"/>
          <ac:spMkLst>
            <pc:docMk/>
            <pc:sldMk cId="2186378430" sldId="267"/>
            <ac:spMk id="17" creationId="{54EF2A9D-D8E3-300D-FBE3-16995F3E91BD}"/>
          </ac:spMkLst>
        </pc:spChg>
        <pc:spChg chg="del mod topLvl">
          <ac:chgData name="Ilaria Laurenzana" userId="d20e3a4c-5152-4781-9a82-e8e358f0fc6e" providerId="ADAL" clId="{F25154BB-24FE-45A5-ACC5-F4DE14291D12}" dt="2024-09-09T12:00:43.539" v="238" actId="478"/>
          <ac:spMkLst>
            <pc:docMk/>
            <pc:sldMk cId="2186378430" sldId="267"/>
            <ac:spMk id="24" creationId="{766E608A-D093-EC1E-2BC2-1EA1EF4C6057}"/>
          </ac:spMkLst>
        </pc:spChg>
        <pc:spChg chg="del mod">
          <ac:chgData name="Ilaria Laurenzana" userId="d20e3a4c-5152-4781-9a82-e8e358f0fc6e" providerId="ADAL" clId="{F25154BB-24FE-45A5-ACC5-F4DE14291D12}" dt="2024-09-09T12:01:31.517" v="308" actId="478"/>
          <ac:spMkLst>
            <pc:docMk/>
            <pc:sldMk cId="2186378430" sldId="267"/>
            <ac:spMk id="26" creationId="{A790E73F-7C8E-4A10-B77C-7F21CB060A15}"/>
          </ac:spMkLst>
        </pc:spChg>
        <pc:spChg chg="del mod">
          <ac:chgData name="Ilaria Laurenzana" userId="d20e3a4c-5152-4781-9a82-e8e358f0fc6e" providerId="ADAL" clId="{F25154BB-24FE-45A5-ACC5-F4DE14291D12}" dt="2024-09-09T12:01:32.852" v="309" actId="478"/>
          <ac:spMkLst>
            <pc:docMk/>
            <pc:sldMk cId="2186378430" sldId="267"/>
            <ac:spMk id="27" creationId="{788B12CA-FE8D-0D4E-99E9-4E23A5F2AAA6}"/>
          </ac:spMkLst>
        </pc:spChg>
        <pc:spChg chg="del mod">
          <ac:chgData name="Ilaria Laurenzana" userId="d20e3a4c-5152-4781-9a82-e8e358f0fc6e" providerId="ADAL" clId="{F25154BB-24FE-45A5-ACC5-F4DE14291D12}" dt="2024-09-09T12:01:34.813" v="310" actId="478"/>
          <ac:spMkLst>
            <pc:docMk/>
            <pc:sldMk cId="2186378430" sldId="267"/>
            <ac:spMk id="29" creationId="{4376D511-8928-BD73-9237-285C9A263F8E}"/>
          </ac:spMkLst>
        </pc:spChg>
        <pc:grpChg chg="del mod">
          <ac:chgData name="Ilaria Laurenzana" userId="d20e3a4c-5152-4781-9a82-e8e358f0fc6e" providerId="ADAL" clId="{F25154BB-24FE-45A5-ACC5-F4DE14291D12}" dt="2024-09-09T12:01:31.517" v="308" actId="478"/>
          <ac:grpSpMkLst>
            <pc:docMk/>
            <pc:sldMk cId="2186378430" sldId="267"/>
            <ac:grpSpMk id="21" creationId="{B7ED3E36-20A5-562E-4907-21B892EC2456}"/>
          </ac:grpSpMkLst>
        </pc:grpChg>
        <pc:grpChg chg="del mod">
          <ac:chgData name="Ilaria Laurenzana" userId="d20e3a4c-5152-4781-9a82-e8e358f0fc6e" providerId="ADAL" clId="{F25154BB-24FE-45A5-ACC5-F4DE14291D12}" dt="2024-09-09T12:01:32.852" v="309" actId="478"/>
          <ac:grpSpMkLst>
            <pc:docMk/>
            <pc:sldMk cId="2186378430" sldId="267"/>
            <ac:grpSpMk id="22" creationId="{C90E6486-A43F-C74C-D798-215204EA4BCD}"/>
          </ac:grpSpMkLst>
        </pc:grpChg>
        <pc:grpChg chg="del mod topLvl">
          <ac:chgData name="Ilaria Laurenzana" userId="d20e3a4c-5152-4781-9a82-e8e358f0fc6e" providerId="ADAL" clId="{F25154BB-24FE-45A5-ACC5-F4DE14291D12}" dt="2024-09-09T11:56:43.835" v="91" actId="165"/>
          <ac:grpSpMkLst>
            <pc:docMk/>
            <pc:sldMk cId="2186378430" sldId="267"/>
            <ac:grpSpMk id="23" creationId="{CE939A5D-5041-CAA5-7E4E-D0FD62BF2885}"/>
          </ac:grpSpMkLst>
        </pc:grpChg>
        <pc:grpChg chg="add del mod">
          <ac:chgData name="Ilaria Laurenzana" userId="d20e3a4c-5152-4781-9a82-e8e358f0fc6e" providerId="ADAL" clId="{F25154BB-24FE-45A5-ACC5-F4DE14291D12}" dt="2024-09-09T11:56:36.190" v="89" actId="165"/>
          <ac:grpSpMkLst>
            <pc:docMk/>
            <pc:sldMk cId="2186378430" sldId="267"/>
            <ac:grpSpMk id="25" creationId="{E62EBF76-CE14-16F5-8891-71171E64C873}"/>
          </ac:grpSpMkLst>
        </pc:grpChg>
        <pc:grpChg chg="add del mod">
          <ac:chgData name="Ilaria Laurenzana" userId="d20e3a4c-5152-4781-9a82-e8e358f0fc6e" providerId="ADAL" clId="{F25154BB-24FE-45A5-ACC5-F4DE14291D12}" dt="2024-09-09T12:01:38.254" v="311" actId="165"/>
          <ac:grpSpMkLst>
            <pc:docMk/>
            <pc:sldMk cId="2186378430" sldId="267"/>
            <ac:grpSpMk id="32" creationId="{94AE6F88-768C-2BDC-71CA-50E93CCE8F3E}"/>
          </ac:grpSpMkLst>
        </pc:grpChg>
        <pc:graphicFrameChg chg="mod topLvl">
          <ac:chgData name="Ilaria Laurenzana" userId="d20e3a4c-5152-4781-9a82-e8e358f0fc6e" providerId="ADAL" clId="{F25154BB-24FE-45A5-ACC5-F4DE14291D12}" dt="2024-09-19T10:43:36.742" v="4998" actId="1036"/>
          <ac:graphicFrameMkLst>
            <pc:docMk/>
            <pc:sldMk cId="2186378430" sldId="267"/>
            <ac:graphicFrameMk id="2" creationId="{E1AACC08-B15F-95AB-00C4-27C54B846440}"/>
          </ac:graphicFrameMkLst>
        </pc:graphicFrameChg>
        <pc:graphicFrameChg chg="del mod topLvl">
          <ac:chgData name="Ilaria Laurenzana" userId="d20e3a4c-5152-4781-9a82-e8e358f0fc6e" providerId="ADAL" clId="{F25154BB-24FE-45A5-ACC5-F4DE14291D12}" dt="2024-09-10T11:44:29.585" v="901" actId="21"/>
          <ac:graphicFrameMkLst>
            <pc:docMk/>
            <pc:sldMk cId="2186378430" sldId="267"/>
            <ac:graphicFrameMk id="3" creationId="{0777DA80-7998-29E9-077A-BEFE264A1499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9T10:44:50.351" v="5128" actId="1037"/>
          <ac:graphicFrameMkLst>
            <pc:docMk/>
            <pc:sldMk cId="2186378430" sldId="267"/>
            <ac:graphicFrameMk id="6" creationId="{C1A38533-C023-12B3-DBCF-8446D6858D53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0:44:35.268" v="5066" actId="1038"/>
          <ac:graphicFrameMkLst>
            <pc:docMk/>
            <pc:sldMk cId="2186378430" sldId="267"/>
            <ac:graphicFrameMk id="7" creationId="{EED842D5-6777-7CDA-D412-897A6B524721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0:44:42.005" v="5095" actId="1038"/>
          <ac:graphicFrameMkLst>
            <pc:docMk/>
            <pc:sldMk cId="2186378430" sldId="267"/>
            <ac:graphicFrameMk id="8" creationId="{165A9C9E-BA67-9A2D-3C9F-DAC858192A70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0:45:41.634" v="5256" actId="1076"/>
          <ac:graphicFrameMkLst>
            <pc:docMk/>
            <pc:sldMk cId="2186378430" sldId="267"/>
            <ac:graphicFrameMk id="10" creationId="{69C019A2-A636-B322-4A61-635D119689CD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0:45:08.625" v="5159" actId="1076"/>
          <ac:graphicFrameMkLst>
            <pc:docMk/>
            <pc:sldMk cId="2186378430" sldId="267"/>
            <ac:graphicFrameMk id="12" creationId="{11E7EC2B-0196-4CE3-5444-5F888F74D7D2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0:45:15.915" v="5190" actId="1038"/>
          <ac:graphicFrameMkLst>
            <pc:docMk/>
            <pc:sldMk cId="2186378430" sldId="267"/>
            <ac:graphicFrameMk id="13" creationId="{CC50E2D5-4A74-5B59-F28A-0BF51D1F89F5}"/>
          </ac:graphicFrameMkLst>
        </pc:graphicFrameChg>
        <pc:graphicFrameChg chg="mod">
          <ac:chgData name="Ilaria Laurenzana" userId="d20e3a4c-5152-4781-9a82-e8e358f0fc6e" providerId="ADAL" clId="{F25154BB-24FE-45A5-ACC5-F4DE14291D12}" dt="2024-09-19T10:45:22.197" v="5213" actId="1037"/>
          <ac:graphicFrameMkLst>
            <pc:docMk/>
            <pc:sldMk cId="2186378430" sldId="267"/>
            <ac:graphicFrameMk id="14" creationId="{13D0F99B-785A-D782-1138-DD1D58A5D0E0}"/>
          </ac:graphicFrameMkLst>
        </pc:graphicFrameChg>
        <pc:graphicFrameChg chg="del mod topLvl">
          <ac:chgData name="Ilaria Laurenzana" userId="d20e3a4c-5152-4781-9a82-e8e358f0fc6e" providerId="ADAL" clId="{F25154BB-24FE-45A5-ACC5-F4DE14291D12}" dt="2024-09-10T11:44:29.585" v="901" actId="21"/>
          <ac:graphicFrameMkLst>
            <pc:docMk/>
            <pc:sldMk cId="2186378430" sldId="267"/>
            <ac:graphicFrameMk id="15" creationId="{9D267487-74B3-D946-9DCD-9F4E8E25CEAB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9T10:45:31.670" v="5254" actId="1038"/>
          <ac:graphicFrameMkLst>
            <pc:docMk/>
            <pc:sldMk cId="2186378430" sldId="267"/>
            <ac:graphicFrameMk id="16" creationId="{2E8C29C3-95FD-7EA0-BAD1-568AB976C4F9}"/>
          </ac:graphicFrameMkLst>
        </pc:graphicFrameChg>
        <pc:picChg chg="add mod">
          <ac:chgData name="Ilaria Laurenzana" userId="d20e3a4c-5152-4781-9a82-e8e358f0fc6e" providerId="ADAL" clId="{F25154BB-24FE-45A5-ACC5-F4DE14291D12}" dt="2024-09-19T10:43:51.309" v="5006" actId="1036"/>
          <ac:picMkLst>
            <pc:docMk/>
            <pc:sldMk cId="2186378430" sldId="267"/>
            <ac:picMk id="9" creationId="{295EBFE0-7143-CC6A-CC49-62672513C5B9}"/>
          </ac:picMkLst>
        </pc:picChg>
      </pc:sldChg>
      <pc:sldChg chg="addSp delSp modSp mod ord">
        <pc:chgData name="Ilaria Laurenzana" userId="d20e3a4c-5152-4781-9a82-e8e358f0fc6e" providerId="ADAL" clId="{F25154BB-24FE-45A5-ACC5-F4DE14291D12}" dt="2024-09-19T10:23:10.291" v="4798"/>
        <pc:sldMkLst>
          <pc:docMk/>
          <pc:sldMk cId="3690092758" sldId="268"/>
        </pc:sldMkLst>
        <pc:spChg chg="mod">
          <ac:chgData name="Ilaria Laurenzana" userId="d20e3a4c-5152-4781-9a82-e8e358f0fc6e" providerId="ADAL" clId="{F25154BB-24FE-45A5-ACC5-F4DE14291D12}" dt="2024-09-12T12:41:06.155" v="2675" actId="6549"/>
          <ac:spMkLst>
            <pc:docMk/>
            <pc:sldMk cId="3690092758" sldId="268"/>
            <ac:spMk id="2" creationId="{C69AAEB6-46E0-3492-CA19-2E430414C3C4}"/>
          </ac:spMkLst>
        </pc:spChg>
        <pc:spChg chg="mod">
          <ac:chgData name="Ilaria Laurenzana" userId="d20e3a4c-5152-4781-9a82-e8e358f0fc6e" providerId="ADAL" clId="{F25154BB-24FE-45A5-ACC5-F4DE14291D12}" dt="2024-09-12T12:41:03.629" v="2674" actId="6549"/>
          <ac:spMkLst>
            <pc:docMk/>
            <pc:sldMk cId="3690092758" sldId="268"/>
            <ac:spMk id="3" creationId="{2A27B85F-4D93-D7A0-7355-27CD6DC5C7E6}"/>
          </ac:spMkLst>
        </pc:spChg>
        <pc:spChg chg="mod">
          <ac:chgData name="Ilaria Laurenzana" userId="d20e3a4c-5152-4781-9a82-e8e358f0fc6e" providerId="ADAL" clId="{F25154BB-24FE-45A5-ACC5-F4DE14291D12}" dt="2024-09-12T09:58:14.386" v="2234" actId="20577"/>
          <ac:spMkLst>
            <pc:docMk/>
            <pc:sldMk cId="3690092758" sldId="268"/>
            <ac:spMk id="6" creationId="{248E34C9-FF70-85AE-BBD4-7940C183F8C4}"/>
          </ac:spMkLst>
        </pc:spChg>
        <pc:spChg chg="mod">
          <ac:chgData name="Ilaria Laurenzana" userId="d20e3a4c-5152-4781-9a82-e8e358f0fc6e" providerId="ADAL" clId="{F25154BB-24FE-45A5-ACC5-F4DE14291D12}" dt="2024-09-10T11:46:25.663" v="906" actId="165"/>
          <ac:spMkLst>
            <pc:docMk/>
            <pc:sldMk cId="3690092758" sldId="268"/>
            <ac:spMk id="32" creationId="{E162FF99-4EF3-265E-7E3B-D25C09D2146F}"/>
          </ac:spMkLst>
        </pc:spChg>
        <pc:spChg chg="mod">
          <ac:chgData name="Ilaria Laurenzana" userId="d20e3a4c-5152-4781-9a82-e8e358f0fc6e" providerId="ADAL" clId="{F25154BB-24FE-45A5-ACC5-F4DE14291D12}" dt="2024-09-10T11:46:25.663" v="906" actId="165"/>
          <ac:spMkLst>
            <pc:docMk/>
            <pc:sldMk cId="3690092758" sldId="268"/>
            <ac:spMk id="33" creationId="{42914F2E-1942-6718-0A73-6E2C97164B68}"/>
          </ac:spMkLst>
        </pc:spChg>
        <pc:spChg chg="mod topLvl">
          <ac:chgData name="Ilaria Laurenzana" userId="d20e3a4c-5152-4781-9a82-e8e358f0fc6e" providerId="ADAL" clId="{F25154BB-24FE-45A5-ACC5-F4DE14291D12}" dt="2024-09-12T10:30:45.436" v="2239" actId="255"/>
          <ac:spMkLst>
            <pc:docMk/>
            <pc:sldMk cId="3690092758" sldId="268"/>
            <ac:spMk id="37" creationId="{169953DE-0B54-71AE-A1CE-CC1F90488181}"/>
          </ac:spMkLst>
        </pc:spChg>
        <pc:spChg chg="mod topLvl">
          <ac:chgData name="Ilaria Laurenzana" userId="d20e3a4c-5152-4781-9a82-e8e358f0fc6e" providerId="ADAL" clId="{F25154BB-24FE-45A5-ACC5-F4DE14291D12}" dt="2024-09-12T10:30:45.436" v="2239" actId="255"/>
          <ac:spMkLst>
            <pc:docMk/>
            <pc:sldMk cId="3690092758" sldId="268"/>
            <ac:spMk id="38" creationId="{7B852479-ABF6-3BCC-227C-121B92000E8A}"/>
          </ac:spMkLst>
        </pc:spChg>
        <pc:spChg chg="mod topLvl">
          <ac:chgData name="Ilaria Laurenzana" userId="d20e3a4c-5152-4781-9a82-e8e358f0fc6e" providerId="ADAL" clId="{F25154BB-24FE-45A5-ACC5-F4DE14291D12}" dt="2024-09-12T10:30:45.436" v="2239" actId="255"/>
          <ac:spMkLst>
            <pc:docMk/>
            <pc:sldMk cId="3690092758" sldId="268"/>
            <ac:spMk id="40" creationId="{14CA7ADE-71A4-31B1-3851-40237D131431}"/>
          </ac:spMkLst>
        </pc:spChg>
        <pc:spChg chg="mod">
          <ac:chgData name="Ilaria Laurenzana" userId="d20e3a4c-5152-4781-9a82-e8e358f0fc6e" providerId="ADAL" clId="{F25154BB-24FE-45A5-ACC5-F4DE14291D12}" dt="2024-09-12T10:30:31.114" v="2238" actId="255"/>
          <ac:spMkLst>
            <pc:docMk/>
            <pc:sldMk cId="3690092758" sldId="268"/>
            <ac:spMk id="46" creationId="{3A46CCD2-D042-3621-5BB4-19C5408681ED}"/>
          </ac:spMkLst>
        </pc:spChg>
        <pc:spChg chg="mod topLvl">
          <ac:chgData name="Ilaria Laurenzana" userId="d20e3a4c-5152-4781-9a82-e8e358f0fc6e" providerId="ADAL" clId="{F25154BB-24FE-45A5-ACC5-F4DE14291D12}" dt="2024-09-12T10:30:45.436" v="2239" actId="255"/>
          <ac:spMkLst>
            <pc:docMk/>
            <pc:sldMk cId="3690092758" sldId="268"/>
            <ac:spMk id="47" creationId="{B4313EE2-825E-B2B9-616E-ECBAFF2CD87D}"/>
          </ac:spMkLst>
        </pc:spChg>
        <pc:spChg chg="mod">
          <ac:chgData name="Ilaria Laurenzana" userId="d20e3a4c-5152-4781-9a82-e8e358f0fc6e" providerId="ADAL" clId="{F25154BB-24FE-45A5-ACC5-F4DE14291D12}" dt="2024-09-10T11:46:25.663" v="906" actId="165"/>
          <ac:spMkLst>
            <pc:docMk/>
            <pc:sldMk cId="3690092758" sldId="268"/>
            <ac:spMk id="48" creationId="{31E1E643-0320-A628-ABBC-B3968A2FFBB4}"/>
          </ac:spMkLst>
        </pc:spChg>
        <pc:spChg chg="mod">
          <ac:chgData name="Ilaria Laurenzana" userId="d20e3a4c-5152-4781-9a82-e8e358f0fc6e" providerId="ADAL" clId="{F25154BB-24FE-45A5-ACC5-F4DE14291D12}" dt="2024-09-18T13:01:22.066" v="4634" actId="13926"/>
          <ac:spMkLst>
            <pc:docMk/>
            <pc:sldMk cId="3690092758" sldId="268"/>
            <ac:spMk id="49" creationId="{271BA922-8DE3-B2C1-9FA2-FBD78A6F2367}"/>
          </ac:spMkLst>
        </pc:spChg>
        <pc:spChg chg="mod">
          <ac:chgData name="Ilaria Laurenzana" userId="d20e3a4c-5152-4781-9a82-e8e358f0fc6e" providerId="ADAL" clId="{F25154BB-24FE-45A5-ACC5-F4DE14291D12}" dt="2024-09-10T11:46:25.663" v="906" actId="165"/>
          <ac:spMkLst>
            <pc:docMk/>
            <pc:sldMk cId="3690092758" sldId="268"/>
            <ac:spMk id="50" creationId="{27E31C64-AD89-19C8-F451-9ABFAF7F731D}"/>
          </ac:spMkLst>
        </pc:spChg>
        <pc:spChg chg="mod topLvl">
          <ac:chgData name="Ilaria Laurenzana" userId="d20e3a4c-5152-4781-9a82-e8e358f0fc6e" providerId="ADAL" clId="{F25154BB-24FE-45A5-ACC5-F4DE14291D12}" dt="2024-09-12T10:07:04.057" v="2236" actId="14100"/>
          <ac:spMkLst>
            <pc:docMk/>
            <pc:sldMk cId="3690092758" sldId="268"/>
            <ac:spMk id="55" creationId="{5E0F924D-AC9A-13B9-CF3A-AF400C13C22D}"/>
          </ac:spMkLst>
        </pc:spChg>
        <pc:spChg chg="del">
          <ac:chgData name="Ilaria Laurenzana" userId="d20e3a4c-5152-4781-9a82-e8e358f0fc6e" providerId="ADAL" clId="{F25154BB-24FE-45A5-ACC5-F4DE14291D12}" dt="2024-09-09T12:09:32.676" v="412" actId="478"/>
          <ac:spMkLst>
            <pc:docMk/>
            <pc:sldMk cId="3690092758" sldId="268"/>
            <ac:spMk id="62" creationId="{E0B9599A-5616-E1B6-770F-C67751F004E2}"/>
          </ac:spMkLst>
        </pc:spChg>
        <pc:spChg chg="del">
          <ac:chgData name="Ilaria Laurenzana" userId="d20e3a4c-5152-4781-9a82-e8e358f0fc6e" providerId="ADAL" clId="{F25154BB-24FE-45A5-ACC5-F4DE14291D12}" dt="2024-09-09T12:09:26.522" v="411" actId="478"/>
          <ac:spMkLst>
            <pc:docMk/>
            <pc:sldMk cId="3690092758" sldId="268"/>
            <ac:spMk id="63" creationId="{4E865456-B907-40D0-98CC-1BD867606A9E}"/>
          </ac:spMkLst>
        </pc:spChg>
        <pc:spChg chg="mod">
          <ac:chgData name="Ilaria Laurenzana" userId="d20e3a4c-5152-4781-9a82-e8e358f0fc6e" providerId="ADAL" clId="{F25154BB-24FE-45A5-ACC5-F4DE14291D12}" dt="2024-09-10T11:47:45.492" v="1185" actId="1038"/>
          <ac:spMkLst>
            <pc:docMk/>
            <pc:sldMk cId="3690092758" sldId="268"/>
            <ac:spMk id="64" creationId="{36F296DC-7E7D-5F4C-0641-CC36A309A64F}"/>
          </ac:spMkLst>
        </pc:spChg>
        <pc:spChg chg="mod">
          <ac:chgData name="Ilaria Laurenzana" userId="d20e3a4c-5152-4781-9a82-e8e358f0fc6e" providerId="ADAL" clId="{F25154BB-24FE-45A5-ACC5-F4DE14291D12}" dt="2024-09-10T11:47:24.815" v="1083" actId="1037"/>
          <ac:spMkLst>
            <pc:docMk/>
            <pc:sldMk cId="3690092758" sldId="268"/>
            <ac:spMk id="65" creationId="{30E7914C-5B03-0D66-2B4E-70DD711956EC}"/>
          </ac:spMkLst>
        </pc:spChg>
        <pc:spChg chg="mod">
          <ac:chgData name="Ilaria Laurenzana" userId="d20e3a4c-5152-4781-9a82-e8e358f0fc6e" providerId="ADAL" clId="{F25154BB-24FE-45A5-ACC5-F4DE14291D12}" dt="2024-09-10T11:47:41.925" v="1184" actId="1038"/>
          <ac:spMkLst>
            <pc:docMk/>
            <pc:sldMk cId="3690092758" sldId="268"/>
            <ac:spMk id="66" creationId="{208671CF-C121-4D9C-F96F-5FF9BB42622F}"/>
          </ac:spMkLst>
        </pc:spChg>
        <pc:spChg chg="mod">
          <ac:chgData name="Ilaria Laurenzana" userId="d20e3a4c-5152-4781-9a82-e8e358f0fc6e" providerId="ADAL" clId="{F25154BB-24FE-45A5-ACC5-F4DE14291D12}" dt="2024-09-10T11:47:24.815" v="1083" actId="1037"/>
          <ac:spMkLst>
            <pc:docMk/>
            <pc:sldMk cId="3690092758" sldId="268"/>
            <ac:spMk id="67" creationId="{840D8B0B-F771-DCCA-F15F-BF932C1AA6D9}"/>
          </ac:spMkLst>
        </pc:spChg>
        <pc:grpChg chg="mod topLvl">
          <ac:chgData name="Ilaria Laurenzana" userId="d20e3a4c-5152-4781-9a82-e8e358f0fc6e" providerId="ADAL" clId="{F25154BB-24FE-45A5-ACC5-F4DE14291D12}" dt="2024-09-10T11:47:45.492" v="1185" actId="1038"/>
          <ac:grpSpMkLst>
            <pc:docMk/>
            <pc:sldMk cId="3690092758" sldId="268"/>
            <ac:grpSpMk id="51" creationId="{16ED50ED-962C-AD07-A565-D9E658B06C76}"/>
          </ac:grpSpMkLst>
        </pc:grpChg>
        <pc:grpChg chg="mod topLvl">
          <ac:chgData name="Ilaria Laurenzana" userId="d20e3a4c-5152-4781-9a82-e8e358f0fc6e" providerId="ADAL" clId="{F25154BB-24FE-45A5-ACC5-F4DE14291D12}" dt="2024-09-10T11:47:24.815" v="1083" actId="1037"/>
          <ac:grpSpMkLst>
            <pc:docMk/>
            <pc:sldMk cId="3690092758" sldId="268"/>
            <ac:grpSpMk id="52" creationId="{50B86645-24C8-69E2-5288-382FC786EC24}"/>
          </ac:grpSpMkLst>
        </pc:grpChg>
        <pc:grpChg chg="mod topLvl">
          <ac:chgData name="Ilaria Laurenzana" userId="d20e3a4c-5152-4781-9a82-e8e358f0fc6e" providerId="ADAL" clId="{F25154BB-24FE-45A5-ACC5-F4DE14291D12}" dt="2024-09-10T11:47:41.925" v="1184" actId="1038"/>
          <ac:grpSpMkLst>
            <pc:docMk/>
            <pc:sldMk cId="3690092758" sldId="268"/>
            <ac:grpSpMk id="53" creationId="{2A87D1F0-9B68-B180-B79E-AE00356169FA}"/>
          </ac:grpSpMkLst>
        </pc:grpChg>
        <pc:grpChg chg="mod topLvl">
          <ac:chgData name="Ilaria Laurenzana" userId="d20e3a4c-5152-4781-9a82-e8e358f0fc6e" providerId="ADAL" clId="{F25154BB-24FE-45A5-ACC5-F4DE14291D12}" dt="2024-09-10T11:47:24.815" v="1083" actId="1037"/>
          <ac:grpSpMkLst>
            <pc:docMk/>
            <pc:sldMk cId="3690092758" sldId="268"/>
            <ac:grpSpMk id="54" creationId="{18318325-C7D2-6E12-2856-1432C1023BCC}"/>
          </ac:grpSpMkLst>
        </pc:grpChg>
        <pc:grpChg chg="del mod">
          <ac:chgData name="Ilaria Laurenzana" userId="d20e3a4c-5152-4781-9a82-e8e358f0fc6e" providerId="ADAL" clId="{F25154BB-24FE-45A5-ACC5-F4DE14291D12}" dt="2024-09-10T11:46:25.663" v="906" actId="165"/>
          <ac:grpSpMkLst>
            <pc:docMk/>
            <pc:sldMk cId="3690092758" sldId="268"/>
            <ac:grpSpMk id="56" creationId="{C1233FAB-BC96-2CE5-002B-9EA7B82DAAE0}"/>
          </ac:grpSpMkLst>
        </pc:grpChg>
        <pc:grpChg chg="del">
          <ac:chgData name="Ilaria Laurenzana" userId="d20e3a4c-5152-4781-9a82-e8e358f0fc6e" providerId="ADAL" clId="{F25154BB-24FE-45A5-ACC5-F4DE14291D12}" dt="2024-09-09T12:09:14.031" v="407" actId="21"/>
          <ac:grpSpMkLst>
            <pc:docMk/>
            <pc:sldMk cId="3690092758" sldId="268"/>
            <ac:grpSpMk id="57" creationId="{90505CDF-1FE7-EF69-C066-A06D42EDC955}"/>
          </ac:grpSpMkLst>
        </pc:grpChg>
        <pc:grpChg chg="del">
          <ac:chgData name="Ilaria Laurenzana" userId="d20e3a4c-5152-4781-9a82-e8e358f0fc6e" providerId="ADAL" clId="{F25154BB-24FE-45A5-ACC5-F4DE14291D12}" dt="2024-09-09T12:09:14.031" v="407" actId="21"/>
          <ac:grpSpMkLst>
            <pc:docMk/>
            <pc:sldMk cId="3690092758" sldId="268"/>
            <ac:grpSpMk id="58" creationId="{591905B3-C149-8CC5-AAAB-AF90F17E035B}"/>
          </ac:grpSpMkLst>
        </pc:grpChg>
        <pc:grpChg chg="del">
          <ac:chgData name="Ilaria Laurenzana" userId="d20e3a4c-5152-4781-9a82-e8e358f0fc6e" providerId="ADAL" clId="{F25154BB-24FE-45A5-ACC5-F4DE14291D12}" dt="2024-09-09T12:09:14.031" v="407" actId="21"/>
          <ac:grpSpMkLst>
            <pc:docMk/>
            <pc:sldMk cId="3690092758" sldId="268"/>
            <ac:grpSpMk id="59" creationId="{FF9E7A87-0B91-F259-40A3-3D691F62488B}"/>
          </ac:grpSpMkLst>
        </pc:grpChg>
        <pc:grpChg chg="mod">
          <ac:chgData name="Ilaria Laurenzana" userId="d20e3a4c-5152-4781-9a82-e8e358f0fc6e" providerId="ADAL" clId="{F25154BB-24FE-45A5-ACC5-F4DE14291D12}" dt="2024-09-09T12:10:12.911" v="536" actId="1076"/>
          <ac:grpSpMkLst>
            <pc:docMk/>
            <pc:sldMk cId="3690092758" sldId="268"/>
            <ac:grpSpMk id="60" creationId="{875F20ED-7384-D3DE-8DC5-BD147D809390}"/>
          </ac:grpSpMkLst>
        </pc:grpChg>
        <pc:grpChg chg="del">
          <ac:chgData name="Ilaria Laurenzana" userId="d20e3a4c-5152-4781-9a82-e8e358f0fc6e" providerId="ADAL" clId="{F25154BB-24FE-45A5-ACC5-F4DE14291D12}" dt="2024-09-09T12:09:14.031" v="407" actId="21"/>
          <ac:grpSpMkLst>
            <pc:docMk/>
            <pc:sldMk cId="3690092758" sldId="268"/>
            <ac:grpSpMk id="61" creationId="{84A86395-B5E8-3820-73DB-92924E32B8EB}"/>
          </ac:grpSpMkLst>
        </pc:grpChg>
        <pc:graphicFrameChg chg="mod topLvl">
          <ac:chgData name="Ilaria Laurenzana" userId="d20e3a4c-5152-4781-9a82-e8e358f0fc6e" providerId="ADAL" clId="{F25154BB-24FE-45A5-ACC5-F4DE14291D12}" dt="2024-09-10T11:47:45.492" v="1185" actId="1038"/>
          <ac:graphicFrameMkLst>
            <pc:docMk/>
            <pc:sldMk cId="3690092758" sldId="268"/>
            <ac:graphicFrameMk id="7" creationId="{2961F93D-E098-144C-B685-E7486C837D08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0T11:47:24.815" v="1083" actId="1037"/>
          <ac:graphicFrameMkLst>
            <pc:docMk/>
            <pc:sldMk cId="3690092758" sldId="268"/>
            <ac:graphicFrameMk id="8" creationId="{0D3E8308-7FBF-B9BE-8414-960138CCC694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0T11:47:41.925" v="1184" actId="1038"/>
          <ac:graphicFrameMkLst>
            <pc:docMk/>
            <pc:sldMk cId="3690092758" sldId="268"/>
            <ac:graphicFrameMk id="9" creationId="{9B391BAC-5F10-5D71-FF26-4EB703E30567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10T11:47:24.815" v="1083" actId="1037"/>
          <ac:graphicFrameMkLst>
            <pc:docMk/>
            <pc:sldMk cId="3690092758" sldId="268"/>
            <ac:graphicFrameMk id="10" creationId="{BC8556AE-BF1E-B839-17D2-B54B37031268}"/>
          </ac:graphicFrameMkLst>
        </pc:graphicFrameChg>
        <pc:graphicFrameChg chg="mod">
          <ac:chgData name="Ilaria Laurenzana" userId="d20e3a4c-5152-4781-9a82-e8e358f0fc6e" providerId="ADAL" clId="{F25154BB-24FE-45A5-ACC5-F4DE14291D12}" dt="2024-09-12T10:31:25.722" v="2241" actId="1076"/>
          <ac:graphicFrameMkLst>
            <pc:docMk/>
            <pc:sldMk cId="3690092758" sldId="268"/>
            <ac:graphicFrameMk id="25" creationId="{0D9326A1-AA6A-0674-39C5-DD761610D17A}"/>
          </ac:graphicFrameMkLst>
        </pc:graphicFrameChg>
        <pc:graphicFrameChg chg="mod">
          <ac:chgData name="Ilaria Laurenzana" userId="d20e3a4c-5152-4781-9a82-e8e358f0fc6e" providerId="ADAL" clId="{F25154BB-24FE-45A5-ACC5-F4DE14291D12}" dt="2024-09-10T11:46:25.663" v="906" actId="165"/>
          <ac:graphicFrameMkLst>
            <pc:docMk/>
            <pc:sldMk cId="3690092758" sldId="268"/>
            <ac:graphicFrameMk id="30" creationId="{41784D3C-606D-F895-5BD1-475E2B6FE801}"/>
          </ac:graphicFrameMkLst>
        </pc:graphicFrameChg>
        <pc:graphicFrameChg chg="mod">
          <ac:chgData name="Ilaria Laurenzana" userId="d20e3a4c-5152-4781-9a82-e8e358f0fc6e" providerId="ADAL" clId="{F25154BB-24FE-45A5-ACC5-F4DE14291D12}" dt="2024-09-10T11:46:25.663" v="906" actId="165"/>
          <ac:graphicFrameMkLst>
            <pc:docMk/>
            <pc:sldMk cId="3690092758" sldId="268"/>
            <ac:graphicFrameMk id="34" creationId="{85617275-3196-E449-6918-327A4857EF87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09:49.979" v="468" actId="1076"/>
          <ac:graphicFrameMkLst>
            <pc:docMk/>
            <pc:sldMk cId="3690092758" sldId="268"/>
            <ac:graphicFrameMk id="35" creationId="{E2301DC4-65C0-E712-63E6-84639A8F5E75}"/>
          </ac:graphicFrameMkLst>
        </pc:graphicFrameChg>
        <pc:graphicFrameChg chg="mod">
          <ac:chgData name="Ilaria Laurenzana" userId="d20e3a4c-5152-4781-9a82-e8e358f0fc6e" providerId="ADAL" clId="{F25154BB-24FE-45A5-ACC5-F4DE14291D12}" dt="2024-09-10T11:46:32.286" v="908" actId="1076"/>
          <ac:graphicFrameMkLst>
            <pc:docMk/>
            <pc:sldMk cId="3690092758" sldId="268"/>
            <ac:graphicFrameMk id="36" creationId="{B13359BE-94D0-85F9-B9BA-636743F90AAF}"/>
          </ac:graphicFrameMkLst>
        </pc:graphicFrameChg>
        <pc:picChg chg="add mod modCrop">
          <ac:chgData name="Ilaria Laurenzana" userId="d20e3a4c-5152-4781-9a82-e8e358f0fc6e" providerId="ADAL" clId="{F25154BB-24FE-45A5-ACC5-F4DE14291D12}" dt="2024-09-16T09:30:03.174" v="2699" actId="14100"/>
          <ac:picMkLst>
            <pc:docMk/>
            <pc:sldMk cId="3690092758" sldId="268"/>
            <ac:picMk id="4" creationId="{BDD359B2-B8DF-A836-E9D2-B19C44D255AA}"/>
          </ac:picMkLst>
        </pc:picChg>
      </pc:sldChg>
      <pc:sldChg chg="addSp delSp modSp mod ord">
        <pc:chgData name="Ilaria Laurenzana" userId="d20e3a4c-5152-4781-9a82-e8e358f0fc6e" providerId="ADAL" clId="{F25154BB-24FE-45A5-ACC5-F4DE14291D12}" dt="2024-09-23T08:55:55.054" v="7319" actId="20577"/>
        <pc:sldMkLst>
          <pc:docMk/>
          <pc:sldMk cId="220276941" sldId="269"/>
        </pc:sldMkLst>
        <pc:spChg chg="add mod">
          <ac:chgData name="Ilaria Laurenzana" userId="d20e3a4c-5152-4781-9a82-e8e358f0fc6e" providerId="ADAL" clId="{F25154BB-24FE-45A5-ACC5-F4DE14291D12}" dt="2024-09-23T08:55:55.054" v="7319" actId="20577"/>
          <ac:spMkLst>
            <pc:docMk/>
            <pc:sldMk cId="220276941" sldId="269"/>
            <ac:spMk id="2" creationId="{9D624420-34C3-E417-184E-F512597865AB}"/>
          </ac:spMkLst>
        </pc:spChg>
        <pc:spChg chg="mod">
          <ac:chgData name="Ilaria Laurenzana" userId="d20e3a4c-5152-4781-9a82-e8e358f0fc6e" providerId="ADAL" clId="{F25154BB-24FE-45A5-ACC5-F4DE14291D12}" dt="2024-09-23T08:55:49.907" v="7316" actId="20577"/>
          <ac:spMkLst>
            <pc:docMk/>
            <pc:sldMk cId="220276941" sldId="269"/>
            <ac:spMk id="6" creationId="{248E34C9-FF70-85AE-BBD4-7940C183F8C4}"/>
          </ac:spMkLst>
        </pc:spChg>
        <pc:spChg chg="mod">
          <ac:chgData name="Ilaria Laurenzana" userId="d20e3a4c-5152-4781-9a82-e8e358f0fc6e" providerId="ADAL" clId="{F25154BB-24FE-45A5-ACC5-F4DE14291D12}" dt="2024-09-18T13:02:40.695" v="4679" actId="13926"/>
          <ac:spMkLst>
            <pc:docMk/>
            <pc:sldMk cId="220276941" sldId="269"/>
            <ac:spMk id="27" creationId="{FDBCF8BA-1E3D-CCEC-390A-BA8910E7EDB4}"/>
          </ac:spMkLst>
        </pc:spChg>
        <pc:spChg chg="del mod topLvl">
          <ac:chgData name="Ilaria Laurenzana" userId="d20e3a4c-5152-4781-9a82-e8e358f0fc6e" providerId="ADAL" clId="{F25154BB-24FE-45A5-ACC5-F4DE14291D12}" dt="2024-09-09T12:12:02.315" v="620" actId="478"/>
          <ac:spMkLst>
            <pc:docMk/>
            <pc:sldMk cId="220276941" sldId="269"/>
            <ac:spMk id="39" creationId="{84F6441B-E5C7-28DE-137E-899A62CB7135}"/>
          </ac:spMkLst>
        </pc:spChg>
        <pc:spChg chg="del mod topLvl">
          <ac:chgData name="Ilaria Laurenzana" userId="d20e3a4c-5152-4781-9a82-e8e358f0fc6e" providerId="ADAL" clId="{F25154BB-24FE-45A5-ACC5-F4DE14291D12}" dt="2024-09-09T12:11:14.614" v="550" actId="478"/>
          <ac:spMkLst>
            <pc:docMk/>
            <pc:sldMk cId="220276941" sldId="269"/>
            <ac:spMk id="41" creationId="{324845C3-B446-8455-C5C7-C4009F601496}"/>
          </ac:spMkLst>
        </pc:spChg>
        <pc:spChg chg="del mod topLvl">
          <ac:chgData name="Ilaria Laurenzana" userId="d20e3a4c-5152-4781-9a82-e8e358f0fc6e" providerId="ADAL" clId="{F25154BB-24FE-45A5-ACC5-F4DE14291D12}" dt="2024-09-09T12:11:16.518" v="551" actId="478"/>
          <ac:spMkLst>
            <pc:docMk/>
            <pc:sldMk cId="220276941" sldId="269"/>
            <ac:spMk id="42" creationId="{9A5E23ED-34A5-DF0D-B1B0-4B85C61C3458}"/>
          </ac:spMkLst>
        </pc:spChg>
        <pc:spChg chg="del mod topLvl">
          <ac:chgData name="Ilaria Laurenzana" userId="d20e3a4c-5152-4781-9a82-e8e358f0fc6e" providerId="ADAL" clId="{F25154BB-24FE-45A5-ACC5-F4DE14291D12}" dt="2024-09-09T12:12:05.652" v="621" actId="478"/>
          <ac:spMkLst>
            <pc:docMk/>
            <pc:sldMk cId="220276941" sldId="269"/>
            <ac:spMk id="44" creationId="{68812554-A442-A2EC-0358-3D9301B2D86C}"/>
          </ac:spMkLst>
        </pc:spChg>
        <pc:grpChg chg="add del mod">
          <ac:chgData name="Ilaria Laurenzana" userId="d20e3a4c-5152-4781-9a82-e8e358f0fc6e" providerId="ADAL" clId="{F25154BB-24FE-45A5-ACC5-F4DE14291D12}" dt="2024-09-09T12:11:14.614" v="550" actId="478"/>
          <ac:grpSpMkLst>
            <pc:docMk/>
            <pc:sldMk cId="220276941" sldId="269"/>
            <ac:grpSpMk id="57" creationId="{90505CDF-1FE7-EF69-C066-A06D42EDC955}"/>
          </ac:grpSpMkLst>
        </pc:grpChg>
        <pc:grpChg chg="add del mod">
          <ac:chgData name="Ilaria Laurenzana" userId="d20e3a4c-5152-4781-9a82-e8e358f0fc6e" providerId="ADAL" clId="{F25154BB-24FE-45A5-ACC5-F4DE14291D12}" dt="2024-09-09T12:11:16.518" v="551" actId="478"/>
          <ac:grpSpMkLst>
            <pc:docMk/>
            <pc:sldMk cId="220276941" sldId="269"/>
            <ac:grpSpMk id="58" creationId="{591905B3-C149-8CC5-AAAB-AF90F17E035B}"/>
          </ac:grpSpMkLst>
        </pc:grpChg>
        <pc:grpChg chg="add del mod">
          <ac:chgData name="Ilaria Laurenzana" userId="d20e3a4c-5152-4781-9a82-e8e358f0fc6e" providerId="ADAL" clId="{F25154BB-24FE-45A5-ACC5-F4DE14291D12}" dt="2024-09-09T12:12:05.652" v="621" actId="478"/>
          <ac:grpSpMkLst>
            <pc:docMk/>
            <pc:sldMk cId="220276941" sldId="269"/>
            <ac:grpSpMk id="59" creationId="{FF9E7A87-0B91-F259-40A3-3D691F62488B}"/>
          </ac:grpSpMkLst>
        </pc:grpChg>
        <pc:grpChg chg="add del mod">
          <ac:chgData name="Ilaria Laurenzana" userId="d20e3a4c-5152-4781-9a82-e8e358f0fc6e" providerId="ADAL" clId="{F25154BB-24FE-45A5-ACC5-F4DE14291D12}" dt="2024-09-09T12:12:02.315" v="620" actId="478"/>
          <ac:grpSpMkLst>
            <pc:docMk/>
            <pc:sldMk cId="220276941" sldId="269"/>
            <ac:grpSpMk id="61" creationId="{84A86395-B5E8-3820-73DB-92924E32B8EB}"/>
          </ac:grpSpMkLst>
        </pc:grpChg>
        <pc:graphicFrameChg chg="mod">
          <ac:chgData name="Ilaria Laurenzana" userId="d20e3a4c-5152-4781-9a82-e8e358f0fc6e" providerId="ADAL" clId="{F25154BB-24FE-45A5-ACC5-F4DE14291D12}" dt="2024-09-09T12:11:42.072" v="558" actId="1076"/>
          <ac:graphicFrameMkLst>
            <pc:docMk/>
            <pc:sldMk cId="220276941" sldId="269"/>
            <ac:graphicFrameMk id="4" creationId="{AB0443C3-56A3-DD00-D4B0-97E0072C3A73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11:57.381" v="618" actId="1076"/>
          <ac:graphicFrameMkLst>
            <pc:docMk/>
            <pc:sldMk cId="220276941" sldId="269"/>
            <ac:graphicFrameMk id="12" creationId="{371068CF-E7B2-F08B-FB24-ADC21C08470B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12:11.276" v="623" actId="1076"/>
          <ac:graphicFrameMkLst>
            <pc:docMk/>
            <pc:sldMk cId="220276941" sldId="269"/>
            <ac:graphicFrameMk id="13" creationId="{1FD2C73D-2A6D-2451-1E41-F0940CA4BDD8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09T12:11:18.927" v="552" actId="1076"/>
          <ac:graphicFrameMkLst>
            <pc:docMk/>
            <pc:sldMk cId="220276941" sldId="269"/>
            <ac:graphicFrameMk id="26" creationId="{D7627F5F-52E0-1259-3EC3-9B2C5293D312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09T12:11:32.455" v="555" actId="1076"/>
          <ac:graphicFrameMkLst>
            <pc:docMk/>
            <pc:sldMk cId="220276941" sldId="269"/>
            <ac:graphicFrameMk id="28" creationId="{7B856D7E-0A05-08A6-9FA2-8489D5E7E927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09T12:12:09.644" v="622" actId="1076"/>
          <ac:graphicFrameMkLst>
            <pc:docMk/>
            <pc:sldMk cId="220276941" sldId="269"/>
            <ac:graphicFrameMk id="29" creationId="{F36F7873-114D-A802-9053-D73C84E012DD}"/>
          </ac:graphicFrameMkLst>
        </pc:graphicFrameChg>
        <pc:graphicFrameChg chg="mod topLvl">
          <ac:chgData name="Ilaria Laurenzana" userId="d20e3a4c-5152-4781-9a82-e8e358f0fc6e" providerId="ADAL" clId="{F25154BB-24FE-45A5-ACC5-F4DE14291D12}" dt="2024-09-09T12:12:02.315" v="620" actId="478"/>
          <ac:graphicFrameMkLst>
            <pc:docMk/>
            <pc:sldMk cId="220276941" sldId="269"/>
            <ac:graphicFrameMk id="31" creationId="{0F36D14D-BB0B-C297-A939-B046E0F358A3}"/>
          </ac:graphicFrameMkLst>
        </pc:graphicFrameChg>
      </pc:sldChg>
      <pc:sldChg chg="addSp delSp modSp mod ord">
        <pc:chgData name="Ilaria Laurenzana" userId="d20e3a4c-5152-4781-9a82-e8e358f0fc6e" providerId="ADAL" clId="{F25154BB-24FE-45A5-ACC5-F4DE14291D12}" dt="2024-09-19T10:23:31.031" v="4810"/>
        <pc:sldMkLst>
          <pc:docMk/>
          <pc:sldMk cId="3128085413" sldId="272"/>
        </pc:sldMkLst>
        <pc:spChg chg="add del mod">
          <ac:chgData name="Ilaria Laurenzana" userId="d20e3a4c-5152-4781-9a82-e8e358f0fc6e" providerId="ADAL" clId="{F25154BB-24FE-45A5-ACC5-F4DE14291D12}" dt="2024-09-11T10:33:55.037" v="1321" actId="478"/>
          <ac:spMkLst>
            <pc:docMk/>
            <pc:sldMk cId="3128085413" sldId="272"/>
            <ac:spMk id="2" creationId="{C40F217A-B852-409B-8837-2B6D71DCD898}"/>
          </ac:spMkLst>
        </pc:spChg>
        <pc:spChg chg="add del mod">
          <ac:chgData name="Ilaria Laurenzana" userId="d20e3a4c-5152-4781-9a82-e8e358f0fc6e" providerId="ADAL" clId="{F25154BB-24FE-45A5-ACC5-F4DE14291D12}" dt="2024-09-11T10:34:29.557" v="1340" actId="478"/>
          <ac:spMkLst>
            <pc:docMk/>
            <pc:sldMk cId="3128085413" sldId="272"/>
            <ac:spMk id="3" creationId="{4CE0CF21-5BFF-6223-FB08-FA47707A2A4D}"/>
          </ac:spMkLst>
        </pc:spChg>
        <pc:spChg chg="mod">
          <ac:chgData name="Ilaria Laurenzana" userId="d20e3a4c-5152-4781-9a82-e8e358f0fc6e" providerId="ADAL" clId="{F25154BB-24FE-45A5-ACC5-F4DE14291D12}" dt="2024-09-12T10:40:56.030" v="2609" actId="20577"/>
          <ac:spMkLst>
            <pc:docMk/>
            <pc:sldMk cId="3128085413" sldId="272"/>
            <ac:spMk id="4" creationId="{8567EAFD-19EE-C8F6-E13F-3AE99187F495}"/>
          </ac:spMkLst>
        </pc:spChg>
        <pc:spChg chg="add mod">
          <ac:chgData name="Ilaria Laurenzana" userId="d20e3a4c-5152-4781-9a82-e8e358f0fc6e" providerId="ADAL" clId="{F25154BB-24FE-45A5-ACC5-F4DE14291D12}" dt="2024-09-12T10:35:48.293" v="2340" actId="164"/>
          <ac:spMkLst>
            <pc:docMk/>
            <pc:sldMk cId="3128085413" sldId="272"/>
            <ac:spMk id="5" creationId="{218280F7-156E-E103-C96E-F04AFB015D8E}"/>
          </ac:spMkLst>
        </pc:spChg>
        <pc:spChg chg="add mod">
          <ac:chgData name="Ilaria Laurenzana" userId="d20e3a4c-5152-4781-9a82-e8e358f0fc6e" providerId="ADAL" clId="{F25154BB-24FE-45A5-ACC5-F4DE14291D12}" dt="2024-09-12T10:38:16.383" v="2478" actId="164"/>
          <ac:spMkLst>
            <pc:docMk/>
            <pc:sldMk cId="3128085413" sldId="272"/>
            <ac:spMk id="6" creationId="{4005B75C-5630-F41C-7782-32E3F59590B7}"/>
          </ac:spMkLst>
        </pc:spChg>
        <pc:spChg chg="add del">
          <ac:chgData name="Ilaria Laurenzana" userId="d20e3a4c-5152-4781-9a82-e8e358f0fc6e" providerId="ADAL" clId="{F25154BB-24FE-45A5-ACC5-F4DE14291D12}" dt="2024-09-09T12:05:29.200" v="366" actId="21"/>
          <ac:spMkLst>
            <pc:docMk/>
            <pc:sldMk cId="3128085413" sldId="272"/>
            <ac:spMk id="7" creationId="{F455EB89-A21A-4828-C9E6-7B65F36CDF4F}"/>
          </ac:spMkLst>
        </pc:spChg>
        <pc:spChg chg="mod">
          <ac:chgData name="Ilaria Laurenzana" userId="d20e3a4c-5152-4781-9a82-e8e358f0fc6e" providerId="ADAL" clId="{F25154BB-24FE-45A5-ACC5-F4DE14291D12}" dt="2024-09-12T12:41:13.280" v="2676" actId="6549"/>
          <ac:spMkLst>
            <pc:docMk/>
            <pc:sldMk cId="3128085413" sldId="272"/>
            <ac:spMk id="14" creationId="{A94AD31E-3591-B7F4-13E9-BEEE9B38EDC8}"/>
          </ac:spMkLst>
        </pc:spChg>
        <pc:spChg chg="del mod">
          <ac:chgData name="Ilaria Laurenzana" userId="d20e3a4c-5152-4781-9a82-e8e358f0fc6e" providerId="ADAL" clId="{F25154BB-24FE-45A5-ACC5-F4DE14291D12}" dt="2024-09-09T12:12:42.050" v="631" actId="478"/>
          <ac:spMkLst>
            <pc:docMk/>
            <pc:sldMk cId="3128085413" sldId="272"/>
            <ac:spMk id="15" creationId="{57BFC1FE-C4EE-22EA-B34D-40A276A5BFE5}"/>
          </ac:spMkLst>
        </pc:spChg>
        <pc:spChg chg="del">
          <ac:chgData name="Ilaria Laurenzana" userId="d20e3a4c-5152-4781-9a82-e8e358f0fc6e" providerId="ADAL" clId="{F25154BB-24FE-45A5-ACC5-F4DE14291D12}" dt="2024-09-09T12:05:29.200" v="366" actId="21"/>
          <ac:spMkLst>
            <pc:docMk/>
            <pc:sldMk cId="3128085413" sldId="272"/>
            <ac:spMk id="16" creationId="{72C6981E-22C4-5196-EECE-FF9DFCB64E51}"/>
          </ac:spMkLst>
        </pc:spChg>
        <pc:spChg chg="del">
          <ac:chgData name="Ilaria Laurenzana" userId="d20e3a4c-5152-4781-9a82-e8e358f0fc6e" providerId="ADAL" clId="{F25154BB-24FE-45A5-ACC5-F4DE14291D12}" dt="2024-09-09T12:05:29.200" v="366" actId="21"/>
          <ac:spMkLst>
            <pc:docMk/>
            <pc:sldMk cId="3128085413" sldId="272"/>
            <ac:spMk id="17" creationId="{A94B07F5-1B5B-2C8D-938F-F7AE2C541A09}"/>
          </ac:spMkLst>
        </pc:spChg>
        <pc:spChg chg="del">
          <ac:chgData name="Ilaria Laurenzana" userId="d20e3a4c-5152-4781-9a82-e8e358f0fc6e" providerId="ADAL" clId="{F25154BB-24FE-45A5-ACC5-F4DE14291D12}" dt="2024-09-09T12:05:29.200" v="366" actId="21"/>
          <ac:spMkLst>
            <pc:docMk/>
            <pc:sldMk cId="3128085413" sldId="272"/>
            <ac:spMk id="18" creationId="{617667FC-1058-FFE0-2BC1-6D9B5C134825}"/>
          </ac:spMkLst>
        </pc:spChg>
        <pc:spChg chg="del mod">
          <ac:chgData name="Ilaria Laurenzana" userId="d20e3a4c-5152-4781-9a82-e8e358f0fc6e" providerId="ADAL" clId="{F25154BB-24FE-45A5-ACC5-F4DE14291D12}" dt="2024-09-09T12:13:40.963" v="668" actId="478"/>
          <ac:spMkLst>
            <pc:docMk/>
            <pc:sldMk cId="3128085413" sldId="272"/>
            <ac:spMk id="29" creationId="{85AA02CE-481B-4485-FDA5-75D53C2E48F4}"/>
          </ac:spMkLst>
        </pc:spChg>
        <pc:spChg chg="mod">
          <ac:chgData name="Ilaria Laurenzana" userId="d20e3a4c-5152-4781-9a82-e8e358f0fc6e" providerId="ADAL" clId="{F25154BB-24FE-45A5-ACC5-F4DE14291D12}" dt="2024-09-12T10:38:13.147" v="2477" actId="164"/>
          <ac:spMkLst>
            <pc:docMk/>
            <pc:sldMk cId="3128085413" sldId="272"/>
            <ac:spMk id="30" creationId="{262B3970-155E-B0E4-83B1-654F75F2D9AB}"/>
          </ac:spMkLst>
        </pc:spChg>
        <pc:spChg chg="mod">
          <ac:chgData name="Ilaria Laurenzana" userId="d20e3a4c-5152-4781-9a82-e8e358f0fc6e" providerId="ADAL" clId="{F25154BB-24FE-45A5-ACC5-F4DE14291D12}" dt="2024-09-12T10:38:10.119" v="2476" actId="164"/>
          <ac:spMkLst>
            <pc:docMk/>
            <pc:sldMk cId="3128085413" sldId="272"/>
            <ac:spMk id="31" creationId="{6BE513E1-DACD-3C03-7B8F-06AF02161C46}"/>
          </ac:spMkLst>
        </pc:spChg>
        <pc:spChg chg="mod">
          <ac:chgData name="Ilaria Laurenzana" userId="d20e3a4c-5152-4781-9a82-e8e358f0fc6e" providerId="ADAL" clId="{F25154BB-24FE-45A5-ACC5-F4DE14291D12}" dt="2024-09-12T10:35:52.028" v="2341" actId="164"/>
          <ac:spMkLst>
            <pc:docMk/>
            <pc:sldMk cId="3128085413" sldId="272"/>
            <ac:spMk id="32" creationId="{2D3A521A-A159-E5D9-A3D4-EEEDC24D4EFA}"/>
          </ac:spMkLst>
        </pc:spChg>
        <pc:spChg chg="del mod">
          <ac:chgData name="Ilaria Laurenzana" userId="d20e3a4c-5152-4781-9a82-e8e358f0fc6e" providerId="ADAL" clId="{F25154BB-24FE-45A5-ACC5-F4DE14291D12}" dt="2024-09-09T12:13:53.652" v="670" actId="478"/>
          <ac:spMkLst>
            <pc:docMk/>
            <pc:sldMk cId="3128085413" sldId="272"/>
            <ac:spMk id="33" creationId="{601EFD19-FD06-E000-872D-898033402471}"/>
          </ac:spMkLst>
        </pc:spChg>
        <pc:spChg chg="mod">
          <ac:chgData name="Ilaria Laurenzana" userId="d20e3a4c-5152-4781-9a82-e8e358f0fc6e" providerId="ADAL" clId="{F25154BB-24FE-45A5-ACC5-F4DE14291D12}" dt="2024-09-12T10:35:55.417" v="2342" actId="164"/>
          <ac:spMkLst>
            <pc:docMk/>
            <pc:sldMk cId="3128085413" sldId="272"/>
            <ac:spMk id="34" creationId="{F21CF923-7492-E7FA-9CF5-8E637A6DCC43}"/>
          </ac:spMkLst>
        </pc:spChg>
        <pc:spChg chg="mod">
          <ac:chgData name="Ilaria Laurenzana" userId="d20e3a4c-5152-4781-9a82-e8e358f0fc6e" providerId="ADAL" clId="{F25154BB-24FE-45A5-ACC5-F4DE14291D12}" dt="2024-09-12T10:39:07.163" v="2544" actId="1035"/>
          <ac:spMkLst>
            <pc:docMk/>
            <pc:sldMk cId="3128085413" sldId="272"/>
            <ac:spMk id="35" creationId="{6486318A-08F3-ABF5-D1E4-BDF52DC8F23E}"/>
          </ac:spMkLst>
        </pc:spChg>
        <pc:spChg chg="mod">
          <ac:chgData name="Ilaria Laurenzana" userId="d20e3a4c-5152-4781-9a82-e8e358f0fc6e" providerId="ADAL" clId="{F25154BB-24FE-45A5-ACC5-F4DE14291D12}" dt="2024-09-12T12:41:14.690" v="2677" actId="6549"/>
          <ac:spMkLst>
            <pc:docMk/>
            <pc:sldMk cId="3128085413" sldId="272"/>
            <ac:spMk id="39" creationId="{B9A912C4-56EA-3849-C463-6FC2CCDDEE9B}"/>
          </ac:spMkLst>
        </pc:spChg>
        <pc:spChg chg="mod">
          <ac:chgData name="Ilaria Laurenzana" userId="d20e3a4c-5152-4781-9a82-e8e358f0fc6e" providerId="ADAL" clId="{F25154BB-24FE-45A5-ACC5-F4DE14291D12}" dt="2024-09-12T10:40:37.444" v="2597" actId="14100"/>
          <ac:spMkLst>
            <pc:docMk/>
            <pc:sldMk cId="3128085413" sldId="272"/>
            <ac:spMk id="41" creationId="{B81A2319-93CE-B822-A578-4250FABFFDF7}"/>
          </ac:spMkLst>
        </pc:spChg>
        <pc:spChg chg="mod">
          <ac:chgData name="Ilaria Laurenzana" userId="d20e3a4c-5152-4781-9a82-e8e358f0fc6e" providerId="ADAL" clId="{F25154BB-24FE-45A5-ACC5-F4DE14291D12}" dt="2024-09-12T10:40:31.432" v="2595" actId="164"/>
          <ac:spMkLst>
            <pc:docMk/>
            <pc:sldMk cId="3128085413" sldId="272"/>
            <ac:spMk id="43" creationId="{572C30F1-FD41-BFB7-98A9-5EF115E7FDAF}"/>
          </ac:spMkLst>
        </pc:spChg>
        <pc:grpChg chg="add mod">
          <ac:chgData name="Ilaria Laurenzana" userId="d20e3a4c-5152-4781-9a82-e8e358f0fc6e" providerId="ADAL" clId="{F25154BB-24FE-45A5-ACC5-F4DE14291D12}" dt="2024-09-12T10:39:07.163" v="2544" actId="1035"/>
          <ac:grpSpMkLst>
            <pc:docMk/>
            <pc:sldMk cId="3128085413" sldId="272"/>
            <ac:grpSpMk id="2" creationId="{F04AC78F-1A37-20A2-701D-6035AF3CCB5C}"/>
          </ac:grpSpMkLst>
        </pc:grpChg>
        <pc:grpChg chg="add mod">
          <ac:chgData name="Ilaria Laurenzana" userId="d20e3a4c-5152-4781-9a82-e8e358f0fc6e" providerId="ADAL" clId="{F25154BB-24FE-45A5-ACC5-F4DE14291D12}" dt="2024-09-12T10:39:07.163" v="2544" actId="1035"/>
          <ac:grpSpMkLst>
            <pc:docMk/>
            <pc:sldMk cId="3128085413" sldId="272"/>
            <ac:grpSpMk id="3" creationId="{DEC64243-9304-EA6B-9894-6485116E38F0}"/>
          </ac:grpSpMkLst>
        </pc:grpChg>
        <pc:grpChg chg="add mod">
          <ac:chgData name="Ilaria Laurenzana" userId="d20e3a4c-5152-4781-9a82-e8e358f0fc6e" providerId="ADAL" clId="{F25154BB-24FE-45A5-ACC5-F4DE14291D12}" dt="2024-09-12T10:39:07.163" v="2544" actId="1035"/>
          <ac:grpSpMkLst>
            <pc:docMk/>
            <pc:sldMk cId="3128085413" sldId="272"/>
            <ac:grpSpMk id="7" creationId="{AA5E06C1-2714-7540-FBDE-D629A3262839}"/>
          </ac:grpSpMkLst>
        </pc:grpChg>
        <pc:grpChg chg="add mod">
          <ac:chgData name="Ilaria Laurenzana" userId="d20e3a4c-5152-4781-9a82-e8e358f0fc6e" providerId="ADAL" clId="{F25154BB-24FE-45A5-ACC5-F4DE14291D12}" dt="2024-09-12T10:39:07.163" v="2544" actId="1035"/>
          <ac:grpSpMkLst>
            <pc:docMk/>
            <pc:sldMk cId="3128085413" sldId="272"/>
            <ac:grpSpMk id="8" creationId="{F9C273D6-3D40-A7C7-C538-D3A36B5655E2}"/>
          </ac:grpSpMkLst>
        </pc:grpChg>
        <pc:grpChg chg="add mod">
          <ac:chgData name="Ilaria Laurenzana" userId="d20e3a4c-5152-4781-9a82-e8e358f0fc6e" providerId="ADAL" clId="{F25154BB-24FE-45A5-ACC5-F4DE14291D12}" dt="2024-09-12T10:39:07.163" v="2544" actId="1035"/>
          <ac:grpSpMkLst>
            <pc:docMk/>
            <pc:sldMk cId="3128085413" sldId="272"/>
            <ac:grpSpMk id="9" creationId="{B59C13F3-2AD3-57AF-1E5D-8DC8F0F5DD8A}"/>
          </ac:grpSpMkLst>
        </pc:grpChg>
        <pc:grpChg chg="add mod">
          <ac:chgData name="Ilaria Laurenzana" userId="d20e3a4c-5152-4781-9a82-e8e358f0fc6e" providerId="ADAL" clId="{F25154BB-24FE-45A5-ACC5-F4DE14291D12}" dt="2024-09-12T10:39:07.163" v="2544" actId="1035"/>
          <ac:grpSpMkLst>
            <pc:docMk/>
            <pc:sldMk cId="3128085413" sldId="272"/>
            <ac:grpSpMk id="10" creationId="{BF62B064-60D8-C514-B922-E8B16C3F8085}"/>
          </ac:grpSpMkLst>
        </pc:grpChg>
        <pc:grpChg chg="add mod">
          <ac:chgData name="Ilaria Laurenzana" userId="d20e3a4c-5152-4781-9a82-e8e358f0fc6e" providerId="ADAL" clId="{F25154BB-24FE-45A5-ACC5-F4DE14291D12}" dt="2024-09-12T10:40:41.646" v="2607" actId="1036"/>
          <ac:grpSpMkLst>
            <pc:docMk/>
            <pc:sldMk cId="3128085413" sldId="272"/>
            <ac:grpSpMk id="11" creationId="{B929F7AB-E00D-1E36-B59A-D9013970A237}"/>
          </ac:grpSpMkLst>
        </pc:grpChg>
        <pc:graphicFrameChg chg="mod">
          <ac:chgData name="Ilaria Laurenzana" userId="d20e3a4c-5152-4781-9a82-e8e358f0fc6e" providerId="ADAL" clId="{F25154BB-24FE-45A5-ACC5-F4DE14291D12}" dt="2024-09-12T10:40:31.432" v="2595" actId="164"/>
          <ac:graphicFrameMkLst>
            <pc:docMk/>
            <pc:sldMk cId="3128085413" sldId="272"/>
            <ac:graphicFrameMk id="42" creationId="{04C9B572-AB91-DF7F-4157-ED5E3418E2D0}"/>
          </ac:graphicFrameMkLst>
        </pc:graphicFrameChg>
        <pc:picChg chg="add del">
          <ac:chgData name="Ilaria Laurenzana" userId="d20e3a4c-5152-4781-9a82-e8e358f0fc6e" providerId="ADAL" clId="{F25154BB-24FE-45A5-ACC5-F4DE14291D12}" dt="2024-09-09T12:05:29.200" v="366" actId="21"/>
          <ac:picMkLst>
            <pc:docMk/>
            <pc:sldMk cId="3128085413" sldId="272"/>
            <ac:picMk id="6" creationId="{084EFF21-D1FA-C833-8FC1-FA2DCB5BB0D2}"/>
          </ac:picMkLst>
        </pc:picChg>
        <pc:picChg chg="add del">
          <ac:chgData name="Ilaria Laurenzana" userId="d20e3a4c-5152-4781-9a82-e8e358f0fc6e" providerId="ADAL" clId="{F25154BB-24FE-45A5-ACC5-F4DE14291D12}" dt="2024-09-09T12:05:29.200" v="366" actId="21"/>
          <ac:picMkLst>
            <pc:docMk/>
            <pc:sldMk cId="3128085413" sldId="272"/>
            <ac:picMk id="9" creationId="{C2D9225F-880C-E527-1C8B-B6B553894625}"/>
          </ac:picMkLst>
        </pc:picChg>
        <pc:picChg chg="add del">
          <ac:chgData name="Ilaria Laurenzana" userId="d20e3a4c-5152-4781-9a82-e8e358f0fc6e" providerId="ADAL" clId="{F25154BB-24FE-45A5-ACC5-F4DE14291D12}" dt="2024-09-09T12:05:29.200" v="366" actId="21"/>
          <ac:picMkLst>
            <pc:docMk/>
            <pc:sldMk cId="3128085413" sldId="272"/>
            <ac:picMk id="10" creationId="{3E6B9AA7-A744-EFC7-6906-9B1B266136A1}"/>
          </ac:picMkLst>
        </pc:picChg>
        <pc:picChg chg="add del mod modCrop">
          <ac:chgData name="Ilaria Laurenzana" userId="d20e3a4c-5152-4781-9a82-e8e358f0fc6e" providerId="ADAL" clId="{F25154BB-24FE-45A5-ACC5-F4DE14291D12}" dt="2024-09-12T10:38:16.383" v="2478" actId="164"/>
          <ac:picMkLst>
            <pc:docMk/>
            <pc:sldMk cId="3128085413" sldId="272"/>
            <ac:picMk id="22" creationId="{422A0A00-8277-FEAA-F842-4B56AB8F424F}"/>
          </ac:picMkLst>
        </pc:picChg>
        <pc:picChg chg="mod modCrop">
          <ac:chgData name="Ilaria Laurenzana" userId="d20e3a4c-5152-4781-9a82-e8e358f0fc6e" providerId="ADAL" clId="{F25154BB-24FE-45A5-ACC5-F4DE14291D12}" dt="2024-09-12T10:38:13.147" v="2477" actId="164"/>
          <ac:picMkLst>
            <pc:docMk/>
            <pc:sldMk cId="3128085413" sldId="272"/>
            <ac:picMk id="23" creationId="{58B2CD0E-6AE7-15A6-1A2B-E4FC8044E7BE}"/>
          </ac:picMkLst>
        </pc:picChg>
        <pc:picChg chg="mod modCrop">
          <ac:chgData name="Ilaria Laurenzana" userId="d20e3a4c-5152-4781-9a82-e8e358f0fc6e" providerId="ADAL" clId="{F25154BB-24FE-45A5-ACC5-F4DE14291D12}" dt="2024-09-12T10:35:52.028" v="2341" actId="164"/>
          <ac:picMkLst>
            <pc:docMk/>
            <pc:sldMk cId="3128085413" sldId="272"/>
            <ac:picMk id="24" creationId="{52FDBE7D-B536-EE77-F88B-A0E2917A7732}"/>
          </ac:picMkLst>
        </pc:picChg>
        <pc:picChg chg="add del mod modCrop">
          <ac:chgData name="Ilaria Laurenzana" userId="d20e3a4c-5152-4781-9a82-e8e358f0fc6e" providerId="ADAL" clId="{F25154BB-24FE-45A5-ACC5-F4DE14291D12}" dt="2024-09-12T10:35:48.293" v="2340" actId="164"/>
          <ac:picMkLst>
            <pc:docMk/>
            <pc:sldMk cId="3128085413" sldId="272"/>
            <ac:picMk id="25" creationId="{091ADF6E-D16A-8F2A-E4DA-A3C462C1F411}"/>
          </ac:picMkLst>
        </pc:picChg>
        <pc:picChg chg="mod modCrop">
          <ac:chgData name="Ilaria Laurenzana" userId="d20e3a4c-5152-4781-9a82-e8e358f0fc6e" providerId="ADAL" clId="{F25154BB-24FE-45A5-ACC5-F4DE14291D12}" dt="2024-09-12T10:38:10.119" v="2476" actId="164"/>
          <ac:picMkLst>
            <pc:docMk/>
            <pc:sldMk cId="3128085413" sldId="272"/>
            <ac:picMk id="27" creationId="{E2880639-7B4E-1C45-DE01-9005D40D6360}"/>
          </ac:picMkLst>
        </pc:picChg>
        <pc:picChg chg="mod">
          <ac:chgData name="Ilaria Laurenzana" userId="d20e3a4c-5152-4781-9a82-e8e358f0fc6e" providerId="ADAL" clId="{F25154BB-24FE-45A5-ACC5-F4DE14291D12}" dt="2024-09-12T10:35:55.417" v="2342" actId="164"/>
          <ac:picMkLst>
            <pc:docMk/>
            <pc:sldMk cId="3128085413" sldId="272"/>
            <ac:picMk id="28" creationId="{0DE283E0-93B7-61E2-CA44-5D58041786C1}"/>
          </ac:picMkLst>
        </pc:picChg>
      </pc:sldChg>
      <pc:sldChg chg="addSp delSp modSp mod ord">
        <pc:chgData name="Ilaria Laurenzana" userId="d20e3a4c-5152-4781-9a82-e8e358f0fc6e" providerId="ADAL" clId="{F25154BB-24FE-45A5-ACC5-F4DE14291D12}" dt="2024-09-23T08:56:05.961" v="7325" actId="20577"/>
        <pc:sldMkLst>
          <pc:docMk/>
          <pc:sldMk cId="302162955" sldId="273"/>
        </pc:sldMkLst>
        <pc:spChg chg="add mod">
          <ac:chgData name="Ilaria Laurenzana" userId="d20e3a4c-5152-4781-9a82-e8e358f0fc6e" providerId="ADAL" clId="{F25154BB-24FE-45A5-ACC5-F4DE14291D12}" dt="2024-09-23T08:56:05.961" v="7325" actId="20577"/>
          <ac:spMkLst>
            <pc:docMk/>
            <pc:sldMk cId="302162955" sldId="273"/>
            <ac:spMk id="2" creationId="{14DA2553-C8D1-DD73-0966-0144DFF9F5F9}"/>
          </ac:spMkLst>
        </pc:spChg>
        <pc:spChg chg="del">
          <ac:chgData name="Ilaria Laurenzana" userId="d20e3a4c-5152-4781-9a82-e8e358f0fc6e" providerId="ADAL" clId="{F25154BB-24FE-45A5-ACC5-F4DE14291D12}" dt="2024-09-09T12:15:14.175" v="686" actId="478"/>
          <ac:spMkLst>
            <pc:docMk/>
            <pc:sldMk cId="302162955" sldId="273"/>
            <ac:spMk id="2" creationId="{AEF20D4B-111E-8002-337F-2837432F098B}"/>
          </ac:spMkLst>
        </pc:spChg>
        <pc:spChg chg="mod">
          <ac:chgData name="Ilaria Laurenzana" userId="d20e3a4c-5152-4781-9a82-e8e358f0fc6e" providerId="ADAL" clId="{F25154BB-24FE-45A5-ACC5-F4DE14291D12}" dt="2024-09-23T08:56:00.124" v="7322" actId="20577"/>
          <ac:spMkLst>
            <pc:docMk/>
            <pc:sldMk cId="302162955" sldId="273"/>
            <ac:spMk id="5" creationId="{07CCE871-86F8-59B4-78CF-BAD355831141}"/>
          </ac:spMkLst>
        </pc:spChg>
        <pc:spChg chg="mod">
          <ac:chgData name="Ilaria Laurenzana" userId="d20e3a4c-5152-4781-9a82-e8e358f0fc6e" providerId="ADAL" clId="{F25154BB-24FE-45A5-ACC5-F4DE14291D12}" dt="2024-09-12T10:51:29.439" v="2611" actId="2711"/>
          <ac:spMkLst>
            <pc:docMk/>
            <pc:sldMk cId="302162955" sldId="273"/>
            <ac:spMk id="7" creationId="{FDDB23E3-7221-C7F2-7EE5-DD399E0F1BBB}"/>
          </ac:spMkLst>
        </pc:spChg>
        <pc:spChg chg="add mod">
          <ac:chgData name="Ilaria Laurenzana" userId="d20e3a4c-5152-4781-9a82-e8e358f0fc6e" providerId="ADAL" clId="{F25154BB-24FE-45A5-ACC5-F4DE14291D12}" dt="2024-09-12T10:51:29.439" v="2611" actId="2711"/>
          <ac:spMkLst>
            <pc:docMk/>
            <pc:sldMk cId="302162955" sldId="273"/>
            <ac:spMk id="15" creationId="{E4828BED-2413-A931-44FA-DB4B6F258D22}"/>
          </ac:spMkLst>
        </pc:spChg>
        <pc:spChg chg="mod">
          <ac:chgData name="Ilaria Laurenzana" userId="d20e3a4c-5152-4781-9a82-e8e358f0fc6e" providerId="ADAL" clId="{F25154BB-24FE-45A5-ACC5-F4DE14291D12}" dt="2024-09-09T12:16:45.965" v="740"/>
          <ac:spMkLst>
            <pc:docMk/>
            <pc:sldMk cId="302162955" sldId="273"/>
            <ac:spMk id="28" creationId="{CB5E0252-A86E-FBC7-4D7C-D94B1419DEFB}"/>
          </ac:spMkLst>
        </pc:spChg>
        <pc:spChg chg="mod">
          <ac:chgData name="Ilaria Laurenzana" userId="d20e3a4c-5152-4781-9a82-e8e358f0fc6e" providerId="ADAL" clId="{F25154BB-24FE-45A5-ACC5-F4DE14291D12}" dt="2024-09-09T12:16:45.965" v="740"/>
          <ac:spMkLst>
            <pc:docMk/>
            <pc:sldMk cId="302162955" sldId="273"/>
            <ac:spMk id="36" creationId="{356F7818-40FB-001F-0A8C-5FB4A202AFE8}"/>
          </ac:spMkLst>
        </pc:spChg>
        <pc:spChg chg="mod">
          <ac:chgData name="Ilaria Laurenzana" userId="d20e3a4c-5152-4781-9a82-e8e358f0fc6e" providerId="ADAL" clId="{F25154BB-24FE-45A5-ACC5-F4DE14291D12}" dt="2024-09-09T12:16:45.965" v="740"/>
          <ac:spMkLst>
            <pc:docMk/>
            <pc:sldMk cId="302162955" sldId="273"/>
            <ac:spMk id="38" creationId="{5206509B-3D8F-1BF1-55EB-A8822E6E15A6}"/>
          </ac:spMkLst>
        </pc:spChg>
        <pc:spChg chg="mod">
          <ac:chgData name="Ilaria Laurenzana" userId="d20e3a4c-5152-4781-9a82-e8e358f0fc6e" providerId="ADAL" clId="{F25154BB-24FE-45A5-ACC5-F4DE14291D12}" dt="2024-09-09T12:16:45.965" v="740"/>
          <ac:spMkLst>
            <pc:docMk/>
            <pc:sldMk cId="302162955" sldId="273"/>
            <ac:spMk id="40" creationId="{83263F09-DB0E-B246-6C80-5C3367D111B6}"/>
          </ac:spMkLst>
        </pc:spChg>
        <pc:grpChg chg="add mod">
          <ac:chgData name="Ilaria Laurenzana" userId="d20e3a4c-5152-4781-9a82-e8e358f0fc6e" providerId="ADAL" clId="{F25154BB-24FE-45A5-ACC5-F4DE14291D12}" dt="2024-09-09T12:18:03.823" v="839" actId="1035"/>
          <ac:grpSpMkLst>
            <pc:docMk/>
            <pc:sldMk cId="302162955" sldId="273"/>
            <ac:grpSpMk id="35" creationId="{970DC4A2-9CB1-CA3D-2F83-C0B4C1868A82}"/>
          </ac:grpSpMkLst>
        </pc:grpChg>
        <pc:grpChg chg="add mod">
          <ac:chgData name="Ilaria Laurenzana" userId="d20e3a4c-5152-4781-9a82-e8e358f0fc6e" providerId="ADAL" clId="{F25154BB-24FE-45A5-ACC5-F4DE14291D12}" dt="2024-09-09T12:18:03.823" v="839" actId="1035"/>
          <ac:grpSpMkLst>
            <pc:docMk/>
            <pc:sldMk cId="302162955" sldId="273"/>
            <ac:grpSpMk id="37" creationId="{ED461D77-E4FF-E994-9645-D0CFB555FDA2}"/>
          </ac:grpSpMkLst>
        </pc:grpChg>
        <pc:grpChg chg="add mod">
          <ac:chgData name="Ilaria Laurenzana" userId="d20e3a4c-5152-4781-9a82-e8e358f0fc6e" providerId="ADAL" clId="{F25154BB-24FE-45A5-ACC5-F4DE14291D12}" dt="2024-09-09T12:18:03.823" v="839" actId="1035"/>
          <ac:grpSpMkLst>
            <pc:docMk/>
            <pc:sldMk cId="302162955" sldId="273"/>
            <ac:grpSpMk id="39" creationId="{BF33CB5B-1AB5-C0DE-501D-ED54DD0B4978}"/>
          </ac:grpSpMkLst>
        </pc:grpChg>
        <pc:grpChg chg="add mod">
          <ac:chgData name="Ilaria Laurenzana" userId="d20e3a4c-5152-4781-9a82-e8e358f0fc6e" providerId="ADAL" clId="{F25154BB-24FE-45A5-ACC5-F4DE14291D12}" dt="2024-09-09T12:18:03.823" v="839" actId="1035"/>
          <ac:grpSpMkLst>
            <pc:docMk/>
            <pc:sldMk cId="302162955" sldId="273"/>
            <ac:grpSpMk id="41" creationId="{72219C42-5CA5-20D8-EDF6-85E3DAB728BB}"/>
          </ac:grpSpMkLst>
        </pc:grpChg>
        <pc:graphicFrameChg chg="add mod">
          <ac:chgData name="Ilaria Laurenzana" userId="d20e3a4c-5152-4781-9a82-e8e358f0fc6e" providerId="ADAL" clId="{F25154BB-24FE-45A5-ACC5-F4DE14291D12}" dt="2024-09-09T12:18:03.823" v="839" actId="1035"/>
          <ac:graphicFrameMkLst>
            <pc:docMk/>
            <pc:sldMk cId="302162955" sldId="273"/>
            <ac:graphicFrameMk id="16" creationId="{65BFF04D-5662-6D2E-45E3-4816C930D052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2:18:03.823" v="839" actId="1035"/>
          <ac:graphicFrameMkLst>
            <pc:docMk/>
            <pc:sldMk cId="302162955" sldId="273"/>
            <ac:graphicFrameMk id="23" creationId="{71CFEBA4-B308-FBD4-7126-9FB11F8D0093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2:18:03.823" v="839" actId="1035"/>
          <ac:graphicFrameMkLst>
            <pc:docMk/>
            <pc:sldMk cId="302162955" sldId="273"/>
            <ac:graphicFrameMk id="24" creationId="{484D4AF2-294D-2495-101F-A3EB222FF32B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2:18:03.823" v="839" actId="1035"/>
          <ac:graphicFrameMkLst>
            <pc:docMk/>
            <pc:sldMk cId="302162955" sldId="273"/>
            <ac:graphicFrameMk id="26" creationId="{25A1B6DC-820F-9E2D-9758-0742FA86E9EE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2:18:03.823" v="839" actId="1035"/>
          <ac:graphicFrameMkLst>
            <pc:docMk/>
            <pc:sldMk cId="302162955" sldId="273"/>
            <ac:graphicFrameMk id="27" creationId="{398408B7-7E79-AB12-507A-DE428709A32D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16:45.965" v="740"/>
          <ac:graphicFrameMkLst>
            <pc:docMk/>
            <pc:sldMk cId="302162955" sldId="273"/>
            <ac:graphicFrameMk id="29" creationId="{708D6EEE-05EF-3400-6D94-66C9FF5582E9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16:45.965" v="740"/>
          <ac:graphicFrameMkLst>
            <pc:docMk/>
            <pc:sldMk cId="302162955" sldId="273"/>
            <ac:graphicFrameMk id="30" creationId="{DB8DECCF-6B0B-AEA0-0EFD-3F2A8CE7F97A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2:18:03.823" v="839" actId="1035"/>
          <ac:graphicFrameMkLst>
            <pc:docMk/>
            <pc:sldMk cId="302162955" sldId="273"/>
            <ac:graphicFrameMk id="31" creationId="{E51715AE-C2A9-7D8F-DABC-3DA9B4CFC829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16:45.965" v="740"/>
          <ac:graphicFrameMkLst>
            <pc:docMk/>
            <pc:sldMk cId="302162955" sldId="273"/>
            <ac:graphicFrameMk id="32" creationId="{FB2B996D-482A-5CFD-2436-BFBF4175E190}"/>
          </ac:graphicFrameMkLst>
        </pc:graphicFrameChg>
        <pc:graphicFrameChg chg="mod">
          <ac:chgData name="Ilaria Laurenzana" userId="d20e3a4c-5152-4781-9a82-e8e358f0fc6e" providerId="ADAL" clId="{F25154BB-24FE-45A5-ACC5-F4DE14291D12}" dt="2024-09-09T12:16:45.965" v="740"/>
          <ac:graphicFrameMkLst>
            <pc:docMk/>
            <pc:sldMk cId="302162955" sldId="273"/>
            <ac:graphicFrameMk id="33" creationId="{937EF13E-1687-EF44-EED6-F05CA12FAD04}"/>
          </ac:graphicFrameMkLst>
        </pc:graphicFrameChg>
        <pc:graphicFrameChg chg="add mod">
          <ac:chgData name="Ilaria Laurenzana" userId="d20e3a4c-5152-4781-9a82-e8e358f0fc6e" providerId="ADAL" clId="{F25154BB-24FE-45A5-ACC5-F4DE14291D12}" dt="2024-09-09T12:18:03.823" v="839" actId="1035"/>
          <ac:graphicFrameMkLst>
            <pc:docMk/>
            <pc:sldMk cId="302162955" sldId="273"/>
            <ac:graphicFrameMk id="34" creationId="{2879F0C6-DB5A-D498-1394-B13F54F48584}"/>
          </ac:graphicFrameMkLst>
        </pc:graphicFrameChg>
        <pc:picChg chg="mod">
          <ac:chgData name="Ilaria Laurenzana" userId="d20e3a4c-5152-4781-9a82-e8e358f0fc6e" providerId="ADAL" clId="{F25154BB-24FE-45A5-ACC5-F4DE14291D12}" dt="2024-09-12T10:51:49.920" v="2618" actId="1037"/>
          <ac:picMkLst>
            <pc:docMk/>
            <pc:sldMk cId="302162955" sldId="273"/>
            <ac:picMk id="3" creationId="{E16383EE-7F2B-EAAA-060F-F37554F20F4E}"/>
          </ac:picMkLst>
        </pc:picChg>
        <pc:picChg chg="mod">
          <ac:chgData name="Ilaria Laurenzana" userId="d20e3a4c-5152-4781-9a82-e8e358f0fc6e" providerId="ADAL" clId="{F25154BB-24FE-45A5-ACC5-F4DE14291D12}" dt="2024-09-12T10:52:02.173" v="2658" actId="1038"/>
          <ac:picMkLst>
            <pc:docMk/>
            <pc:sldMk cId="302162955" sldId="273"/>
            <ac:picMk id="4" creationId="{839C1FF8-9A58-4C32-C569-11E339B66E2A}"/>
          </ac:picMkLst>
        </pc:picChg>
        <pc:picChg chg="mod">
          <ac:chgData name="Ilaria Laurenzana" userId="d20e3a4c-5152-4781-9a82-e8e358f0fc6e" providerId="ADAL" clId="{F25154BB-24FE-45A5-ACC5-F4DE14291D12}" dt="2024-09-12T10:51:43.573" v="2612" actId="14100"/>
          <ac:picMkLst>
            <pc:docMk/>
            <pc:sldMk cId="302162955" sldId="273"/>
            <ac:picMk id="6" creationId="{1A38BD96-7AAB-2151-0200-DFDF8C232F30}"/>
          </ac:picMkLst>
        </pc:picChg>
        <pc:picChg chg="del">
          <ac:chgData name="Ilaria Laurenzana" userId="d20e3a4c-5152-4781-9a82-e8e358f0fc6e" providerId="ADAL" clId="{F25154BB-24FE-45A5-ACC5-F4DE14291D12}" dt="2024-09-09T12:15:12.720" v="685" actId="478"/>
          <ac:picMkLst>
            <pc:docMk/>
            <pc:sldMk cId="302162955" sldId="273"/>
            <ac:picMk id="8" creationId="{89CB2316-8ED9-3DA3-F379-9957AF970C43}"/>
          </ac:picMkLst>
        </pc:picChg>
        <pc:picChg chg="del">
          <ac:chgData name="Ilaria Laurenzana" userId="d20e3a4c-5152-4781-9a82-e8e358f0fc6e" providerId="ADAL" clId="{F25154BB-24FE-45A5-ACC5-F4DE14291D12}" dt="2024-09-09T12:15:14.897" v="687" actId="478"/>
          <ac:picMkLst>
            <pc:docMk/>
            <pc:sldMk cId="302162955" sldId="273"/>
            <ac:picMk id="9" creationId="{74F88B03-1EC0-5AB1-92E7-B1A236A13C0E}"/>
          </ac:picMkLst>
        </pc:picChg>
        <pc:picChg chg="del">
          <ac:chgData name="Ilaria Laurenzana" userId="d20e3a4c-5152-4781-9a82-e8e358f0fc6e" providerId="ADAL" clId="{F25154BB-24FE-45A5-ACC5-F4DE14291D12}" dt="2024-09-09T12:15:16.152" v="689" actId="478"/>
          <ac:picMkLst>
            <pc:docMk/>
            <pc:sldMk cId="302162955" sldId="273"/>
            <ac:picMk id="10" creationId="{30C7E740-7576-7A80-0090-289333DCD923}"/>
          </ac:picMkLst>
        </pc:picChg>
        <pc:picChg chg="del">
          <ac:chgData name="Ilaria Laurenzana" userId="d20e3a4c-5152-4781-9a82-e8e358f0fc6e" providerId="ADAL" clId="{F25154BB-24FE-45A5-ACC5-F4DE14291D12}" dt="2024-09-09T12:15:15.744" v="688" actId="478"/>
          <ac:picMkLst>
            <pc:docMk/>
            <pc:sldMk cId="302162955" sldId="273"/>
            <ac:picMk id="11" creationId="{76E50415-919B-550E-212B-1C2A04192796}"/>
          </ac:picMkLst>
        </pc:picChg>
        <pc:picChg chg="del">
          <ac:chgData name="Ilaria Laurenzana" userId="d20e3a4c-5152-4781-9a82-e8e358f0fc6e" providerId="ADAL" clId="{F25154BB-24FE-45A5-ACC5-F4DE14291D12}" dt="2024-09-09T12:15:16.497" v="690" actId="478"/>
          <ac:picMkLst>
            <pc:docMk/>
            <pc:sldMk cId="302162955" sldId="273"/>
            <ac:picMk id="12" creationId="{5F5B637A-2E6C-8ECB-9E5F-AD86E9F13A99}"/>
          </ac:picMkLst>
        </pc:picChg>
        <pc:picChg chg="mod">
          <ac:chgData name="Ilaria Laurenzana" userId="d20e3a4c-5152-4781-9a82-e8e358f0fc6e" providerId="ADAL" clId="{F25154BB-24FE-45A5-ACC5-F4DE14291D12}" dt="2024-09-12T10:51:55.992" v="2632" actId="1038"/>
          <ac:picMkLst>
            <pc:docMk/>
            <pc:sldMk cId="302162955" sldId="273"/>
            <ac:picMk id="13" creationId="{8560BD30-B42A-E452-8E58-7098638ABC45}"/>
          </ac:picMkLst>
        </pc:picChg>
        <pc:picChg chg="mod">
          <ac:chgData name="Ilaria Laurenzana" userId="d20e3a4c-5152-4781-9a82-e8e358f0fc6e" providerId="ADAL" clId="{F25154BB-24FE-45A5-ACC5-F4DE14291D12}" dt="2024-09-12T10:52:02.173" v="2658" actId="1038"/>
          <ac:picMkLst>
            <pc:docMk/>
            <pc:sldMk cId="302162955" sldId="273"/>
            <ac:picMk id="14" creationId="{B3EC20D2-BAE3-ECD4-9C8C-289B73385C83}"/>
          </ac:picMkLst>
        </pc:picChg>
        <pc:picChg chg="add mod">
          <ac:chgData name="Ilaria Laurenzana" userId="d20e3a4c-5152-4781-9a82-e8e358f0fc6e" providerId="ADAL" clId="{F25154BB-24FE-45A5-ACC5-F4DE14291D12}" dt="2024-09-09T12:17:19.014" v="769" actId="571"/>
          <ac:picMkLst>
            <pc:docMk/>
            <pc:sldMk cId="302162955" sldId="273"/>
            <ac:picMk id="17" creationId="{A933B1CB-35CC-F08C-0877-4CB00B31F419}"/>
          </ac:picMkLst>
        </pc:picChg>
        <pc:picChg chg="add mod">
          <ac:chgData name="Ilaria Laurenzana" userId="d20e3a4c-5152-4781-9a82-e8e358f0fc6e" providerId="ADAL" clId="{F25154BB-24FE-45A5-ACC5-F4DE14291D12}" dt="2024-09-09T12:17:19.014" v="769" actId="571"/>
          <ac:picMkLst>
            <pc:docMk/>
            <pc:sldMk cId="302162955" sldId="273"/>
            <ac:picMk id="18" creationId="{C57060D7-7ED6-6DF5-AF6A-A74FA7E5446C}"/>
          </ac:picMkLst>
        </pc:picChg>
        <pc:picChg chg="add mod">
          <ac:chgData name="Ilaria Laurenzana" userId="d20e3a4c-5152-4781-9a82-e8e358f0fc6e" providerId="ADAL" clId="{F25154BB-24FE-45A5-ACC5-F4DE14291D12}" dt="2024-09-09T12:17:19.014" v="769" actId="571"/>
          <ac:picMkLst>
            <pc:docMk/>
            <pc:sldMk cId="302162955" sldId="273"/>
            <ac:picMk id="19" creationId="{D1A13919-6748-4B76-27CB-2E6989BBEC51}"/>
          </ac:picMkLst>
        </pc:picChg>
        <pc:picChg chg="add mod">
          <ac:chgData name="Ilaria Laurenzana" userId="d20e3a4c-5152-4781-9a82-e8e358f0fc6e" providerId="ADAL" clId="{F25154BB-24FE-45A5-ACC5-F4DE14291D12}" dt="2024-09-09T12:17:19.014" v="769" actId="571"/>
          <ac:picMkLst>
            <pc:docMk/>
            <pc:sldMk cId="302162955" sldId="273"/>
            <ac:picMk id="20" creationId="{29740ADF-0A8F-30F7-E040-D61BDAA4EAC1}"/>
          </ac:picMkLst>
        </pc:picChg>
        <pc:picChg chg="add mod">
          <ac:chgData name="Ilaria Laurenzana" userId="d20e3a4c-5152-4781-9a82-e8e358f0fc6e" providerId="ADAL" clId="{F25154BB-24FE-45A5-ACC5-F4DE14291D12}" dt="2024-09-09T12:17:19.014" v="769" actId="571"/>
          <ac:picMkLst>
            <pc:docMk/>
            <pc:sldMk cId="302162955" sldId="273"/>
            <ac:picMk id="21" creationId="{48184BD9-B756-0770-F57A-9F4912482F70}"/>
          </ac:picMkLst>
        </pc:picChg>
        <pc:picChg chg="add del mod">
          <ac:chgData name="Ilaria Laurenzana" userId="d20e3a4c-5152-4781-9a82-e8e358f0fc6e" providerId="ADAL" clId="{F25154BB-24FE-45A5-ACC5-F4DE14291D12}" dt="2024-09-11T10:34:15.072" v="1333" actId="21"/>
          <ac:picMkLst>
            <pc:docMk/>
            <pc:sldMk cId="302162955" sldId="273"/>
            <ac:picMk id="22" creationId="{422A0A00-8277-FEAA-F842-4B56AB8F424F}"/>
          </ac:picMkLst>
        </pc:picChg>
        <pc:picChg chg="add del mod">
          <ac:chgData name="Ilaria Laurenzana" userId="d20e3a4c-5152-4781-9a82-e8e358f0fc6e" providerId="ADAL" clId="{F25154BB-24FE-45A5-ACC5-F4DE14291D12}" dt="2024-09-11T10:33:44.814" v="1317" actId="21"/>
          <ac:picMkLst>
            <pc:docMk/>
            <pc:sldMk cId="302162955" sldId="273"/>
            <ac:picMk id="25" creationId="{091ADF6E-D16A-8F2A-E4DA-A3C462C1F411}"/>
          </ac:picMkLst>
        </pc:picChg>
        <pc:picChg chg="add mod">
          <ac:chgData name="Ilaria Laurenzana" userId="d20e3a4c-5152-4781-9a82-e8e358f0fc6e" providerId="ADAL" clId="{F25154BB-24FE-45A5-ACC5-F4DE14291D12}" dt="2024-09-09T12:17:19.014" v="769" actId="571"/>
          <ac:picMkLst>
            <pc:docMk/>
            <pc:sldMk cId="302162955" sldId="273"/>
            <ac:picMk id="42" creationId="{9D266346-CE97-DBDD-8EAB-8D265006B49D}"/>
          </ac:picMkLst>
        </pc:picChg>
      </pc:sldChg>
      <pc:sldChg chg="delSp modSp del mod">
        <pc:chgData name="Ilaria Laurenzana" userId="d20e3a4c-5152-4781-9a82-e8e358f0fc6e" providerId="ADAL" clId="{F25154BB-24FE-45A5-ACC5-F4DE14291D12}" dt="2024-09-09T12:18:07.848" v="840" actId="47"/>
        <pc:sldMkLst>
          <pc:docMk/>
          <pc:sldMk cId="1796530968" sldId="274"/>
        </pc:sldMkLst>
        <pc:spChg chg="del mod">
          <ac:chgData name="Ilaria Laurenzana" userId="d20e3a4c-5152-4781-9a82-e8e358f0fc6e" providerId="ADAL" clId="{F25154BB-24FE-45A5-ACC5-F4DE14291D12}" dt="2024-09-09T12:16:40.868" v="738" actId="478"/>
          <ac:spMkLst>
            <pc:docMk/>
            <pc:sldMk cId="1796530968" sldId="274"/>
            <ac:spMk id="2" creationId="{89B9B57F-0C2B-0567-9020-D06BAE999825}"/>
          </ac:spMkLst>
        </pc:spChg>
        <pc:spChg chg="del">
          <ac:chgData name="Ilaria Laurenzana" userId="d20e3a4c-5152-4781-9a82-e8e358f0fc6e" providerId="ADAL" clId="{F25154BB-24FE-45A5-ACC5-F4DE14291D12}" dt="2024-09-09T12:16:44.507" v="739" actId="21"/>
          <ac:spMkLst>
            <pc:docMk/>
            <pc:sldMk cId="1796530968" sldId="274"/>
            <ac:spMk id="3" creationId="{E4828BED-2413-A931-44FA-DB4B6F258D22}"/>
          </ac:spMkLst>
        </pc:spChg>
        <pc:grpChg chg="del">
          <ac:chgData name="Ilaria Laurenzana" userId="d20e3a4c-5152-4781-9a82-e8e358f0fc6e" providerId="ADAL" clId="{F25154BB-24FE-45A5-ACC5-F4DE14291D12}" dt="2024-09-09T12:16:44.507" v="739" actId="21"/>
          <ac:grpSpMkLst>
            <pc:docMk/>
            <pc:sldMk cId="1796530968" sldId="274"/>
            <ac:grpSpMk id="35" creationId="{970DC4A2-9CB1-CA3D-2F83-C0B4C1868A82}"/>
          </ac:grpSpMkLst>
        </pc:grpChg>
        <pc:grpChg chg="del">
          <ac:chgData name="Ilaria Laurenzana" userId="d20e3a4c-5152-4781-9a82-e8e358f0fc6e" providerId="ADAL" clId="{F25154BB-24FE-45A5-ACC5-F4DE14291D12}" dt="2024-09-09T12:16:44.507" v="739" actId="21"/>
          <ac:grpSpMkLst>
            <pc:docMk/>
            <pc:sldMk cId="1796530968" sldId="274"/>
            <ac:grpSpMk id="37" creationId="{ED461D77-E4FF-E994-9645-D0CFB555FDA2}"/>
          </ac:grpSpMkLst>
        </pc:grpChg>
        <pc:grpChg chg="del">
          <ac:chgData name="Ilaria Laurenzana" userId="d20e3a4c-5152-4781-9a82-e8e358f0fc6e" providerId="ADAL" clId="{F25154BB-24FE-45A5-ACC5-F4DE14291D12}" dt="2024-09-09T12:16:44.507" v="739" actId="21"/>
          <ac:grpSpMkLst>
            <pc:docMk/>
            <pc:sldMk cId="1796530968" sldId="274"/>
            <ac:grpSpMk id="39" creationId="{BF33CB5B-1AB5-C0DE-501D-ED54DD0B4978}"/>
          </ac:grpSpMkLst>
        </pc:grpChg>
        <pc:grpChg chg="del">
          <ac:chgData name="Ilaria Laurenzana" userId="d20e3a4c-5152-4781-9a82-e8e358f0fc6e" providerId="ADAL" clId="{F25154BB-24FE-45A5-ACC5-F4DE14291D12}" dt="2024-09-09T12:16:44.507" v="739" actId="21"/>
          <ac:grpSpMkLst>
            <pc:docMk/>
            <pc:sldMk cId="1796530968" sldId="274"/>
            <ac:grpSpMk id="41" creationId="{72219C42-5CA5-20D8-EDF6-85E3DAB728BB}"/>
          </ac:grpSpMkLst>
        </pc:grpChg>
        <pc:graphicFrameChg chg="del">
          <ac:chgData name="Ilaria Laurenzana" userId="d20e3a4c-5152-4781-9a82-e8e358f0fc6e" providerId="ADAL" clId="{F25154BB-24FE-45A5-ACC5-F4DE14291D12}" dt="2024-09-09T12:16:44.507" v="739" actId="21"/>
          <ac:graphicFrameMkLst>
            <pc:docMk/>
            <pc:sldMk cId="1796530968" sldId="274"/>
            <ac:graphicFrameMk id="23" creationId="{71CFEBA4-B308-FBD4-7126-9FB11F8D0093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16:44.507" v="739" actId="21"/>
          <ac:graphicFrameMkLst>
            <pc:docMk/>
            <pc:sldMk cId="1796530968" sldId="274"/>
            <ac:graphicFrameMk id="24" creationId="{484D4AF2-294D-2495-101F-A3EB222FF32B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16:44.507" v="739" actId="21"/>
          <ac:graphicFrameMkLst>
            <pc:docMk/>
            <pc:sldMk cId="1796530968" sldId="274"/>
            <ac:graphicFrameMk id="25" creationId="{65BFF04D-5662-6D2E-45E3-4816C930D052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16:44.507" v="739" actId="21"/>
          <ac:graphicFrameMkLst>
            <pc:docMk/>
            <pc:sldMk cId="1796530968" sldId="274"/>
            <ac:graphicFrameMk id="26" creationId="{25A1B6DC-820F-9E2D-9758-0742FA86E9EE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16:44.507" v="739" actId="21"/>
          <ac:graphicFrameMkLst>
            <pc:docMk/>
            <pc:sldMk cId="1796530968" sldId="274"/>
            <ac:graphicFrameMk id="27" creationId="{398408B7-7E79-AB12-507A-DE428709A32D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16:44.507" v="739" actId="21"/>
          <ac:graphicFrameMkLst>
            <pc:docMk/>
            <pc:sldMk cId="1796530968" sldId="274"/>
            <ac:graphicFrameMk id="31" creationId="{E51715AE-C2A9-7D8F-DABC-3DA9B4CFC829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16:44.507" v="739" actId="21"/>
          <ac:graphicFrameMkLst>
            <pc:docMk/>
            <pc:sldMk cId="1796530968" sldId="274"/>
            <ac:graphicFrameMk id="34" creationId="{2879F0C6-DB5A-D498-1394-B13F54F48584}"/>
          </ac:graphicFrameMkLst>
        </pc:graphicFrameChg>
        <pc:picChg chg="del">
          <ac:chgData name="Ilaria Laurenzana" userId="d20e3a4c-5152-4781-9a82-e8e358f0fc6e" providerId="ADAL" clId="{F25154BB-24FE-45A5-ACC5-F4DE14291D12}" dt="2024-09-09T12:16:35.553" v="726" actId="478"/>
          <ac:picMkLst>
            <pc:docMk/>
            <pc:sldMk cId="1796530968" sldId="274"/>
            <ac:picMk id="10" creationId="{D8752FED-5035-FEEA-C8A8-FBAA380F6AFE}"/>
          </ac:picMkLst>
        </pc:picChg>
        <pc:picChg chg="del">
          <ac:chgData name="Ilaria Laurenzana" userId="d20e3a4c-5152-4781-9a82-e8e358f0fc6e" providerId="ADAL" clId="{F25154BB-24FE-45A5-ACC5-F4DE14291D12}" dt="2024-09-09T12:16:38.233" v="734" actId="478"/>
          <ac:picMkLst>
            <pc:docMk/>
            <pc:sldMk cId="1796530968" sldId="274"/>
            <ac:picMk id="11" creationId="{34D3EE78-F6E2-0FCB-7CA1-4B4DCD060709}"/>
          </ac:picMkLst>
        </pc:picChg>
        <pc:picChg chg="del mod">
          <ac:chgData name="Ilaria Laurenzana" userId="d20e3a4c-5152-4781-9a82-e8e358f0fc6e" providerId="ADAL" clId="{F25154BB-24FE-45A5-ACC5-F4DE14291D12}" dt="2024-09-09T12:16:35.930" v="728" actId="478"/>
          <ac:picMkLst>
            <pc:docMk/>
            <pc:sldMk cId="1796530968" sldId="274"/>
            <ac:picMk id="12" creationId="{61089F04-884F-5C95-F742-FE3FD5686027}"/>
          </ac:picMkLst>
        </pc:picChg>
        <pc:picChg chg="del">
          <ac:chgData name="Ilaria Laurenzana" userId="d20e3a4c-5152-4781-9a82-e8e358f0fc6e" providerId="ADAL" clId="{F25154BB-24FE-45A5-ACC5-F4DE14291D12}" dt="2024-09-09T12:16:38.719" v="735" actId="478"/>
          <ac:picMkLst>
            <pc:docMk/>
            <pc:sldMk cId="1796530968" sldId="274"/>
            <ac:picMk id="13" creationId="{1B004F38-8660-D55C-B83B-3084199EF8F9}"/>
          </ac:picMkLst>
        </pc:picChg>
        <pc:picChg chg="del mod">
          <ac:chgData name="Ilaria Laurenzana" userId="d20e3a4c-5152-4781-9a82-e8e358f0fc6e" providerId="ADAL" clId="{F25154BB-24FE-45A5-ACC5-F4DE14291D12}" dt="2024-09-09T12:16:37.806" v="733" actId="478"/>
          <ac:picMkLst>
            <pc:docMk/>
            <pc:sldMk cId="1796530968" sldId="274"/>
            <ac:picMk id="14" creationId="{06519645-8BD3-F02B-5D1F-A5C160FB13A5}"/>
          </ac:picMkLst>
        </pc:picChg>
        <pc:picChg chg="del">
          <ac:chgData name="Ilaria Laurenzana" userId="d20e3a4c-5152-4781-9a82-e8e358f0fc6e" providerId="ADAL" clId="{F25154BB-24FE-45A5-ACC5-F4DE14291D12}" dt="2024-09-09T12:16:39.080" v="736" actId="478"/>
          <ac:picMkLst>
            <pc:docMk/>
            <pc:sldMk cId="1796530968" sldId="274"/>
            <ac:picMk id="15" creationId="{CFE50A75-CFF7-0A1D-6D48-687D1AE30414}"/>
          </ac:picMkLst>
        </pc:picChg>
        <pc:picChg chg="del">
          <ac:chgData name="Ilaria Laurenzana" userId="d20e3a4c-5152-4781-9a82-e8e358f0fc6e" providerId="ADAL" clId="{F25154BB-24FE-45A5-ACC5-F4DE14291D12}" dt="2024-09-09T12:16:37.482" v="731" actId="478"/>
          <ac:picMkLst>
            <pc:docMk/>
            <pc:sldMk cId="1796530968" sldId="274"/>
            <ac:picMk id="17" creationId="{B8A7CF89-55DC-2374-017A-981426D0069D}"/>
          </ac:picMkLst>
        </pc:picChg>
        <pc:picChg chg="del">
          <ac:chgData name="Ilaria Laurenzana" userId="d20e3a4c-5152-4781-9a82-e8e358f0fc6e" providerId="ADAL" clId="{F25154BB-24FE-45A5-ACC5-F4DE14291D12}" dt="2024-09-09T12:16:35.099" v="725" actId="478"/>
          <ac:picMkLst>
            <pc:docMk/>
            <pc:sldMk cId="1796530968" sldId="274"/>
            <ac:picMk id="18" creationId="{68B907D0-E2EC-1CE0-551B-232FD89833D7}"/>
          </ac:picMkLst>
        </pc:picChg>
        <pc:picChg chg="del">
          <ac:chgData name="Ilaria Laurenzana" userId="d20e3a4c-5152-4781-9a82-e8e358f0fc6e" providerId="ADAL" clId="{F25154BB-24FE-45A5-ACC5-F4DE14291D12}" dt="2024-09-09T12:16:36.980" v="730" actId="478"/>
          <ac:picMkLst>
            <pc:docMk/>
            <pc:sldMk cId="1796530968" sldId="274"/>
            <ac:picMk id="19" creationId="{8162C6DA-2978-4084-0C71-5062B39F2211}"/>
          </ac:picMkLst>
        </pc:picChg>
        <pc:picChg chg="del">
          <ac:chgData name="Ilaria Laurenzana" userId="d20e3a4c-5152-4781-9a82-e8e358f0fc6e" providerId="ADAL" clId="{F25154BB-24FE-45A5-ACC5-F4DE14291D12}" dt="2024-09-09T12:16:36.298" v="729" actId="478"/>
          <ac:picMkLst>
            <pc:docMk/>
            <pc:sldMk cId="1796530968" sldId="274"/>
            <ac:picMk id="20" creationId="{C6BCA9BC-80E1-3708-D838-95F821208025}"/>
          </ac:picMkLst>
        </pc:picChg>
        <pc:picChg chg="del">
          <ac:chgData name="Ilaria Laurenzana" userId="d20e3a4c-5152-4781-9a82-e8e358f0fc6e" providerId="ADAL" clId="{F25154BB-24FE-45A5-ACC5-F4DE14291D12}" dt="2024-09-09T12:16:33.639" v="723" actId="478"/>
          <ac:picMkLst>
            <pc:docMk/>
            <pc:sldMk cId="1796530968" sldId="274"/>
            <ac:picMk id="21" creationId="{0D3C626E-EB83-FB1B-54B4-8BBF621CD4EC}"/>
          </ac:picMkLst>
        </pc:picChg>
        <pc:picChg chg="del">
          <ac:chgData name="Ilaria Laurenzana" userId="d20e3a4c-5152-4781-9a82-e8e358f0fc6e" providerId="ADAL" clId="{F25154BB-24FE-45A5-ACC5-F4DE14291D12}" dt="2024-09-09T12:16:39.899" v="737" actId="478"/>
          <ac:picMkLst>
            <pc:docMk/>
            <pc:sldMk cId="1796530968" sldId="274"/>
            <ac:picMk id="22" creationId="{A4AC95E8-A24D-7FB0-79FC-063B23C056B4}"/>
          </ac:picMkLst>
        </pc:picChg>
      </pc:sldChg>
      <pc:sldChg chg="addSp delSp modSp mod">
        <pc:chgData name="Ilaria Laurenzana" userId="d20e3a4c-5152-4781-9a82-e8e358f0fc6e" providerId="ADAL" clId="{F25154BB-24FE-45A5-ACC5-F4DE14291D12}" dt="2024-09-23T07:24:11.147" v="7273" actId="1036"/>
        <pc:sldMkLst>
          <pc:docMk/>
          <pc:sldMk cId="3557762631" sldId="275"/>
        </pc:sldMkLst>
        <pc:spChg chg="add mod">
          <ac:chgData name="Ilaria Laurenzana" userId="d20e3a4c-5152-4781-9a82-e8e358f0fc6e" providerId="ADAL" clId="{F25154BB-24FE-45A5-ACC5-F4DE14291D12}" dt="2024-09-20T12:36:03.984" v="6987"/>
          <ac:spMkLst>
            <pc:docMk/>
            <pc:sldMk cId="3557762631" sldId="275"/>
            <ac:spMk id="3" creationId="{DE32E2C9-A818-F7F3-5870-26E8FA6602EF}"/>
          </ac:spMkLst>
        </pc:spChg>
        <pc:spChg chg="mod">
          <ac:chgData name="Ilaria Laurenzana" userId="d20e3a4c-5152-4781-9a82-e8e358f0fc6e" providerId="ADAL" clId="{F25154BB-24FE-45A5-ACC5-F4DE14291D12}" dt="2024-09-12T12:40:05.865" v="2662" actId="6549"/>
          <ac:spMkLst>
            <pc:docMk/>
            <pc:sldMk cId="3557762631" sldId="275"/>
            <ac:spMk id="5" creationId="{5DC379A5-1740-3833-D664-0222E9FA597B}"/>
          </ac:spMkLst>
        </pc:spChg>
        <pc:spChg chg="mod">
          <ac:chgData name="Ilaria Laurenzana" userId="d20e3a4c-5152-4781-9a82-e8e358f0fc6e" providerId="ADAL" clId="{F25154BB-24FE-45A5-ACC5-F4DE14291D12}" dt="2024-09-12T12:40:11.794" v="2666" actId="20577"/>
          <ac:spMkLst>
            <pc:docMk/>
            <pc:sldMk cId="3557762631" sldId="275"/>
            <ac:spMk id="6" creationId="{C0A41116-FD43-E099-695E-68DDD029BF03}"/>
          </ac:spMkLst>
        </pc:spChg>
        <pc:spChg chg="mod">
          <ac:chgData name="Ilaria Laurenzana" userId="d20e3a4c-5152-4781-9a82-e8e358f0fc6e" providerId="ADAL" clId="{F25154BB-24FE-45A5-ACC5-F4DE14291D12}" dt="2024-09-12T12:40:03.165" v="2661" actId="6549"/>
          <ac:spMkLst>
            <pc:docMk/>
            <pc:sldMk cId="3557762631" sldId="275"/>
            <ac:spMk id="7" creationId="{74961D96-6562-CA16-2140-BCBB7E5B1571}"/>
          </ac:spMkLst>
        </pc:spChg>
        <pc:spChg chg="add del mod">
          <ac:chgData name="Ilaria Laurenzana" userId="d20e3a4c-5152-4781-9a82-e8e358f0fc6e" providerId="ADAL" clId="{F25154BB-24FE-45A5-ACC5-F4DE14291D12}" dt="2024-09-19T12:38:59.612" v="6813" actId="478"/>
          <ac:spMkLst>
            <pc:docMk/>
            <pc:sldMk cId="3557762631" sldId="275"/>
            <ac:spMk id="19" creationId="{84A2116C-999A-5485-79BD-D3DA3AAF85F1}"/>
          </ac:spMkLst>
        </pc:spChg>
        <pc:spChg chg="add del mod">
          <ac:chgData name="Ilaria Laurenzana" userId="d20e3a4c-5152-4781-9a82-e8e358f0fc6e" providerId="ADAL" clId="{F25154BB-24FE-45A5-ACC5-F4DE14291D12}" dt="2024-09-20T12:54:20.285" v="7054" actId="478"/>
          <ac:spMkLst>
            <pc:docMk/>
            <pc:sldMk cId="3557762631" sldId="275"/>
            <ac:spMk id="20" creationId="{6E0BC5C4-809A-CBF6-72DF-2E6321458504}"/>
          </ac:spMkLst>
        </pc:spChg>
        <pc:spChg chg="add mod">
          <ac:chgData name="Ilaria Laurenzana" userId="d20e3a4c-5152-4781-9a82-e8e358f0fc6e" providerId="ADAL" clId="{F25154BB-24FE-45A5-ACC5-F4DE14291D12}" dt="2024-09-23T06:42:10.980" v="7227" actId="554"/>
          <ac:spMkLst>
            <pc:docMk/>
            <pc:sldMk cId="3557762631" sldId="275"/>
            <ac:spMk id="20" creationId="{A215118E-FC4B-588C-973D-7FF1A545BC54}"/>
          </ac:spMkLst>
        </pc:spChg>
        <pc:spChg chg="mod">
          <ac:chgData name="Ilaria Laurenzana" userId="d20e3a4c-5152-4781-9a82-e8e358f0fc6e" providerId="ADAL" clId="{F25154BB-24FE-45A5-ACC5-F4DE14291D12}" dt="2024-09-20T06:57:05.305" v="6969" actId="1036"/>
          <ac:spMkLst>
            <pc:docMk/>
            <pc:sldMk cId="3557762631" sldId="275"/>
            <ac:spMk id="21" creationId="{CBEF332D-A9F5-7D69-A618-56D893047203}"/>
          </ac:spMkLst>
        </pc:spChg>
        <pc:spChg chg="add mod">
          <ac:chgData name="Ilaria Laurenzana" userId="d20e3a4c-5152-4781-9a82-e8e358f0fc6e" providerId="ADAL" clId="{F25154BB-24FE-45A5-ACC5-F4DE14291D12}" dt="2024-09-23T06:42:10.980" v="7227" actId="554"/>
          <ac:spMkLst>
            <pc:docMk/>
            <pc:sldMk cId="3557762631" sldId="275"/>
            <ac:spMk id="25" creationId="{833B38FA-E7D1-C734-D674-9B3ADFEAFB61}"/>
          </ac:spMkLst>
        </pc:spChg>
        <pc:spChg chg="add del mod">
          <ac:chgData name="Ilaria Laurenzana" userId="d20e3a4c-5152-4781-9a82-e8e358f0fc6e" providerId="ADAL" clId="{F25154BB-24FE-45A5-ACC5-F4DE14291D12}" dt="2024-09-20T12:54:12.609" v="7049" actId="478"/>
          <ac:spMkLst>
            <pc:docMk/>
            <pc:sldMk cId="3557762631" sldId="275"/>
            <ac:spMk id="28" creationId="{55F023BF-D4B8-22D2-E234-F4E11FDF6BC6}"/>
          </ac:spMkLst>
        </pc:spChg>
        <pc:spChg chg="add del mod">
          <ac:chgData name="Ilaria Laurenzana" userId="d20e3a4c-5152-4781-9a82-e8e358f0fc6e" providerId="ADAL" clId="{F25154BB-24FE-45A5-ACC5-F4DE14291D12}" dt="2024-09-23T06:44:49.814" v="7242" actId="478"/>
          <ac:spMkLst>
            <pc:docMk/>
            <pc:sldMk cId="3557762631" sldId="275"/>
            <ac:spMk id="28" creationId="{E41E8C91-A36E-F2FC-2E9D-D77358E80912}"/>
          </ac:spMkLst>
        </pc:spChg>
        <pc:spChg chg="mod">
          <ac:chgData name="Ilaria Laurenzana" userId="d20e3a4c-5152-4781-9a82-e8e358f0fc6e" providerId="ADAL" clId="{F25154BB-24FE-45A5-ACC5-F4DE14291D12}" dt="2024-09-20T06:57:08.994" v="6970" actId="1036"/>
          <ac:spMkLst>
            <pc:docMk/>
            <pc:sldMk cId="3557762631" sldId="275"/>
            <ac:spMk id="35" creationId="{DA0D3B90-EE88-AD0C-DFE5-E971B9EAAA23}"/>
          </ac:spMkLst>
        </pc:spChg>
        <pc:spChg chg="mod">
          <ac:chgData name="Ilaria Laurenzana" userId="d20e3a4c-5152-4781-9a82-e8e358f0fc6e" providerId="ADAL" clId="{F25154BB-24FE-45A5-ACC5-F4DE14291D12}" dt="2024-09-23T07:24:11.147" v="7273" actId="1036"/>
          <ac:spMkLst>
            <pc:docMk/>
            <pc:sldMk cId="3557762631" sldId="275"/>
            <ac:spMk id="38" creationId="{2FD800BB-AA31-EFDC-A473-7D2BA97371A6}"/>
          </ac:spMkLst>
        </pc:spChg>
        <pc:spChg chg="add del mod">
          <ac:chgData name="Ilaria Laurenzana" userId="d20e3a4c-5152-4781-9a82-e8e358f0fc6e" providerId="ADAL" clId="{F25154BB-24FE-45A5-ACC5-F4DE14291D12}" dt="2024-09-23T07:18:09.270" v="7243" actId="478"/>
          <ac:spMkLst>
            <pc:docMk/>
            <pc:sldMk cId="3557762631" sldId="275"/>
            <ac:spMk id="39" creationId="{CFC8324C-FCD5-DEB2-8727-BF0FCD14044A}"/>
          </ac:spMkLst>
        </pc:spChg>
        <pc:spChg chg="add del mod">
          <ac:chgData name="Ilaria Laurenzana" userId="d20e3a4c-5152-4781-9a82-e8e358f0fc6e" providerId="ADAL" clId="{F25154BB-24FE-45A5-ACC5-F4DE14291D12}" dt="2024-09-23T07:18:11.240" v="7244" actId="478"/>
          <ac:spMkLst>
            <pc:docMk/>
            <pc:sldMk cId="3557762631" sldId="275"/>
            <ac:spMk id="40" creationId="{5D4C93A6-3DBC-0959-EE10-22CF7135013C}"/>
          </ac:spMkLst>
        </pc:spChg>
        <pc:spChg chg="mod">
          <ac:chgData name="Ilaria Laurenzana" userId="d20e3a4c-5152-4781-9a82-e8e358f0fc6e" providerId="ADAL" clId="{F25154BB-24FE-45A5-ACC5-F4DE14291D12}" dt="2024-09-12T08:31:25.979" v="1730" actId="255"/>
          <ac:spMkLst>
            <pc:docMk/>
            <pc:sldMk cId="3557762631" sldId="275"/>
            <ac:spMk id="43" creationId="{01CEF2A1-1F50-73F6-4EAE-DBECF5594DF6}"/>
          </ac:spMkLst>
        </pc:spChg>
        <pc:spChg chg="mod">
          <ac:chgData name="Ilaria Laurenzana" userId="d20e3a4c-5152-4781-9a82-e8e358f0fc6e" providerId="ADAL" clId="{F25154BB-24FE-45A5-ACC5-F4DE14291D12}" dt="2024-09-12T08:31:31.832" v="1731" actId="255"/>
          <ac:spMkLst>
            <pc:docMk/>
            <pc:sldMk cId="3557762631" sldId="275"/>
            <ac:spMk id="44" creationId="{E1E1932B-9454-EE1E-1DDD-F4CFAA81E032}"/>
          </ac:spMkLst>
        </pc:spChg>
        <pc:spChg chg="add mod">
          <ac:chgData name="Ilaria Laurenzana" userId="d20e3a4c-5152-4781-9a82-e8e358f0fc6e" providerId="ADAL" clId="{F25154BB-24FE-45A5-ACC5-F4DE14291D12}" dt="2024-09-20T06:52:05.210" v="6900" actId="164"/>
          <ac:spMkLst>
            <pc:docMk/>
            <pc:sldMk cId="3557762631" sldId="275"/>
            <ac:spMk id="47" creationId="{D00D8C6E-54B7-B075-4966-E2DEFA34460C}"/>
          </ac:spMkLst>
        </pc:spChg>
        <pc:spChg chg="add mod">
          <ac:chgData name="Ilaria Laurenzana" userId="d20e3a4c-5152-4781-9a82-e8e358f0fc6e" providerId="ADAL" clId="{F25154BB-24FE-45A5-ACC5-F4DE14291D12}" dt="2024-09-20T06:52:21.705" v="6905" actId="164"/>
          <ac:spMkLst>
            <pc:docMk/>
            <pc:sldMk cId="3557762631" sldId="275"/>
            <ac:spMk id="49" creationId="{17581AB7-E80B-F1E4-97E4-70BAE8491B6E}"/>
          </ac:spMkLst>
        </pc:spChg>
        <pc:spChg chg="add del mod">
          <ac:chgData name="Ilaria Laurenzana" userId="d20e3a4c-5152-4781-9a82-e8e358f0fc6e" providerId="ADAL" clId="{F25154BB-24FE-45A5-ACC5-F4DE14291D12}" dt="2024-09-23T06:37:30.743" v="7084" actId="478"/>
          <ac:spMkLst>
            <pc:docMk/>
            <pc:sldMk cId="3557762631" sldId="275"/>
            <ac:spMk id="53" creationId="{1054387F-4325-D729-422B-0F10C2B0B236}"/>
          </ac:spMkLst>
        </pc:spChg>
        <pc:spChg chg="mod">
          <ac:chgData name="Ilaria Laurenzana" userId="d20e3a4c-5152-4781-9a82-e8e358f0fc6e" providerId="ADAL" clId="{F25154BB-24FE-45A5-ACC5-F4DE14291D12}" dt="2024-09-23T06:41:24.193" v="7212" actId="1038"/>
          <ac:spMkLst>
            <pc:docMk/>
            <pc:sldMk cId="3557762631" sldId="275"/>
            <ac:spMk id="62" creationId="{77FEFDBE-7C7A-0A09-FE8C-7ED8D21B6E82}"/>
          </ac:spMkLst>
        </pc:spChg>
        <pc:spChg chg="mod topLvl">
          <ac:chgData name="Ilaria Laurenzana" userId="d20e3a4c-5152-4781-9a82-e8e358f0fc6e" providerId="ADAL" clId="{F25154BB-24FE-45A5-ACC5-F4DE14291D12}" dt="2024-09-23T06:41:34.712" v="7219" actId="1036"/>
          <ac:spMkLst>
            <pc:docMk/>
            <pc:sldMk cId="3557762631" sldId="275"/>
            <ac:spMk id="65" creationId="{F5D5A9D8-AC10-C5A5-68C5-7AACF75D6D10}"/>
          </ac:spMkLst>
        </pc:spChg>
        <pc:spChg chg="mod topLvl">
          <ac:chgData name="Ilaria Laurenzana" userId="d20e3a4c-5152-4781-9a82-e8e358f0fc6e" providerId="ADAL" clId="{F25154BB-24FE-45A5-ACC5-F4DE14291D12}" dt="2024-09-23T06:41:34.712" v="7219" actId="1036"/>
          <ac:spMkLst>
            <pc:docMk/>
            <pc:sldMk cId="3557762631" sldId="275"/>
            <ac:spMk id="66" creationId="{1E1B6738-E9E0-100A-E486-6A1A39A394AA}"/>
          </ac:spMkLst>
        </pc:spChg>
        <pc:spChg chg="mod">
          <ac:chgData name="Ilaria Laurenzana" userId="d20e3a4c-5152-4781-9a82-e8e358f0fc6e" providerId="ADAL" clId="{F25154BB-24FE-45A5-ACC5-F4DE14291D12}" dt="2024-09-12T12:40:18.727" v="2667" actId="6549"/>
          <ac:spMkLst>
            <pc:docMk/>
            <pc:sldMk cId="3557762631" sldId="275"/>
            <ac:spMk id="75" creationId="{5D2F2023-105D-C22A-6897-2686786F5C7C}"/>
          </ac:spMkLst>
        </pc:spChg>
        <pc:spChg chg="mod">
          <ac:chgData name="Ilaria Laurenzana" userId="d20e3a4c-5152-4781-9a82-e8e358f0fc6e" providerId="ADAL" clId="{F25154BB-24FE-45A5-ACC5-F4DE14291D12}" dt="2024-09-12T08:30:59.788" v="1726" actId="255"/>
          <ac:spMkLst>
            <pc:docMk/>
            <pc:sldMk cId="3557762631" sldId="275"/>
            <ac:spMk id="76" creationId="{A2C22D5D-63C8-E192-1008-9FBB403441EE}"/>
          </ac:spMkLst>
        </pc:spChg>
        <pc:spChg chg="mod">
          <ac:chgData name="Ilaria Laurenzana" userId="d20e3a4c-5152-4781-9a82-e8e358f0fc6e" providerId="ADAL" clId="{F25154BB-24FE-45A5-ACC5-F4DE14291D12}" dt="2024-09-12T08:31:08.870" v="1728" actId="255"/>
          <ac:spMkLst>
            <pc:docMk/>
            <pc:sldMk cId="3557762631" sldId="275"/>
            <ac:spMk id="77" creationId="{6BB79323-DCF5-9082-E175-786757E53BB1}"/>
          </ac:spMkLst>
        </pc:spChg>
        <pc:spChg chg="mod">
          <ac:chgData name="Ilaria Laurenzana" userId="d20e3a4c-5152-4781-9a82-e8e358f0fc6e" providerId="ADAL" clId="{F25154BB-24FE-45A5-ACC5-F4DE14291D12}" dt="2024-09-12T08:31:13.920" v="1729" actId="255"/>
          <ac:spMkLst>
            <pc:docMk/>
            <pc:sldMk cId="3557762631" sldId="275"/>
            <ac:spMk id="78" creationId="{2EF780F1-864E-1046-CC1F-049502AB3973}"/>
          </ac:spMkLst>
        </pc:spChg>
        <pc:spChg chg="mod">
          <ac:chgData name="Ilaria Laurenzana" userId="d20e3a4c-5152-4781-9a82-e8e358f0fc6e" providerId="ADAL" clId="{F25154BB-24FE-45A5-ACC5-F4DE14291D12}" dt="2024-09-12T08:31:04.268" v="1727" actId="255"/>
          <ac:spMkLst>
            <pc:docMk/>
            <pc:sldMk cId="3557762631" sldId="275"/>
            <ac:spMk id="79" creationId="{C323F3EC-52A6-3859-4C8F-992786F0583F}"/>
          </ac:spMkLst>
        </pc:spChg>
        <pc:spChg chg="mod">
          <ac:chgData name="Ilaria Laurenzana" userId="d20e3a4c-5152-4781-9a82-e8e358f0fc6e" providerId="ADAL" clId="{F25154BB-24FE-45A5-ACC5-F4DE14291D12}" dt="2024-09-12T12:40:24.615" v="2668" actId="6549"/>
          <ac:spMkLst>
            <pc:docMk/>
            <pc:sldMk cId="3557762631" sldId="275"/>
            <ac:spMk id="80" creationId="{4E54EC4D-C18F-AA01-8C56-DA9031A3A502}"/>
          </ac:spMkLst>
        </pc:spChg>
        <pc:grpChg chg="del mod">
          <ac:chgData name="Ilaria Laurenzana" userId="d20e3a4c-5152-4781-9a82-e8e358f0fc6e" providerId="ADAL" clId="{F25154BB-24FE-45A5-ACC5-F4DE14291D12}" dt="2024-09-20T06:56:06.258" v="6933" actId="478"/>
          <ac:grpSpMkLst>
            <pc:docMk/>
            <pc:sldMk cId="3557762631" sldId="275"/>
            <ac:grpSpMk id="34" creationId="{50A2B518-F614-C728-260B-D99C88DD36FE}"/>
          </ac:grpSpMkLst>
        </pc:grpChg>
        <pc:grpChg chg="add del mod">
          <ac:chgData name="Ilaria Laurenzana" userId="d20e3a4c-5152-4781-9a82-e8e358f0fc6e" providerId="ADAL" clId="{F25154BB-24FE-45A5-ACC5-F4DE14291D12}" dt="2024-09-23T07:18:09.270" v="7243" actId="478"/>
          <ac:grpSpMkLst>
            <pc:docMk/>
            <pc:sldMk cId="3557762631" sldId="275"/>
            <ac:grpSpMk id="41" creationId="{66CDF8E3-5EC9-0D59-AE34-180B2C72CF77}"/>
          </ac:grpSpMkLst>
        </pc:grpChg>
        <pc:grpChg chg="add del mod">
          <ac:chgData name="Ilaria Laurenzana" userId="d20e3a4c-5152-4781-9a82-e8e358f0fc6e" providerId="ADAL" clId="{F25154BB-24FE-45A5-ACC5-F4DE14291D12}" dt="2024-09-23T07:18:11.240" v="7244" actId="478"/>
          <ac:grpSpMkLst>
            <pc:docMk/>
            <pc:sldMk cId="3557762631" sldId="275"/>
            <ac:grpSpMk id="42" creationId="{B643C23E-A4E4-B674-9363-4BDCA026A2A4}"/>
          </ac:grpSpMkLst>
        </pc:grpChg>
        <pc:grpChg chg="add mod">
          <ac:chgData name="Ilaria Laurenzana" userId="d20e3a4c-5152-4781-9a82-e8e358f0fc6e" providerId="ADAL" clId="{F25154BB-24FE-45A5-ACC5-F4DE14291D12}" dt="2024-09-20T06:55:53.184" v="6906" actId="164"/>
          <ac:grpSpMkLst>
            <pc:docMk/>
            <pc:sldMk cId="3557762631" sldId="275"/>
            <ac:grpSpMk id="48" creationId="{0793CEC3-7902-10FE-A0F5-AB31D480CC62}"/>
          </ac:grpSpMkLst>
        </pc:grpChg>
        <pc:grpChg chg="add mod">
          <ac:chgData name="Ilaria Laurenzana" userId="d20e3a4c-5152-4781-9a82-e8e358f0fc6e" providerId="ADAL" clId="{F25154BB-24FE-45A5-ACC5-F4DE14291D12}" dt="2024-09-20T06:55:53.184" v="6906" actId="164"/>
          <ac:grpSpMkLst>
            <pc:docMk/>
            <pc:sldMk cId="3557762631" sldId="275"/>
            <ac:grpSpMk id="50" creationId="{C2E28992-7420-0FC6-6475-290FB68B44A3}"/>
          </ac:grpSpMkLst>
        </pc:grpChg>
        <pc:grpChg chg="add mod">
          <ac:chgData name="Ilaria Laurenzana" userId="d20e3a4c-5152-4781-9a82-e8e358f0fc6e" providerId="ADAL" clId="{F25154BB-24FE-45A5-ACC5-F4DE14291D12}" dt="2024-09-20T06:56:36.344" v="6966" actId="1038"/>
          <ac:grpSpMkLst>
            <pc:docMk/>
            <pc:sldMk cId="3557762631" sldId="275"/>
            <ac:grpSpMk id="51" creationId="{E13140F7-373A-6347-4662-8CA218132861}"/>
          </ac:grpSpMkLst>
        </pc:grpChg>
        <pc:grpChg chg="add del mod">
          <ac:chgData name="Ilaria Laurenzana" userId="d20e3a4c-5152-4781-9a82-e8e358f0fc6e" providerId="ADAL" clId="{F25154BB-24FE-45A5-ACC5-F4DE14291D12}" dt="2024-09-20T12:54:34.496" v="7057" actId="165"/>
          <ac:grpSpMkLst>
            <pc:docMk/>
            <pc:sldMk cId="3557762631" sldId="275"/>
            <ac:grpSpMk id="63" creationId="{1AAA8A24-CECF-8750-91AD-D8FBEAF46834}"/>
          </ac:grpSpMkLst>
        </pc:grpChg>
        <pc:picChg chg="add mod modCrop">
          <ac:chgData name="Ilaria Laurenzana" userId="d20e3a4c-5152-4781-9a82-e8e358f0fc6e" providerId="ADAL" clId="{F25154BB-24FE-45A5-ACC5-F4DE14291D12}" dt="2024-09-23T06:41:34.712" v="7219" actId="1036"/>
          <ac:picMkLst>
            <pc:docMk/>
            <pc:sldMk cId="3557762631" sldId="275"/>
            <ac:picMk id="16" creationId="{B0AD2932-50DC-C7C2-ADB2-1F74E78E77CE}"/>
          </ac:picMkLst>
        </pc:picChg>
        <pc:picChg chg="add mod">
          <ac:chgData name="Ilaria Laurenzana" userId="d20e3a4c-5152-4781-9a82-e8e358f0fc6e" providerId="ADAL" clId="{F25154BB-24FE-45A5-ACC5-F4DE14291D12}" dt="2024-09-20T06:51:31.026" v="6893" actId="164"/>
          <ac:picMkLst>
            <pc:docMk/>
            <pc:sldMk cId="3557762631" sldId="275"/>
            <ac:picMk id="19" creationId="{7BD6409C-FB0A-BC55-7AF6-BDB967737E9C}"/>
          </ac:picMkLst>
        </pc:picChg>
        <pc:picChg chg="add mod modCrop">
          <ac:chgData name="Ilaria Laurenzana" userId="d20e3a4c-5152-4781-9a82-e8e358f0fc6e" providerId="ADAL" clId="{F25154BB-24FE-45A5-ACC5-F4DE14291D12}" dt="2024-09-23T06:41:34.712" v="7219" actId="1036"/>
          <ac:picMkLst>
            <pc:docMk/>
            <pc:sldMk cId="3557762631" sldId="275"/>
            <ac:picMk id="34" creationId="{8A302958-5872-46E2-CADE-972DE44D759D}"/>
          </ac:picMkLst>
        </pc:picChg>
        <pc:picChg chg="add mod">
          <ac:chgData name="Ilaria Laurenzana" userId="d20e3a4c-5152-4781-9a82-e8e358f0fc6e" providerId="ADAL" clId="{F25154BB-24FE-45A5-ACC5-F4DE14291D12}" dt="2024-09-20T06:51:27.181" v="6892" actId="164"/>
          <ac:picMkLst>
            <pc:docMk/>
            <pc:sldMk cId="3557762631" sldId="275"/>
            <ac:picMk id="37" creationId="{6D8D14FD-AC50-1EC3-6182-AF700CF4B563}"/>
          </ac:picMkLst>
        </pc:picChg>
        <pc:picChg chg="add mod modCrop">
          <ac:chgData name="Ilaria Laurenzana" userId="d20e3a4c-5152-4781-9a82-e8e358f0fc6e" providerId="ADAL" clId="{F25154BB-24FE-45A5-ACC5-F4DE14291D12}" dt="2024-09-23T06:41:34.712" v="7219" actId="1036"/>
          <ac:picMkLst>
            <pc:docMk/>
            <pc:sldMk cId="3557762631" sldId="275"/>
            <ac:picMk id="52" creationId="{55D302A2-AF3E-2F20-1D30-1DA1B59C9961}"/>
          </ac:picMkLst>
        </pc:picChg>
        <pc:picChg chg="del">
          <ac:chgData name="Ilaria Laurenzana" userId="d20e3a4c-5152-4781-9a82-e8e358f0fc6e" providerId="ADAL" clId="{F25154BB-24FE-45A5-ACC5-F4DE14291D12}" dt="2024-09-20T12:54:21.948" v="7055" actId="478"/>
          <ac:picMkLst>
            <pc:docMk/>
            <pc:sldMk cId="3557762631" sldId="275"/>
            <ac:picMk id="64" creationId="{AA22FBF7-0479-D056-EAF1-62FE31931E24}"/>
          </ac:picMkLst>
        </pc:picChg>
        <pc:cxnChg chg="add del mod">
          <ac:chgData name="Ilaria Laurenzana" userId="d20e3a4c-5152-4781-9a82-e8e358f0fc6e" providerId="ADAL" clId="{F25154BB-24FE-45A5-ACC5-F4DE14291D12}" dt="2024-09-20T12:54:17.930" v="7052" actId="478"/>
          <ac:cxnSpMkLst>
            <pc:docMk/>
            <pc:sldMk cId="3557762631" sldId="275"/>
            <ac:cxnSpMk id="16" creationId="{36099AFC-96A0-7B4B-FB2C-FB022CA66DA6}"/>
          </ac:cxnSpMkLst>
        </pc:cxnChg>
        <pc:cxnChg chg="add del mod">
          <ac:chgData name="Ilaria Laurenzana" userId="d20e3a4c-5152-4781-9a82-e8e358f0fc6e" providerId="ADAL" clId="{F25154BB-24FE-45A5-ACC5-F4DE14291D12}" dt="2024-09-20T12:54:18.653" v="7053" actId="478"/>
          <ac:cxnSpMkLst>
            <pc:docMk/>
            <pc:sldMk cId="3557762631" sldId="275"/>
            <ac:cxnSpMk id="25" creationId="{18D8F250-5F44-89A5-602F-880A599A6B22}"/>
          </ac:cxnSpMkLst>
        </pc:cxnChg>
        <pc:cxnChg chg="add mod">
          <ac:chgData name="Ilaria Laurenzana" userId="d20e3a4c-5152-4781-9a82-e8e358f0fc6e" providerId="ADAL" clId="{F25154BB-24FE-45A5-ACC5-F4DE14291D12}" dt="2024-09-23T06:41:34.712" v="7219" actId="1036"/>
          <ac:cxnSpMkLst>
            <pc:docMk/>
            <pc:sldMk cId="3557762631" sldId="275"/>
            <ac:cxnSpMk id="54" creationId="{16C33F1D-5654-256E-CD32-29562BEFFBF8}"/>
          </ac:cxnSpMkLst>
        </pc:cxnChg>
      </pc:sldChg>
      <pc:sldChg chg="addSp modSp mod ord">
        <pc:chgData name="Ilaria Laurenzana" userId="d20e3a4c-5152-4781-9a82-e8e358f0fc6e" providerId="ADAL" clId="{F25154BB-24FE-45A5-ACC5-F4DE14291D12}" dt="2024-09-23T08:30:42.956" v="7289" actId="20577"/>
        <pc:sldMkLst>
          <pc:docMk/>
          <pc:sldMk cId="2412630881" sldId="276"/>
        </pc:sldMkLst>
        <pc:spChg chg="mod">
          <ac:chgData name="Ilaria Laurenzana" userId="d20e3a4c-5152-4781-9a82-e8e358f0fc6e" providerId="ADAL" clId="{F25154BB-24FE-45A5-ACC5-F4DE14291D12}" dt="2024-09-23T08:30:36.443" v="7286" actId="20577"/>
          <ac:spMkLst>
            <pc:docMk/>
            <pc:sldMk cId="2412630881" sldId="276"/>
            <ac:spMk id="4" creationId="{C7B457B4-ABFB-7A5B-3CB7-7F2D3622C671}"/>
          </ac:spMkLst>
        </pc:spChg>
        <pc:spChg chg="add mod">
          <ac:chgData name="Ilaria Laurenzana" userId="d20e3a4c-5152-4781-9a82-e8e358f0fc6e" providerId="ADAL" clId="{F25154BB-24FE-45A5-ACC5-F4DE14291D12}" dt="2024-09-23T08:30:42.956" v="7289" actId="20577"/>
          <ac:spMkLst>
            <pc:docMk/>
            <pc:sldMk cId="2412630881" sldId="276"/>
            <ac:spMk id="5" creationId="{D8322C17-F6B7-AEC2-548B-5C567D71D36B}"/>
          </ac:spMkLst>
        </pc:spChg>
      </pc:sldChg>
      <pc:sldChg chg="addSp delSp modSp new del mod ord">
        <pc:chgData name="Ilaria Laurenzana" userId="d20e3a4c-5152-4781-9a82-e8e358f0fc6e" providerId="ADAL" clId="{F25154BB-24FE-45A5-ACC5-F4DE14291D12}" dt="2024-09-12T08:58:04.662" v="2227" actId="2696"/>
        <pc:sldMkLst>
          <pc:docMk/>
          <pc:sldMk cId="2421372740" sldId="277"/>
        </pc:sldMkLst>
        <pc:spChg chg="del">
          <ac:chgData name="Ilaria Laurenzana" userId="d20e3a4c-5152-4781-9a82-e8e358f0fc6e" providerId="ADAL" clId="{F25154BB-24FE-45A5-ACC5-F4DE14291D12}" dt="2024-09-09T12:05:03.871" v="363" actId="478"/>
          <ac:spMkLst>
            <pc:docMk/>
            <pc:sldMk cId="2421372740" sldId="277"/>
            <ac:spMk id="2" creationId="{D1716708-28D7-E830-B713-5C5F9D596FEE}"/>
          </ac:spMkLst>
        </pc:spChg>
        <pc:spChg chg="del">
          <ac:chgData name="Ilaria Laurenzana" userId="d20e3a4c-5152-4781-9a82-e8e358f0fc6e" providerId="ADAL" clId="{F25154BB-24FE-45A5-ACC5-F4DE14291D12}" dt="2024-09-09T12:05:03.088" v="362" actId="478"/>
          <ac:spMkLst>
            <pc:docMk/>
            <pc:sldMk cId="2421372740" sldId="277"/>
            <ac:spMk id="3" creationId="{19B22E44-7999-BC37-E420-B2201F3113B4}"/>
          </ac:spMkLst>
        </pc:spChg>
        <pc:spChg chg="add mod">
          <ac:chgData name="Ilaria Laurenzana" userId="d20e3a4c-5152-4781-9a82-e8e358f0fc6e" providerId="ADAL" clId="{F25154BB-24FE-45A5-ACC5-F4DE14291D12}" dt="2024-09-09T12:22:26.532" v="844" actId="20577"/>
          <ac:spMkLst>
            <pc:docMk/>
            <pc:sldMk cId="2421372740" sldId="277"/>
            <ac:spMk id="4" creationId="{A90D793A-393B-1DA0-9950-FC31F0AF9AC5}"/>
          </ac:spMkLst>
        </pc:spChg>
        <pc:spChg chg="add del mod">
          <ac:chgData name="Ilaria Laurenzana" userId="d20e3a4c-5152-4781-9a82-e8e358f0fc6e" providerId="ADAL" clId="{F25154BB-24FE-45A5-ACC5-F4DE14291D12}" dt="2024-09-12T08:35:55.788" v="1938" actId="21"/>
          <ac:spMkLst>
            <pc:docMk/>
            <pc:sldMk cId="2421372740" sldId="277"/>
            <ac:spMk id="7" creationId="{F455EB89-A21A-4828-C9E6-7B65F36CDF4F}"/>
          </ac:spMkLst>
        </pc:spChg>
        <pc:spChg chg="add del mod">
          <ac:chgData name="Ilaria Laurenzana" userId="d20e3a4c-5152-4781-9a82-e8e358f0fc6e" providerId="ADAL" clId="{F25154BB-24FE-45A5-ACC5-F4DE14291D12}" dt="2024-09-12T08:35:55.788" v="1938" actId="21"/>
          <ac:spMkLst>
            <pc:docMk/>
            <pc:sldMk cId="2421372740" sldId="277"/>
            <ac:spMk id="16" creationId="{72C6981E-22C4-5196-EECE-FF9DFCB64E51}"/>
          </ac:spMkLst>
        </pc:spChg>
        <pc:spChg chg="add del mod">
          <ac:chgData name="Ilaria Laurenzana" userId="d20e3a4c-5152-4781-9a82-e8e358f0fc6e" providerId="ADAL" clId="{F25154BB-24FE-45A5-ACC5-F4DE14291D12}" dt="2024-09-12T08:35:55.788" v="1938" actId="21"/>
          <ac:spMkLst>
            <pc:docMk/>
            <pc:sldMk cId="2421372740" sldId="277"/>
            <ac:spMk id="17" creationId="{A94B07F5-1B5B-2C8D-938F-F7AE2C541A09}"/>
          </ac:spMkLst>
        </pc:spChg>
        <pc:spChg chg="add del mod">
          <ac:chgData name="Ilaria Laurenzana" userId="d20e3a4c-5152-4781-9a82-e8e358f0fc6e" providerId="ADAL" clId="{F25154BB-24FE-45A5-ACC5-F4DE14291D12}" dt="2024-09-12T08:35:55.788" v="1938" actId="21"/>
          <ac:spMkLst>
            <pc:docMk/>
            <pc:sldMk cId="2421372740" sldId="277"/>
            <ac:spMk id="18" creationId="{617667FC-1058-FFE0-2BC1-6D9B5C134825}"/>
          </ac:spMkLst>
        </pc:spChg>
        <pc:picChg chg="add del mod">
          <ac:chgData name="Ilaria Laurenzana" userId="d20e3a4c-5152-4781-9a82-e8e358f0fc6e" providerId="ADAL" clId="{F25154BB-24FE-45A5-ACC5-F4DE14291D12}" dt="2024-09-12T08:35:55.788" v="1938" actId="21"/>
          <ac:picMkLst>
            <pc:docMk/>
            <pc:sldMk cId="2421372740" sldId="277"/>
            <ac:picMk id="6" creationId="{084EFF21-D1FA-C833-8FC1-FA2DCB5BB0D2}"/>
          </ac:picMkLst>
        </pc:picChg>
        <pc:picChg chg="add del mod">
          <ac:chgData name="Ilaria Laurenzana" userId="d20e3a4c-5152-4781-9a82-e8e358f0fc6e" providerId="ADAL" clId="{F25154BB-24FE-45A5-ACC5-F4DE14291D12}" dt="2024-09-12T08:35:55.788" v="1938" actId="21"/>
          <ac:picMkLst>
            <pc:docMk/>
            <pc:sldMk cId="2421372740" sldId="277"/>
            <ac:picMk id="9" creationId="{C2D9225F-880C-E527-1C8B-B6B553894625}"/>
          </ac:picMkLst>
        </pc:picChg>
        <pc:picChg chg="add del mod">
          <ac:chgData name="Ilaria Laurenzana" userId="d20e3a4c-5152-4781-9a82-e8e358f0fc6e" providerId="ADAL" clId="{F25154BB-24FE-45A5-ACC5-F4DE14291D12}" dt="2024-09-12T08:35:55.788" v="1938" actId="21"/>
          <ac:picMkLst>
            <pc:docMk/>
            <pc:sldMk cId="2421372740" sldId="277"/>
            <ac:picMk id="10" creationId="{3E6B9AA7-A744-EFC7-6906-9B1B266136A1}"/>
          </ac:picMkLst>
        </pc:picChg>
      </pc:sldChg>
      <pc:sldChg chg="addSp delSp modSp add mod ord">
        <pc:chgData name="Ilaria Laurenzana" userId="d20e3a4c-5152-4781-9a82-e8e358f0fc6e" providerId="ADAL" clId="{F25154BB-24FE-45A5-ACC5-F4DE14291D12}" dt="2024-09-23T08:31:26.378" v="7301" actId="20577"/>
        <pc:sldMkLst>
          <pc:docMk/>
          <pc:sldMk cId="3623638635" sldId="278"/>
        </pc:sldMkLst>
        <pc:spChg chg="del mod">
          <ac:chgData name="Ilaria Laurenzana" userId="d20e3a4c-5152-4781-9a82-e8e358f0fc6e" providerId="ADAL" clId="{F25154BB-24FE-45A5-ACC5-F4DE14291D12}" dt="2024-09-19T11:19:15.075" v="6043" actId="478"/>
          <ac:spMkLst>
            <pc:docMk/>
            <pc:sldMk cId="3623638635" sldId="278"/>
            <ac:spMk id="2" creationId="{AEF20D4B-111E-8002-337F-2837432F098B}"/>
          </ac:spMkLst>
        </pc:spChg>
        <pc:spChg chg="add mod">
          <ac:chgData name="Ilaria Laurenzana" userId="d20e3a4c-5152-4781-9a82-e8e358f0fc6e" providerId="ADAL" clId="{F25154BB-24FE-45A5-ACC5-F4DE14291D12}" dt="2024-09-19T11:18:12.384" v="5981" actId="1035"/>
          <ac:spMkLst>
            <pc:docMk/>
            <pc:sldMk cId="3623638635" sldId="278"/>
            <ac:spMk id="3" creationId="{032C79FA-F572-72CA-2346-F447ACA00F09}"/>
          </ac:spMkLst>
        </pc:spChg>
        <pc:spChg chg="add mod">
          <ac:chgData name="Ilaria Laurenzana" userId="d20e3a4c-5152-4781-9a82-e8e358f0fc6e" providerId="ADAL" clId="{F25154BB-24FE-45A5-ACC5-F4DE14291D12}" dt="2024-09-12T12:40:55.975" v="2672" actId="6549"/>
          <ac:spMkLst>
            <pc:docMk/>
            <pc:sldMk cId="3623638635" sldId="278"/>
            <ac:spMk id="4" creationId="{53595E63-5C54-5E29-B709-FCEF276E4532}"/>
          </ac:spMkLst>
        </pc:spChg>
        <pc:spChg chg="mod">
          <ac:chgData name="Ilaria Laurenzana" userId="d20e3a4c-5152-4781-9a82-e8e358f0fc6e" providerId="ADAL" clId="{F25154BB-24FE-45A5-ACC5-F4DE14291D12}" dt="2024-09-23T08:31:10.765" v="7298" actId="20577"/>
          <ac:spMkLst>
            <pc:docMk/>
            <pc:sldMk cId="3623638635" sldId="278"/>
            <ac:spMk id="5" creationId="{07CCE871-86F8-59B4-78CF-BAD355831141}"/>
          </ac:spMkLst>
        </pc:spChg>
        <pc:spChg chg="add mod">
          <ac:chgData name="Ilaria Laurenzana" userId="d20e3a4c-5152-4781-9a82-e8e358f0fc6e" providerId="ADAL" clId="{F25154BB-24FE-45A5-ACC5-F4DE14291D12}" dt="2024-09-23T08:31:26.378" v="7301" actId="20577"/>
          <ac:spMkLst>
            <pc:docMk/>
            <pc:sldMk cId="3623638635" sldId="278"/>
            <ac:spMk id="6" creationId="{4C2C216D-613B-A38D-B02B-1EF396AF8E74}"/>
          </ac:spMkLst>
        </pc:spChg>
        <pc:spChg chg="del">
          <ac:chgData name="Ilaria Laurenzana" userId="d20e3a4c-5152-4781-9a82-e8e358f0fc6e" providerId="ADAL" clId="{F25154BB-24FE-45A5-ACC5-F4DE14291D12}" dt="2024-09-09T12:06:18.843" v="375" actId="478"/>
          <ac:spMkLst>
            <pc:docMk/>
            <pc:sldMk cId="3623638635" sldId="278"/>
            <ac:spMk id="7" creationId="{FDDB23E3-7221-C7F2-7EE5-DD399E0F1BBB}"/>
          </ac:spMkLst>
        </pc:spChg>
        <pc:spChg chg="add del mod">
          <ac:chgData name="Ilaria Laurenzana" userId="d20e3a4c-5152-4781-9a82-e8e358f0fc6e" providerId="ADAL" clId="{F25154BB-24FE-45A5-ACC5-F4DE14291D12}" dt="2024-09-19T11:19:18.329" v="6044" actId="478"/>
          <ac:spMkLst>
            <pc:docMk/>
            <pc:sldMk cId="3623638635" sldId="278"/>
            <ac:spMk id="21" creationId="{89B9B57F-0C2B-0567-9020-D06BAE999825}"/>
          </ac:spMkLst>
        </pc:spChg>
        <pc:picChg chg="del">
          <ac:chgData name="Ilaria Laurenzana" userId="d20e3a4c-5152-4781-9a82-e8e358f0fc6e" providerId="ADAL" clId="{F25154BB-24FE-45A5-ACC5-F4DE14291D12}" dt="2024-09-09T12:06:19.439" v="376" actId="478"/>
          <ac:picMkLst>
            <pc:docMk/>
            <pc:sldMk cId="3623638635" sldId="278"/>
            <ac:picMk id="3" creationId="{E16383EE-7F2B-EAAA-060F-F37554F20F4E}"/>
          </ac:picMkLst>
        </pc:picChg>
        <pc:picChg chg="del">
          <ac:chgData name="Ilaria Laurenzana" userId="d20e3a4c-5152-4781-9a82-e8e358f0fc6e" providerId="ADAL" clId="{F25154BB-24FE-45A5-ACC5-F4DE14291D12}" dt="2024-09-09T12:06:21.008" v="379" actId="478"/>
          <ac:picMkLst>
            <pc:docMk/>
            <pc:sldMk cId="3623638635" sldId="278"/>
            <ac:picMk id="4" creationId="{839C1FF8-9A58-4C32-C569-11E339B66E2A}"/>
          </ac:picMkLst>
        </pc:picChg>
        <pc:picChg chg="del">
          <ac:chgData name="Ilaria Laurenzana" userId="d20e3a4c-5152-4781-9a82-e8e358f0fc6e" providerId="ADAL" clId="{F25154BB-24FE-45A5-ACC5-F4DE14291D12}" dt="2024-09-09T12:06:19.910" v="377" actId="478"/>
          <ac:picMkLst>
            <pc:docMk/>
            <pc:sldMk cId="3623638635" sldId="278"/>
            <ac:picMk id="6" creationId="{1A38BD96-7AAB-2151-0200-DFDF8C232F30}"/>
          </ac:picMkLst>
        </pc:picChg>
        <pc:picChg chg="add mod">
          <ac:chgData name="Ilaria Laurenzana" userId="d20e3a4c-5152-4781-9a82-e8e358f0fc6e" providerId="ADAL" clId="{F25154BB-24FE-45A5-ACC5-F4DE14291D12}" dt="2024-09-19T11:04:49.121" v="5383" actId="1076"/>
          <ac:picMkLst>
            <pc:docMk/>
            <pc:sldMk cId="3623638635" sldId="278"/>
            <ac:picMk id="7" creationId="{E21987B3-477B-B9D7-EE7E-8B4A5B857F4B}"/>
          </ac:picMkLst>
        </pc:picChg>
        <pc:picChg chg="mod modCrop">
          <ac:chgData name="Ilaria Laurenzana" userId="d20e3a4c-5152-4781-9a82-e8e358f0fc6e" providerId="ADAL" clId="{F25154BB-24FE-45A5-ACC5-F4DE14291D12}" dt="2024-09-19T11:19:30.036" v="6070" actId="1036"/>
          <ac:picMkLst>
            <pc:docMk/>
            <pc:sldMk cId="3623638635" sldId="278"/>
            <ac:picMk id="8" creationId="{89CB2316-8ED9-3DA3-F379-9957AF970C43}"/>
          </ac:picMkLst>
        </pc:picChg>
        <pc:picChg chg="mod modCrop">
          <ac:chgData name="Ilaria Laurenzana" userId="d20e3a4c-5152-4781-9a82-e8e358f0fc6e" providerId="ADAL" clId="{F25154BB-24FE-45A5-ACC5-F4DE14291D12}" dt="2024-09-19T11:19:30.036" v="6070" actId="1036"/>
          <ac:picMkLst>
            <pc:docMk/>
            <pc:sldMk cId="3623638635" sldId="278"/>
            <ac:picMk id="9" creationId="{74F88B03-1EC0-5AB1-92E7-B1A236A13C0E}"/>
          </ac:picMkLst>
        </pc:picChg>
        <pc:picChg chg="mod">
          <ac:chgData name="Ilaria Laurenzana" userId="d20e3a4c-5152-4781-9a82-e8e358f0fc6e" providerId="ADAL" clId="{F25154BB-24FE-45A5-ACC5-F4DE14291D12}" dt="2024-09-19T11:19:30.036" v="6070" actId="1036"/>
          <ac:picMkLst>
            <pc:docMk/>
            <pc:sldMk cId="3623638635" sldId="278"/>
            <ac:picMk id="10" creationId="{30C7E740-7576-7A80-0090-289333DCD923}"/>
          </ac:picMkLst>
        </pc:picChg>
        <pc:picChg chg="mod">
          <ac:chgData name="Ilaria Laurenzana" userId="d20e3a4c-5152-4781-9a82-e8e358f0fc6e" providerId="ADAL" clId="{F25154BB-24FE-45A5-ACC5-F4DE14291D12}" dt="2024-09-19T11:19:30.036" v="6070" actId="1036"/>
          <ac:picMkLst>
            <pc:docMk/>
            <pc:sldMk cId="3623638635" sldId="278"/>
            <ac:picMk id="11" creationId="{76E50415-919B-550E-212B-1C2A04192796}"/>
          </ac:picMkLst>
        </pc:picChg>
        <pc:picChg chg="mod modCrop">
          <ac:chgData name="Ilaria Laurenzana" userId="d20e3a4c-5152-4781-9a82-e8e358f0fc6e" providerId="ADAL" clId="{F25154BB-24FE-45A5-ACC5-F4DE14291D12}" dt="2024-09-19T11:19:30.036" v="6070" actId="1036"/>
          <ac:picMkLst>
            <pc:docMk/>
            <pc:sldMk cId="3623638635" sldId="278"/>
            <ac:picMk id="12" creationId="{5F5B637A-2E6C-8ECB-9E5F-AD86E9F13A99}"/>
          </ac:picMkLst>
        </pc:picChg>
        <pc:picChg chg="del">
          <ac:chgData name="Ilaria Laurenzana" userId="d20e3a4c-5152-4781-9a82-e8e358f0fc6e" providerId="ADAL" clId="{F25154BB-24FE-45A5-ACC5-F4DE14291D12}" dt="2024-09-09T12:06:17.002" v="374" actId="478"/>
          <ac:picMkLst>
            <pc:docMk/>
            <pc:sldMk cId="3623638635" sldId="278"/>
            <ac:picMk id="13" creationId="{8560BD30-B42A-E452-8E58-7098638ABC45}"/>
          </ac:picMkLst>
        </pc:picChg>
        <pc:picChg chg="add mod">
          <ac:chgData name="Ilaria Laurenzana" userId="d20e3a4c-5152-4781-9a82-e8e358f0fc6e" providerId="ADAL" clId="{F25154BB-24FE-45A5-ACC5-F4DE14291D12}" dt="2024-09-19T11:09:48.450" v="5404" actId="14100"/>
          <ac:picMkLst>
            <pc:docMk/>
            <pc:sldMk cId="3623638635" sldId="278"/>
            <ac:picMk id="13" creationId="{ECA5C339-D8D1-6351-4DF7-92981A6E14EE}"/>
          </ac:picMkLst>
        </pc:picChg>
        <pc:picChg chg="add mod modCrop">
          <ac:chgData name="Ilaria Laurenzana" userId="d20e3a4c-5152-4781-9a82-e8e358f0fc6e" providerId="ADAL" clId="{F25154BB-24FE-45A5-ACC5-F4DE14291D12}" dt="2024-09-19T11:19:30.036" v="6070" actId="1036"/>
          <ac:picMkLst>
            <pc:docMk/>
            <pc:sldMk cId="3623638635" sldId="278"/>
            <ac:picMk id="14" creationId="{3B7BEB9A-8E4D-C1F4-B3C1-05AC23579EF0}"/>
          </ac:picMkLst>
        </pc:picChg>
        <pc:picChg chg="del">
          <ac:chgData name="Ilaria Laurenzana" userId="d20e3a4c-5152-4781-9a82-e8e358f0fc6e" providerId="ADAL" clId="{F25154BB-24FE-45A5-ACC5-F4DE14291D12}" dt="2024-09-09T12:06:20.632" v="378" actId="478"/>
          <ac:picMkLst>
            <pc:docMk/>
            <pc:sldMk cId="3623638635" sldId="278"/>
            <ac:picMk id="14" creationId="{B3EC20D2-BAE3-ECD4-9C8C-289B73385C83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15" creationId="{06519645-8BD3-F02B-5D1F-A5C160FB13A5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16" creationId="{34D3EE78-F6E2-0FCB-7CA1-4B4DCD060709}"/>
          </ac:picMkLst>
        </pc:picChg>
        <pc:picChg chg="add mod or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17" creationId="{1B004F38-8660-D55C-B83B-3084199EF8F9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18" creationId="{CFE50A75-CFF7-0A1D-6D48-687D1AE30414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19" creationId="{B8A7CF89-55DC-2374-017A-981426D0069D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20" creationId="{68B907D0-E2EC-1CE0-551B-232FD89833D7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22" creationId="{D8752FED-5035-FEEA-C8A8-FBAA380F6AFE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23" creationId="{8162C6DA-2978-4084-0C71-5062B39F2211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24" creationId="{C6BCA9BC-80E1-3708-D838-95F821208025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25" creationId="{61089F04-884F-5C95-F742-FE3FD5686027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26" creationId="{A4AC95E8-A24D-7FB0-79FC-063B23C056B4}"/>
          </ac:picMkLst>
        </pc:picChg>
        <pc:picChg chg="add mod">
          <ac:chgData name="Ilaria Laurenzana" userId="d20e3a4c-5152-4781-9a82-e8e358f0fc6e" providerId="ADAL" clId="{F25154BB-24FE-45A5-ACC5-F4DE14291D12}" dt="2024-09-19T12:10:16.527" v="6211" actId="1036"/>
          <ac:picMkLst>
            <pc:docMk/>
            <pc:sldMk cId="3623638635" sldId="278"/>
            <ac:picMk id="27" creationId="{0D3C626E-EB83-FB1B-54B4-8BBF621CD4EC}"/>
          </ac:picMkLst>
        </pc:picChg>
        <pc:picChg chg="add mod modCrop">
          <ac:chgData name="Ilaria Laurenzana" userId="d20e3a4c-5152-4781-9a82-e8e358f0fc6e" providerId="ADAL" clId="{F25154BB-24FE-45A5-ACC5-F4DE14291D12}" dt="2024-09-19T11:19:30.036" v="6070" actId="1036"/>
          <ac:picMkLst>
            <pc:docMk/>
            <pc:sldMk cId="3623638635" sldId="278"/>
            <ac:picMk id="28" creationId="{820BD914-50A3-A76C-C67D-B2A51E20BE37}"/>
          </ac:picMkLst>
        </pc:picChg>
        <pc:picChg chg="add mod modCrop">
          <ac:chgData name="Ilaria Laurenzana" userId="d20e3a4c-5152-4781-9a82-e8e358f0fc6e" providerId="ADAL" clId="{F25154BB-24FE-45A5-ACC5-F4DE14291D12}" dt="2024-09-19T11:19:30.036" v="6070" actId="1036"/>
          <ac:picMkLst>
            <pc:docMk/>
            <pc:sldMk cId="3623638635" sldId="278"/>
            <ac:picMk id="29" creationId="{0EC3F3D7-28DD-CED5-C97C-376B51034844}"/>
          </ac:picMkLst>
        </pc:picChg>
        <pc:picChg chg="add mod modCrop">
          <ac:chgData name="Ilaria Laurenzana" userId="d20e3a4c-5152-4781-9a82-e8e358f0fc6e" providerId="ADAL" clId="{F25154BB-24FE-45A5-ACC5-F4DE14291D12}" dt="2024-09-19T11:19:30.036" v="6070" actId="1036"/>
          <ac:picMkLst>
            <pc:docMk/>
            <pc:sldMk cId="3623638635" sldId="278"/>
            <ac:picMk id="30" creationId="{F92A34DD-7559-ED0C-4204-2EDA6016E029}"/>
          </ac:picMkLst>
        </pc:picChg>
      </pc:sldChg>
      <pc:sldChg chg="delSp add del mod ord replId">
        <pc:chgData name="Ilaria Laurenzana" userId="d20e3a4c-5152-4781-9a82-e8e358f0fc6e" providerId="ADAL" clId="{F25154BB-24FE-45A5-ACC5-F4DE14291D12}" dt="2024-09-09T12:07:19.626" v="398" actId="47"/>
        <pc:sldMkLst>
          <pc:docMk/>
          <pc:sldMk cId="1488602654" sldId="279"/>
        </pc:sldMkLst>
        <pc:spChg chg="del">
          <ac:chgData name="Ilaria Laurenzana" userId="d20e3a4c-5152-4781-9a82-e8e358f0fc6e" providerId="ADAL" clId="{F25154BB-24FE-45A5-ACC5-F4DE14291D12}" dt="2024-09-09T12:06:36.573" v="381" actId="21"/>
          <ac:spMkLst>
            <pc:docMk/>
            <pc:sldMk cId="1488602654" sldId="279"/>
            <ac:spMk id="2" creationId="{89B9B57F-0C2B-0567-9020-D06BAE999825}"/>
          </ac:spMkLst>
        </pc:spChg>
        <pc:spChg chg="del">
          <ac:chgData name="Ilaria Laurenzana" userId="d20e3a4c-5152-4781-9a82-e8e358f0fc6e" providerId="ADAL" clId="{F25154BB-24FE-45A5-ACC5-F4DE14291D12}" dt="2024-09-09T12:06:30.149" v="380" actId="478"/>
          <ac:spMkLst>
            <pc:docMk/>
            <pc:sldMk cId="1488602654" sldId="279"/>
            <ac:spMk id="3" creationId="{E4828BED-2413-A931-44FA-DB4B6F258D22}"/>
          </ac:spMkLst>
        </pc:spChg>
        <pc:grpChg chg="del">
          <ac:chgData name="Ilaria Laurenzana" userId="d20e3a4c-5152-4781-9a82-e8e358f0fc6e" providerId="ADAL" clId="{F25154BB-24FE-45A5-ACC5-F4DE14291D12}" dt="2024-09-09T12:06:30.149" v="380" actId="478"/>
          <ac:grpSpMkLst>
            <pc:docMk/>
            <pc:sldMk cId="1488602654" sldId="279"/>
            <ac:grpSpMk id="35" creationId="{970DC4A2-9CB1-CA3D-2F83-C0B4C1868A82}"/>
          </ac:grpSpMkLst>
        </pc:grpChg>
        <pc:grpChg chg="del">
          <ac:chgData name="Ilaria Laurenzana" userId="d20e3a4c-5152-4781-9a82-e8e358f0fc6e" providerId="ADAL" clId="{F25154BB-24FE-45A5-ACC5-F4DE14291D12}" dt="2024-09-09T12:06:30.149" v="380" actId="478"/>
          <ac:grpSpMkLst>
            <pc:docMk/>
            <pc:sldMk cId="1488602654" sldId="279"/>
            <ac:grpSpMk id="37" creationId="{ED461D77-E4FF-E994-9645-D0CFB555FDA2}"/>
          </ac:grpSpMkLst>
        </pc:grpChg>
        <pc:grpChg chg="del">
          <ac:chgData name="Ilaria Laurenzana" userId="d20e3a4c-5152-4781-9a82-e8e358f0fc6e" providerId="ADAL" clId="{F25154BB-24FE-45A5-ACC5-F4DE14291D12}" dt="2024-09-09T12:06:30.149" v="380" actId="478"/>
          <ac:grpSpMkLst>
            <pc:docMk/>
            <pc:sldMk cId="1488602654" sldId="279"/>
            <ac:grpSpMk id="39" creationId="{BF33CB5B-1AB5-C0DE-501D-ED54DD0B4978}"/>
          </ac:grpSpMkLst>
        </pc:grpChg>
        <pc:grpChg chg="del">
          <ac:chgData name="Ilaria Laurenzana" userId="d20e3a4c-5152-4781-9a82-e8e358f0fc6e" providerId="ADAL" clId="{F25154BB-24FE-45A5-ACC5-F4DE14291D12}" dt="2024-09-09T12:06:30.149" v="380" actId="478"/>
          <ac:grpSpMkLst>
            <pc:docMk/>
            <pc:sldMk cId="1488602654" sldId="279"/>
            <ac:grpSpMk id="41" creationId="{72219C42-5CA5-20D8-EDF6-85E3DAB728BB}"/>
          </ac:grpSpMkLst>
        </pc:grpChg>
        <pc:graphicFrameChg chg="del">
          <ac:chgData name="Ilaria Laurenzana" userId="d20e3a4c-5152-4781-9a82-e8e358f0fc6e" providerId="ADAL" clId="{F25154BB-24FE-45A5-ACC5-F4DE14291D12}" dt="2024-09-09T12:06:30.149" v="380" actId="478"/>
          <ac:graphicFrameMkLst>
            <pc:docMk/>
            <pc:sldMk cId="1488602654" sldId="279"/>
            <ac:graphicFrameMk id="23" creationId="{71CFEBA4-B308-FBD4-7126-9FB11F8D0093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06:30.149" v="380" actId="478"/>
          <ac:graphicFrameMkLst>
            <pc:docMk/>
            <pc:sldMk cId="1488602654" sldId="279"/>
            <ac:graphicFrameMk id="24" creationId="{484D4AF2-294D-2495-101F-A3EB222FF32B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06:30.149" v="380" actId="478"/>
          <ac:graphicFrameMkLst>
            <pc:docMk/>
            <pc:sldMk cId="1488602654" sldId="279"/>
            <ac:graphicFrameMk id="25" creationId="{65BFF04D-5662-6D2E-45E3-4816C930D052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06:30.149" v="380" actId="478"/>
          <ac:graphicFrameMkLst>
            <pc:docMk/>
            <pc:sldMk cId="1488602654" sldId="279"/>
            <ac:graphicFrameMk id="26" creationId="{25A1B6DC-820F-9E2D-9758-0742FA86E9EE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06:30.149" v="380" actId="478"/>
          <ac:graphicFrameMkLst>
            <pc:docMk/>
            <pc:sldMk cId="1488602654" sldId="279"/>
            <ac:graphicFrameMk id="27" creationId="{398408B7-7E79-AB12-507A-DE428709A32D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06:30.149" v="380" actId="478"/>
          <ac:graphicFrameMkLst>
            <pc:docMk/>
            <pc:sldMk cId="1488602654" sldId="279"/>
            <ac:graphicFrameMk id="31" creationId="{E51715AE-C2A9-7D8F-DABC-3DA9B4CFC829}"/>
          </ac:graphicFrameMkLst>
        </pc:graphicFrameChg>
        <pc:graphicFrameChg chg="del">
          <ac:chgData name="Ilaria Laurenzana" userId="d20e3a4c-5152-4781-9a82-e8e358f0fc6e" providerId="ADAL" clId="{F25154BB-24FE-45A5-ACC5-F4DE14291D12}" dt="2024-09-09T12:06:30.149" v="380" actId="478"/>
          <ac:graphicFrameMkLst>
            <pc:docMk/>
            <pc:sldMk cId="1488602654" sldId="279"/>
            <ac:graphicFrameMk id="34" creationId="{2879F0C6-DB5A-D498-1394-B13F54F48584}"/>
          </ac:graphicFrameMkLst>
        </pc:graphicFrame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10" creationId="{D8752FED-5035-FEEA-C8A8-FBAA380F6AFE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11" creationId="{34D3EE78-F6E2-0FCB-7CA1-4B4DCD060709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12" creationId="{61089F04-884F-5C95-F742-FE3FD5686027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13" creationId="{1B004F38-8660-D55C-B83B-3084199EF8F9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14" creationId="{06519645-8BD3-F02B-5D1F-A5C160FB13A5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15" creationId="{CFE50A75-CFF7-0A1D-6D48-687D1AE30414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17" creationId="{B8A7CF89-55DC-2374-017A-981426D0069D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18" creationId="{68B907D0-E2EC-1CE0-551B-232FD89833D7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19" creationId="{8162C6DA-2978-4084-0C71-5062B39F2211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20" creationId="{C6BCA9BC-80E1-3708-D838-95F821208025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21" creationId="{0D3C626E-EB83-FB1B-54B4-8BBF621CD4EC}"/>
          </ac:picMkLst>
        </pc:picChg>
        <pc:picChg chg="del">
          <ac:chgData name="Ilaria Laurenzana" userId="d20e3a4c-5152-4781-9a82-e8e358f0fc6e" providerId="ADAL" clId="{F25154BB-24FE-45A5-ACC5-F4DE14291D12}" dt="2024-09-09T12:06:36.573" v="381" actId="21"/>
          <ac:picMkLst>
            <pc:docMk/>
            <pc:sldMk cId="1488602654" sldId="279"/>
            <ac:picMk id="22" creationId="{A4AC95E8-A24D-7FB0-79FC-063B23C056B4}"/>
          </ac:picMkLst>
        </pc:picChg>
      </pc:sldChg>
      <pc:sldChg chg="addSp delSp modSp new mod">
        <pc:chgData name="Ilaria Laurenzana" userId="d20e3a4c-5152-4781-9a82-e8e358f0fc6e" providerId="ADAL" clId="{F25154BB-24FE-45A5-ACC5-F4DE14291D12}" dt="2024-09-20T11:59:52.119" v="6985" actId="1076"/>
        <pc:sldMkLst>
          <pc:docMk/>
          <pc:sldMk cId="4252137472" sldId="279"/>
        </pc:sldMkLst>
        <pc:spChg chg="del">
          <ac:chgData name="Ilaria Laurenzana" userId="d20e3a4c-5152-4781-9a82-e8e358f0fc6e" providerId="ADAL" clId="{F25154BB-24FE-45A5-ACC5-F4DE14291D12}" dt="2024-09-20T11:56:41.099" v="6973" actId="478"/>
          <ac:spMkLst>
            <pc:docMk/>
            <pc:sldMk cId="4252137472" sldId="279"/>
            <ac:spMk id="2" creationId="{B6E6E8FF-ABC1-36CC-F271-532983577E67}"/>
          </ac:spMkLst>
        </pc:spChg>
        <pc:spChg chg="del">
          <ac:chgData name="Ilaria Laurenzana" userId="d20e3a4c-5152-4781-9a82-e8e358f0fc6e" providerId="ADAL" clId="{F25154BB-24FE-45A5-ACC5-F4DE14291D12}" dt="2024-09-20T11:56:38.450" v="6972" actId="478"/>
          <ac:spMkLst>
            <pc:docMk/>
            <pc:sldMk cId="4252137472" sldId="279"/>
            <ac:spMk id="3" creationId="{6C791561-F97E-19A3-9E6B-4C7EA6706F6A}"/>
          </ac:spMkLst>
        </pc:spChg>
        <pc:spChg chg="add mod">
          <ac:chgData name="Ilaria Laurenzana" userId="d20e3a4c-5152-4781-9a82-e8e358f0fc6e" providerId="ADAL" clId="{F25154BB-24FE-45A5-ACC5-F4DE14291D12}" dt="2024-09-20T11:56:50.731" v="6976" actId="20577"/>
          <ac:spMkLst>
            <pc:docMk/>
            <pc:sldMk cId="4252137472" sldId="279"/>
            <ac:spMk id="4" creationId="{BA77C1FF-6066-F4B6-EEFC-DB69161CE623}"/>
          </ac:spMkLst>
        </pc:spChg>
        <pc:picChg chg="add mod">
          <ac:chgData name="Ilaria Laurenzana" userId="d20e3a4c-5152-4781-9a82-e8e358f0fc6e" providerId="ADAL" clId="{F25154BB-24FE-45A5-ACC5-F4DE14291D12}" dt="2024-09-20T11:59:52.119" v="6985" actId="1076"/>
          <ac:picMkLst>
            <pc:docMk/>
            <pc:sldMk cId="4252137472" sldId="279"/>
            <ac:picMk id="6" creationId="{8EA5325E-ED05-8E82-B2D9-F74A330E9354}"/>
          </ac:picMkLst>
        </pc:picChg>
      </pc:sldChg>
    </pc:docChg>
  </pc:docChgLst>
  <pc:docChgLst>
    <pc:chgData name="Ilaria Laurenzana" userId="S::ilaria.laurenzana@crob.it::d20e3a4c-5152-4781-9a82-e8e358f0fc6e" providerId="AD" clId="Web-{E54BB84D-D7AC-045F-E31F-9C114971F03F}"/>
    <pc:docChg chg="modSld">
      <pc:chgData name="Ilaria Laurenzana" userId="S::ilaria.laurenzana@crob.it::d20e3a4c-5152-4781-9a82-e8e358f0fc6e" providerId="AD" clId="Web-{E54BB84D-D7AC-045F-E31F-9C114971F03F}" dt="2024-09-26T11:37:36.847" v="1" actId="1076"/>
      <pc:docMkLst>
        <pc:docMk/>
      </pc:docMkLst>
      <pc:sldChg chg="modSp">
        <pc:chgData name="Ilaria Laurenzana" userId="S::ilaria.laurenzana@crob.it::d20e3a4c-5152-4781-9a82-e8e358f0fc6e" providerId="AD" clId="Web-{E54BB84D-D7AC-045F-E31F-9C114971F03F}" dt="2024-09-26T11:37:36.847" v="1" actId="1076"/>
        <pc:sldMkLst>
          <pc:docMk/>
          <pc:sldMk cId="425908882" sldId="258"/>
        </pc:sldMkLst>
        <pc:spChg chg="mod">
          <ac:chgData name="Ilaria Laurenzana" userId="S::ilaria.laurenzana@crob.it::d20e3a4c-5152-4781-9a82-e8e358f0fc6e" providerId="AD" clId="Web-{E54BB84D-D7AC-045F-E31F-9C114971F03F}" dt="2024-09-26T11:37:36.847" v="1" actId="1076"/>
          <ac:spMkLst>
            <pc:docMk/>
            <pc:sldMk cId="425908882" sldId="258"/>
            <ac:spMk id="6" creationId="{A014E532-993D-4D50-66EF-21E53F4CC508}"/>
          </ac:spMkLst>
        </pc:spChg>
        <pc:picChg chg="mod">
          <ac:chgData name="Ilaria Laurenzana" userId="S::ilaria.laurenzana@crob.it::d20e3a4c-5152-4781-9a82-e8e358f0fc6e" providerId="AD" clId="Web-{E54BB84D-D7AC-045F-E31F-9C114971F03F}" dt="2024-09-26T11:37:24.144" v="0" actId="1076"/>
          <ac:picMkLst>
            <pc:docMk/>
            <pc:sldMk cId="425908882" sldId="258"/>
            <ac:picMk id="15" creationId="{41B43AF4-826A-A3C5-F74C-3B7B735BB113}"/>
          </ac:picMkLst>
        </pc:picChg>
      </pc:sldChg>
    </pc:docChg>
  </pc:docChgLst>
  <pc:docChgLst>
    <pc:chgData clId="Web-{3BD1CA31-8EE9-054E-24F8-DC28452908FF}"/>
    <pc:docChg chg="modSld">
      <pc:chgData name="" userId="" providerId="" clId="Web-{3BD1CA31-8EE9-054E-24F8-DC28452908FF}" dt="2024-09-26T09:42:38.091" v="0"/>
      <pc:docMkLst>
        <pc:docMk/>
      </pc:docMkLst>
      <pc:sldChg chg="delSp">
        <pc:chgData name="" userId="" providerId="" clId="Web-{3BD1CA31-8EE9-054E-24F8-DC28452908FF}" dt="2024-09-26T09:42:38.091" v="0"/>
        <pc:sldMkLst>
          <pc:docMk/>
          <pc:sldMk cId="425908882" sldId="258"/>
        </pc:sldMkLst>
        <pc:picChg chg="del">
          <ac:chgData name="" userId="" providerId="" clId="Web-{3BD1CA31-8EE9-054E-24F8-DC28452908FF}" dt="2024-09-26T09:42:38.091" v="0"/>
          <ac:picMkLst>
            <pc:docMk/>
            <pc:sldMk cId="425908882" sldId="258"/>
            <ac:picMk id="18" creationId="{2A76350F-4267-349B-850E-F0949A10A0BF}"/>
          </ac:picMkLst>
        </pc:picChg>
      </pc:sldChg>
    </pc:docChg>
  </pc:docChgLst>
  <pc:docChgLst>
    <pc:chgData clId="Web-{E9A5C8F4-8985-7D32-C257-EDC77104564A}"/>
    <pc:docChg chg="modSld">
      <pc:chgData name="" userId="" providerId="" clId="Web-{E9A5C8F4-8985-7D32-C257-EDC77104564A}" dt="2024-09-26T11:36:18.129" v="0"/>
      <pc:docMkLst>
        <pc:docMk/>
      </pc:docMkLst>
      <pc:sldChg chg="delSp">
        <pc:chgData name="" userId="" providerId="" clId="Web-{E9A5C8F4-8985-7D32-C257-EDC77104564A}" dt="2024-09-26T11:36:18.129" v="0"/>
        <pc:sldMkLst>
          <pc:docMk/>
          <pc:sldMk cId="425908882" sldId="258"/>
        </pc:sldMkLst>
        <pc:picChg chg="del">
          <ac:chgData name="" userId="" providerId="" clId="Web-{E9A5C8F4-8985-7D32-C257-EDC77104564A}" dt="2024-09-26T11:36:18.129" v="0"/>
          <ac:picMkLst>
            <pc:docMk/>
            <pc:sldMk cId="425908882" sldId="258"/>
            <ac:picMk id="9" creationId="{2087FB63-8DF9-6BC8-5B06-B1B1CDC5BF66}"/>
          </ac:picMkLst>
        </pc:picChg>
      </pc:sldChg>
    </pc:docChg>
  </pc:docChgLst>
  <pc:docChgLst>
    <pc:chgData name="Luciana De Luca" userId="S::luciana.deluca@crob.it::bae8d283-e187-4b8e-966b-081af72c9cd4" providerId="AD" clId="Web-{56B6EAE2-8D2B-9878-434D-991B9EECED73}"/>
    <pc:docChg chg="addSld delSld modSld sldOrd">
      <pc:chgData name="Luciana De Luca" userId="S::luciana.deluca@crob.it::bae8d283-e187-4b8e-966b-081af72c9cd4" providerId="AD" clId="Web-{56B6EAE2-8D2B-9878-434D-991B9EECED73}" dt="2024-11-13T12:08:41.960" v="16"/>
      <pc:docMkLst>
        <pc:docMk/>
      </pc:docMkLst>
      <pc:sldChg chg="addSp delSp modSp new del ord">
        <pc:chgData name="Luciana De Luca" userId="S::luciana.deluca@crob.it::bae8d283-e187-4b8e-966b-081af72c9cd4" providerId="AD" clId="Web-{56B6EAE2-8D2B-9878-434D-991B9EECED73}" dt="2024-11-13T12:08:41.960" v="16"/>
        <pc:sldMkLst>
          <pc:docMk/>
          <pc:sldMk cId="3497107316" sldId="279"/>
        </pc:sldMkLst>
        <pc:spChg chg="del">
          <ac:chgData name="Luciana De Luca" userId="S::luciana.deluca@crob.it::bae8d283-e187-4b8e-966b-081af72c9cd4" providerId="AD" clId="Web-{56B6EAE2-8D2B-9878-434D-991B9EECED73}" dt="2024-11-13T12:08:21.693" v="8"/>
          <ac:spMkLst>
            <pc:docMk/>
            <pc:sldMk cId="3497107316" sldId="279"/>
            <ac:spMk id="2" creationId="{F21E53CC-95EE-8B7F-012A-3C40B40D4ADA}"/>
          </ac:spMkLst>
        </pc:spChg>
        <pc:spChg chg="del">
          <ac:chgData name="Luciana De Luca" userId="S::luciana.deluca@crob.it::bae8d283-e187-4b8e-966b-081af72c9cd4" providerId="AD" clId="Web-{56B6EAE2-8D2B-9878-434D-991B9EECED73}" dt="2024-11-13T12:08:24.303" v="9"/>
          <ac:spMkLst>
            <pc:docMk/>
            <pc:sldMk cId="3497107316" sldId="279"/>
            <ac:spMk id="3" creationId="{28E7C6A0-94F4-4AA3-8AE7-52C291D2AC4D}"/>
          </ac:spMkLst>
        </pc:spChg>
        <pc:spChg chg="add del mod">
          <ac:chgData name="Luciana De Luca" userId="S::luciana.deluca@crob.it::bae8d283-e187-4b8e-966b-081af72c9cd4" providerId="AD" clId="Web-{56B6EAE2-8D2B-9878-434D-991B9EECED73}" dt="2024-11-13T12:08:39.428" v="14"/>
          <ac:spMkLst>
            <pc:docMk/>
            <pc:sldMk cId="3497107316" sldId="279"/>
            <ac:spMk id="6" creationId="{78521D8C-EBF6-7A5D-24CB-4C0AE3E97C94}"/>
          </ac:spMkLst>
        </pc:spChg>
        <pc:graphicFrameChg chg="add del mod modGraphic">
          <ac:chgData name="Luciana De Luca" userId="S::luciana.deluca@crob.it::bae8d283-e187-4b8e-966b-081af72c9cd4" providerId="AD" clId="Web-{56B6EAE2-8D2B-9878-434D-991B9EECED73}" dt="2024-11-13T12:08:39.428" v="15"/>
          <ac:graphicFrameMkLst>
            <pc:docMk/>
            <pc:sldMk cId="3497107316" sldId="279"/>
            <ac:graphicFrameMk id="5" creationId="{E536F8BC-40FF-7A91-7619-200BE330732F}"/>
          </ac:graphicFrameMkLst>
        </pc:graphicFrameChg>
      </pc:sldChg>
    </pc:docChg>
  </pc:docChgLst>
  <pc:docChgLst>
    <pc:chgData name="Ilaria Laurenzana" userId="S::ilaria.laurenzana@crob.it::d20e3a4c-5152-4781-9a82-e8e358f0fc6e" providerId="AD" clId="Web-{C6B30261-9FC3-49ED-D7F1-9AB406D9286F}"/>
    <pc:docChg chg="modSld">
      <pc:chgData name="Ilaria Laurenzana" userId="S::ilaria.laurenzana@crob.it::d20e3a4c-5152-4781-9a82-e8e358f0fc6e" providerId="AD" clId="Web-{C6B30261-9FC3-49ED-D7F1-9AB406D9286F}" dt="2024-09-26T08:20:36.536" v="7" actId="14100"/>
      <pc:docMkLst>
        <pc:docMk/>
      </pc:docMkLst>
      <pc:sldChg chg="addSp delSp modSp">
        <pc:chgData name="Ilaria Laurenzana" userId="S::ilaria.laurenzana@crob.it::d20e3a4c-5152-4781-9a82-e8e358f0fc6e" providerId="AD" clId="Web-{C6B30261-9FC3-49ED-D7F1-9AB406D9286F}" dt="2024-09-26T08:20:36.536" v="7" actId="14100"/>
        <pc:sldMkLst>
          <pc:docMk/>
          <pc:sldMk cId="425908882" sldId="258"/>
        </pc:sldMkLst>
        <pc:picChg chg="del">
          <ac:chgData name="Ilaria Laurenzana" userId="S::ilaria.laurenzana@crob.it::d20e3a4c-5152-4781-9a82-e8e358f0fc6e" providerId="AD" clId="Web-{C6B30261-9FC3-49ED-D7F1-9AB406D9286F}" dt="2024-09-26T08:20:28.926" v="5"/>
          <ac:picMkLst>
            <pc:docMk/>
            <pc:sldMk cId="425908882" sldId="258"/>
            <ac:picMk id="9" creationId="{9D15BB14-5E57-16C7-FB40-1A47BFFCF7B1}"/>
          </ac:picMkLst>
        </pc:picChg>
        <pc:picChg chg="add del mod">
          <ac:chgData name="Ilaria Laurenzana" userId="S::ilaria.laurenzana@crob.it::d20e3a4c-5152-4781-9a82-e8e358f0fc6e" providerId="AD" clId="Web-{C6B30261-9FC3-49ED-D7F1-9AB406D9286F}" dt="2024-09-26T08:20:28.364" v="4"/>
          <ac:picMkLst>
            <pc:docMk/>
            <pc:sldMk cId="425908882" sldId="258"/>
            <ac:picMk id="15" creationId="{8ADE6768-090F-EA3A-E10C-D7C1C906494D}"/>
          </ac:picMkLst>
        </pc:picChg>
        <pc:picChg chg="add mod">
          <ac:chgData name="Ilaria Laurenzana" userId="S::ilaria.laurenzana@crob.it::d20e3a4c-5152-4781-9a82-e8e358f0fc6e" providerId="AD" clId="Web-{C6B30261-9FC3-49ED-D7F1-9AB406D9286F}" dt="2024-09-26T08:20:36.536" v="7" actId="14100"/>
          <ac:picMkLst>
            <pc:docMk/>
            <pc:sldMk cId="425908882" sldId="258"/>
            <ac:picMk id="18" creationId="{2A76350F-4267-349B-850E-F0949A10A0BF}"/>
          </ac:picMkLst>
        </pc:picChg>
      </pc:sldChg>
    </pc:docChg>
  </pc:docChgLst>
  <pc:docChgLst>
    <pc:chgData name="Ilaria Laurenzana" userId="S::ilaria.laurenzana@crob.it::d20e3a4c-5152-4781-9a82-e8e358f0fc6e" providerId="AD" clId="Web-{3BD1CA31-8EE9-054E-24F8-DC28452908FF}"/>
    <pc:docChg chg="modSld">
      <pc:chgData name="Ilaria Laurenzana" userId="S::ilaria.laurenzana@crob.it::d20e3a4c-5152-4781-9a82-e8e358f0fc6e" providerId="AD" clId="Web-{3BD1CA31-8EE9-054E-24F8-DC28452908FF}" dt="2024-09-26T09:42:55.748" v="5" actId="1076"/>
      <pc:docMkLst>
        <pc:docMk/>
      </pc:docMkLst>
      <pc:sldChg chg="addSp modSp">
        <pc:chgData name="Ilaria Laurenzana" userId="S::ilaria.laurenzana@crob.it::d20e3a4c-5152-4781-9a82-e8e358f0fc6e" providerId="AD" clId="Web-{3BD1CA31-8EE9-054E-24F8-DC28452908FF}" dt="2024-09-26T09:42:55.748" v="5" actId="1076"/>
        <pc:sldMkLst>
          <pc:docMk/>
          <pc:sldMk cId="425908882" sldId="258"/>
        </pc:sldMkLst>
        <pc:picChg chg="add mod">
          <ac:chgData name="Ilaria Laurenzana" userId="S::ilaria.laurenzana@crob.it::d20e3a4c-5152-4781-9a82-e8e358f0fc6e" providerId="AD" clId="Web-{3BD1CA31-8EE9-054E-24F8-DC28452908FF}" dt="2024-09-26T09:42:55.748" v="5" actId="1076"/>
          <ac:picMkLst>
            <pc:docMk/>
            <pc:sldMk cId="425908882" sldId="258"/>
            <ac:picMk id="9" creationId="{2087FB63-8DF9-6BC8-5B06-B1B1CDC5BF6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5"/>
          </a:xfrm>
          <a:prstGeom prst="rect">
            <a:avLst/>
          </a:prstGeom>
        </p:spPr>
        <p:txBody>
          <a:bodyPr vert="horz" lIns="91614" tIns="45807" rIns="91614" bIns="45807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5"/>
          </a:xfrm>
          <a:prstGeom prst="rect">
            <a:avLst/>
          </a:prstGeom>
        </p:spPr>
        <p:txBody>
          <a:bodyPr vert="horz" lIns="91614" tIns="45807" rIns="91614" bIns="45807" rtlCol="0"/>
          <a:lstStyle>
            <a:lvl1pPr algn="r">
              <a:defRPr sz="1200"/>
            </a:lvl1pPr>
          </a:lstStyle>
          <a:p>
            <a:fld id="{7D317023-B6F4-41D8-8101-EA0CE8F5D6B5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963738" y="1241425"/>
            <a:ext cx="287020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614" tIns="45807" rIns="91614" bIns="45807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614" tIns="45807" rIns="91614" bIns="45807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4"/>
          </a:xfrm>
          <a:prstGeom prst="rect">
            <a:avLst/>
          </a:prstGeom>
        </p:spPr>
        <p:txBody>
          <a:bodyPr vert="horz" lIns="91614" tIns="45807" rIns="91614" bIns="45807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4"/>
          </a:xfrm>
          <a:prstGeom prst="rect">
            <a:avLst/>
          </a:prstGeom>
        </p:spPr>
        <p:txBody>
          <a:bodyPr vert="horz" lIns="91614" tIns="45807" rIns="91614" bIns="45807" rtlCol="0" anchor="b"/>
          <a:lstStyle>
            <a:lvl1pPr algn="r">
              <a:defRPr sz="1200"/>
            </a:lvl1pPr>
          </a:lstStyle>
          <a:p>
            <a:fld id="{5A793294-1CE5-4B28-858C-8A9DD6418A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4335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159879" rtl="0" eaLnBrk="1" latinLnBrk="0" hangingPunct="1">
      <a:defRPr sz="2835" kern="1200">
        <a:solidFill>
          <a:schemeClr val="tx1"/>
        </a:solidFill>
        <a:latin typeface="+mn-lt"/>
        <a:ea typeface="+mn-ea"/>
        <a:cs typeface="+mn-cs"/>
      </a:defRPr>
    </a:lvl1pPr>
    <a:lvl2pPr marL="1079939" algn="l" defTabSz="2159879" rtl="0" eaLnBrk="1" latinLnBrk="0" hangingPunct="1">
      <a:defRPr sz="2835" kern="1200">
        <a:solidFill>
          <a:schemeClr val="tx1"/>
        </a:solidFill>
        <a:latin typeface="+mn-lt"/>
        <a:ea typeface="+mn-ea"/>
        <a:cs typeface="+mn-cs"/>
      </a:defRPr>
    </a:lvl2pPr>
    <a:lvl3pPr marL="2159879" algn="l" defTabSz="2159879" rtl="0" eaLnBrk="1" latinLnBrk="0" hangingPunct="1">
      <a:defRPr sz="2835" kern="1200">
        <a:solidFill>
          <a:schemeClr val="tx1"/>
        </a:solidFill>
        <a:latin typeface="+mn-lt"/>
        <a:ea typeface="+mn-ea"/>
        <a:cs typeface="+mn-cs"/>
      </a:defRPr>
    </a:lvl3pPr>
    <a:lvl4pPr marL="3239818" algn="l" defTabSz="2159879" rtl="0" eaLnBrk="1" latinLnBrk="0" hangingPunct="1">
      <a:defRPr sz="2835" kern="1200">
        <a:solidFill>
          <a:schemeClr val="tx1"/>
        </a:solidFill>
        <a:latin typeface="+mn-lt"/>
        <a:ea typeface="+mn-ea"/>
        <a:cs typeface="+mn-cs"/>
      </a:defRPr>
    </a:lvl4pPr>
    <a:lvl5pPr marL="4319757" algn="l" defTabSz="2159879" rtl="0" eaLnBrk="1" latinLnBrk="0" hangingPunct="1">
      <a:defRPr sz="2835" kern="1200">
        <a:solidFill>
          <a:schemeClr val="tx1"/>
        </a:solidFill>
        <a:latin typeface="+mn-lt"/>
        <a:ea typeface="+mn-ea"/>
        <a:cs typeface="+mn-cs"/>
      </a:defRPr>
    </a:lvl5pPr>
    <a:lvl6pPr marL="5399697" algn="l" defTabSz="2159879" rtl="0" eaLnBrk="1" latinLnBrk="0" hangingPunct="1">
      <a:defRPr sz="2835" kern="1200">
        <a:solidFill>
          <a:schemeClr val="tx1"/>
        </a:solidFill>
        <a:latin typeface="+mn-lt"/>
        <a:ea typeface="+mn-ea"/>
        <a:cs typeface="+mn-cs"/>
      </a:defRPr>
    </a:lvl6pPr>
    <a:lvl7pPr marL="6479637" algn="l" defTabSz="2159879" rtl="0" eaLnBrk="1" latinLnBrk="0" hangingPunct="1">
      <a:defRPr sz="2835" kern="1200">
        <a:solidFill>
          <a:schemeClr val="tx1"/>
        </a:solidFill>
        <a:latin typeface="+mn-lt"/>
        <a:ea typeface="+mn-ea"/>
        <a:cs typeface="+mn-cs"/>
      </a:defRPr>
    </a:lvl7pPr>
    <a:lvl8pPr marL="7559576" algn="l" defTabSz="2159879" rtl="0" eaLnBrk="1" latinLnBrk="0" hangingPunct="1">
      <a:defRPr sz="2835" kern="1200">
        <a:solidFill>
          <a:schemeClr val="tx1"/>
        </a:solidFill>
        <a:latin typeface="+mn-lt"/>
        <a:ea typeface="+mn-ea"/>
        <a:cs typeface="+mn-cs"/>
      </a:defRPr>
    </a:lvl8pPr>
    <a:lvl9pPr marL="8639515" algn="l" defTabSz="2159879" rtl="0" eaLnBrk="1" latinLnBrk="0" hangingPunct="1">
      <a:defRPr sz="283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793294-1CE5-4B28-858C-8A9DD6418AAF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42716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793294-1CE5-4B28-858C-8A9DD6418AAF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56865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793294-1CE5-4B28-858C-8A9DD6418AAF}" type="slidenum">
              <a:rPr lang="it-IT" smtClean="0"/>
              <a:t>8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53808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9965" y="4124164"/>
            <a:ext cx="18359596" cy="8773325"/>
          </a:xfrm>
        </p:spPr>
        <p:txBody>
          <a:bodyPr anchor="b"/>
          <a:lstStyle>
            <a:lvl1pPr algn="ctr">
              <a:defRPr sz="14173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9941" y="13235822"/>
            <a:ext cx="16199644" cy="6084159"/>
          </a:xfrm>
        </p:spPr>
        <p:txBody>
          <a:bodyPr/>
          <a:lstStyle>
            <a:lvl1pPr marL="0" indent="0" algn="ctr">
              <a:buNone/>
              <a:defRPr sz="5669"/>
            </a:lvl1pPr>
            <a:lvl2pPr marL="1079998" indent="0" algn="ctr">
              <a:buNone/>
              <a:defRPr sz="4724"/>
            </a:lvl2pPr>
            <a:lvl3pPr marL="2159996" indent="0" algn="ctr">
              <a:buNone/>
              <a:defRPr sz="4252"/>
            </a:lvl3pPr>
            <a:lvl4pPr marL="3239994" indent="0" algn="ctr">
              <a:buNone/>
              <a:defRPr sz="3780"/>
            </a:lvl4pPr>
            <a:lvl5pPr marL="4319991" indent="0" algn="ctr">
              <a:buNone/>
              <a:defRPr sz="3780"/>
            </a:lvl5pPr>
            <a:lvl6pPr marL="5399989" indent="0" algn="ctr">
              <a:buNone/>
              <a:defRPr sz="3780"/>
            </a:lvl6pPr>
            <a:lvl7pPr marL="6479987" indent="0" algn="ctr">
              <a:buNone/>
              <a:defRPr sz="3780"/>
            </a:lvl7pPr>
            <a:lvl8pPr marL="7559985" indent="0" algn="ctr">
              <a:buNone/>
              <a:defRPr sz="3780"/>
            </a:lvl8pPr>
            <a:lvl9pPr marL="8639983" indent="0" algn="ctr">
              <a:buNone/>
              <a:defRPr sz="378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6507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7967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7161" y="1341665"/>
            <a:ext cx="4657398" cy="21355814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4968" y="1341665"/>
            <a:ext cx="13702199" cy="21355814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9448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8214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719" y="6282501"/>
            <a:ext cx="18629590" cy="10482488"/>
          </a:xfrm>
        </p:spPr>
        <p:txBody>
          <a:bodyPr anchor="b"/>
          <a:lstStyle>
            <a:lvl1pPr>
              <a:defRPr sz="14173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719" y="16864157"/>
            <a:ext cx="18629590" cy="5512493"/>
          </a:xfrm>
        </p:spPr>
        <p:txBody>
          <a:bodyPr/>
          <a:lstStyle>
            <a:lvl1pPr marL="0" indent="0">
              <a:buNone/>
              <a:defRPr sz="5669">
                <a:solidFill>
                  <a:schemeClr val="tx1">
                    <a:tint val="82000"/>
                  </a:schemeClr>
                </a:solidFill>
              </a:defRPr>
            </a:lvl1pPr>
            <a:lvl2pPr marL="1079998" indent="0">
              <a:buNone/>
              <a:defRPr sz="4724">
                <a:solidFill>
                  <a:schemeClr val="tx1">
                    <a:tint val="82000"/>
                  </a:schemeClr>
                </a:solidFill>
              </a:defRPr>
            </a:lvl2pPr>
            <a:lvl3pPr marL="2159996" indent="0">
              <a:buNone/>
              <a:defRPr sz="4252">
                <a:solidFill>
                  <a:schemeClr val="tx1">
                    <a:tint val="82000"/>
                  </a:schemeClr>
                </a:solidFill>
              </a:defRPr>
            </a:lvl3pPr>
            <a:lvl4pPr marL="3239994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4pPr>
            <a:lvl5pPr marL="4319991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5pPr>
            <a:lvl6pPr marL="5399989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6pPr>
            <a:lvl7pPr marL="6479987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7pPr>
            <a:lvl8pPr marL="7559985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8pPr>
            <a:lvl9pPr marL="8639983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8977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4967" y="6708326"/>
            <a:ext cx="9179798" cy="1598915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4760" y="6708326"/>
            <a:ext cx="9179798" cy="1598915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4033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341671"/>
            <a:ext cx="18629590" cy="4870830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783" y="6177496"/>
            <a:ext cx="9137610" cy="3027495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783" y="9204991"/>
            <a:ext cx="9137610" cy="13539155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4761" y="6177496"/>
            <a:ext cx="9182611" cy="3027495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4761" y="9204991"/>
            <a:ext cx="9182611" cy="13539155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6923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8692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91352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679998"/>
            <a:ext cx="6966409" cy="5879994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2611" y="3628335"/>
            <a:ext cx="10934760" cy="17908316"/>
          </a:xfrm>
        </p:spPr>
        <p:txBody>
          <a:bodyPr/>
          <a:lstStyle>
            <a:lvl1pPr>
              <a:defRPr sz="7559"/>
            </a:lvl1pPr>
            <a:lvl2pPr>
              <a:defRPr sz="6614"/>
            </a:lvl2pPr>
            <a:lvl3pPr>
              <a:defRPr sz="5669"/>
            </a:lvl3pPr>
            <a:lvl4pPr>
              <a:defRPr sz="4724"/>
            </a:lvl4pPr>
            <a:lvl5pPr>
              <a:defRPr sz="4724"/>
            </a:lvl5pPr>
            <a:lvl6pPr>
              <a:defRPr sz="4724"/>
            </a:lvl6pPr>
            <a:lvl7pPr>
              <a:defRPr sz="4724"/>
            </a:lvl7pPr>
            <a:lvl8pPr>
              <a:defRPr sz="4724"/>
            </a:lvl8pPr>
            <a:lvl9pPr>
              <a:defRPr sz="4724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7559993"/>
            <a:ext cx="6966409" cy="14005821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3596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679998"/>
            <a:ext cx="6966409" cy="5879994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2611" y="3628335"/>
            <a:ext cx="10934760" cy="17908316"/>
          </a:xfrm>
        </p:spPr>
        <p:txBody>
          <a:bodyPr anchor="t"/>
          <a:lstStyle>
            <a:lvl1pPr marL="0" indent="0">
              <a:buNone/>
              <a:defRPr sz="7559"/>
            </a:lvl1pPr>
            <a:lvl2pPr marL="1079998" indent="0">
              <a:buNone/>
              <a:defRPr sz="6614"/>
            </a:lvl2pPr>
            <a:lvl3pPr marL="2159996" indent="0">
              <a:buNone/>
              <a:defRPr sz="5669"/>
            </a:lvl3pPr>
            <a:lvl4pPr marL="3239994" indent="0">
              <a:buNone/>
              <a:defRPr sz="4724"/>
            </a:lvl4pPr>
            <a:lvl5pPr marL="4319991" indent="0">
              <a:buNone/>
              <a:defRPr sz="4724"/>
            </a:lvl5pPr>
            <a:lvl6pPr marL="5399989" indent="0">
              <a:buNone/>
              <a:defRPr sz="4724"/>
            </a:lvl6pPr>
            <a:lvl7pPr marL="6479987" indent="0">
              <a:buNone/>
              <a:defRPr sz="4724"/>
            </a:lvl7pPr>
            <a:lvl8pPr marL="7559985" indent="0">
              <a:buNone/>
              <a:defRPr sz="4724"/>
            </a:lvl8pPr>
            <a:lvl9pPr marL="8639983" indent="0">
              <a:buNone/>
              <a:defRPr sz="4724"/>
            </a:lvl9pPr>
          </a:lstStyle>
          <a:p>
            <a:r>
              <a:rPr lang="it-IT"/>
              <a:t>Fare clic sull'icona per inserire un'immagin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7559993"/>
            <a:ext cx="6966409" cy="14005821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18164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4968" y="1341671"/>
            <a:ext cx="18629590" cy="487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4968" y="6708326"/>
            <a:ext cx="18629590" cy="1598915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4967" y="23356649"/>
            <a:ext cx="4859893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3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2E566EE-8A1B-4819-8B8B-3BA6680B3660}" type="datetimeFigureOut">
              <a:rPr lang="it-IT" smtClean="0"/>
              <a:t>13/11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4843" y="23356649"/>
            <a:ext cx="7289840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3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4665" y="23356649"/>
            <a:ext cx="4859893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3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E11ECEB-759B-4F74-AEAA-36B512A8BF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8465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159996" rtl="0" eaLnBrk="1" latinLnBrk="0" hangingPunct="1">
        <a:lnSpc>
          <a:spcPct val="90000"/>
        </a:lnSpc>
        <a:spcBef>
          <a:spcPct val="0"/>
        </a:spcBef>
        <a:buNone/>
        <a:defRPr sz="103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39999" indent="-539999" algn="l" defTabSz="2159996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1pPr>
      <a:lvl2pPr marL="1619997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699995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3pPr>
      <a:lvl4pPr marL="377999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859990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939988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7019986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8099984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917998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159996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3pPr>
      <a:lvl4pPr marL="3239994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319991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399989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6479987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7559985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8639983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8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10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7.emf"/><Relationship Id="rId5" Type="http://schemas.openxmlformats.org/officeDocument/2006/relationships/image" Target="../media/image4.emf"/><Relationship Id="rId15" Type="http://schemas.openxmlformats.org/officeDocument/2006/relationships/image" Target="../media/image9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11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emf"/><Relationship Id="rId14" Type="http://schemas.openxmlformats.org/officeDocument/2006/relationships/oleObject" Target="../embeddings/oleObject7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oleObject" Target="../embeddings/oleObject15.bin"/><Relationship Id="rId18" Type="http://schemas.openxmlformats.org/officeDocument/2006/relationships/image" Target="../media/image24.emf"/><Relationship Id="rId26" Type="http://schemas.openxmlformats.org/officeDocument/2006/relationships/image" Target="../media/image28.emf"/><Relationship Id="rId3" Type="http://schemas.openxmlformats.org/officeDocument/2006/relationships/oleObject" Target="../embeddings/oleObject10.bin"/><Relationship Id="rId21" Type="http://schemas.openxmlformats.org/officeDocument/2006/relationships/oleObject" Target="../embeddings/oleObject19.bin"/><Relationship Id="rId7" Type="http://schemas.openxmlformats.org/officeDocument/2006/relationships/oleObject" Target="../embeddings/oleObject12.bin"/><Relationship Id="rId12" Type="http://schemas.openxmlformats.org/officeDocument/2006/relationships/image" Target="../media/image21.emf"/><Relationship Id="rId17" Type="http://schemas.openxmlformats.org/officeDocument/2006/relationships/oleObject" Target="../embeddings/oleObject17.bin"/><Relationship Id="rId25" Type="http://schemas.openxmlformats.org/officeDocument/2006/relationships/oleObject" Target="../embeddings/oleObject21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3.emf"/><Relationship Id="rId20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emf"/><Relationship Id="rId11" Type="http://schemas.openxmlformats.org/officeDocument/2006/relationships/oleObject" Target="../embeddings/oleObject14.bin"/><Relationship Id="rId24" Type="http://schemas.openxmlformats.org/officeDocument/2006/relationships/image" Target="../media/image27.emf"/><Relationship Id="rId5" Type="http://schemas.openxmlformats.org/officeDocument/2006/relationships/oleObject" Target="../embeddings/oleObject11.bin"/><Relationship Id="rId15" Type="http://schemas.openxmlformats.org/officeDocument/2006/relationships/oleObject" Target="../embeddings/oleObject16.bin"/><Relationship Id="rId23" Type="http://schemas.openxmlformats.org/officeDocument/2006/relationships/oleObject" Target="../embeddings/oleObject20.bin"/><Relationship Id="rId28" Type="http://schemas.openxmlformats.org/officeDocument/2006/relationships/image" Target="../media/image29.emf"/><Relationship Id="rId10" Type="http://schemas.openxmlformats.org/officeDocument/2006/relationships/image" Target="../media/image20.emf"/><Relationship Id="rId19" Type="http://schemas.openxmlformats.org/officeDocument/2006/relationships/oleObject" Target="../embeddings/oleObject18.bin"/><Relationship Id="rId4" Type="http://schemas.openxmlformats.org/officeDocument/2006/relationships/image" Target="../media/image17.emf"/><Relationship Id="rId9" Type="http://schemas.openxmlformats.org/officeDocument/2006/relationships/oleObject" Target="../embeddings/oleObject13.bin"/><Relationship Id="rId14" Type="http://schemas.openxmlformats.org/officeDocument/2006/relationships/image" Target="../media/image22.emf"/><Relationship Id="rId22" Type="http://schemas.openxmlformats.org/officeDocument/2006/relationships/image" Target="../media/image26.emf"/><Relationship Id="rId27" Type="http://schemas.openxmlformats.org/officeDocument/2006/relationships/oleObject" Target="../embeddings/oleObject22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6.bin"/><Relationship Id="rId13" Type="http://schemas.openxmlformats.org/officeDocument/2006/relationships/image" Target="../media/image35.emf"/><Relationship Id="rId18" Type="http://schemas.openxmlformats.org/officeDocument/2006/relationships/oleObject" Target="../embeddings/oleObject31.bin"/><Relationship Id="rId26" Type="http://schemas.openxmlformats.org/officeDocument/2006/relationships/oleObject" Target="../embeddings/oleObject35.bin"/><Relationship Id="rId3" Type="http://schemas.openxmlformats.org/officeDocument/2006/relationships/image" Target="../media/image30.emf"/><Relationship Id="rId21" Type="http://schemas.openxmlformats.org/officeDocument/2006/relationships/image" Target="../media/image39.emf"/><Relationship Id="rId7" Type="http://schemas.openxmlformats.org/officeDocument/2006/relationships/image" Target="../media/image32.emf"/><Relationship Id="rId12" Type="http://schemas.openxmlformats.org/officeDocument/2006/relationships/oleObject" Target="../embeddings/oleObject28.bin"/><Relationship Id="rId17" Type="http://schemas.openxmlformats.org/officeDocument/2006/relationships/image" Target="../media/image37.emf"/><Relationship Id="rId25" Type="http://schemas.openxmlformats.org/officeDocument/2006/relationships/image" Target="../media/image41.emf"/><Relationship Id="rId2" Type="http://schemas.openxmlformats.org/officeDocument/2006/relationships/oleObject" Target="../embeddings/oleObject23.bin"/><Relationship Id="rId16" Type="http://schemas.openxmlformats.org/officeDocument/2006/relationships/oleObject" Target="../embeddings/oleObject30.bin"/><Relationship Id="rId20" Type="http://schemas.openxmlformats.org/officeDocument/2006/relationships/oleObject" Target="../embeddings/oleObject32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5.bin"/><Relationship Id="rId11" Type="http://schemas.openxmlformats.org/officeDocument/2006/relationships/image" Target="../media/image34.emf"/><Relationship Id="rId24" Type="http://schemas.openxmlformats.org/officeDocument/2006/relationships/oleObject" Target="../embeddings/oleObject34.bin"/><Relationship Id="rId5" Type="http://schemas.openxmlformats.org/officeDocument/2006/relationships/image" Target="../media/image31.emf"/><Relationship Id="rId15" Type="http://schemas.openxmlformats.org/officeDocument/2006/relationships/image" Target="../media/image36.emf"/><Relationship Id="rId23" Type="http://schemas.openxmlformats.org/officeDocument/2006/relationships/image" Target="../media/image40.emf"/><Relationship Id="rId10" Type="http://schemas.openxmlformats.org/officeDocument/2006/relationships/oleObject" Target="../embeddings/oleObject27.bin"/><Relationship Id="rId19" Type="http://schemas.openxmlformats.org/officeDocument/2006/relationships/image" Target="../media/image38.emf"/><Relationship Id="rId4" Type="http://schemas.openxmlformats.org/officeDocument/2006/relationships/oleObject" Target="../embeddings/oleObject24.bin"/><Relationship Id="rId9" Type="http://schemas.openxmlformats.org/officeDocument/2006/relationships/image" Target="../media/image33.emf"/><Relationship Id="rId14" Type="http://schemas.openxmlformats.org/officeDocument/2006/relationships/oleObject" Target="../embeddings/oleObject29.bin"/><Relationship Id="rId22" Type="http://schemas.openxmlformats.org/officeDocument/2006/relationships/oleObject" Target="../embeddings/oleObject33.bin"/><Relationship Id="rId27" Type="http://schemas.openxmlformats.org/officeDocument/2006/relationships/image" Target="../media/image42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9.bin"/><Relationship Id="rId13" Type="http://schemas.openxmlformats.org/officeDocument/2006/relationships/image" Target="../media/image48.emf"/><Relationship Id="rId3" Type="http://schemas.openxmlformats.org/officeDocument/2006/relationships/image" Target="../media/image43.emf"/><Relationship Id="rId7" Type="http://schemas.openxmlformats.org/officeDocument/2006/relationships/image" Target="../media/image45.emf"/><Relationship Id="rId12" Type="http://schemas.openxmlformats.org/officeDocument/2006/relationships/oleObject" Target="../embeddings/oleObject41.bin"/><Relationship Id="rId2" Type="http://schemas.openxmlformats.org/officeDocument/2006/relationships/oleObject" Target="../embeddings/oleObject3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8.bin"/><Relationship Id="rId11" Type="http://schemas.openxmlformats.org/officeDocument/2006/relationships/image" Target="../media/image47.emf"/><Relationship Id="rId5" Type="http://schemas.openxmlformats.org/officeDocument/2006/relationships/image" Target="../media/image44.emf"/><Relationship Id="rId15" Type="http://schemas.openxmlformats.org/officeDocument/2006/relationships/image" Target="../media/image49.emf"/><Relationship Id="rId10" Type="http://schemas.openxmlformats.org/officeDocument/2006/relationships/oleObject" Target="../embeddings/oleObject40.bin"/><Relationship Id="rId4" Type="http://schemas.openxmlformats.org/officeDocument/2006/relationships/oleObject" Target="../embeddings/oleObject37.bin"/><Relationship Id="rId9" Type="http://schemas.openxmlformats.org/officeDocument/2006/relationships/image" Target="../media/image46.emf"/><Relationship Id="rId14" Type="http://schemas.openxmlformats.org/officeDocument/2006/relationships/oleObject" Target="../embeddings/oleObject42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emf"/><Relationship Id="rId13" Type="http://schemas.openxmlformats.org/officeDocument/2006/relationships/oleObject" Target="../embeddings/oleObject48.bin"/><Relationship Id="rId18" Type="http://schemas.openxmlformats.org/officeDocument/2006/relationships/image" Target="../media/image58.emf"/><Relationship Id="rId3" Type="http://schemas.openxmlformats.org/officeDocument/2006/relationships/oleObject" Target="../embeddings/oleObject43.bin"/><Relationship Id="rId21" Type="http://schemas.openxmlformats.org/officeDocument/2006/relationships/oleObject" Target="../embeddings/oleObject52.bin"/><Relationship Id="rId7" Type="http://schemas.openxmlformats.org/officeDocument/2006/relationships/oleObject" Target="../embeddings/oleObject45.bin"/><Relationship Id="rId12" Type="http://schemas.openxmlformats.org/officeDocument/2006/relationships/image" Target="../media/image55.emf"/><Relationship Id="rId17" Type="http://schemas.openxmlformats.org/officeDocument/2006/relationships/oleObject" Target="../embeddings/oleObject50.bin"/><Relationship Id="rId2" Type="http://schemas.openxmlformats.org/officeDocument/2006/relationships/image" Target="../media/image50.emf"/><Relationship Id="rId16" Type="http://schemas.openxmlformats.org/officeDocument/2006/relationships/image" Target="../media/image57.emf"/><Relationship Id="rId20" Type="http://schemas.openxmlformats.org/officeDocument/2006/relationships/image" Target="../media/image5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emf"/><Relationship Id="rId11" Type="http://schemas.openxmlformats.org/officeDocument/2006/relationships/oleObject" Target="../embeddings/oleObject47.bin"/><Relationship Id="rId24" Type="http://schemas.openxmlformats.org/officeDocument/2006/relationships/image" Target="../media/image61.emf"/><Relationship Id="rId5" Type="http://schemas.openxmlformats.org/officeDocument/2006/relationships/oleObject" Target="../embeddings/oleObject44.bin"/><Relationship Id="rId15" Type="http://schemas.openxmlformats.org/officeDocument/2006/relationships/oleObject" Target="../embeddings/oleObject49.bin"/><Relationship Id="rId23" Type="http://schemas.openxmlformats.org/officeDocument/2006/relationships/oleObject" Target="../embeddings/oleObject53.bin"/><Relationship Id="rId10" Type="http://schemas.openxmlformats.org/officeDocument/2006/relationships/image" Target="../media/image54.emf"/><Relationship Id="rId19" Type="http://schemas.openxmlformats.org/officeDocument/2006/relationships/oleObject" Target="../embeddings/oleObject51.bin"/><Relationship Id="rId4" Type="http://schemas.openxmlformats.org/officeDocument/2006/relationships/image" Target="../media/image51.emf"/><Relationship Id="rId9" Type="http://schemas.openxmlformats.org/officeDocument/2006/relationships/oleObject" Target="../embeddings/oleObject46.bin"/><Relationship Id="rId14" Type="http://schemas.openxmlformats.org/officeDocument/2006/relationships/image" Target="../media/image56.emf"/><Relationship Id="rId22" Type="http://schemas.openxmlformats.org/officeDocument/2006/relationships/image" Target="../media/image60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emf"/><Relationship Id="rId13" Type="http://schemas.openxmlformats.org/officeDocument/2006/relationships/oleObject" Target="../embeddings/oleObject59.bin"/><Relationship Id="rId18" Type="http://schemas.openxmlformats.org/officeDocument/2006/relationships/image" Target="../media/image69.emf"/><Relationship Id="rId3" Type="http://schemas.openxmlformats.org/officeDocument/2006/relationships/oleObject" Target="../embeddings/oleObject54.bin"/><Relationship Id="rId21" Type="http://schemas.openxmlformats.org/officeDocument/2006/relationships/oleObject" Target="../embeddings/oleObject63.bin"/><Relationship Id="rId7" Type="http://schemas.openxmlformats.org/officeDocument/2006/relationships/oleObject" Target="../embeddings/oleObject56.bin"/><Relationship Id="rId12" Type="http://schemas.openxmlformats.org/officeDocument/2006/relationships/image" Target="../media/image66.emf"/><Relationship Id="rId17" Type="http://schemas.openxmlformats.org/officeDocument/2006/relationships/oleObject" Target="../embeddings/oleObject61.bin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68.emf"/><Relationship Id="rId20" Type="http://schemas.openxmlformats.org/officeDocument/2006/relationships/image" Target="../media/image7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emf"/><Relationship Id="rId11" Type="http://schemas.openxmlformats.org/officeDocument/2006/relationships/oleObject" Target="../embeddings/oleObject58.bin"/><Relationship Id="rId5" Type="http://schemas.openxmlformats.org/officeDocument/2006/relationships/oleObject" Target="../embeddings/oleObject55.bin"/><Relationship Id="rId15" Type="http://schemas.openxmlformats.org/officeDocument/2006/relationships/oleObject" Target="../embeddings/oleObject60.bin"/><Relationship Id="rId10" Type="http://schemas.openxmlformats.org/officeDocument/2006/relationships/image" Target="../media/image65.emf"/><Relationship Id="rId19" Type="http://schemas.openxmlformats.org/officeDocument/2006/relationships/oleObject" Target="../embeddings/oleObject62.bin"/><Relationship Id="rId4" Type="http://schemas.openxmlformats.org/officeDocument/2006/relationships/image" Target="../media/image62.emf"/><Relationship Id="rId9" Type="http://schemas.openxmlformats.org/officeDocument/2006/relationships/oleObject" Target="../embeddings/oleObject57.bin"/><Relationship Id="rId14" Type="http://schemas.openxmlformats.org/officeDocument/2006/relationships/image" Target="../media/image67.emf"/><Relationship Id="rId22" Type="http://schemas.openxmlformats.org/officeDocument/2006/relationships/image" Target="../media/image7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o 18">
            <a:extLst>
              <a:ext uri="{FF2B5EF4-FFF2-40B4-BE49-F238E27FC236}">
                <a16:creationId xmlns:a16="http://schemas.microsoft.com/office/drawing/2014/main" id="{A35D4C6E-D905-C849-8868-12C2E5A7C496}"/>
              </a:ext>
            </a:extLst>
          </p:cNvPr>
          <p:cNvGrpSpPr/>
          <p:nvPr/>
        </p:nvGrpSpPr>
        <p:grpSpPr>
          <a:xfrm>
            <a:off x="246101" y="1110487"/>
            <a:ext cx="11060995" cy="5224386"/>
            <a:chOff x="2061445" y="1254866"/>
            <a:chExt cx="11060995" cy="5224386"/>
          </a:xfrm>
        </p:grpSpPr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1B987ECD-8C80-F982-0E89-A8DC4DB4291D}"/>
                </a:ext>
              </a:extLst>
            </p:cNvPr>
            <p:cNvSpPr txBox="1"/>
            <p:nvPr/>
          </p:nvSpPr>
          <p:spPr>
            <a:xfrm>
              <a:off x="3031959" y="6109920"/>
              <a:ext cx="1009048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/>
                <a:t>CFSE - H</a:t>
              </a:r>
            </a:p>
          </p:txBody>
        </p:sp>
        <p:cxnSp>
          <p:nvCxnSpPr>
            <p:cNvPr id="11" name="Connettore diritto 10">
              <a:extLst>
                <a:ext uri="{FF2B5EF4-FFF2-40B4-BE49-F238E27FC236}">
                  <a16:creationId xmlns:a16="http://schemas.microsoft.com/office/drawing/2014/main" id="{3589F03B-00A6-F8FD-8315-3405E7689FF2}"/>
                </a:ext>
              </a:extLst>
            </p:cNvPr>
            <p:cNvCxnSpPr>
              <a:cxnSpLocks/>
            </p:cNvCxnSpPr>
            <p:nvPr/>
          </p:nvCxnSpPr>
          <p:spPr>
            <a:xfrm>
              <a:off x="3583652" y="6137827"/>
              <a:ext cx="89279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2" name="Picture 10">
              <a:extLst>
                <a:ext uri="{FF2B5EF4-FFF2-40B4-BE49-F238E27FC236}">
                  <a16:creationId xmlns:a16="http://schemas.microsoft.com/office/drawing/2014/main" id="{AB3B429D-3AFE-B04F-20ED-683D8D0D12D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b="3992"/>
            <a:stretch/>
          </p:blipFill>
          <p:spPr>
            <a:xfrm>
              <a:off x="2308194" y="1254868"/>
              <a:ext cx="5382850" cy="4849648"/>
            </a:xfrm>
            <a:prstGeom prst="rect">
              <a:avLst/>
            </a:prstGeom>
          </p:spPr>
        </p:pic>
        <p:pic>
          <p:nvPicPr>
            <p:cNvPr id="3" name="Picture 12">
              <a:extLst>
                <a:ext uri="{FF2B5EF4-FFF2-40B4-BE49-F238E27FC236}">
                  <a16:creationId xmlns:a16="http://schemas.microsoft.com/office/drawing/2014/main" id="{A9477966-3D22-6883-314D-181BD64FDDE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b="3992"/>
            <a:stretch/>
          </p:blipFill>
          <p:spPr>
            <a:xfrm>
              <a:off x="7739590" y="1254866"/>
              <a:ext cx="5382850" cy="4849649"/>
            </a:xfrm>
            <a:prstGeom prst="rect">
              <a:avLst/>
            </a:prstGeom>
          </p:spPr>
        </p:pic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1A8CA2CF-EA5A-6C82-2384-43882F93923F}"/>
                </a:ext>
              </a:extLst>
            </p:cNvPr>
            <p:cNvSpPr txBox="1"/>
            <p:nvPr/>
          </p:nvSpPr>
          <p:spPr>
            <a:xfrm rot="16200000">
              <a:off x="189739" y="3479495"/>
              <a:ext cx="4150581" cy="40717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/>
                <a:t>SSC - H</a:t>
              </a:r>
            </a:p>
          </p:txBody>
        </p:sp>
        <p:cxnSp>
          <p:nvCxnSpPr>
            <p:cNvPr id="12" name="Connettore diritto 11">
              <a:extLst>
                <a:ext uri="{FF2B5EF4-FFF2-40B4-BE49-F238E27FC236}">
                  <a16:creationId xmlns:a16="http://schemas.microsoft.com/office/drawing/2014/main" id="{030DEFCF-AEAC-8063-B555-38267F0F2BED}"/>
                </a:ext>
              </a:extLst>
            </p:cNvPr>
            <p:cNvCxnSpPr/>
            <p:nvPr/>
          </p:nvCxnSpPr>
          <p:spPr>
            <a:xfrm>
              <a:off x="2436531" y="1884050"/>
              <a:ext cx="0" cy="3591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D8322C17-F6B7-AEC2-548B-5C567D71D36B}"/>
              </a:ext>
            </a:extLst>
          </p:cNvPr>
          <p:cNvSpPr txBox="1"/>
          <p:nvPr/>
        </p:nvSpPr>
        <p:spPr>
          <a:xfrm>
            <a:off x="621186" y="6591542"/>
            <a:ext cx="12974497" cy="7694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2200" b="1">
                <a:latin typeface="Arial"/>
                <a:cs typeface="Arial"/>
              </a:rPr>
              <a:t>Supplementary Figure 1: </a:t>
            </a:r>
            <a:r>
              <a:rPr lang="en-US" sz="2200">
                <a:latin typeface="Arial"/>
                <a:cs typeface="Arial"/>
              </a:rPr>
              <a:t>Flow cytometer settings for EV characterization. CFSE-H/SSC-H dot plots of </a:t>
            </a:r>
            <a:r>
              <a:rPr lang="en-US" sz="2200" err="1">
                <a:latin typeface="Arial"/>
                <a:cs typeface="Arial"/>
              </a:rPr>
              <a:t>Megamix</a:t>
            </a:r>
            <a:r>
              <a:rPr lang="en-US" sz="2200">
                <a:latin typeface="Arial"/>
                <a:cs typeface="Arial"/>
              </a:rPr>
              <a:t> Plus FSC beads with 0.1 µm, 0.3 µm, 0.5 µm and 0.9 µm and of 0.02 µm filtered PBS.</a:t>
            </a:r>
            <a:endParaRPr lang="en-US" sz="2200" b="1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12630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EED842D5-6777-7CDA-D412-897A6B5247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4220486"/>
              </p:ext>
            </p:extLst>
          </p:nvPr>
        </p:nvGraphicFramePr>
        <p:xfrm>
          <a:off x="4133578" y="7648215"/>
          <a:ext cx="4896000" cy="4317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61514" imgH="2700075" progId="Prism10.Document">
                  <p:embed/>
                </p:oleObj>
              </mc:Choice>
              <mc:Fallback>
                <p:oleObj name="Prism 10" r:id="rId2" imgW="3061514" imgH="2700075" progId="Prism10.Document">
                  <p:embed/>
                  <p:pic>
                    <p:nvPicPr>
                      <p:cNvPr id="7" name="Oggetto 6">
                        <a:extLst>
                          <a:ext uri="{FF2B5EF4-FFF2-40B4-BE49-F238E27FC236}">
                            <a16:creationId xmlns:a16="http://schemas.microsoft.com/office/drawing/2014/main" id="{EED842D5-6777-7CDA-D412-897A6B5247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33578" y="7648215"/>
                        <a:ext cx="4896000" cy="4317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ggetto 7">
            <a:extLst>
              <a:ext uri="{FF2B5EF4-FFF2-40B4-BE49-F238E27FC236}">
                <a16:creationId xmlns:a16="http://schemas.microsoft.com/office/drawing/2014/main" id="{165A9C9E-BA67-9A2D-3C9F-DAC858192A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0319334"/>
              </p:ext>
            </p:extLst>
          </p:nvPr>
        </p:nvGraphicFramePr>
        <p:xfrm>
          <a:off x="8209072" y="7648625"/>
          <a:ext cx="4896000" cy="43169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61514" imgH="2700075" progId="Prism10.Document">
                  <p:embed/>
                </p:oleObj>
              </mc:Choice>
              <mc:Fallback>
                <p:oleObj name="Prism 10" r:id="rId4" imgW="3061514" imgH="2700075" progId="Prism10.Document">
                  <p:embed/>
                  <p:pic>
                    <p:nvPicPr>
                      <p:cNvPr id="8" name="Oggetto 7">
                        <a:extLst>
                          <a:ext uri="{FF2B5EF4-FFF2-40B4-BE49-F238E27FC236}">
                            <a16:creationId xmlns:a16="http://schemas.microsoft.com/office/drawing/2014/main" id="{165A9C9E-BA67-9A2D-3C9F-DAC858192A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209072" y="7648625"/>
                        <a:ext cx="4896000" cy="43169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ggetto 9">
            <a:extLst>
              <a:ext uri="{FF2B5EF4-FFF2-40B4-BE49-F238E27FC236}">
                <a16:creationId xmlns:a16="http://schemas.microsoft.com/office/drawing/2014/main" id="{69C019A2-A636-B322-4A61-635D119689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2970805"/>
              </p:ext>
            </p:extLst>
          </p:nvPr>
        </p:nvGraphicFramePr>
        <p:xfrm>
          <a:off x="16533923" y="7361370"/>
          <a:ext cx="4896000" cy="45973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097887" imgH="2908964" progId="Prism10.Document">
                  <p:embed/>
                </p:oleObj>
              </mc:Choice>
              <mc:Fallback>
                <p:oleObj name="Prism 10" r:id="rId6" imgW="3097887" imgH="2908964" progId="Prism10.Document">
                  <p:embed/>
                  <p:pic>
                    <p:nvPicPr>
                      <p:cNvPr id="10" name="Oggetto 9">
                        <a:extLst>
                          <a:ext uri="{FF2B5EF4-FFF2-40B4-BE49-F238E27FC236}">
                            <a16:creationId xmlns:a16="http://schemas.microsoft.com/office/drawing/2014/main" id="{69C019A2-A636-B322-4A61-635D119689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6533923" y="7361370"/>
                        <a:ext cx="4896000" cy="45973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ggetto 11">
            <a:extLst>
              <a:ext uri="{FF2B5EF4-FFF2-40B4-BE49-F238E27FC236}">
                <a16:creationId xmlns:a16="http://schemas.microsoft.com/office/drawing/2014/main" id="{11E7EC2B-0196-4CE3-5444-5F888F74D7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3956117"/>
              </p:ext>
            </p:extLst>
          </p:nvPr>
        </p:nvGraphicFramePr>
        <p:xfrm>
          <a:off x="1685578" y="12280728"/>
          <a:ext cx="4896000" cy="41807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161992" imgH="2700075" progId="Prism10.Document">
                  <p:embed/>
                </p:oleObj>
              </mc:Choice>
              <mc:Fallback>
                <p:oleObj name="Prism 10" r:id="rId8" imgW="3161992" imgH="2700075" progId="Prism10.Document">
                  <p:embed/>
                  <p:pic>
                    <p:nvPicPr>
                      <p:cNvPr id="12" name="Oggetto 11">
                        <a:extLst>
                          <a:ext uri="{FF2B5EF4-FFF2-40B4-BE49-F238E27FC236}">
                            <a16:creationId xmlns:a16="http://schemas.microsoft.com/office/drawing/2014/main" id="{11E7EC2B-0196-4CE3-5444-5F888F74D7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685578" y="12280728"/>
                        <a:ext cx="4896000" cy="41807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ggetto 12">
            <a:extLst>
              <a:ext uri="{FF2B5EF4-FFF2-40B4-BE49-F238E27FC236}">
                <a16:creationId xmlns:a16="http://schemas.microsoft.com/office/drawing/2014/main" id="{CC50E2D5-4A74-5B59-F28A-0BF51D1F89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2149327"/>
              </p:ext>
            </p:extLst>
          </p:nvPr>
        </p:nvGraphicFramePr>
        <p:xfrm>
          <a:off x="5931564" y="12168247"/>
          <a:ext cx="4896000" cy="4317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061514" imgH="2700075" progId="Prism10.Document">
                  <p:embed/>
                </p:oleObj>
              </mc:Choice>
              <mc:Fallback>
                <p:oleObj name="Prism 10" r:id="rId10" imgW="3061514" imgH="2700075" progId="Prism10.Document">
                  <p:embed/>
                  <p:pic>
                    <p:nvPicPr>
                      <p:cNvPr id="13" name="Oggetto 12">
                        <a:extLst>
                          <a:ext uri="{FF2B5EF4-FFF2-40B4-BE49-F238E27FC236}">
                            <a16:creationId xmlns:a16="http://schemas.microsoft.com/office/drawing/2014/main" id="{CC50E2D5-4A74-5B59-F28A-0BF51D1F89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931564" y="12168247"/>
                        <a:ext cx="4896000" cy="4317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ggetto 13">
            <a:extLst>
              <a:ext uri="{FF2B5EF4-FFF2-40B4-BE49-F238E27FC236}">
                <a16:creationId xmlns:a16="http://schemas.microsoft.com/office/drawing/2014/main" id="{13D0F99B-785A-D782-1138-DD1D58A5D0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0851474"/>
              </p:ext>
            </p:extLst>
          </p:nvPr>
        </p:nvGraphicFramePr>
        <p:xfrm>
          <a:off x="10209228" y="12064003"/>
          <a:ext cx="4896000" cy="43900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180358" imgH="2850979" progId="Prism10.Document">
                  <p:embed/>
                </p:oleObj>
              </mc:Choice>
              <mc:Fallback>
                <p:oleObj name="Prism 10" r:id="rId12" imgW="3180358" imgH="2850979" progId="Prism10.Document">
                  <p:embed/>
                  <p:pic>
                    <p:nvPicPr>
                      <p:cNvPr id="14" name="Oggetto 13">
                        <a:extLst>
                          <a:ext uri="{FF2B5EF4-FFF2-40B4-BE49-F238E27FC236}">
                            <a16:creationId xmlns:a16="http://schemas.microsoft.com/office/drawing/2014/main" id="{13D0F99B-785A-D782-1138-DD1D58A5D0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0209228" y="12064003"/>
                        <a:ext cx="4896000" cy="43900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E1AACC08-B15F-95AB-00C4-27C54B8464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9179477"/>
              </p:ext>
            </p:extLst>
          </p:nvPr>
        </p:nvGraphicFramePr>
        <p:xfrm>
          <a:off x="0" y="7648215"/>
          <a:ext cx="4896000" cy="4317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3061514" imgH="2700075" progId="Prism10.Document">
                  <p:embed/>
                </p:oleObj>
              </mc:Choice>
              <mc:Fallback>
                <p:oleObj name="Prism 10" r:id="rId14" imgW="3061514" imgH="2700075" progId="Prism10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E1AACC08-B15F-95AB-00C4-27C54B8464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0" y="7648215"/>
                        <a:ext cx="4896000" cy="4317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C1A38533-C023-12B3-DBCF-8446D6858D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1881579"/>
              </p:ext>
            </p:extLst>
          </p:nvPr>
        </p:nvGraphicFramePr>
        <p:xfrm>
          <a:off x="12383884" y="7771163"/>
          <a:ext cx="4896000" cy="41703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3170995" imgH="2700075" progId="Prism10.Document">
                  <p:embed/>
                </p:oleObj>
              </mc:Choice>
              <mc:Fallback>
                <p:oleObj name="Prism 10" r:id="rId16" imgW="3170995" imgH="2700075" progId="Prism10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C1A38533-C023-12B3-DBCF-8446D6858D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2383884" y="7771163"/>
                        <a:ext cx="4896000" cy="41703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ggetto 15">
            <a:extLst>
              <a:ext uri="{FF2B5EF4-FFF2-40B4-BE49-F238E27FC236}">
                <a16:creationId xmlns:a16="http://schemas.microsoft.com/office/drawing/2014/main" id="{2E8C29C3-95FD-7EA0-BAD1-568AB976C4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3313431"/>
              </p:ext>
            </p:extLst>
          </p:nvPr>
        </p:nvGraphicFramePr>
        <p:xfrm>
          <a:off x="14405185" y="12142865"/>
          <a:ext cx="4896000" cy="43426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3061514" imgH="2715561" progId="Prism10.Document">
                  <p:embed/>
                </p:oleObj>
              </mc:Choice>
              <mc:Fallback>
                <p:oleObj name="Prism 10" r:id="rId18" imgW="3061514" imgH="2715561" progId="Prism10.Document">
                  <p:embed/>
                  <p:pic>
                    <p:nvPicPr>
                      <p:cNvPr id="16" name="Oggetto 15">
                        <a:extLst>
                          <a:ext uri="{FF2B5EF4-FFF2-40B4-BE49-F238E27FC236}">
                            <a16:creationId xmlns:a16="http://schemas.microsoft.com/office/drawing/2014/main" id="{2E8C29C3-95FD-7EA0-BAD1-568AB976C4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4405185" y="12142865"/>
                        <a:ext cx="4896000" cy="43426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CasellaDiTesto 2">
            <a:extLst>
              <a:ext uri="{FF2B5EF4-FFF2-40B4-BE49-F238E27FC236}">
                <a16:creationId xmlns:a16="http://schemas.microsoft.com/office/drawing/2014/main" id="{74FF4113-2BEA-C9E4-D8F8-05FD8346D6A6}"/>
              </a:ext>
            </a:extLst>
          </p:cNvPr>
          <p:cNvSpPr txBox="1"/>
          <p:nvPr/>
        </p:nvSpPr>
        <p:spPr>
          <a:xfrm>
            <a:off x="532455" y="17729815"/>
            <a:ext cx="19779915" cy="144655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2200" b="1">
                <a:latin typeface="Arial"/>
                <a:cs typeface="Arial"/>
              </a:rPr>
              <a:t>Supplementary Figure 2: 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Association of EVs and miRNA expression with immunotherapy response in advanced stage NSCLC patients. Dot plot comparison of (</a:t>
            </a:r>
            <a:r>
              <a:rPr lang="en-US" sz="2200" b="1" i="0">
                <a:solidFill>
                  <a:srgbClr val="000000"/>
                </a:solidFill>
                <a:effectLst/>
                <a:latin typeface="Arial"/>
                <a:cs typeface="Arial"/>
              </a:rPr>
              <a:t>A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) EV concentration and size and of (</a:t>
            </a:r>
            <a:r>
              <a:rPr lang="en-US" sz="2200" b="1" i="0">
                <a:solidFill>
                  <a:srgbClr val="000000"/>
                </a:solidFill>
                <a:effectLst/>
                <a:latin typeface="Arial"/>
                <a:cs typeface="Arial"/>
              </a:rPr>
              <a:t>B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) miR-10a, miR</a:t>
            </a:r>
            <a:r>
              <a:rPr lang="en-US" sz="2200">
                <a:solidFill>
                  <a:srgbClr val="000000"/>
                </a:solidFill>
                <a:latin typeface="Arial"/>
                <a:cs typeface="Arial"/>
              </a:rPr>
              <a:t>-21, miR-22, miR-30a, miR-34a, miR-125b, miR-150, amiR-155 and miR-181a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 expression (n. copies/µl) in responder (R) patients vs non-responder (NR) ones. The horizontal bars indicate the median values with range and s</a:t>
            </a:r>
            <a:r>
              <a:rPr lang="en-US" sz="2200">
                <a:solidFill>
                  <a:srgbClr val="000000"/>
                </a:solidFill>
                <a:latin typeface="Arial"/>
                <a:cs typeface="Arial"/>
              </a:rPr>
              <a:t>tatistical analysis are indicated on graphs.</a:t>
            </a:r>
            <a:endParaRPr lang="en-US" sz="2200" b="1">
              <a:latin typeface="Arial"/>
              <a:cs typeface="Arial"/>
            </a:endParaRPr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295EBFE0-7143-CC6A-CC49-62672513C5B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-57364" y="1651196"/>
            <a:ext cx="22108471" cy="4862626"/>
          </a:xfrm>
          <a:prstGeom prst="rect">
            <a:avLst/>
          </a:prstGeom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1ECC4346-9AFA-39CA-6F04-47B1EE99CFF6}"/>
              </a:ext>
            </a:extLst>
          </p:cNvPr>
          <p:cNvSpPr txBox="1"/>
          <p:nvPr/>
        </p:nvSpPr>
        <p:spPr>
          <a:xfrm>
            <a:off x="126842" y="6885112"/>
            <a:ext cx="8112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996CAB75-0BC3-78EA-A6EF-3B4D6D75081B}"/>
              </a:ext>
            </a:extLst>
          </p:cNvPr>
          <p:cNvSpPr txBox="1"/>
          <p:nvPr/>
        </p:nvSpPr>
        <p:spPr>
          <a:xfrm>
            <a:off x="126842" y="1147205"/>
            <a:ext cx="1168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>
                <a:latin typeface="Arial" pitchFamily="34" charset="0"/>
                <a:cs typeface="Arial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1863784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magine 7">
            <a:extLst>
              <a:ext uri="{FF2B5EF4-FFF2-40B4-BE49-F238E27FC236}">
                <a16:creationId xmlns:a16="http://schemas.microsoft.com/office/drawing/2014/main" id="{89CB2316-8ED9-3DA3-F379-9957AF970C4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68816" b="74865"/>
          <a:stretch/>
        </p:blipFill>
        <p:spPr>
          <a:xfrm>
            <a:off x="1" y="6886027"/>
            <a:ext cx="4637314" cy="2705671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74F88B03-1EC0-5AB1-92E7-B1A236A13C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5296" r="68829" b="49569"/>
          <a:stretch/>
        </p:blipFill>
        <p:spPr>
          <a:xfrm>
            <a:off x="12917731" y="6956654"/>
            <a:ext cx="4637314" cy="2706771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30C7E740-7576-7A80-0090-289333DCD92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3164" r="68480"/>
          <a:stretch/>
        </p:blipFill>
        <p:spPr>
          <a:xfrm>
            <a:off x="15042509" y="9583824"/>
            <a:ext cx="4881174" cy="3008144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76E50415-919B-550E-212B-1C2A0419279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9156" r="66328" b="26305"/>
          <a:stretch/>
        </p:blipFill>
        <p:spPr>
          <a:xfrm>
            <a:off x="654031" y="9611565"/>
            <a:ext cx="5256910" cy="2773153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5F5B637A-2E6C-8ECB-9E5F-AD86E9F13A9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057" t="48223" r="36047" b="26642"/>
          <a:stretch/>
        </p:blipFill>
        <p:spPr>
          <a:xfrm>
            <a:off x="5337377" y="9490091"/>
            <a:ext cx="4683467" cy="2850292"/>
          </a:xfrm>
          <a:prstGeom prst="rect">
            <a:avLst/>
          </a:prstGeom>
        </p:spPr>
      </p:pic>
      <p:pic>
        <p:nvPicPr>
          <p:cNvPr id="15" name="Immagine 14">
            <a:extLst>
              <a:ext uri="{FF2B5EF4-FFF2-40B4-BE49-F238E27FC236}">
                <a16:creationId xmlns:a16="http://schemas.microsoft.com/office/drawing/2014/main" id="{06519645-8BD3-F02B-5D1F-A5C160FB13A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69038" b="75134"/>
          <a:stretch/>
        </p:blipFill>
        <p:spPr>
          <a:xfrm>
            <a:off x="557977" y="13015690"/>
            <a:ext cx="5653138" cy="3258436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34D3EE78-F6E2-0FCB-7CA1-4B4DCD06070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5266" t="25296" r="35111" b="50877"/>
          <a:stretch/>
        </p:blipFill>
        <p:spPr>
          <a:xfrm>
            <a:off x="775978" y="16562304"/>
            <a:ext cx="5408571" cy="3122334"/>
          </a:xfrm>
          <a:prstGeom prst="rect">
            <a:avLst/>
          </a:prstGeom>
        </p:spPr>
      </p:pic>
      <p:pic>
        <p:nvPicPr>
          <p:cNvPr id="17" name="Immagine 16">
            <a:extLst>
              <a:ext uri="{FF2B5EF4-FFF2-40B4-BE49-F238E27FC236}">
                <a16:creationId xmlns:a16="http://schemas.microsoft.com/office/drawing/2014/main" id="{1B004F38-8660-D55C-B83B-3084199EF8F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8591" t="48921" b="26501"/>
          <a:stretch/>
        </p:blipFill>
        <p:spPr>
          <a:xfrm>
            <a:off x="705671" y="19963271"/>
            <a:ext cx="5734656" cy="3220652"/>
          </a:xfrm>
          <a:prstGeom prst="rect">
            <a:avLst/>
          </a:prstGeom>
        </p:spPr>
      </p:pic>
      <p:pic>
        <p:nvPicPr>
          <p:cNvPr id="18" name="Immagine 17">
            <a:extLst>
              <a:ext uri="{FF2B5EF4-FFF2-40B4-BE49-F238E27FC236}">
                <a16:creationId xmlns:a16="http://schemas.microsoft.com/office/drawing/2014/main" id="{CFE50A75-CFF7-0A1D-6D48-687D1AE3041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3134" r="74239"/>
          <a:stretch/>
        </p:blipFill>
        <p:spPr>
          <a:xfrm>
            <a:off x="5220249" y="19972816"/>
            <a:ext cx="4703478" cy="3520510"/>
          </a:xfrm>
          <a:prstGeom prst="rect">
            <a:avLst/>
          </a:prstGeom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B8A7CF89-55DC-2374-017A-981426D0069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5111" r="35266" b="75134"/>
          <a:stretch/>
        </p:blipFill>
        <p:spPr>
          <a:xfrm>
            <a:off x="5305895" y="13015690"/>
            <a:ext cx="5408570" cy="3258436"/>
          </a:xfrm>
          <a:prstGeom prst="rect">
            <a:avLst/>
          </a:prstGeom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68B907D0-E2EC-1CE0-551B-232FD89833D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8102" b="75134"/>
          <a:stretch/>
        </p:blipFill>
        <p:spPr>
          <a:xfrm>
            <a:off x="9817700" y="13015690"/>
            <a:ext cx="5824003" cy="3258436"/>
          </a:xfrm>
          <a:prstGeom prst="rect">
            <a:avLst/>
          </a:prstGeom>
        </p:spPr>
      </p:pic>
      <p:pic>
        <p:nvPicPr>
          <p:cNvPr id="22" name="Immagine 21">
            <a:extLst>
              <a:ext uri="{FF2B5EF4-FFF2-40B4-BE49-F238E27FC236}">
                <a16:creationId xmlns:a16="http://schemas.microsoft.com/office/drawing/2014/main" id="{D8752FED-5035-FEEA-C8A8-FBAA380F6AF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4422" r="69038" b="49541"/>
          <a:stretch/>
        </p:blipFill>
        <p:spPr>
          <a:xfrm>
            <a:off x="14529177" y="13015690"/>
            <a:ext cx="5653137" cy="3411908"/>
          </a:xfrm>
          <a:prstGeom prst="rect">
            <a:avLst/>
          </a:prstGeom>
        </p:spPr>
      </p:pic>
      <p:pic>
        <p:nvPicPr>
          <p:cNvPr id="23" name="Immagine 22">
            <a:extLst>
              <a:ext uri="{FF2B5EF4-FFF2-40B4-BE49-F238E27FC236}">
                <a16:creationId xmlns:a16="http://schemas.microsoft.com/office/drawing/2014/main" id="{8162C6DA-2978-4084-0C71-5062B39F221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8102" t="25296" b="50877"/>
          <a:stretch/>
        </p:blipFill>
        <p:spPr>
          <a:xfrm>
            <a:off x="5322750" y="16562304"/>
            <a:ext cx="5824005" cy="3122334"/>
          </a:xfrm>
          <a:prstGeom prst="rect">
            <a:avLst/>
          </a:prstGeom>
        </p:spPr>
      </p:pic>
      <p:pic>
        <p:nvPicPr>
          <p:cNvPr id="24" name="Immagine 23">
            <a:extLst>
              <a:ext uri="{FF2B5EF4-FFF2-40B4-BE49-F238E27FC236}">
                <a16:creationId xmlns:a16="http://schemas.microsoft.com/office/drawing/2014/main" id="{C6BCA9BC-80E1-3708-D838-95F82120802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8893" r="74239" b="24903"/>
          <a:stretch/>
        </p:blipFill>
        <p:spPr>
          <a:xfrm>
            <a:off x="10015576" y="16498831"/>
            <a:ext cx="4703477" cy="3433758"/>
          </a:xfrm>
          <a:prstGeom prst="rect">
            <a:avLst/>
          </a:prstGeom>
        </p:spPr>
      </p:pic>
      <p:pic>
        <p:nvPicPr>
          <p:cNvPr id="25" name="Immagine 24">
            <a:extLst>
              <a:ext uri="{FF2B5EF4-FFF2-40B4-BE49-F238E27FC236}">
                <a16:creationId xmlns:a16="http://schemas.microsoft.com/office/drawing/2014/main" id="{61089F04-884F-5C95-F742-FE3FD56860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4327" t="48893" r="33142" b="24903"/>
          <a:stretch/>
        </p:blipFill>
        <p:spPr>
          <a:xfrm>
            <a:off x="14719053" y="16474686"/>
            <a:ext cx="5939569" cy="3433757"/>
          </a:xfrm>
          <a:prstGeom prst="rect">
            <a:avLst/>
          </a:prstGeom>
        </p:spPr>
      </p:pic>
      <p:pic>
        <p:nvPicPr>
          <p:cNvPr id="26" name="Immagine 25">
            <a:extLst>
              <a:ext uri="{FF2B5EF4-FFF2-40B4-BE49-F238E27FC236}">
                <a16:creationId xmlns:a16="http://schemas.microsoft.com/office/drawing/2014/main" id="{A4AC95E8-A24D-7FB0-79FC-063B23C056B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4464" t="73134" r="34573"/>
          <a:stretch/>
        </p:blipFill>
        <p:spPr>
          <a:xfrm>
            <a:off x="10131795" y="19908443"/>
            <a:ext cx="5653138" cy="3520510"/>
          </a:xfrm>
          <a:prstGeom prst="rect">
            <a:avLst/>
          </a:prstGeom>
        </p:spPr>
      </p:pic>
      <p:pic>
        <p:nvPicPr>
          <p:cNvPr id="27" name="Immagine 26">
            <a:extLst>
              <a:ext uri="{FF2B5EF4-FFF2-40B4-BE49-F238E27FC236}">
                <a16:creationId xmlns:a16="http://schemas.microsoft.com/office/drawing/2014/main" id="{0D3C626E-EB83-FB1B-54B4-8BBF621CD4E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7469" t="73134"/>
          <a:stretch/>
        </p:blipFill>
        <p:spPr>
          <a:xfrm>
            <a:off x="14719053" y="19908443"/>
            <a:ext cx="5939569" cy="3520510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032C79FA-F572-72CA-2346-F447ACA00F09}"/>
              </a:ext>
            </a:extLst>
          </p:cNvPr>
          <p:cNvSpPr txBox="1"/>
          <p:nvPr/>
        </p:nvSpPr>
        <p:spPr>
          <a:xfrm>
            <a:off x="181914" y="6546578"/>
            <a:ext cx="8112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53595E63-5C54-5E29-B709-FCEF276E4532}"/>
              </a:ext>
            </a:extLst>
          </p:cNvPr>
          <p:cNvSpPr txBox="1"/>
          <p:nvPr/>
        </p:nvSpPr>
        <p:spPr>
          <a:xfrm>
            <a:off x="32160" y="452014"/>
            <a:ext cx="1168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4C2C216D-613B-A38D-B02B-1EF396AF8E74}"/>
              </a:ext>
            </a:extLst>
          </p:cNvPr>
          <p:cNvSpPr txBox="1"/>
          <p:nvPr/>
        </p:nvSpPr>
        <p:spPr>
          <a:xfrm>
            <a:off x="176395" y="23581059"/>
            <a:ext cx="20822721" cy="110799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2200" b="1">
                <a:latin typeface="Arial"/>
                <a:cs typeface="Arial"/>
              </a:rPr>
              <a:t>Supplementary Figure 3: 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Association of EV concentration, size and miRNA expression with </a:t>
            </a:r>
            <a:r>
              <a:rPr lang="en-US" sz="2200">
                <a:solidFill>
                  <a:srgbClr val="000000"/>
                </a:solidFill>
                <a:latin typeface="Arial"/>
                <a:cs typeface="Arial"/>
              </a:rPr>
              <a:t>survival outcomes in advanced NSCLC patients. 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Kaplan-Meier curves for (</a:t>
            </a:r>
            <a:r>
              <a:rPr lang="en-US" sz="2200" b="1" i="0">
                <a:solidFill>
                  <a:srgbClr val="000000"/>
                </a:solidFill>
                <a:effectLst/>
                <a:latin typeface="Arial"/>
                <a:cs typeface="Arial"/>
              </a:rPr>
              <a:t>A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) PFS and OS according to EV concentration and size, and of (</a:t>
            </a:r>
            <a:r>
              <a:rPr lang="en-US" sz="2200" b="1" i="0">
                <a:solidFill>
                  <a:srgbClr val="000000"/>
                </a:solidFill>
                <a:effectLst/>
                <a:latin typeface="Arial"/>
                <a:cs typeface="Arial"/>
              </a:rPr>
              <a:t>B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) PFS and OS according to the expression of </a:t>
            </a:r>
            <a:r>
              <a:rPr lang="en-US" sz="2200" b="0" i="0" err="1">
                <a:solidFill>
                  <a:srgbClr val="000000"/>
                </a:solidFill>
                <a:effectLst/>
                <a:latin typeface="Arial"/>
                <a:cs typeface="Arial"/>
              </a:rPr>
              <a:t>cEV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 miRNAs. Median expression values classified patients into low/high expression groups.</a:t>
            </a:r>
            <a:endParaRPr lang="en-US" sz="2200" b="1">
              <a:latin typeface="Arial"/>
              <a:cs typeface="Arial"/>
            </a:endParaRP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E21987B3-477B-B9D7-EE7E-8B4A5B857F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160" y="740937"/>
            <a:ext cx="21768107" cy="3098159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ECA5C339-D8D1-6351-4DF7-92981A6E14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160" y="3434633"/>
            <a:ext cx="21768107" cy="3098158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3B7BEB9A-8E4D-C1F4-B3C1-05AC23579EF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544" r="34273" b="74865"/>
          <a:stretch/>
        </p:blipFill>
        <p:spPr>
          <a:xfrm>
            <a:off x="4431770" y="6853850"/>
            <a:ext cx="4637314" cy="2705671"/>
          </a:xfrm>
          <a:prstGeom prst="rect">
            <a:avLst/>
          </a:prstGeom>
        </p:spPr>
      </p:pic>
      <p:pic>
        <p:nvPicPr>
          <p:cNvPr id="28" name="Immagine 27">
            <a:extLst>
              <a:ext uri="{FF2B5EF4-FFF2-40B4-BE49-F238E27FC236}">
                <a16:creationId xmlns:a16="http://schemas.microsoft.com/office/drawing/2014/main" id="{820BD914-50A3-A76C-C67D-B2A51E20BE3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9087" b="74865"/>
          <a:stretch/>
        </p:blipFill>
        <p:spPr>
          <a:xfrm>
            <a:off x="8771155" y="6829098"/>
            <a:ext cx="4597197" cy="2705671"/>
          </a:xfrm>
          <a:prstGeom prst="rect">
            <a:avLst/>
          </a:prstGeom>
        </p:spPr>
      </p:pic>
      <p:pic>
        <p:nvPicPr>
          <p:cNvPr id="29" name="Immagine 28">
            <a:extLst>
              <a:ext uri="{FF2B5EF4-FFF2-40B4-BE49-F238E27FC236}">
                <a16:creationId xmlns:a16="http://schemas.microsoft.com/office/drawing/2014/main" id="{0EC3F3D7-28DD-CED5-C97C-376B510348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772" t="25296" r="34057" b="49569"/>
          <a:stretch/>
        </p:blipFill>
        <p:spPr>
          <a:xfrm>
            <a:off x="17221889" y="6956652"/>
            <a:ext cx="4637315" cy="2706771"/>
          </a:xfrm>
          <a:prstGeom prst="rect">
            <a:avLst/>
          </a:prstGeom>
        </p:spPr>
      </p:pic>
      <p:pic>
        <p:nvPicPr>
          <p:cNvPr id="30" name="Immagine 29">
            <a:extLst>
              <a:ext uri="{FF2B5EF4-FFF2-40B4-BE49-F238E27FC236}">
                <a16:creationId xmlns:a16="http://schemas.microsoft.com/office/drawing/2014/main" id="{F92A34DD-7559-ED0C-4204-2EDA6016E02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842" t="48223" b="26642"/>
          <a:stretch/>
        </p:blipFill>
        <p:spPr>
          <a:xfrm>
            <a:off x="10114013" y="9479773"/>
            <a:ext cx="4881174" cy="28502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36386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49C65AEB-CA5A-65B8-7F99-C1B8997A5F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835260"/>
              </p:ext>
            </p:extLst>
          </p:nvPr>
        </p:nvGraphicFramePr>
        <p:xfrm>
          <a:off x="1055784" y="6594067"/>
          <a:ext cx="4689050" cy="4134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061514" imgH="2700075" progId="Prism10.Document">
                  <p:embed/>
                </p:oleObj>
              </mc:Choice>
              <mc:Fallback>
                <p:oleObj name="Prism 10" r:id="rId3" imgW="3061514" imgH="2700075" progId="Prism10.Document">
                  <p:embed/>
                  <p:pic>
                    <p:nvPicPr>
                      <p:cNvPr id="5" name="Oggetto 4">
                        <a:extLst>
                          <a:ext uri="{FF2B5EF4-FFF2-40B4-BE49-F238E27FC236}">
                            <a16:creationId xmlns:a16="http://schemas.microsoft.com/office/drawing/2014/main" id="{49C65AEB-CA5A-65B8-7F99-C1B8997A5F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55784" y="6594067"/>
                        <a:ext cx="4689050" cy="4134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ggetto 15">
            <a:extLst>
              <a:ext uri="{FF2B5EF4-FFF2-40B4-BE49-F238E27FC236}">
                <a16:creationId xmlns:a16="http://schemas.microsoft.com/office/drawing/2014/main" id="{D9374029-72DB-5050-C761-4236F90B11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8074393"/>
              </p:ext>
            </p:extLst>
          </p:nvPr>
        </p:nvGraphicFramePr>
        <p:xfrm>
          <a:off x="5428715" y="6594067"/>
          <a:ext cx="4689050" cy="4134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061514" imgH="2700075" progId="Prism10.Document">
                  <p:embed/>
                </p:oleObj>
              </mc:Choice>
              <mc:Fallback>
                <p:oleObj name="Prism 10" r:id="rId5" imgW="3061514" imgH="2700075" progId="Prism10.Document">
                  <p:embed/>
                  <p:pic>
                    <p:nvPicPr>
                      <p:cNvPr id="16" name="Oggetto 15">
                        <a:extLst>
                          <a:ext uri="{FF2B5EF4-FFF2-40B4-BE49-F238E27FC236}">
                            <a16:creationId xmlns:a16="http://schemas.microsoft.com/office/drawing/2014/main" id="{D9374029-72DB-5050-C761-4236F90B11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428715" y="6594067"/>
                        <a:ext cx="4689050" cy="4134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ggetto 16">
            <a:extLst>
              <a:ext uri="{FF2B5EF4-FFF2-40B4-BE49-F238E27FC236}">
                <a16:creationId xmlns:a16="http://schemas.microsoft.com/office/drawing/2014/main" id="{32A32D1E-1710-83BF-FF49-D992E535EC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9750289"/>
              </p:ext>
            </p:extLst>
          </p:nvPr>
        </p:nvGraphicFramePr>
        <p:xfrm>
          <a:off x="9844759" y="6594067"/>
          <a:ext cx="4689050" cy="4134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061514" imgH="2700075" progId="Prism10.Document">
                  <p:embed/>
                </p:oleObj>
              </mc:Choice>
              <mc:Fallback>
                <p:oleObj name="Prism 10" r:id="rId7" imgW="3061514" imgH="2700075" progId="Prism10.Document">
                  <p:embed/>
                  <p:pic>
                    <p:nvPicPr>
                      <p:cNvPr id="17" name="Oggetto 16">
                        <a:extLst>
                          <a:ext uri="{FF2B5EF4-FFF2-40B4-BE49-F238E27FC236}">
                            <a16:creationId xmlns:a16="http://schemas.microsoft.com/office/drawing/2014/main" id="{32A32D1E-1710-83BF-FF49-D992E535EC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844759" y="6594067"/>
                        <a:ext cx="4689050" cy="4134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ggetto 17">
            <a:extLst>
              <a:ext uri="{FF2B5EF4-FFF2-40B4-BE49-F238E27FC236}">
                <a16:creationId xmlns:a16="http://schemas.microsoft.com/office/drawing/2014/main" id="{AFAD40CC-1D80-3170-9E69-A5E7F7C4D8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3941809"/>
              </p:ext>
            </p:extLst>
          </p:nvPr>
        </p:nvGraphicFramePr>
        <p:xfrm>
          <a:off x="14382742" y="6594067"/>
          <a:ext cx="4854345" cy="4134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170995" imgH="2700075" progId="Prism10.Document">
                  <p:embed/>
                </p:oleObj>
              </mc:Choice>
              <mc:Fallback>
                <p:oleObj name="Prism 10" r:id="rId9" imgW="3170995" imgH="2700075" progId="Prism10.Document">
                  <p:embed/>
                  <p:pic>
                    <p:nvPicPr>
                      <p:cNvPr id="18" name="Oggetto 17">
                        <a:extLst>
                          <a:ext uri="{FF2B5EF4-FFF2-40B4-BE49-F238E27FC236}">
                            <a16:creationId xmlns:a16="http://schemas.microsoft.com/office/drawing/2014/main" id="{AFAD40CC-1D80-3170-9E69-A5E7F7C4D8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4382742" y="6594067"/>
                        <a:ext cx="4854345" cy="4134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ggetto 18">
            <a:extLst>
              <a:ext uri="{FF2B5EF4-FFF2-40B4-BE49-F238E27FC236}">
                <a16:creationId xmlns:a16="http://schemas.microsoft.com/office/drawing/2014/main" id="{3977DA2B-85DC-99E1-CB19-A7C1AB9535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504957"/>
              </p:ext>
            </p:extLst>
          </p:nvPr>
        </p:nvGraphicFramePr>
        <p:xfrm>
          <a:off x="1055784" y="10909423"/>
          <a:ext cx="4689050" cy="44459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061514" imgH="2902842" progId="Prism10.Document">
                  <p:embed/>
                </p:oleObj>
              </mc:Choice>
              <mc:Fallback>
                <p:oleObj name="Prism 10" r:id="rId11" imgW="3061514" imgH="2902842" progId="Prism10.Document">
                  <p:embed/>
                  <p:pic>
                    <p:nvPicPr>
                      <p:cNvPr id="19" name="Oggetto 18">
                        <a:extLst>
                          <a:ext uri="{FF2B5EF4-FFF2-40B4-BE49-F238E27FC236}">
                            <a16:creationId xmlns:a16="http://schemas.microsoft.com/office/drawing/2014/main" id="{3977DA2B-85DC-99E1-CB19-A7C1AB9535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055784" y="10909423"/>
                        <a:ext cx="4689050" cy="44459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ggetto 19">
            <a:extLst>
              <a:ext uri="{FF2B5EF4-FFF2-40B4-BE49-F238E27FC236}">
                <a16:creationId xmlns:a16="http://schemas.microsoft.com/office/drawing/2014/main" id="{5C5D0E6C-6374-4F57-775E-86C3798EC4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4981576"/>
              </p:ext>
            </p:extLst>
          </p:nvPr>
        </p:nvGraphicFramePr>
        <p:xfrm>
          <a:off x="5428715" y="11143609"/>
          <a:ext cx="4689050" cy="42199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061514" imgH="2756619" progId="Prism10.Document">
                  <p:embed/>
                </p:oleObj>
              </mc:Choice>
              <mc:Fallback>
                <p:oleObj name="Prism 10" r:id="rId13" imgW="3061514" imgH="2756619" progId="Prism10.Document">
                  <p:embed/>
                  <p:pic>
                    <p:nvPicPr>
                      <p:cNvPr id="20" name="Oggetto 19">
                        <a:extLst>
                          <a:ext uri="{FF2B5EF4-FFF2-40B4-BE49-F238E27FC236}">
                            <a16:creationId xmlns:a16="http://schemas.microsoft.com/office/drawing/2014/main" id="{5C5D0E6C-6374-4F57-775E-86C3798EC4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428715" y="11143609"/>
                        <a:ext cx="4689050" cy="42199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ggetto 20">
            <a:extLst>
              <a:ext uri="{FF2B5EF4-FFF2-40B4-BE49-F238E27FC236}">
                <a16:creationId xmlns:a16="http://schemas.microsoft.com/office/drawing/2014/main" id="{14A6DE69-92DD-0CA7-CE5F-A92346524C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6373265"/>
              </p:ext>
            </p:extLst>
          </p:nvPr>
        </p:nvGraphicFramePr>
        <p:xfrm>
          <a:off x="9884732" y="11231746"/>
          <a:ext cx="4842191" cy="4134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3161992" imgH="2700075" progId="Prism10.Document">
                  <p:embed/>
                </p:oleObj>
              </mc:Choice>
              <mc:Fallback>
                <p:oleObj name="Prism 10" r:id="rId15" imgW="3161992" imgH="2700075" progId="Prism10.Document">
                  <p:embed/>
                  <p:pic>
                    <p:nvPicPr>
                      <p:cNvPr id="21" name="Oggetto 20">
                        <a:extLst>
                          <a:ext uri="{FF2B5EF4-FFF2-40B4-BE49-F238E27FC236}">
                            <a16:creationId xmlns:a16="http://schemas.microsoft.com/office/drawing/2014/main" id="{14A6DE69-92DD-0CA7-CE5F-A92346524C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884732" y="11231746"/>
                        <a:ext cx="4842191" cy="4134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ggetto 21">
            <a:extLst>
              <a:ext uri="{FF2B5EF4-FFF2-40B4-BE49-F238E27FC236}">
                <a16:creationId xmlns:a16="http://schemas.microsoft.com/office/drawing/2014/main" id="{DF83BB9F-8CA0-B689-B0E8-1F931E98C8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0342957"/>
              </p:ext>
            </p:extLst>
          </p:nvPr>
        </p:nvGraphicFramePr>
        <p:xfrm>
          <a:off x="14567904" y="11231746"/>
          <a:ext cx="4689050" cy="4134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3062954" imgH="2700075" progId="Prism10.Document">
                  <p:embed/>
                </p:oleObj>
              </mc:Choice>
              <mc:Fallback>
                <p:oleObj name="Prism 10" r:id="rId17" imgW="3062954" imgH="2700075" progId="Prism10.Document">
                  <p:embed/>
                  <p:pic>
                    <p:nvPicPr>
                      <p:cNvPr id="22" name="Oggetto 21">
                        <a:extLst>
                          <a:ext uri="{FF2B5EF4-FFF2-40B4-BE49-F238E27FC236}">
                            <a16:creationId xmlns:a16="http://schemas.microsoft.com/office/drawing/2014/main" id="{DF83BB9F-8CA0-B689-B0E8-1F931E98C8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4567904" y="11231746"/>
                        <a:ext cx="4689050" cy="4134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ggetto 22">
            <a:extLst>
              <a:ext uri="{FF2B5EF4-FFF2-40B4-BE49-F238E27FC236}">
                <a16:creationId xmlns:a16="http://schemas.microsoft.com/office/drawing/2014/main" id="{664DF3E2-EC51-555A-2F21-B2A4866DEE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8026846"/>
              </p:ext>
            </p:extLst>
          </p:nvPr>
        </p:nvGraphicFramePr>
        <p:xfrm>
          <a:off x="896888" y="15505954"/>
          <a:ext cx="4854344" cy="43657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3170995" imgH="2850979" progId="Prism10.Document">
                  <p:embed/>
                </p:oleObj>
              </mc:Choice>
              <mc:Fallback>
                <p:oleObj name="Prism 10" r:id="rId19" imgW="3170995" imgH="2850979" progId="Prism10.Document">
                  <p:embed/>
                  <p:pic>
                    <p:nvPicPr>
                      <p:cNvPr id="23" name="Oggetto 22">
                        <a:extLst>
                          <a:ext uri="{FF2B5EF4-FFF2-40B4-BE49-F238E27FC236}">
                            <a16:creationId xmlns:a16="http://schemas.microsoft.com/office/drawing/2014/main" id="{664DF3E2-EC51-555A-2F21-B2A4866DEE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96888" y="15505954"/>
                        <a:ext cx="4854344" cy="43657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ggetto 23">
            <a:extLst>
              <a:ext uri="{FF2B5EF4-FFF2-40B4-BE49-F238E27FC236}">
                <a16:creationId xmlns:a16="http://schemas.microsoft.com/office/drawing/2014/main" id="{1DD05725-BB1A-28C8-2A58-17B333EA22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6683657"/>
              </p:ext>
            </p:extLst>
          </p:nvPr>
        </p:nvGraphicFramePr>
        <p:xfrm>
          <a:off x="5427125" y="15719998"/>
          <a:ext cx="4689049" cy="41591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3061514" imgH="2715561" progId="Prism10.Document">
                  <p:embed/>
                </p:oleObj>
              </mc:Choice>
              <mc:Fallback>
                <p:oleObj name="Prism 10" r:id="rId21" imgW="3061514" imgH="2715561" progId="Prism10.Document">
                  <p:embed/>
                  <p:pic>
                    <p:nvPicPr>
                      <p:cNvPr id="24" name="Oggetto 23">
                        <a:extLst>
                          <a:ext uri="{FF2B5EF4-FFF2-40B4-BE49-F238E27FC236}">
                            <a16:creationId xmlns:a16="http://schemas.microsoft.com/office/drawing/2014/main" id="{1DD05725-BB1A-28C8-2A58-17B333EA22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427125" y="15719998"/>
                        <a:ext cx="4689049" cy="41591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ggetto 24">
            <a:extLst>
              <a:ext uri="{FF2B5EF4-FFF2-40B4-BE49-F238E27FC236}">
                <a16:creationId xmlns:a16="http://schemas.microsoft.com/office/drawing/2014/main" id="{CA1E2B7D-710A-8C8C-0F66-E8D2AC4C25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853660"/>
              </p:ext>
            </p:extLst>
          </p:nvPr>
        </p:nvGraphicFramePr>
        <p:xfrm>
          <a:off x="10035258" y="15558835"/>
          <a:ext cx="4689049" cy="43147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3061514" imgH="2817485" progId="Prism10.Document">
                  <p:embed/>
                </p:oleObj>
              </mc:Choice>
              <mc:Fallback>
                <p:oleObj name="Prism 10" r:id="rId23" imgW="3061514" imgH="2817485" progId="Prism10.Document">
                  <p:embed/>
                  <p:pic>
                    <p:nvPicPr>
                      <p:cNvPr id="25" name="Oggetto 24">
                        <a:extLst>
                          <a:ext uri="{FF2B5EF4-FFF2-40B4-BE49-F238E27FC236}">
                            <a16:creationId xmlns:a16="http://schemas.microsoft.com/office/drawing/2014/main" id="{CA1E2B7D-710A-8C8C-0F66-E8D2AC4C25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0035258" y="15558835"/>
                        <a:ext cx="4689049" cy="43147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ggetto 25">
            <a:extLst>
              <a:ext uri="{FF2B5EF4-FFF2-40B4-BE49-F238E27FC236}">
                <a16:creationId xmlns:a16="http://schemas.microsoft.com/office/drawing/2014/main" id="{D68CB885-5AA3-E5FA-334E-BBE155ADA0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6409560"/>
              </p:ext>
            </p:extLst>
          </p:nvPr>
        </p:nvGraphicFramePr>
        <p:xfrm>
          <a:off x="14586954" y="15533656"/>
          <a:ext cx="4689051" cy="43390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3061514" imgH="2834412" progId="Prism10.Document">
                  <p:embed/>
                </p:oleObj>
              </mc:Choice>
              <mc:Fallback>
                <p:oleObj name="Prism 10" r:id="rId25" imgW="3061514" imgH="2834412" progId="Prism10.Document">
                  <p:embed/>
                  <p:pic>
                    <p:nvPicPr>
                      <p:cNvPr id="26" name="Oggetto 25">
                        <a:extLst>
                          <a:ext uri="{FF2B5EF4-FFF2-40B4-BE49-F238E27FC236}">
                            <a16:creationId xmlns:a16="http://schemas.microsoft.com/office/drawing/2014/main" id="{D68CB885-5AA3-E5FA-334E-BBE155ADA0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4586954" y="15533656"/>
                        <a:ext cx="4689051" cy="43390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45ED1FF6-81DF-599C-E177-42FA8A0097E3}"/>
              </a:ext>
            </a:extLst>
          </p:cNvPr>
          <p:cNvSpPr txBox="1"/>
          <p:nvPr/>
        </p:nvSpPr>
        <p:spPr>
          <a:xfrm>
            <a:off x="388401" y="20698592"/>
            <a:ext cx="19632146" cy="110799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2200" b="1">
                <a:latin typeface="Arial"/>
                <a:cs typeface="Arial"/>
              </a:rPr>
              <a:t>Supplementary Figure 4: </a:t>
            </a:r>
            <a:r>
              <a:rPr lang="en-US" sz="2200" err="1">
                <a:solidFill>
                  <a:srgbClr val="000000"/>
                </a:solidFill>
                <a:latin typeface="Arial"/>
                <a:cs typeface="Arial"/>
              </a:rPr>
              <a:t>cEV</a:t>
            </a:r>
            <a:r>
              <a:rPr lang="en-US" sz="2200">
                <a:solidFill>
                  <a:srgbClr val="000000"/>
                </a:solidFill>
                <a:latin typeface="Arial"/>
                <a:cs typeface="Arial"/>
              </a:rPr>
              <a:t> concentration, size and miRNA analysis in different histological advanced stage NSCLC subtypes. Dot plots of (</a:t>
            </a:r>
            <a:r>
              <a:rPr lang="en-US" sz="2200" b="1">
                <a:solidFill>
                  <a:srgbClr val="000000"/>
                </a:solidFill>
                <a:latin typeface="Arial"/>
                <a:cs typeface="Arial"/>
              </a:rPr>
              <a:t>A</a:t>
            </a:r>
            <a:r>
              <a:rPr lang="en-US" sz="2200">
                <a:solidFill>
                  <a:srgbClr val="000000"/>
                </a:solidFill>
                <a:latin typeface="Arial"/>
                <a:cs typeface="Arial"/>
              </a:rPr>
              <a:t>) EV concentration (n. EVs/ml) and size (nm), and of (</a:t>
            </a:r>
            <a:r>
              <a:rPr lang="en-US" sz="2200" b="1">
                <a:solidFill>
                  <a:srgbClr val="000000"/>
                </a:solidFill>
                <a:latin typeface="Arial"/>
                <a:cs typeface="Arial"/>
              </a:rPr>
              <a:t>B</a:t>
            </a:r>
            <a:r>
              <a:rPr lang="en-US" sz="2200">
                <a:solidFill>
                  <a:srgbClr val="000000"/>
                </a:solidFill>
                <a:latin typeface="Arial"/>
                <a:cs typeface="Arial"/>
              </a:rPr>
              <a:t>) miRNA expression (n. copies/µl) comparison in adenocarcinoma versus squamous cell carcinoma subtype groups. The horizontal bars indicate the median values with range and statistical analysis are indicated on graphs.</a:t>
            </a:r>
            <a:endParaRPr lang="en-US" sz="2200" b="1">
              <a:latin typeface="Arial"/>
              <a:cs typeface="Arial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06A4C7AF-92F4-E21B-C317-DCAE75B23D4D}"/>
              </a:ext>
            </a:extLst>
          </p:cNvPr>
          <p:cNvSpPr txBox="1"/>
          <p:nvPr/>
        </p:nvSpPr>
        <p:spPr>
          <a:xfrm>
            <a:off x="85662" y="6205792"/>
            <a:ext cx="8112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B71E9C9D-0486-4492-1C8E-B5181E56C5A2}"/>
              </a:ext>
            </a:extLst>
          </p:cNvPr>
          <p:cNvSpPr txBox="1"/>
          <p:nvPr/>
        </p:nvSpPr>
        <p:spPr>
          <a:xfrm>
            <a:off x="32160" y="857184"/>
            <a:ext cx="1168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>
                <a:latin typeface="Arial" pitchFamily="34" charset="0"/>
                <a:cs typeface="Arial" pitchFamily="34" charset="0"/>
              </a:rPr>
              <a:t>A</a:t>
            </a:r>
          </a:p>
        </p:txBody>
      </p:sp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2F6AD1B3-F2E6-87DE-FF6D-9C142CA524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8120032"/>
              </p:ext>
            </p:extLst>
          </p:nvPr>
        </p:nvGraphicFramePr>
        <p:xfrm>
          <a:off x="15177" y="1438087"/>
          <a:ext cx="21552188" cy="43365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10232896" imgH="2058280" progId="Prism10.Document">
                  <p:embed/>
                </p:oleObj>
              </mc:Choice>
              <mc:Fallback>
                <p:oleObj name="Prism 10" r:id="rId27" imgW="10232896" imgH="2058280" progId="Prism10.Document">
                  <p:embed/>
                  <p:pic>
                    <p:nvPicPr>
                      <p:cNvPr id="7" name="Oggetto 6">
                        <a:extLst>
                          <a:ext uri="{FF2B5EF4-FFF2-40B4-BE49-F238E27FC236}">
                            <a16:creationId xmlns:a16="http://schemas.microsoft.com/office/drawing/2014/main" id="{2F6AD1B3-F2E6-87DE-FF6D-9C142CA524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5177" y="1438087"/>
                        <a:ext cx="21552188" cy="43365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260448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40E1CE83-F5A8-C10D-EE2F-3ADABEE7E8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3695283"/>
              </p:ext>
            </p:extLst>
          </p:nvPr>
        </p:nvGraphicFramePr>
        <p:xfrm>
          <a:off x="5347326" y="6755386"/>
          <a:ext cx="4927697" cy="4909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61514" imgH="3050865" progId="Prism10.Document">
                  <p:embed/>
                </p:oleObj>
              </mc:Choice>
              <mc:Fallback>
                <p:oleObj name="Prism 10" r:id="rId2" imgW="3061514" imgH="3050865" progId="Prism10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40E1CE83-F5A8-C10D-EE2F-3ADABEE7E8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47326" y="6755386"/>
                        <a:ext cx="4927697" cy="4909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A5EA9854-5B0E-730A-7803-C27B03C11F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7273024"/>
              </p:ext>
            </p:extLst>
          </p:nvPr>
        </p:nvGraphicFramePr>
        <p:xfrm>
          <a:off x="9965762" y="6755384"/>
          <a:ext cx="4912376" cy="4909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52150" imgH="3050865" progId="Prism10.Document">
                  <p:embed/>
                </p:oleObj>
              </mc:Choice>
              <mc:Fallback>
                <p:oleObj name="Prism 10" r:id="rId4" imgW="3052150" imgH="3050865" progId="Prism10.Document">
                  <p:embed/>
                  <p:pic>
                    <p:nvPicPr>
                      <p:cNvPr id="3" name="Oggetto 2">
                        <a:extLst>
                          <a:ext uri="{FF2B5EF4-FFF2-40B4-BE49-F238E27FC236}">
                            <a16:creationId xmlns:a16="http://schemas.microsoft.com/office/drawing/2014/main" id="{A5EA9854-5B0E-730A-7803-C27B03C11F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965762" y="6755384"/>
                        <a:ext cx="4912376" cy="4909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B2455BC1-E312-D5EA-2CF8-ABDF3A3E32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475364"/>
              </p:ext>
            </p:extLst>
          </p:nvPr>
        </p:nvGraphicFramePr>
        <p:xfrm>
          <a:off x="15111626" y="6755384"/>
          <a:ext cx="5101407" cy="4909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170995" imgH="3050865" progId="Prism10.Document">
                  <p:embed/>
                </p:oleObj>
              </mc:Choice>
              <mc:Fallback>
                <p:oleObj name="Prism 10" r:id="rId6" imgW="3170995" imgH="3050865" progId="Prism10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B2455BC1-E312-D5EA-2CF8-ABDF3A3E32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5111626" y="6755384"/>
                        <a:ext cx="5101407" cy="4909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19CA2CFC-51DE-59F1-14A8-1763A48DE7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2481112"/>
              </p:ext>
            </p:extLst>
          </p:nvPr>
        </p:nvGraphicFramePr>
        <p:xfrm>
          <a:off x="15187273" y="11997077"/>
          <a:ext cx="4927697" cy="4909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061514" imgH="3050865" progId="Prism10.Document">
                  <p:embed/>
                </p:oleObj>
              </mc:Choice>
              <mc:Fallback>
                <p:oleObj name="Prism 10" r:id="rId8" imgW="3061514" imgH="3050865" progId="Prism10.Document">
                  <p:embed/>
                  <p:pic>
                    <p:nvPicPr>
                      <p:cNvPr id="7" name="Oggetto 6">
                        <a:extLst>
                          <a:ext uri="{FF2B5EF4-FFF2-40B4-BE49-F238E27FC236}">
                            <a16:creationId xmlns:a16="http://schemas.microsoft.com/office/drawing/2014/main" id="{19CA2CFC-51DE-59F1-14A8-1763A48DE7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187273" y="11997077"/>
                        <a:ext cx="4927697" cy="4909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ggetto 7">
            <a:extLst>
              <a:ext uri="{FF2B5EF4-FFF2-40B4-BE49-F238E27FC236}">
                <a16:creationId xmlns:a16="http://schemas.microsoft.com/office/drawing/2014/main" id="{D75E5927-271B-EBE3-1061-31A28E4B7C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5405514"/>
              </p:ext>
            </p:extLst>
          </p:nvPr>
        </p:nvGraphicFramePr>
        <p:xfrm>
          <a:off x="372251" y="17143749"/>
          <a:ext cx="5101407" cy="51524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170995" imgH="3201769" progId="Prism10.Document">
                  <p:embed/>
                </p:oleObj>
              </mc:Choice>
              <mc:Fallback>
                <p:oleObj name="Prism 10" r:id="rId10" imgW="3170995" imgH="3201769" progId="Prism10.Document">
                  <p:embed/>
                  <p:pic>
                    <p:nvPicPr>
                      <p:cNvPr id="8" name="Oggetto 7">
                        <a:extLst>
                          <a:ext uri="{FF2B5EF4-FFF2-40B4-BE49-F238E27FC236}">
                            <a16:creationId xmlns:a16="http://schemas.microsoft.com/office/drawing/2014/main" id="{D75E5927-271B-EBE3-1061-31A28E4B7C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72251" y="17143749"/>
                        <a:ext cx="5101407" cy="51524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ggetto 8">
            <a:extLst>
              <a:ext uri="{FF2B5EF4-FFF2-40B4-BE49-F238E27FC236}">
                <a16:creationId xmlns:a16="http://schemas.microsoft.com/office/drawing/2014/main" id="{4E555D9E-3ED1-A954-02D0-85B47C5C60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3562750"/>
              </p:ext>
            </p:extLst>
          </p:nvPr>
        </p:nvGraphicFramePr>
        <p:xfrm>
          <a:off x="5347326" y="17363439"/>
          <a:ext cx="4927700" cy="49328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061514" imgH="3065991" progId="Prism10.Document">
                  <p:embed/>
                </p:oleObj>
              </mc:Choice>
              <mc:Fallback>
                <p:oleObj name="Prism 10" r:id="rId12" imgW="3061514" imgH="3065991" progId="Prism10.Document">
                  <p:embed/>
                  <p:pic>
                    <p:nvPicPr>
                      <p:cNvPr id="9" name="Oggetto 8">
                        <a:extLst>
                          <a:ext uri="{FF2B5EF4-FFF2-40B4-BE49-F238E27FC236}">
                            <a16:creationId xmlns:a16="http://schemas.microsoft.com/office/drawing/2014/main" id="{4E555D9E-3ED1-A954-02D0-85B47C5C60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347326" y="17363439"/>
                        <a:ext cx="4927700" cy="49328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ggetto 9">
            <a:extLst>
              <a:ext uri="{FF2B5EF4-FFF2-40B4-BE49-F238E27FC236}">
                <a16:creationId xmlns:a16="http://schemas.microsoft.com/office/drawing/2014/main" id="{35018769-3148-ADE5-37E5-15D6D0E312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2460255"/>
              </p:ext>
            </p:extLst>
          </p:nvPr>
        </p:nvGraphicFramePr>
        <p:xfrm>
          <a:off x="9965762" y="17197392"/>
          <a:ext cx="4927700" cy="5098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3061514" imgH="3168275" progId="Prism10.Document">
                  <p:embed/>
                </p:oleObj>
              </mc:Choice>
              <mc:Fallback>
                <p:oleObj name="Prism 10" r:id="rId14" imgW="3061514" imgH="3168275" progId="Prism10.Document">
                  <p:embed/>
                  <p:pic>
                    <p:nvPicPr>
                      <p:cNvPr id="10" name="Oggetto 9">
                        <a:extLst>
                          <a:ext uri="{FF2B5EF4-FFF2-40B4-BE49-F238E27FC236}">
                            <a16:creationId xmlns:a16="http://schemas.microsoft.com/office/drawing/2014/main" id="{35018769-3148-ADE5-37E5-15D6D0E312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965762" y="17197392"/>
                        <a:ext cx="4927700" cy="50988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ggetto 10">
            <a:extLst>
              <a:ext uri="{FF2B5EF4-FFF2-40B4-BE49-F238E27FC236}">
                <a16:creationId xmlns:a16="http://schemas.microsoft.com/office/drawing/2014/main" id="{498E299F-17BA-FDA0-4A39-3CFC8B3EFA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9994427"/>
              </p:ext>
            </p:extLst>
          </p:nvPr>
        </p:nvGraphicFramePr>
        <p:xfrm>
          <a:off x="372251" y="6755383"/>
          <a:ext cx="4927700" cy="49098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3061514" imgH="3050865" progId="Prism10.Document">
                  <p:embed/>
                </p:oleObj>
              </mc:Choice>
              <mc:Fallback>
                <p:oleObj name="Prism 10" r:id="rId16" imgW="3061514" imgH="3050865" progId="Prism10.Document">
                  <p:embed/>
                  <p:pic>
                    <p:nvPicPr>
                      <p:cNvPr id="11" name="Oggetto 10">
                        <a:extLst>
                          <a:ext uri="{FF2B5EF4-FFF2-40B4-BE49-F238E27FC236}">
                            <a16:creationId xmlns:a16="http://schemas.microsoft.com/office/drawing/2014/main" id="{498E299F-17BA-FDA0-4A39-3CFC8B3EFA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72251" y="6755383"/>
                        <a:ext cx="4927700" cy="49098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ggetto 13">
            <a:extLst>
              <a:ext uri="{FF2B5EF4-FFF2-40B4-BE49-F238E27FC236}">
                <a16:creationId xmlns:a16="http://schemas.microsoft.com/office/drawing/2014/main" id="{DD305292-C524-5545-9C24-71EF21D3C8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8291051"/>
              </p:ext>
            </p:extLst>
          </p:nvPr>
        </p:nvGraphicFramePr>
        <p:xfrm>
          <a:off x="372251" y="11533351"/>
          <a:ext cx="5056372" cy="53735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3061514" imgH="3253632" progId="Prism10.Document">
                  <p:embed/>
                </p:oleObj>
              </mc:Choice>
              <mc:Fallback>
                <p:oleObj name="Prism 10" r:id="rId18" imgW="3061514" imgH="3253632" progId="Prism10.Document">
                  <p:embed/>
                  <p:pic>
                    <p:nvPicPr>
                      <p:cNvPr id="14" name="Oggetto 13">
                        <a:extLst>
                          <a:ext uri="{FF2B5EF4-FFF2-40B4-BE49-F238E27FC236}">
                            <a16:creationId xmlns:a16="http://schemas.microsoft.com/office/drawing/2014/main" id="{DD305292-C524-5545-9C24-71EF21D3C8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72251" y="11533351"/>
                        <a:ext cx="5056372" cy="5373543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ggetto 14">
            <a:extLst>
              <a:ext uri="{FF2B5EF4-FFF2-40B4-BE49-F238E27FC236}">
                <a16:creationId xmlns:a16="http://schemas.microsoft.com/office/drawing/2014/main" id="{830E2FB2-CEB2-14AB-F0CC-BB255E989E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4227102"/>
              </p:ext>
            </p:extLst>
          </p:nvPr>
        </p:nvGraphicFramePr>
        <p:xfrm>
          <a:off x="5347326" y="11777129"/>
          <a:ext cx="5056370" cy="51297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0" imgW="3061514" imgH="3107409" progId="Prism10.Document">
                  <p:embed/>
                </p:oleObj>
              </mc:Choice>
              <mc:Fallback>
                <p:oleObj name="Prism 10" r:id="rId20" imgW="3061514" imgH="3107409" progId="Prism10.Document">
                  <p:embed/>
                  <p:pic>
                    <p:nvPicPr>
                      <p:cNvPr id="15" name="Oggetto 14">
                        <a:extLst>
                          <a:ext uri="{FF2B5EF4-FFF2-40B4-BE49-F238E27FC236}">
                            <a16:creationId xmlns:a16="http://schemas.microsoft.com/office/drawing/2014/main" id="{830E2FB2-CEB2-14AB-F0CC-BB255E989E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347326" y="11777129"/>
                        <a:ext cx="5056370" cy="5129765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ggetto 15">
            <a:extLst>
              <a:ext uri="{FF2B5EF4-FFF2-40B4-BE49-F238E27FC236}">
                <a16:creationId xmlns:a16="http://schemas.microsoft.com/office/drawing/2014/main" id="{7D133F4A-9CD6-8CC8-7016-AE9864884D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0281430"/>
              </p:ext>
            </p:extLst>
          </p:nvPr>
        </p:nvGraphicFramePr>
        <p:xfrm>
          <a:off x="9965762" y="11868872"/>
          <a:ext cx="5221511" cy="50380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2" imgW="3161992" imgH="3050865" progId="Prism10.Document">
                  <p:embed/>
                </p:oleObj>
              </mc:Choice>
              <mc:Fallback>
                <p:oleObj name="Prism 10" r:id="rId22" imgW="3161992" imgH="3050865" progId="Prism10.Document">
                  <p:embed/>
                  <p:pic>
                    <p:nvPicPr>
                      <p:cNvPr id="16" name="Oggetto 15">
                        <a:extLst>
                          <a:ext uri="{FF2B5EF4-FFF2-40B4-BE49-F238E27FC236}">
                            <a16:creationId xmlns:a16="http://schemas.microsoft.com/office/drawing/2014/main" id="{7D133F4A-9CD6-8CC8-7016-AE9864884D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9965762" y="11868872"/>
                        <a:ext cx="5221511" cy="503802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ggetto 16">
            <a:extLst>
              <a:ext uri="{FF2B5EF4-FFF2-40B4-BE49-F238E27FC236}">
                <a16:creationId xmlns:a16="http://schemas.microsoft.com/office/drawing/2014/main" id="{A74E0F31-8289-4A9F-6760-CD0F163ACC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0590814"/>
              </p:ext>
            </p:extLst>
          </p:nvPr>
        </p:nvGraphicFramePr>
        <p:xfrm>
          <a:off x="15111626" y="17038041"/>
          <a:ext cx="5056372" cy="52582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4" imgW="3061514" imgH="3184842" progId="Prism10.Document">
                  <p:embed/>
                </p:oleObj>
              </mc:Choice>
              <mc:Fallback>
                <p:oleObj name="Prism 10" r:id="rId24" imgW="3061514" imgH="3184842" progId="Prism10.Document">
                  <p:embed/>
                  <p:pic>
                    <p:nvPicPr>
                      <p:cNvPr id="17" name="Oggetto 16">
                        <a:extLst>
                          <a:ext uri="{FF2B5EF4-FFF2-40B4-BE49-F238E27FC236}">
                            <a16:creationId xmlns:a16="http://schemas.microsoft.com/office/drawing/2014/main" id="{A74E0F31-8289-4A9F-6760-CD0F163ACC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5111626" y="17038041"/>
                        <a:ext cx="5056372" cy="5258207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A03200F7-95D6-2B5B-32DE-BBC23B80256E}"/>
              </a:ext>
            </a:extLst>
          </p:cNvPr>
          <p:cNvSpPr txBox="1"/>
          <p:nvPr/>
        </p:nvSpPr>
        <p:spPr>
          <a:xfrm>
            <a:off x="372251" y="23224060"/>
            <a:ext cx="19632146" cy="110799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2200" b="1">
                <a:latin typeface="Arial"/>
                <a:cs typeface="Arial"/>
              </a:rPr>
              <a:t>Supplementary Figure 5: 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Association of EV concentration, size and miRNA expressions with number of metastatic sites in advanced stage NSCLC patients. Dot plot comparisons of (</a:t>
            </a:r>
            <a:r>
              <a:rPr lang="en-US" sz="2200" b="1" i="0">
                <a:solidFill>
                  <a:srgbClr val="000000"/>
                </a:solidFill>
                <a:effectLst/>
                <a:latin typeface="Arial"/>
                <a:cs typeface="Arial"/>
              </a:rPr>
              <a:t>A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) EV concentration and size, and of (</a:t>
            </a:r>
            <a:r>
              <a:rPr lang="en-US" sz="2200" b="1" i="0">
                <a:solidFill>
                  <a:srgbClr val="000000"/>
                </a:solidFill>
                <a:effectLst/>
                <a:latin typeface="Arial"/>
                <a:cs typeface="Arial"/>
              </a:rPr>
              <a:t>B</a:t>
            </a:r>
            <a:r>
              <a:rPr lang="en-US" sz="2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) miRNA expressions (n. copies/µl) in patients with n=1/2 metastatic sites vs patients with n=3/4 metastatic sites. The horizontal bars indicate the median values with range and statistical analysis are indicated on graphs.</a:t>
            </a:r>
            <a:endParaRPr lang="en-US" sz="2200" b="1">
              <a:latin typeface="Arial"/>
              <a:cs typeface="Arial"/>
            </a:endParaRPr>
          </a:p>
        </p:txBody>
      </p:sp>
      <p:graphicFrame>
        <p:nvGraphicFramePr>
          <p:cNvPr id="12" name="Oggetto 11">
            <a:extLst>
              <a:ext uri="{FF2B5EF4-FFF2-40B4-BE49-F238E27FC236}">
                <a16:creationId xmlns:a16="http://schemas.microsoft.com/office/drawing/2014/main" id="{DDD5355E-D20A-0BEF-0C72-540CF32CA6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3870728"/>
              </p:ext>
            </p:extLst>
          </p:nvPr>
        </p:nvGraphicFramePr>
        <p:xfrm>
          <a:off x="0" y="1404732"/>
          <a:ext cx="21490259" cy="46985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6" imgW="10237578" imgH="2238357" progId="Prism10.Document">
                  <p:embed/>
                </p:oleObj>
              </mc:Choice>
              <mc:Fallback>
                <p:oleObj name="Prism 10" r:id="rId26" imgW="10237578" imgH="2238357" progId="Prism10.Document">
                  <p:embed/>
                  <p:pic>
                    <p:nvPicPr>
                      <p:cNvPr id="12" name="Oggetto 11">
                        <a:extLst>
                          <a:ext uri="{FF2B5EF4-FFF2-40B4-BE49-F238E27FC236}">
                            <a16:creationId xmlns:a16="http://schemas.microsoft.com/office/drawing/2014/main" id="{DDD5355E-D20A-0BEF-0C72-540CF32CA6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0" y="1404732"/>
                        <a:ext cx="21490259" cy="46985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99DF8BE5-A182-6215-FED9-20BA700592B5}"/>
              </a:ext>
            </a:extLst>
          </p:cNvPr>
          <p:cNvSpPr txBox="1"/>
          <p:nvPr/>
        </p:nvSpPr>
        <p:spPr>
          <a:xfrm>
            <a:off x="85662" y="6205792"/>
            <a:ext cx="8112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EFD1BF0-4DCE-A352-81FC-5472A797366D}"/>
              </a:ext>
            </a:extLst>
          </p:cNvPr>
          <p:cNvSpPr txBox="1"/>
          <p:nvPr/>
        </p:nvSpPr>
        <p:spPr>
          <a:xfrm>
            <a:off x="32160" y="857184"/>
            <a:ext cx="1168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>
                <a:latin typeface="Arial" pitchFamily="34" charset="0"/>
                <a:cs typeface="Arial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8073402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AB0443C3-56A3-DD00-D4B0-97E0072C3A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6844664"/>
              </p:ext>
            </p:extLst>
          </p:nvPr>
        </p:nvGraphicFramePr>
        <p:xfrm>
          <a:off x="6573685" y="1822949"/>
          <a:ext cx="6149876" cy="54229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61514" imgH="2700075" progId="Prism10.Document">
                  <p:embed/>
                </p:oleObj>
              </mc:Choice>
              <mc:Fallback>
                <p:oleObj name="Prism 10" r:id="rId2" imgW="3061514" imgH="2700075" progId="Prism10.Document">
                  <p:embed/>
                  <p:pic>
                    <p:nvPicPr>
                      <p:cNvPr id="4" name="Oggetto 3">
                        <a:extLst>
                          <a:ext uri="{FF2B5EF4-FFF2-40B4-BE49-F238E27FC236}">
                            <a16:creationId xmlns:a16="http://schemas.microsoft.com/office/drawing/2014/main" id="{AB0443C3-56A3-DD00-D4B0-97E0072C3A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573685" y="1822949"/>
                        <a:ext cx="6149876" cy="54229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ggetto 11">
            <a:extLst>
              <a:ext uri="{FF2B5EF4-FFF2-40B4-BE49-F238E27FC236}">
                <a16:creationId xmlns:a16="http://schemas.microsoft.com/office/drawing/2014/main" id="{371068CF-E7B2-F08B-FB24-ADC21C0847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4360600"/>
              </p:ext>
            </p:extLst>
          </p:nvPr>
        </p:nvGraphicFramePr>
        <p:xfrm>
          <a:off x="12891547" y="7804939"/>
          <a:ext cx="6407891" cy="56505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61514" imgH="2700075" progId="Prism10.Document">
                  <p:embed/>
                </p:oleObj>
              </mc:Choice>
              <mc:Fallback>
                <p:oleObj name="Prism 10" r:id="rId4" imgW="3061514" imgH="2700075" progId="Prism10.Document">
                  <p:embed/>
                  <p:pic>
                    <p:nvPicPr>
                      <p:cNvPr id="12" name="Oggetto 11">
                        <a:extLst>
                          <a:ext uri="{FF2B5EF4-FFF2-40B4-BE49-F238E27FC236}">
                            <a16:creationId xmlns:a16="http://schemas.microsoft.com/office/drawing/2014/main" id="{371068CF-E7B2-F08B-FB24-ADC21C0847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891547" y="7804939"/>
                        <a:ext cx="6407891" cy="56505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ggetto 12">
            <a:extLst>
              <a:ext uri="{FF2B5EF4-FFF2-40B4-BE49-F238E27FC236}">
                <a16:creationId xmlns:a16="http://schemas.microsoft.com/office/drawing/2014/main" id="{1FD2C73D-2A6D-2451-1E41-F0940CA4BD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4480673"/>
              </p:ext>
            </p:extLst>
          </p:nvPr>
        </p:nvGraphicFramePr>
        <p:xfrm>
          <a:off x="135168" y="13455444"/>
          <a:ext cx="6653711" cy="5966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180358" imgH="2850979" progId="Prism10.Document">
                  <p:embed/>
                </p:oleObj>
              </mc:Choice>
              <mc:Fallback>
                <p:oleObj name="Prism 10" r:id="rId6" imgW="3180358" imgH="2850979" progId="Prism10.Document">
                  <p:embed/>
                  <p:pic>
                    <p:nvPicPr>
                      <p:cNvPr id="13" name="Oggetto 12">
                        <a:extLst>
                          <a:ext uri="{FF2B5EF4-FFF2-40B4-BE49-F238E27FC236}">
                            <a16:creationId xmlns:a16="http://schemas.microsoft.com/office/drawing/2014/main" id="{1FD2C73D-2A6D-2451-1E41-F0940CA4BD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35168" y="13455444"/>
                        <a:ext cx="6653711" cy="5966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ggetto 28">
            <a:extLst>
              <a:ext uri="{FF2B5EF4-FFF2-40B4-BE49-F238E27FC236}">
                <a16:creationId xmlns:a16="http://schemas.microsoft.com/office/drawing/2014/main" id="{F36F7873-114D-A802-9053-D73C84E012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6779979"/>
              </p:ext>
            </p:extLst>
          </p:nvPr>
        </p:nvGraphicFramePr>
        <p:xfrm>
          <a:off x="444144" y="7787829"/>
          <a:ext cx="6035761" cy="56676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097887" imgH="2908964" progId="Prism10.Document">
                  <p:embed/>
                </p:oleObj>
              </mc:Choice>
              <mc:Fallback>
                <p:oleObj name="Prism 10" r:id="rId8" imgW="3097887" imgH="2908964" progId="Prism10.Document">
                  <p:embed/>
                  <p:pic>
                    <p:nvPicPr>
                      <p:cNvPr id="29" name="Oggetto 28">
                        <a:extLst>
                          <a:ext uri="{FF2B5EF4-FFF2-40B4-BE49-F238E27FC236}">
                            <a16:creationId xmlns:a16="http://schemas.microsoft.com/office/drawing/2014/main" id="{F36F7873-114D-A802-9053-D73C84E012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44144" y="7787829"/>
                        <a:ext cx="6035761" cy="56676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ggetto 25">
            <a:extLst>
              <a:ext uri="{FF2B5EF4-FFF2-40B4-BE49-F238E27FC236}">
                <a16:creationId xmlns:a16="http://schemas.microsoft.com/office/drawing/2014/main" id="{D7627F5F-52E0-1259-3EC3-9B2C5293D3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7618351"/>
              </p:ext>
            </p:extLst>
          </p:nvPr>
        </p:nvGraphicFramePr>
        <p:xfrm>
          <a:off x="444144" y="1822949"/>
          <a:ext cx="5967698" cy="52623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061514" imgH="2700075" progId="Prism10.Document">
                  <p:embed/>
                </p:oleObj>
              </mc:Choice>
              <mc:Fallback>
                <p:oleObj name="Prism 10" r:id="rId10" imgW="3061514" imgH="2700075" progId="Prism10.Document">
                  <p:embed/>
                  <p:pic>
                    <p:nvPicPr>
                      <p:cNvPr id="26" name="Oggetto 25">
                        <a:extLst>
                          <a:ext uri="{FF2B5EF4-FFF2-40B4-BE49-F238E27FC236}">
                            <a16:creationId xmlns:a16="http://schemas.microsoft.com/office/drawing/2014/main" id="{D7627F5F-52E0-1259-3EC3-9B2C5293D3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44144" y="1822949"/>
                        <a:ext cx="5967698" cy="52623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ggetto 27">
            <a:extLst>
              <a:ext uri="{FF2B5EF4-FFF2-40B4-BE49-F238E27FC236}">
                <a16:creationId xmlns:a16="http://schemas.microsoft.com/office/drawing/2014/main" id="{7B856D7E-0A05-08A6-9FA2-8489D5E7E9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1949964"/>
              </p:ext>
            </p:extLst>
          </p:nvPr>
        </p:nvGraphicFramePr>
        <p:xfrm>
          <a:off x="12824458" y="1969982"/>
          <a:ext cx="6178067" cy="52623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170995" imgH="2700075" progId="Prism10.Document">
                  <p:embed/>
                </p:oleObj>
              </mc:Choice>
              <mc:Fallback>
                <p:oleObj name="Prism 10" r:id="rId12" imgW="3170995" imgH="2700075" progId="Prism10.Document">
                  <p:embed/>
                  <p:pic>
                    <p:nvPicPr>
                      <p:cNvPr id="28" name="Oggetto 27">
                        <a:extLst>
                          <a:ext uri="{FF2B5EF4-FFF2-40B4-BE49-F238E27FC236}">
                            <a16:creationId xmlns:a16="http://schemas.microsoft.com/office/drawing/2014/main" id="{7B856D7E-0A05-08A6-9FA2-8489D5E7E9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2824458" y="1969982"/>
                        <a:ext cx="6178067" cy="52623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ggetto 30">
            <a:extLst>
              <a:ext uri="{FF2B5EF4-FFF2-40B4-BE49-F238E27FC236}">
                <a16:creationId xmlns:a16="http://schemas.microsoft.com/office/drawing/2014/main" id="{0F36D14D-BB0B-C297-A939-B046E0F358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9294354"/>
              </p:ext>
            </p:extLst>
          </p:nvPr>
        </p:nvGraphicFramePr>
        <p:xfrm>
          <a:off x="6335113" y="8193105"/>
          <a:ext cx="6162601" cy="52623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3161992" imgH="2700075" progId="Prism10.Document">
                  <p:embed/>
                </p:oleObj>
              </mc:Choice>
              <mc:Fallback>
                <p:oleObj name="Prism 10" r:id="rId14" imgW="3161992" imgH="2700075" progId="Prism10.Document">
                  <p:embed/>
                  <p:pic>
                    <p:nvPicPr>
                      <p:cNvPr id="31" name="Oggetto 30">
                        <a:extLst>
                          <a:ext uri="{FF2B5EF4-FFF2-40B4-BE49-F238E27FC236}">
                            <a16:creationId xmlns:a16="http://schemas.microsoft.com/office/drawing/2014/main" id="{0F36D14D-BB0B-C297-A939-B046E0F358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6335113" y="8193105"/>
                        <a:ext cx="6162601" cy="52623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9D624420-34C3-E417-184E-F512597865AB}"/>
              </a:ext>
            </a:extLst>
          </p:cNvPr>
          <p:cNvSpPr txBox="1"/>
          <p:nvPr/>
        </p:nvSpPr>
        <p:spPr>
          <a:xfrm>
            <a:off x="721895" y="20030234"/>
            <a:ext cx="19779915" cy="10156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2000" b="1">
                <a:latin typeface="Arial"/>
                <a:cs typeface="Arial"/>
              </a:rPr>
              <a:t>Supplementary Figure 6: </a:t>
            </a:r>
            <a:r>
              <a:rPr lang="en-US" sz="20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Association of miRNA expression with immunotherapy response in adenocarcinoma NSCLC patients. Dot plot comparison of miRNA expressions (n. copies/µl) in responder (R) patients vs non-responder (NR) ones. The horizontal bars indicate the median values with range and s</a:t>
            </a:r>
            <a:r>
              <a:rPr lang="en-US" sz="2000">
                <a:solidFill>
                  <a:srgbClr val="000000"/>
                </a:solidFill>
                <a:latin typeface="Arial"/>
                <a:cs typeface="Arial"/>
              </a:rPr>
              <a:t>tatistical analysis are indicated on graphs.</a:t>
            </a:r>
            <a:endParaRPr lang="en-US" sz="2000" b="1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02769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E16383EE-7F2B-EAAA-060F-F37554F20F4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3738" r="34271" b="73850"/>
          <a:stretch/>
        </p:blipFill>
        <p:spPr>
          <a:xfrm>
            <a:off x="1405814" y="1619775"/>
            <a:ext cx="5972682" cy="3503840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839C1FF8-9A58-4C32-C569-11E339B66E2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4210" r="69157" b="1379"/>
          <a:stretch/>
        </p:blipFill>
        <p:spPr>
          <a:xfrm>
            <a:off x="13750791" y="5220101"/>
            <a:ext cx="5758352" cy="3270756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8560BD30-B42A-E452-8E58-7098638ABC4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5423" r="68642" b="50166"/>
          <a:stretch/>
        </p:blipFill>
        <p:spPr>
          <a:xfrm>
            <a:off x="7607935" y="1831272"/>
            <a:ext cx="5854525" cy="3270755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B3EC20D2-BAE3-ECD4-9C8C-289B73385C8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9551" r="68009" b="26038"/>
          <a:stretch/>
        </p:blipFill>
        <p:spPr>
          <a:xfrm>
            <a:off x="13556309" y="1790560"/>
            <a:ext cx="5972683" cy="3270756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1A38BD96-7AAB-2151-0200-DFDF8C232F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087" t="49551" b="26038"/>
          <a:stretch/>
        </p:blipFill>
        <p:spPr>
          <a:xfrm>
            <a:off x="1394478" y="5135881"/>
            <a:ext cx="12305622" cy="3270756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FDDB23E3-7221-C7F2-7EE5-DD399E0F1BBB}"/>
              </a:ext>
            </a:extLst>
          </p:cNvPr>
          <p:cNvSpPr txBox="1"/>
          <p:nvPr/>
        </p:nvSpPr>
        <p:spPr>
          <a:xfrm>
            <a:off x="246100" y="841609"/>
            <a:ext cx="2093691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600" b="1">
                <a:latin typeface="Arial" panose="020B0604020202020204" pitchFamily="34" charset="0"/>
                <a:cs typeface="Arial" panose="020B0604020202020204" pitchFamily="34" charset="0"/>
              </a:rPr>
              <a:t>PFS in adenocarcinoma NSCLC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E4828BED-2413-A931-44FA-DB4B6F258D22}"/>
              </a:ext>
            </a:extLst>
          </p:cNvPr>
          <p:cNvSpPr txBox="1"/>
          <p:nvPr/>
        </p:nvSpPr>
        <p:spPr>
          <a:xfrm>
            <a:off x="511397" y="9914282"/>
            <a:ext cx="2093691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600" b="1">
                <a:latin typeface="Arial" panose="020B0604020202020204" pitchFamily="34" charset="0"/>
                <a:cs typeface="Arial" panose="020B0604020202020204" pitchFamily="34" charset="0"/>
              </a:rPr>
              <a:t>OS in adenocarcinoma NSCLC</a:t>
            </a:r>
          </a:p>
        </p:txBody>
      </p:sp>
      <p:graphicFrame>
        <p:nvGraphicFramePr>
          <p:cNvPr id="23" name="Oggetto 22">
            <a:extLst>
              <a:ext uri="{FF2B5EF4-FFF2-40B4-BE49-F238E27FC236}">
                <a16:creationId xmlns:a16="http://schemas.microsoft.com/office/drawing/2014/main" id="{71CFEBA4-B308-FBD4-7126-9FB11F8D00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338418"/>
              </p:ext>
            </p:extLst>
          </p:nvPr>
        </p:nvGraphicFramePr>
        <p:xfrm>
          <a:off x="159710" y="10859969"/>
          <a:ext cx="5922069" cy="3444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5115008" imgH="2974512" progId="Prism10.Document">
                  <p:embed/>
                </p:oleObj>
              </mc:Choice>
              <mc:Fallback>
                <p:oleObj name="Prism 10" r:id="rId3" imgW="5115008" imgH="2974512" progId="Prism10.Document">
                  <p:embed/>
                  <p:pic>
                    <p:nvPicPr>
                      <p:cNvPr id="23" name="Oggetto 22">
                        <a:extLst>
                          <a:ext uri="{FF2B5EF4-FFF2-40B4-BE49-F238E27FC236}">
                            <a16:creationId xmlns:a16="http://schemas.microsoft.com/office/drawing/2014/main" id="{71CFEBA4-B308-FBD4-7126-9FB11F8D00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9710" y="10859969"/>
                        <a:ext cx="5922069" cy="34444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ggetto 23">
            <a:extLst>
              <a:ext uri="{FF2B5EF4-FFF2-40B4-BE49-F238E27FC236}">
                <a16:creationId xmlns:a16="http://schemas.microsoft.com/office/drawing/2014/main" id="{484D4AF2-294D-2495-101F-A3EB222FF3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2236189"/>
              </p:ext>
            </p:extLst>
          </p:nvPr>
        </p:nvGraphicFramePr>
        <p:xfrm>
          <a:off x="5141930" y="10831041"/>
          <a:ext cx="5922069" cy="3444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5115008" imgH="2974512" progId="Prism10.Document">
                  <p:embed/>
                </p:oleObj>
              </mc:Choice>
              <mc:Fallback>
                <p:oleObj name="Prism 10" r:id="rId5" imgW="5115008" imgH="2974512" progId="Prism10.Document">
                  <p:embed/>
                  <p:pic>
                    <p:nvPicPr>
                      <p:cNvPr id="24" name="Oggetto 23">
                        <a:extLst>
                          <a:ext uri="{FF2B5EF4-FFF2-40B4-BE49-F238E27FC236}">
                            <a16:creationId xmlns:a16="http://schemas.microsoft.com/office/drawing/2014/main" id="{484D4AF2-294D-2495-101F-A3EB222FF32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141930" y="10831041"/>
                        <a:ext cx="5922069" cy="34444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ggetto 15">
            <a:extLst>
              <a:ext uri="{FF2B5EF4-FFF2-40B4-BE49-F238E27FC236}">
                <a16:creationId xmlns:a16="http://schemas.microsoft.com/office/drawing/2014/main" id="{65BFF04D-5662-6D2E-45E3-4816C930D0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3428070"/>
              </p:ext>
            </p:extLst>
          </p:nvPr>
        </p:nvGraphicFramePr>
        <p:xfrm>
          <a:off x="10127292" y="10800543"/>
          <a:ext cx="5922074" cy="34664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5115008" imgH="2994321" progId="Prism10.Document">
                  <p:embed/>
                </p:oleObj>
              </mc:Choice>
              <mc:Fallback>
                <p:oleObj name="Prism 10" r:id="rId7" imgW="5115008" imgH="2994321" progId="Prism10.Document">
                  <p:embed/>
                  <p:pic>
                    <p:nvPicPr>
                      <p:cNvPr id="16" name="Oggetto 15">
                        <a:extLst>
                          <a:ext uri="{FF2B5EF4-FFF2-40B4-BE49-F238E27FC236}">
                            <a16:creationId xmlns:a16="http://schemas.microsoft.com/office/drawing/2014/main" id="{65BFF04D-5662-6D2E-45E3-4816C930D0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127292" y="10800543"/>
                        <a:ext cx="5922074" cy="3466490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ggetto 25">
            <a:extLst>
              <a:ext uri="{FF2B5EF4-FFF2-40B4-BE49-F238E27FC236}">
                <a16:creationId xmlns:a16="http://schemas.microsoft.com/office/drawing/2014/main" id="{25A1B6DC-820F-9E2D-9758-0742FA86E9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929335"/>
              </p:ext>
            </p:extLst>
          </p:nvPr>
        </p:nvGraphicFramePr>
        <p:xfrm>
          <a:off x="15099944" y="10759831"/>
          <a:ext cx="5922069" cy="3444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5115008" imgH="2974512" progId="Prism10.Document">
                  <p:embed/>
                </p:oleObj>
              </mc:Choice>
              <mc:Fallback>
                <p:oleObj name="Prism 10" r:id="rId9" imgW="5115008" imgH="2974512" progId="Prism10.Document">
                  <p:embed/>
                  <p:pic>
                    <p:nvPicPr>
                      <p:cNvPr id="26" name="Oggetto 25">
                        <a:extLst>
                          <a:ext uri="{FF2B5EF4-FFF2-40B4-BE49-F238E27FC236}">
                            <a16:creationId xmlns:a16="http://schemas.microsoft.com/office/drawing/2014/main" id="{25A1B6DC-820F-9E2D-9758-0742FA86E9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099944" y="10759831"/>
                        <a:ext cx="5922069" cy="34444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ggetto 26">
            <a:extLst>
              <a:ext uri="{FF2B5EF4-FFF2-40B4-BE49-F238E27FC236}">
                <a16:creationId xmlns:a16="http://schemas.microsoft.com/office/drawing/2014/main" id="{398408B7-7E79-AB12-507A-DE428709A3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2247015"/>
              </p:ext>
            </p:extLst>
          </p:nvPr>
        </p:nvGraphicFramePr>
        <p:xfrm>
          <a:off x="153352" y="14573223"/>
          <a:ext cx="5922069" cy="3444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5115008" imgH="2974512" progId="Prism10.Document">
                  <p:embed/>
                </p:oleObj>
              </mc:Choice>
              <mc:Fallback>
                <p:oleObj name="Prism 10" r:id="rId11" imgW="5115008" imgH="2974512" progId="Prism10.Document">
                  <p:embed/>
                  <p:pic>
                    <p:nvPicPr>
                      <p:cNvPr id="27" name="Oggetto 26">
                        <a:extLst>
                          <a:ext uri="{FF2B5EF4-FFF2-40B4-BE49-F238E27FC236}">
                            <a16:creationId xmlns:a16="http://schemas.microsoft.com/office/drawing/2014/main" id="{398408B7-7E79-AB12-507A-DE428709A3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53352" y="14573223"/>
                        <a:ext cx="5922069" cy="34444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5" name="Gruppo 34">
            <a:extLst>
              <a:ext uri="{FF2B5EF4-FFF2-40B4-BE49-F238E27FC236}">
                <a16:creationId xmlns:a16="http://schemas.microsoft.com/office/drawing/2014/main" id="{970DC4A2-9CB1-CA3D-2F83-C0B4C1868A82}"/>
              </a:ext>
            </a:extLst>
          </p:cNvPr>
          <p:cNvGrpSpPr/>
          <p:nvPr/>
        </p:nvGrpSpPr>
        <p:grpSpPr>
          <a:xfrm>
            <a:off x="246100" y="18118713"/>
            <a:ext cx="5714830" cy="3216094"/>
            <a:chOff x="246100" y="20502687"/>
            <a:chExt cx="5714830" cy="3216094"/>
          </a:xfrm>
        </p:grpSpPr>
        <p:graphicFrame>
          <p:nvGraphicFramePr>
            <p:cNvPr id="32" name="Oggetto 31">
              <a:extLst>
                <a:ext uri="{FF2B5EF4-FFF2-40B4-BE49-F238E27FC236}">
                  <a16:creationId xmlns:a16="http://schemas.microsoft.com/office/drawing/2014/main" id="{FB2B996D-482A-5CFD-2436-BFBF4175E19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48196980"/>
                </p:ext>
              </p:extLst>
            </p:nvPr>
          </p:nvGraphicFramePr>
          <p:xfrm>
            <a:off x="246100" y="20502687"/>
            <a:ext cx="5714830" cy="321609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3" imgW="5287152" imgH="2974512" progId="Prism10.Document">
                    <p:embed/>
                  </p:oleObj>
                </mc:Choice>
                <mc:Fallback>
                  <p:oleObj name="Prism 10" r:id="rId13" imgW="5287152" imgH="2974512" progId="Prism10.Document">
                    <p:embed/>
                    <p:pic>
                      <p:nvPicPr>
                        <p:cNvPr id="32" name="Oggetto 31">
                          <a:extLst>
                            <a:ext uri="{FF2B5EF4-FFF2-40B4-BE49-F238E27FC236}">
                              <a16:creationId xmlns:a16="http://schemas.microsoft.com/office/drawing/2014/main" id="{FB2B996D-482A-5CFD-2436-BFBF4175E19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46100" y="20502687"/>
                          <a:ext cx="5714830" cy="3216094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8" name="Rettangolo 27">
              <a:extLst>
                <a:ext uri="{FF2B5EF4-FFF2-40B4-BE49-F238E27FC236}">
                  <a16:creationId xmlns:a16="http://schemas.microsoft.com/office/drawing/2014/main" id="{CB5E0252-A86E-FBC7-4D7C-D94B1419DEFB}"/>
                </a:ext>
              </a:extLst>
            </p:cNvPr>
            <p:cNvSpPr/>
            <p:nvPr/>
          </p:nvSpPr>
          <p:spPr>
            <a:xfrm>
              <a:off x="4808307" y="21007137"/>
              <a:ext cx="918725" cy="8862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37" name="Gruppo 36">
            <a:extLst>
              <a:ext uri="{FF2B5EF4-FFF2-40B4-BE49-F238E27FC236}">
                <a16:creationId xmlns:a16="http://schemas.microsoft.com/office/drawing/2014/main" id="{ED461D77-E4FF-E994-9645-D0CFB555FDA2}"/>
              </a:ext>
            </a:extLst>
          </p:cNvPr>
          <p:cNvGrpSpPr/>
          <p:nvPr/>
        </p:nvGrpSpPr>
        <p:grpSpPr>
          <a:xfrm>
            <a:off x="5141930" y="18142773"/>
            <a:ext cx="5529484" cy="3216093"/>
            <a:chOff x="5141930" y="20526747"/>
            <a:chExt cx="5529484" cy="3216093"/>
          </a:xfrm>
        </p:grpSpPr>
        <p:graphicFrame>
          <p:nvGraphicFramePr>
            <p:cNvPr id="33" name="Oggetto 32">
              <a:extLst>
                <a:ext uri="{FF2B5EF4-FFF2-40B4-BE49-F238E27FC236}">
                  <a16:creationId xmlns:a16="http://schemas.microsoft.com/office/drawing/2014/main" id="{937EF13E-1687-EF44-EED6-F05CA12FAD0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04959698"/>
                </p:ext>
              </p:extLst>
            </p:nvPr>
          </p:nvGraphicFramePr>
          <p:xfrm>
            <a:off x="5141930" y="20526747"/>
            <a:ext cx="5529484" cy="32160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5" imgW="5115008" imgH="2974512" progId="Prism10.Document">
                    <p:embed/>
                  </p:oleObj>
                </mc:Choice>
                <mc:Fallback>
                  <p:oleObj name="Prism 10" r:id="rId15" imgW="5115008" imgH="2974512" progId="Prism10.Document">
                    <p:embed/>
                    <p:pic>
                      <p:nvPicPr>
                        <p:cNvPr id="33" name="Oggetto 32">
                          <a:extLst>
                            <a:ext uri="{FF2B5EF4-FFF2-40B4-BE49-F238E27FC236}">
                              <a16:creationId xmlns:a16="http://schemas.microsoft.com/office/drawing/2014/main" id="{937EF13E-1687-EF44-EED6-F05CA12FAD0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5141930" y="20526747"/>
                          <a:ext cx="5529484" cy="3216093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" name="Rettangolo 35">
              <a:extLst>
                <a:ext uri="{FF2B5EF4-FFF2-40B4-BE49-F238E27FC236}">
                  <a16:creationId xmlns:a16="http://schemas.microsoft.com/office/drawing/2014/main" id="{356F7818-40FB-001F-0A8C-5FB4A202AFE8}"/>
                </a:ext>
              </a:extLst>
            </p:cNvPr>
            <p:cNvSpPr/>
            <p:nvPr/>
          </p:nvSpPr>
          <p:spPr>
            <a:xfrm>
              <a:off x="9794483" y="21007137"/>
              <a:ext cx="876931" cy="8862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aphicFrame>
        <p:nvGraphicFramePr>
          <p:cNvPr id="34" name="Oggetto 33">
            <a:extLst>
              <a:ext uri="{FF2B5EF4-FFF2-40B4-BE49-F238E27FC236}">
                <a16:creationId xmlns:a16="http://schemas.microsoft.com/office/drawing/2014/main" id="{2879F0C6-DB5A-D498-1394-B13F54F485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8016978"/>
              </p:ext>
            </p:extLst>
          </p:nvPr>
        </p:nvGraphicFramePr>
        <p:xfrm>
          <a:off x="10126572" y="18117417"/>
          <a:ext cx="5529484" cy="32160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5115008" imgH="2974512" progId="Prism10.Document">
                  <p:embed/>
                </p:oleObj>
              </mc:Choice>
              <mc:Fallback>
                <p:oleObj name="Prism 10" r:id="rId17" imgW="5115008" imgH="2974512" progId="Prism10.Document">
                  <p:embed/>
                  <p:pic>
                    <p:nvPicPr>
                      <p:cNvPr id="34" name="Oggetto 33">
                        <a:extLst>
                          <a:ext uri="{FF2B5EF4-FFF2-40B4-BE49-F238E27FC236}">
                            <a16:creationId xmlns:a16="http://schemas.microsoft.com/office/drawing/2014/main" id="{2879F0C6-DB5A-D498-1394-B13F54F485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0126572" y="18117417"/>
                        <a:ext cx="5529484" cy="3216093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9" name="Gruppo 38">
            <a:extLst>
              <a:ext uri="{FF2B5EF4-FFF2-40B4-BE49-F238E27FC236}">
                <a16:creationId xmlns:a16="http://schemas.microsoft.com/office/drawing/2014/main" id="{BF33CB5B-1AB5-C0DE-501D-ED54DD0B4978}"/>
              </a:ext>
            </a:extLst>
          </p:cNvPr>
          <p:cNvGrpSpPr/>
          <p:nvPr/>
        </p:nvGrpSpPr>
        <p:grpSpPr>
          <a:xfrm>
            <a:off x="5101722" y="14750038"/>
            <a:ext cx="5529484" cy="3216093"/>
            <a:chOff x="5101722" y="17134012"/>
            <a:chExt cx="5529484" cy="3216093"/>
          </a:xfrm>
        </p:grpSpPr>
        <p:graphicFrame>
          <p:nvGraphicFramePr>
            <p:cNvPr id="29" name="Oggetto 28">
              <a:extLst>
                <a:ext uri="{FF2B5EF4-FFF2-40B4-BE49-F238E27FC236}">
                  <a16:creationId xmlns:a16="http://schemas.microsoft.com/office/drawing/2014/main" id="{708D6EEE-05EF-3400-6D94-66C9FF5582E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31497550"/>
                </p:ext>
              </p:extLst>
            </p:nvPr>
          </p:nvGraphicFramePr>
          <p:xfrm>
            <a:off x="5101722" y="17134012"/>
            <a:ext cx="5529484" cy="32160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9" imgW="5115008" imgH="2974512" progId="Prism10.Document">
                    <p:embed/>
                  </p:oleObj>
                </mc:Choice>
                <mc:Fallback>
                  <p:oleObj name="Prism 10" r:id="rId19" imgW="5115008" imgH="2974512" progId="Prism10.Document">
                    <p:embed/>
                    <p:pic>
                      <p:nvPicPr>
                        <p:cNvPr id="29" name="Oggetto 28">
                          <a:extLst>
                            <a:ext uri="{FF2B5EF4-FFF2-40B4-BE49-F238E27FC236}">
                              <a16:creationId xmlns:a16="http://schemas.microsoft.com/office/drawing/2014/main" id="{708D6EEE-05EF-3400-6D94-66C9FF5582E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5101722" y="17134012"/>
                          <a:ext cx="5529484" cy="3216093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8" name="Rettangolo 37">
              <a:extLst>
                <a:ext uri="{FF2B5EF4-FFF2-40B4-BE49-F238E27FC236}">
                  <a16:creationId xmlns:a16="http://schemas.microsoft.com/office/drawing/2014/main" id="{5206509B-3D8F-1BF1-55EB-A8822E6E15A6}"/>
                </a:ext>
              </a:extLst>
            </p:cNvPr>
            <p:cNvSpPr/>
            <p:nvPr/>
          </p:nvSpPr>
          <p:spPr>
            <a:xfrm>
              <a:off x="9546751" y="17653393"/>
              <a:ext cx="876931" cy="8862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41" name="Gruppo 40">
            <a:extLst>
              <a:ext uri="{FF2B5EF4-FFF2-40B4-BE49-F238E27FC236}">
                <a16:creationId xmlns:a16="http://schemas.microsoft.com/office/drawing/2014/main" id="{72219C42-5CA5-20D8-EDF6-85E3DAB728BB}"/>
              </a:ext>
            </a:extLst>
          </p:cNvPr>
          <p:cNvGrpSpPr/>
          <p:nvPr/>
        </p:nvGrpSpPr>
        <p:grpSpPr>
          <a:xfrm>
            <a:off x="10097792" y="14696463"/>
            <a:ext cx="5529484" cy="3216093"/>
            <a:chOff x="10097792" y="17080437"/>
            <a:chExt cx="5529484" cy="3216093"/>
          </a:xfrm>
        </p:grpSpPr>
        <p:graphicFrame>
          <p:nvGraphicFramePr>
            <p:cNvPr id="30" name="Oggetto 29">
              <a:extLst>
                <a:ext uri="{FF2B5EF4-FFF2-40B4-BE49-F238E27FC236}">
                  <a16:creationId xmlns:a16="http://schemas.microsoft.com/office/drawing/2014/main" id="{DB8DECCF-6B0B-AEA0-0EFD-3F2A8CE7F97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76510397"/>
                </p:ext>
              </p:extLst>
            </p:nvPr>
          </p:nvGraphicFramePr>
          <p:xfrm>
            <a:off x="10097792" y="17080437"/>
            <a:ext cx="5529484" cy="32160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1" imgW="5115008" imgH="2974512" progId="Prism10.Document">
                    <p:embed/>
                  </p:oleObj>
                </mc:Choice>
                <mc:Fallback>
                  <p:oleObj name="Prism 10" r:id="rId21" imgW="5115008" imgH="2974512" progId="Prism10.Document">
                    <p:embed/>
                    <p:pic>
                      <p:nvPicPr>
                        <p:cNvPr id="30" name="Oggetto 29">
                          <a:extLst>
                            <a:ext uri="{FF2B5EF4-FFF2-40B4-BE49-F238E27FC236}">
                              <a16:creationId xmlns:a16="http://schemas.microsoft.com/office/drawing/2014/main" id="{DB8DECCF-6B0B-AEA0-0EFD-3F2A8CE7F97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10097792" y="17080437"/>
                          <a:ext cx="5529484" cy="3216093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0" name="Rettangolo 39">
              <a:extLst>
                <a:ext uri="{FF2B5EF4-FFF2-40B4-BE49-F238E27FC236}">
                  <a16:creationId xmlns:a16="http://schemas.microsoft.com/office/drawing/2014/main" id="{83263F09-DB0E-B246-6C80-5C3367D111B6}"/>
                </a:ext>
              </a:extLst>
            </p:cNvPr>
            <p:cNvSpPr/>
            <p:nvPr/>
          </p:nvSpPr>
          <p:spPr>
            <a:xfrm>
              <a:off x="14712956" y="17653393"/>
              <a:ext cx="876931" cy="8862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aphicFrame>
        <p:nvGraphicFramePr>
          <p:cNvPr id="31" name="Oggetto 30">
            <a:extLst>
              <a:ext uri="{FF2B5EF4-FFF2-40B4-BE49-F238E27FC236}">
                <a16:creationId xmlns:a16="http://schemas.microsoft.com/office/drawing/2014/main" id="{E51715AE-C2A9-7D8F-DABC-3DA9B4CFC8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1371603"/>
              </p:ext>
            </p:extLst>
          </p:nvPr>
        </p:nvGraphicFramePr>
        <p:xfrm>
          <a:off x="15151422" y="14673111"/>
          <a:ext cx="5529484" cy="32160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5115008" imgH="2974512" progId="Prism10.Document">
                  <p:embed/>
                </p:oleObj>
              </mc:Choice>
              <mc:Fallback>
                <p:oleObj name="Prism 10" r:id="rId23" imgW="5115008" imgH="2974512" progId="Prism10.Document">
                  <p:embed/>
                  <p:pic>
                    <p:nvPicPr>
                      <p:cNvPr id="31" name="Oggetto 30">
                        <a:extLst>
                          <a:ext uri="{FF2B5EF4-FFF2-40B4-BE49-F238E27FC236}">
                            <a16:creationId xmlns:a16="http://schemas.microsoft.com/office/drawing/2014/main" id="{E51715AE-C2A9-7D8F-DABC-3DA9B4CFC8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5151422" y="14673111"/>
                        <a:ext cx="5529484" cy="3216093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14DA2553-C8D1-DD73-0966-0144DFF9F5F9}"/>
              </a:ext>
            </a:extLst>
          </p:cNvPr>
          <p:cNvSpPr txBox="1"/>
          <p:nvPr/>
        </p:nvSpPr>
        <p:spPr>
          <a:xfrm>
            <a:off x="176395" y="22708702"/>
            <a:ext cx="20822721" cy="70788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2000" b="1">
                <a:latin typeface="Arial"/>
                <a:cs typeface="Arial"/>
              </a:rPr>
              <a:t>Supplementary Figure 7: </a:t>
            </a:r>
            <a:r>
              <a:rPr lang="en-US" sz="20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Association of miRNA expression with survival outcomes in adenocarcinoma NSCLC patients. Kaplan-Meier curves for (</a:t>
            </a:r>
            <a:r>
              <a:rPr lang="en-US" sz="2000" b="1" i="0">
                <a:solidFill>
                  <a:srgbClr val="000000"/>
                </a:solidFill>
                <a:effectLst/>
                <a:latin typeface="Arial"/>
                <a:cs typeface="Arial"/>
              </a:rPr>
              <a:t>A</a:t>
            </a:r>
            <a:r>
              <a:rPr lang="en-US" sz="20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) PFS and (</a:t>
            </a:r>
            <a:r>
              <a:rPr lang="en-US" sz="2000" b="1" i="0">
                <a:solidFill>
                  <a:srgbClr val="000000"/>
                </a:solidFill>
                <a:effectLst/>
                <a:latin typeface="Arial"/>
                <a:cs typeface="Arial"/>
              </a:rPr>
              <a:t>B</a:t>
            </a:r>
            <a:r>
              <a:rPr lang="en-US" sz="20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) OS according to the expression of </a:t>
            </a:r>
            <a:r>
              <a:rPr lang="en-US" sz="2000" b="0" i="0" err="1">
                <a:solidFill>
                  <a:srgbClr val="000000"/>
                </a:solidFill>
                <a:effectLst/>
                <a:latin typeface="Arial"/>
                <a:cs typeface="Arial"/>
              </a:rPr>
              <a:t>cEV</a:t>
            </a:r>
            <a:r>
              <a:rPr lang="en-US" sz="20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 miRNAs. Median expression values classified patients into low/high expression groups.</a:t>
            </a:r>
            <a:endParaRPr lang="en-US" sz="2000" b="1">
              <a:latin typeface="Arial"/>
              <a:cs typeface="Arial"/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E4BFA399-B7B9-9173-4346-5BEE3F8A7E00}"/>
              </a:ext>
            </a:extLst>
          </p:cNvPr>
          <p:cNvSpPr txBox="1"/>
          <p:nvPr/>
        </p:nvSpPr>
        <p:spPr>
          <a:xfrm>
            <a:off x="32160" y="857184"/>
            <a:ext cx="1168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b="1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893B85F0-C729-AB89-1007-D028FD6BE6A3}"/>
              </a:ext>
            </a:extLst>
          </p:cNvPr>
          <p:cNvSpPr txBox="1"/>
          <p:nvPr/>
        </p:nvSpPr>
        <p:spPr>
          <a:xfrm>
            <a:off x="8149" y="9583345"/>
            <a:ext cx="1168416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it-IT" sz="3600" b="1">
                <a:latin typeface="Arial"/>
                <a:cs typeface="Arial"/>
              </a:rPr>
              <a:t>B</a:t>
            </a:r>
            <a:endParaRPr lang="it-IT" sz="3600" b="1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1629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Oggetto 17">
            <a:extLst>
              <a:ext uri="{FF2B5EF4-FFF2-40B4-BE49-F238E27FC236}">
                <a16:creationId xmlns:a16="http://schemas.microsoft.com/office/drawing/2014/main" id="{9A720ADE-36EF-0B4F-24E5-68F48666F2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2275268"/>
              </p:ext>
            </p:extLst>
          </p:nvPr>
        </p:nvGraphicFramePr>
        <p:xfrm>
          <a:off x="43258" y="1411642"/>
          <a:ext cx="5566811" cy="5546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061514" imgH="3050865" progId="Prism10.Document">
                  <p:embed/>
                </p:oleObj>
              </mc:Choice>
              <mc:Fallback>
                <p:oleObj name="Prism 10" r:id="rId3" imgW="3061514" imgH="3050865" progId="Prism10.Document">
                  <p:embed/>
                  <p:pic>
                    <p:nvPicPr>
                      <p:cNvPr id="18" name="Oggetto 17">
                        <a:extLst>
                          <a:ext uri="{FF2B5EF4-FFF2-40B4-BE49-F238E27FC236}">
                            <a16:creationId xmlns:a16="http://schemas.microsoft.com/office/drawing/2014/main" id="{9A720ADE-36EF-0B4F-24E5-68F48666F2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258" y="1411642"/>
                        <a:ext cx="5566811" cy="5546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ggetto 19">
            <a:extLst>
              <a:ext uri="{FF2B5EF4-FFF2-40B4-BE49-F238E27FC236}">
                <a16:creationId xmlns:a16="http://schemas.microsoft.com/office/drawing/2014/main" id="{3A3C9FE2-95D9-4680-E073-DD0E54CAE2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3009441"/>
              </p:ext>
            </p:extLst>
          </p:nvPr>
        </p:nvGraphicFramePr>
        <p:xfrm>
          <a:off x="5460663" y="1411642"/>
          <a:ext cx="5566811" cy="5546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061514" imgH="3050865" progId="Prism10.Document">
                  <p:embed/>
                </p:oleObj>
              </mc:Choice>
              <mc:Fallback>
                <p:oleObj name="Prism 10" r:id="rId5" imgW="3061514" imgH="3050865" progId="Prism10.Document">
                  <p:embed/>
                  <p:pic>
                    <p:nvPicPr>
                      <p:cNvPr id="20" name="Oggetto 19">
                        <a:extLst>
                          <a:ext uri="{FF2B5EF4-FFF2-40B4-BE49-F238E27FC236}">
                            <a16:creationId xmlns:a16="http://schemas.microsoft.com/office/drawing/2014/main" id="{3A3C9FE2-95D9-4680-E073-DD0E54CAE2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460663" y="1411642"/>
                        <a:ext cx="5566811" cy="5546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ggetto 20">
            <a:extLst>
              <a:ext uri="{FF2B5EF4-FFF2-40B4-BE49-F238E27FC236}">
                <a16:creationId xmlns:a16="http://schemas.microsoft.com/office/drawing/2014/main" id="{5E025D1A-3610-5C88-DC3A-C066CDA214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3924191"/>
              </p:ext>
            </p:extLst>
          </p:nvPr>
        </p:nvGraphicFramePr>
        <p:xfrm>
          <a:off x="10813926" y="1441578"/>
          <a:ext cx="5549495" cy="5546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052150" imgH="3050865" progId="Prism10.Document">
                  <p:embed/>
                </p:oleObj>
              </mc:Choice>
              <mc:Fallback>
                <p:oleObj name="Prism 10" r:id="rId7" imgW="3052150" imgH="3050865" progId="Prism10.Document">
                  <p:embed/>
                  <p:pic>
                    <p:nvPicPr>
                      <p:cNvPr id="21" name="Oggetto 20">
                        <a:extLst>
                          <a:ext uri="{FF2B5EF4-FFF2-40B4-BE49-F238E27FC236}">
                            <a16:creationId xmlns:a16="http://schemas.microsoft.com/office/drawing/2014/main" id="{5E025D1A-3610-5C88-DC3A-C066CDA214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813926" y="1441578"/>
                        <a:ext cx="5549495" cy="5546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ggetto 21">
            <a:extLst>
              <a:ext uri="{FF2B5EF4-FFF2-40B4-BE49-F238E27FC236}">
                <a16:creationId xmlns:a16="http://schemas.microsoft.com/office/drawing/2014/main" id="{0AEE7B40-C030-4696-6D43-35CF7F820B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1003545"/>
              </p:ext>
            </p:extLst>
          </p:nvPr>
        </p:nvGraphicFramePr>
        <p:xfrm>
          <a:off x="15821114" y="1441578"/>
          <a:ext cx="5763050" cy="5546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170995" imgH="3050865" progId="Prism10.Document">
                  <p:embed/>
                </p:oleObj>
              </mc:Choice>
              <mc:Fallback>
                <p:oleObj name="Prism 10" r:id="rId9" imgW="3170995" imgH="3050865" progId="Prism10.Document">
                  <p:embed/>
                  <p:pic>
                    <p:nvPicPr>
                      <p:cNvPr id="22" name="Oggetto 21">
                        <a:extLst>
                          <a:ext uri="{FF2B5EF4-FFF2-40B4-BE49-F238E27FC236}">
                            <a16:creationId xmlns:a16="http://schemas.microsoft.com/office/drawing/2014/main" id="{0AEE7B40-C030-4696-6D43-35CF7F820B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821114" y="1441578"/>
                        <a:ext cx="5763050" cy="5546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ggetto 25">
            <a:extLst>
              <a:ext uri="{FF2B5EF4-FFF2-40B4-BE49-F238E27FC236}">
                <a16:creationId xmlns:a16="http://schemas.microsoft.com/office/drawing/2014/main" id="{18D01538-9BF9-157B-5EE9-AF0DAEBC5B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324332"/>
              </p:ext>
            </p:extLst>
          </p:nvPr>
        </p:nvGraphicFramePr>
        <p:xfrm>
          <a:off x="11255222" y="7210366"/>
          <a:ext cx="5566811" cy="5546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3061514" imgH="3050865" progId="Prism10.Document">
                  <p:embed/>
                </p:oleObj>
              </mc:Choice>
              <mc:Fallback>
                <p:oleObj name="Prism 10" r:id="rId11" imgW="3061514" imgH="3050865" progId="Prism10.Document">
                  <p:embed/>
                  <p:pic>
                    <p:nvPicPr>
                      <p:cNvPr id="26" name="Oggetto 25">
                        <a:extLst>
                          <a:ext uri="{FF2B5EF4-FFF2-40B4-BE49-F238E27FC236}">
                            <a16:creationId xmlns:a16="http://schemas.microsoft.com/office/drawing/2014/main" id="{18D01538-9BF9-157B-5EE9-AF0DAEBC5B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1255222" y="7210366"/>
                        <a:ext cx="5566811" cy="5546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ggetto 26">
            <a:extLst>
              <a:ext uri="{FF2B5EF4-FFF2-40B4-BE49-F238E27FC236}">
                <a16:creationId xmlns:a16="http://schemas.microsoft.com/office/drawing/2014/main" id="{ED167F1D-BBB9-53C5-0D61-3E8E00E386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8432143"/>
              </p:ext>
            </p:extLst>
          </p:nvPr>
        </p:nvGraphicFramePr>
        <p:xfrm>
          <a:off x="15976304" y="6779222"/>
          <a:ext cx="5763048" cy="58207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170995" imgH="3201769" progId="Prism10.Document">
                  <p:embed/>
                </p:oleObj>
              </mc:Choice>
              <mc:Fallback>
                <p:oleObj name="Prism 10" r:id="rId13" imgW="3170995" imgH="3201769" progId="Prism10.Document">
                  <p:embed/>
                  <p:pic>
                    <p:nvPicPr>
                      <p:cNvPr id="27" name="Oggetto 26">
                        <a:extLst>
                          <a:ext uri="{FF2B5EF4-FFF2-40B4-BE49-F238E27FC236}">
                            <a16:creationId xmlns:a16="http://schemas.microsoft.com/office/drawing/2014/main" id="{ED167F1D-BBB9-53C5-0D61-3E8E00E386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5976304" y="6779222"/>
                        <a:ext cx="5763048" cy="58207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ggetto 27">
            <a:extLst>
              <a:ext uri="{FF2B5EF4-FFF2-40B4-BE49-F238E27FC236}">
                <a16:creationId xmlns:a16="http://schemas.microsoft.com/office/drawing/2014/main" id="{FDECDE19-0E04-DDF7-0B99-F80099BF1A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0368246"/>
              </p:ext>
            </p:extLst>
          </p:nvPr>
        </p:nvGraphicFramePr>
        <p:xfrm>
          <a:off x="32188" y="13009091"/>
          <a:ext cx="5566810" cy="57313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3061514" imgH="3153149" progId="Prism10.Document">
                  <p:embed/>
                </p:oleObj>
              </mc:Choice>
              <mc:Fallback>
                <p:oleObj name="Prism 10" r:id="rId15" imgW="3061514" imgH="3153149" progId="Prism10.Document">
                  <p:embed/>
                  <p:pic>
                    <p:nvPicPr>
                      <p:cNvPr id="28" name="Oggetto 27">
                        <a:extLst>
                          <a:ext uri="{FF2B5EF4-FFF2-40B4-BE49-F238E27FC236}">
                            <a16:creationId xmlns:a16="http://schemas.microsoft.com/office/drawing/2014/main" id="{FDECDE19-0E04-DDF7-0B99-F80099BF1A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2188" y="13009091"/>
                        <a:ext cx="5566810" cy="57313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ggetto 28">
            <a:extLst>
              <a:ext uri="{FF2B5EF4-FFF2-40B4-BE49-F238E27FC236}">
                <a16:creationId xmlns:a16="http://schemas.microsoft.com/office/drawing/2014/main" id="{3FFD888C-5868-6AF0-4B3A-CBBC67C085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2863467"/>
              </p:ext>
            </p:extLst>
          </p:nvPr>
        </p:nvGraphicFramePr>
        <p:xfrm>
          <a:off x="5383508" y="12979155"/>
          <a:ext cx="5566810" cy="5760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3061514" imgH="3168275" progId="Prism10.Document">
                  <p:embed/>
                </p:oleObj>
              </mc:Choice>
              <mc:Fallback>
                <p:oleObj name="Prism 10" r:id="rId17" imgW="3061514" imgH="3168275" progId="Prism10.Document">
                  <p:embed/>
                  <p:pic>
                    <p:nvPicPr>
                      <p:cNvPr id="29" name="Oggetto 28">
                        <a:extLst>
                          <a:ext uri="{FF2B5EF4-FFF2-40B4-BE49-F238E27FC236}">
                            <a16:creationId xmlns:a16="http://schemas.microsoft.com/office/drawing/2014/main" id="{3FFD888C-5868-6AF0-4B3A-CBBC67C085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383508" y="12979155"/>
                        <a:ext cx="5566810" cy="5760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CD172DF4-F594-4209-3CF2-CD6FB28B70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8602446"/>
              </p:ext>
            </p:extLst>
          </p:nvPr>
        </p:nvGraphicFramePr>
        <p:xfrm>
          <a:off x="43258" y="6988188"/>
          <a:ext cx="5485185" cy="58292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3061514" imgH="3253632" progId="Prism10.Document">
                  <p:embed/>
                </p:oleObj>
              </mc:Choice>
              <mc:Fallback>
                <p:oleObj name="Prism 10" r:id="rId19" imgW="3061514" imgH="3253632" progId="Prism10.Document">
                  <p:embed/>
                  <p:pic>
                    <p:nvPicPr>
                      <p:cNvPr id="3" name="Oggetto 2">
                        <a:extLst>
                          <a:ext uri="{FF2B5EF4-FFF2-40B4-BE49-F238E27FC236}">
                            <a16:creationId xmlns:a16="http://schemas.microsoft.com/office/drawing/2014/main" id="{CD172DF4-F594-4209-3CF2-CD6FB28B70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3258" y="6988188"/>
                        <a:ext cx="5485185" cy="58292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0DCCA837-C239-A0B7-92A8-D3EC76BC6B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4053421"/>
              </p:ext>
            </p:extLst>
          </p:nvPr>
        </p:nvGraphicFramePr>
        <p:xfrm>
          <a:off x="4989827" y="7149902"/>
          <a:ext cx="5873951" cy="56675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3161992" imgH="3050865" progId="Prism10.Document">
                  <p:embed/>
                </p:oleObj>
              </mc:Choice>
              <mc:Fallback>
                <p:oleObj name="Prism 10" r:id="rId21" imgW="3161992" imgH="3050865" progId="Prism10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0DCCA837-C239-A0B7-92A8-D3EC76BC6B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989827" y="7149902"/>
                        <a:ext cx="5873951" cy="56675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579A38AE-37D6-05EF-9F03-DF4A31ACC761}"/>
              </a:ext>
            </a:extLst>
          </p:cNvPr>
          <p:cNvSpPr txBox="1"/>
          <p:nvPr/>
        </p:nvSpPr>
        <p:spPr>
          <a:xfrm>
            <a:off x="246101" y="19520200"/>
            <a:ext cx="19632146" cy="10156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2000" b="1">
                <a:latin typeface="Arial"/>
                <a:cs typeface="Arial"/>
              </a:rPr>
              <a:t>Supplementary Figure 8: </a:t>
            </a:r>
            <a:r>
              <a:rPr lang="en-US" sz="20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Association of miRNA expressions and metastases in adenocarcinoma NSCLC patients. Dot plot comparisons miRNA expressions (n. copies/µl) in patients with n=1/2 metastatic sites vs patients with n=3/4 metastatic sites. The horizontal bars indicate the median values with range and statistical analysis are indicated on graphs.</a:t>
            </a:r>
            <a:endParaRPr lang="en-US" sz="2000" b="1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1560663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Application>Microsoft Office PowerPoint</Application>
  <PresentationFormat>Custom</PresentationFormat>
  <Slides>8</Slides>
  <Notes>3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laria Laurenzana</dc:creator>
  <cp:revision>1</cp:revision>
  <cp:lastPrinted>2024-08-27T07:23:24Z</cp:lastPrinted>
  <dcterms:created xsi:type="dcterms:W3CDTF">2024-08-21T09:42:30Z</dcterms:created>
  <dcterms:modified xsi:type="dcterms:W3CDTF">2024-11-13T12:09:20Z</dcterms:modified>
</cp:coreProperties>
</file>